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media/image2.jpeg" ContentType="image/jpe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2358FD-8AA0-419A-B38B-992B915F01A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81DF1C-884B-44C6-A90D-CECEE54F545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9F8BB3-0AF6-4459-9ED4-E0385ACB81E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532413-77F7-4085-B592-9E70AEFFC33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0400CC-BAA9-46B7-AAD6-945558335A8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A4D911-640F-4285-B1A4-65333FF82C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BEF08F-2B4D-42C3-AC87-32175911DF4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D6949D-CD36-4224-BD1A-95536271B65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77EBCB-C9E8-4A07-AAE9-0A467601E99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9D8FBA-D87A-4CCD-A8F7-711D72A78C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781623-58FF-4F2D-83C4-9EB6B56E6E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2604F5-C6AB-4777-B271-178628B028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A938EA5-5E9A-456D-95E2-477F9655C6A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image" Target="../media/image5.png"/><Relationship Id="rId4" Type="http://schemas.openxmlformats.org/officeDocument/2006/relationships/image" Target="../media/image6.png"/><Relationship Id="rId5" Type="http://schemas.openxmlformats.org/officeDocument/2006/relationships/slideLayout" Target="../slideLayouts/slideLayout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7.wmf"/><Relationship Id="rId3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301"/>
          <p:cNvSpPr/>
          <p:nvPr/>
        </p:nvSpPr>
        <p:spPr>
          <a:xfrm>
            <a:off x="6203880" y="8969400"/>
            <a:ext cx="642960" cy="172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1" lang="en-GB" sz="700" spc="-1" strike="noStrike">
                <a:solidFill>
                  <a:srgbClr val="000000"/>
                </a:solidFill>
                <a:latin typeface="Arial"/>
              </a:rPr>
              <a:t>Marino</a:t>
            </a:r>
            <a:r>
              <a:rPr b="1" i="1" lang="en-GB" sz="700" spc="-1" strike="noStrike">
                <a:solidFill>
                  <a:srgbClr val="000000"/>
                </a:solidFill>
                <a:latin typeface="Arial"/>
              </a:rPr>
              <a:t> et al.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Rectangle 302"/>
          <p:cNvSpPr/>
          <p:nvPr/>
        </p:nvSpPr>
        <p:spPr>
          <a:xfrm>
            <a:off x="-10440" y="8895240"/>
            <a:ext cx="6425280" cy="24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Figure S1.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(Utiliser une police de caractè"/>
              </a:rPr>
              <a:t>Bayesian phylogenetic tree of RBOH amino acid sequences in Viridiplantae</a:t>
            </a: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Zone de texte 4"/>
          <p:cNvSpPr/>
          <p:nvPr/>
        </p:nvSpPr>
        <p:spPr>
          <a:xfrm>
            <a:off x="0" y="0"/>
            <a:ext cx="1413000" cy="27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5160" rIns="65160" tIns="32760" bIns="3276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Rectangle à coins arrondis 737"/>
          <p:cNvSpPr/>
          <p:nvPr/>
        </p:nvSpPr>
        <p:spPr>
          <a:xfrm>
            <a:off x="3668760" y="1722600"/>
            <a:ext cx="1968480" cy="2241360"/>
          </a:xfrm>
          <a:custGeom>
            <a:avLst/>
            <a:gdLst>
              <a:gd name="textAreaLeft" fmla="*/ 95760 w 1968480"/>
              <a:gd name="textAreaRight" fmla="*/ 1872720 w 1968480"/>
              <a:gd name="textAreaTop" fmla="*/ 95760 h 2241360"/>
              <a:gd name="textAreaBottom" fmla="*/ 2145600 h 2241360"/>
            </a:gdLst>
            <a:ahLst/>
            <a:rect l="textAreaLeft" t="textAreaTop" r="textAreaRight" b="textAreaBottom"/>
            <a:pathLst>
              <a:path w="21600" h="24594">
                <a:moveTo>
                  <a:pt x="3600" y="0"/>
                </a:moveTo>
                <a:arcTo wR="3600" hR="3600" stAng="16200000" swAng="-5400000"/>
                <a:lnTo>
                  <a:pt x="0" y="20994"/>
                </a:lnTo>
                <a:arcTo wR="3600" hR="3600" stAng="10800000" swAng="-5400000"/>
                <a:lnTo>
                  <a:pt x="18000" y="24594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solidFill>
            <a:srgbClr val="92d050">
              <a:alpha val="41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5160" rIns="65160" tIns="32760" bIns="327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Rectangle à coins arrondis 735"/>
          <p:cNvSpPr/>
          <p:nvPr/>
        </p:nvSpPr>
        <p:spPr>
          <a:xfrm>
            <a:off x="3710160" y="444600"/>
            <a:ext cx="1692000" cy="1270080"/>
          </a:xfrm>
          <a:prstGeom prst="roundRect">
            <a:avLst>
              <a:gd name="adj" fmla="val 16667"/>
            </a:avLst>
          </a:prstGeom>
          <a:solidFill>
            <a:srgbClr val="4f81bd">
              <a:alpha val="41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5160" rIns="65160" tIns="32760" bIns="327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Line 5"/>
          <p:cNvSpPr/>
          <p:nvPr/>
        </p:nvSpPr>
        <p:spPr>
          <a:xfrm>
            <a:off x="533520" y="8712360"/>
            <a:ext cx="941400" cy="144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Rectangle 6"/>
          <p:cNvSpPr/>
          <p:nvPr/>
        </p:nvSpPr>
        <p:spPr>
          <a:xfrm>
            <a:off x="981360" y="8740800"/>
            <a:ext cx="540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.9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Freeform 8"/>
          <p:cNvSpPr/>
          <p:nvPr/>
        </p:nvSpPr>
        <p:spPr>
          <a:xfrm>
            <a:off x="4253040" y="1131840"/>
            <a:ext cx="106200" cy="20520"/>
          </a:xfrm>
          <a:custGeom>
            <a:avLst/>
            <a:gdLst>
              <a:gd name="textAreaLeft" fmla="*/ 0 w 106200"/>
              <a:gd name="textAreaRight" fmla="*/ 106560 w 106200"/>
              <a:gd name="textAreaTop" fmla="*/ 0 h 20520"/>
              <a:gd name="textAreaBottom" fmla="*/ 20520 h 20520"/>
            </a:gdLst>
            <a:ahLst/>
            <a:rect l="textAreaLeft" t="textAreaTop" r="textAreaRight" b="textAreaBottom"/>
            <a:pathLst>
              <a:path w="749" h="91">
                <a:moveTo>
                  <a:pt x="749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Freeform 13"/>
          <p:cNvSpPr/>
          <p:nvPr/>
        </p:nvSpPr>
        <p:spPr>
          <a:xfrm>
            <a:off x="4127400" y="2519280"/>
            <a:ext cx="92160" cy="50760"/>
          </a:xfrm>
          <a:custGeom>
            <a:avLst/>
            <a:gdLst>
              <a:gd name="textAreaLeft" fmla="*/ 0 w 92160"/>
              <a:gd name="textAreaRight" fmla="*/ 92520 w 92160"/>
              <a:gd name="textAreaTop" fmla="*/ 0 h 50760"/>
              <a:gd name="textAreaBottom" fmla="*/ 51120 h 50760"/>
            </a:gdLst>
            <a:ahLst/>
            <a:rect l="textAreaLeft" t="textAreaTop" r="textAreaRight" b="textAreaBottom"/>
            <a:pathLst>
              <a:path w="638" h="206">
                <a:moveTo>
                  <a:pt x="638" y="0"/>
                </a:moveTo>
                <a:lnTo>
                  <a:pt x="0" y="0"/>
                </a:lnTo>
                <a:lnTo>
                  <a:pt x="0" y="206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20" bIns="43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Freeform 18"/>
          <p:cNvSpPr/>
          <p:nvPr/>
        </p:nvSpPr>
        <p:spPr>
          <a:xfrm>
            <a:off x="4025880" y="1030320"/>
            <a:ext cx="171360" cy="33480"/>
          </a:xfrm>
          <a:custGeom>
            <a:avLst/>
            <a:gdLst>
              <a:gd name="textAreaLeft" fmla="*/ 0 w 171360"/>
              <a:gd name="textAreaRight" fmla="*/ 171720 w 171360"/>
              <a:gd name="textAreaTop" fmla="*/ 0 h 33480"/>
              <a:gd name="textAreaBottom" fmla="*/ 33840 h 33480"/>
            </a:gdLst>
            <a:ahLst/>
            <a:rect l="textAreaLeft" t="textAreaTop" r="textAreaRight" b="textAreaBottom"/>
            <a:pathLst>
              <a:path w="1187" h="137">
                <a:moveTo>
                  <a:pt x="1187" y="137"/>
                </a:moveTo>
                <a:lnTo>
                  <a:pt x="0" y="137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Freeform 19"/>
          <p:cNvSpPr/>
          <p:nvPr/>
        </p:nvSpPr>
        <p:spPr>
          <a:xfrm>
            <a:off x="4491000" y="839880"/>
            <a:ext cx="34920" cy="23760"/>
          </a:xfrm>
          <a:custGeom>
            <a:avLst/>
            <a:gdLst>
              <a:gd name="textAreaLeft" fmla="*/ 0 w 34920"/>
              <a:gd name="textAreaRight" fmla="*/ 35280 w 34920"/>
              <a:gd name="textAreaTop" fmla="*/ 0 h 23760"/>
              <a:gd name="textAreaBottom" fmla="*/ 24120 h 23760"/>
            </a:gdLst>
            <a:ahLst/>
            <a:rect l="textAreaLeft" t="textAreaTop" r="textAreaRight" b="textAreaBottom"/>
            <a:pathLst>
              <a:path w="248" h="92">
                <a:moveTo>
                  <a:pt x="248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Freeform 24"/>
          <p:cNvSpPr/>
          <p:nvPr/>
        </p:nvSpPr>
        <p:spPr>
          <a:xfrm>
            <a:off x="4710240" y="2386080"/>
            <a:ext cx="39600" cy="20520"/>
          </a:xfrm>
          <a:custGeom>
            <a:avLst/>
            <a:gdLst>
              <a:gd name="textAreaLeft" fmla="*/ 0 w 39600"/>
              <a:gd name="textAreaRight" fmla="*/ 39960 w 39600"/>
              <a:gd name="textAreaTop" fmla="*/ 0 h 20520"/>
              <a:gd name="textAreaBottom" fmla="*/ 20880 h 20520"/>
            </a:gdLst>
            <a:ahLst/>
            <a:rect l="textAreaLeft" t="textAreaTop" r="textAreaRight" b="textAreaBottom"/>
            <a:pathLst>
              <a:path w="281" h="92">
                <a:moveTo>
                  <a:pt x="281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Freeform 26"/>
          <p:cNvSpPr/>
          <p:nvPr/>
        </p:nvSpPr>
        <p:spPr>
          <a:xfrm>
            <a:off x="3641760" y="2268360"/>
            <a:ext cx="88920" cy="1146240"/>
          </a:xfrm>
          <a:custGeom>
            <a:avLst/>
            <a:gdLst>
              <a:gd name="textAreaLeft" fmla="*/ 0 w 88920"/>
              <a:gd name="textAreaRight" fmla="*/ 89280 w 88920"/>
              <a:gd name="textAreaTop" fmla="*/ 0 h 1146240"/>
              <a:gd name="textAreaBottom" fmla="*/ 1146600 h 1146240"/>
            </a:gdLst>
            <a:ahLst/>
            <a:rect l="textAreaLeft" t="textAreaTop" r="textAreaRight" b="textAreaBottom"/>
            <a:pathLst>
              <a:path w="623" h="4683">
                <a:moveTo>
                  <a:pt x="623" y="4683"/>
                </a:moveTo>
                <a:lnTo>
                  <a:pt x="0" y="4683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Freeform 29"/>
          <p:cNvSpPr/>
          <p:nvPr/>
        </p:nvSpPr>
        <p:spPr>
          <a:xfrm>
            <a:off x="3855960" y="1430280"/>
            <a:ext cx="39600" cy="130320"/>
          </a:xfrm>
          <a:custGeom>
            <a:avLst/>
            <a:gdLst>
              <a:gd name="textAreaLeft" fmla="*/ 0 w 39600"/>
              <a:gd name="textAreaRight" fmla="*/ 39960 w 39600"/>
              <a:gd name="textAreaTop" fmla="*/ 0 h 130320"/>
              <a:gd name="textAreaBottom" fmla="*/ 130680 h 130320"/>
            </a:gdLst>
            <a:ahLst/>
            <a:rect l="textAreaLeft" t="textAreaTop" r="textAreaRight" b="textAreaBottom"/>
            <a:pathLst>
              <a:path w="280" h="533">
                <a:moveTo>
                  <a:pt x="280" y="0"/>
                </a:moveTo>
                <a:lnTo>
                  <a:pt x="0" y="0"/>
                </a:lnTo>
                <a:lnTo>
                  <a:pt x="0" y="533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Freeform 31"/>
          <p:cNvSpPr/>
          <p:nvPr/>
        </p:nvSpPr>
        <p:spPr>
          <a:xfrm>
            <a:off x="3981600" y="2873520"/>
            <a:ext cx="23760" cy="85680"/>
          </a:xfrm>
          <a:custGeom>
            <a:avLst/>
            <a:gdLst>
              <a:gd name="textAreaLeft" fmla="*/ 0 w 23760"/>
              <a:gd name="textAreaRight" fmla="*/ 24120 w 23760"/>
              <a:gd name="textAreaTop" fmla="*/ 0 h 85680"/>
              <a:gd name="textAreaBottom" fmla="*/ 86040 h 85680"/>
            </a:gdLst>
            <a:ahLst/>
            <a:rect l="textAreaLeft" t="textAreaTop" r="textAreaRight" b="textAreaBottom"/>
            <a:pathLst>
              <a:path w="158" h="349">
                <a:moveTo>
                  <a:pt x="158" y="349"/>
                </a:moveTo>
                <a:lnTo>
                  <a:pt x="0" y="349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9240" bIns="3924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Freeform 34"/>
          <p:cNvSpPr/>
          <p:nvPr/>
        </p:nvSpPr>
        <p:spPr>
          <a:xfrm>
            <a:off x="4253040" y="1109520"/>
            <a:ext cx="455400" cy="22320"/>
          </a:xfrm>
          <a:custGeom>
            <a:avLst/>
            <a:gdLst>
              <a:gd name="textAreaLeft" fmla="*/ 0 w 455400"/>
              <a:gd name="textAreaRight" fmla="*/ 455760 w 45540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3165" h="92">
                <a:moveTo>
                  <a:pt x="3165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Freeform 36"/>
          <p:cNvSpPr/>
          <p:nvPr/>
        </p:nvSpPr>
        <p:spPr>
          <a:xfrm>
            <a:off x="3730680" y="3009960"/>
            <a:ext cx="120600" cy="404640"/>
          </a:xfrm>
          <a:custGeom>
            <a:avLst/>
            <a:gdLst>
              <a:gd name="textAreaLeft" fmla="*/ 0 w 120600"/>
              <a:gd name="textAreaRight" fmla="*/ 120960 w 120600"/>
              <a:gd name="textAreaTop" fmla="*/ 0 h 404640"/>
              <a:gd name="textAreaBottom" fmla="*/ 405000 h 404640"/>
            </a:gdLst>
            <a:ahLst/>
            <a:rect l="textAreaLeft" t="textAreaTop" r="textAreaRight" b="textAreaBottom"/>
            <a:pathLst>
              <a:path w="834" h="1653">
                <a:moveTo>
                  <a:pt x="834" y="0"/>
                </a:moveTo>
                <a:lnTo>
                  <a:pt x="0" y="0"/>
                </a:lnTo>
                <a:lnTo>
                  <a:pt x="0" y="1653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Freeform 38"/>
          <p:cNvSpPr/>
          <p:nvPr/>
        </p:nvSpPr>
        <p:spPr>
          <a:xfrm>
            <a:off x="4255920" y="2206800"/>
            <a:ext cx="627120" cy="66600"/>
          </a:xfrm>
          <a:custGeom>
            <a:avLst/>
            <a:gdLst>
              <a:gd name="textAreaLeft" fmla="*/ 0 w 627120"/>
              <a:gd name="textAreaRight" fmla="*/ 627480 w 627120"/>
              <a:gd name="textAreaTop" fmla="*/ 0 h 66600"/>
              <a:gd name="textAreaBottom" fmla="*/ 66960 h 66600"/>
            </a:gdLst>
            <a:ahLst/>
            <a:rect l="textAreaLeft" t="textAreaTop" r="textAreaRight" b="textAreaBottom"/>
            <a:pathLst>
              <a:path w="4334" h="275">
                <a:moveTo>
                  <a:pt x="4334" y="0"/>
                </a:moveTo>
                <a:lnTo>
                  <a:pt x="0" y="0"/>
                </a:lnTo>
                <a:lnTo>
                  <a:pt x="0" y="275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Freeform 41"/>
          <p:cNvSpPr/>
          <p:nvPr/>
        </p:nvSpPr>
        <p:spPr>
          <a:xfrm>
            <a:off x="4626000" y="974880"/>
            <a:ext cx="55440" cy="21960"/>
          </a:xfrm>
          <a:custGeom>
            <a:avLst/>
            <a:gdLst>
              <a:gd name="textAreaLeft" fmla="*/ 0 w 55440"/>
              <a:gd name="textAreaRight" fmla="*/ 55800 w 55440"/>
              <a:gd name="textAreaTop" fmla="*/ 0 h 21960"/>
              <a:gd name="textAreaBottom" fmla="*/ 22320 h 21960"/>
            </a:gdLst>
            <a:ahLst/>
            <a:rect l="textAreaLeft" t="textAreaTop" r="textAreaRight" b="textAreaBottom"/>
            <a:pathLst>
              <a:path w="378" h="91">
                <a:moveTo>
                  <a:pt x="378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Freeform 42"/>
          <p:cNvSpPr/>
          <p:nvPr/>
        </p:nvSpPr>
        <p:spPr>
          <a:xfrm>
            <a:off x="4183200" y="1366920"/>
            <a:ext cx="55440" cy="33120"/>
          </a:xfrm>
          <a:custGeom>
            <a:avLst/>
            <a:gdLst>
              <a:gd name="textAreaLeft" fmla="*/ 0 w 55440"/>
              <a:gd name="textAreaRight" fmla="*/ 55800 w 55440"/>
              <a:gd name="textAreaTop" fmla="*/ 0 h 33120"/>
              <a:gd name="textAreaBottom" fmla="*/ 33480 h 33120"/>
            </a:gdLst>
            <a:ahLst/>
            <a:rect l="textAreaLeft" t="textAreaTop" r="textAreaRight" b="textAreaBottom"/>
            <a:pathLst>
              <a:path w="387" h="138">
                <a:moveTo>
                  <a:pt x="387" y="138"/>
                </a:moveTo>
                <a:lnTo>
                  <a:pt x="0" y="138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Freeform 45"/>
          <p:cNvSpPr/>
          <p:nvPr/>
        </p:nvSpPr>
        <p:spPr>
          <a:xfrm>
            <a:off x="3984480" y="1871640"/>
            <a:ext cx="81000" cy="297000"/>
          </a:xfrm>
          <a:custGeom>
            <a:avLst/>
            <a:gdLst>
              <a:gd name="textAreaLeft" fmla="*/ 0 w 81000"/>
              <a:gd name="textAreaRight" fmla="*/ 81360 w 81000"/>
              <a:gd name="textAreaTop" fmla="*/ 0 h 297000"/>
              <a:gd name="textAreaBottom" fmla="*/ 297000 h 297000"/>
            </a:gdLst>
            <a:ahLst/>
            <a:rect l="textAreaLeft" t="textAreaTop" r="textAreaRight" b="textAreaBottom"/>
            <a:pathLst>
              <a:path w="562" h="1218">
                <a:moveTo>
                  <a:pt x="562" y="0"/>
                </a:moveTo>
                <a:lnTo>
                  <a:pt x="0" y="0"/>
                </a:lnTo>
                <a:lnTo>
                  <a:pt x="0" y="1218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Freeform 46"/>
          <p:cNvSpPr/>
          <p:nvPr/>
        </p:nvSpPr>
        <p:spPr>
          <a:xfrm>
            <a:off x="4157640" y="3102120"/>
            <a:ext cx="11160" cy="21960"/>
          </a:xfrm>
          <a:custGeom>
            <a:avLst/>
            <a:gdLst>
              <a:gd name="textAreaLeft" fmla="*/ 0 w 11160"/>
              <a:gd name="textAreaRight" fmla="*/ 11520 w 11160"/>
              <a:gd name="textAreaTop" fmla="*/ 0 h 21960"/>
              <a:gd name="textAreaBottom" fmla="*/ 22320 h 21960"/>
            </a:gdLst>
            <a:ahLst/>
            <a:rect l="textAreaLeft" t="textAreaTop" r="textAreaRight" b="textAreaBottom"/>
            <a:pathLst>
              <a:path w="78" h="92">
                <a:moveTo>
                  <a:pt x="78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Freeform 47"/>
          <p:cNvSpPr/>
          <p:nvPr/>
        </p:nvSpPr>
        <p:spPr>
          <a:xfrm>
            <a:off x="3500280" y="8612280"/>
            <a:ext cx="2625840" cy="21960"/>
          </a:xfrm>
          <a:custGeom>
            <a:avLst/>
            <a:gdLst>
              <a:gd name="textAreaLeft" fmla="*/ 0 w 2625840"/>
              <a:gd name="textAreaRight" fmla="*/ 2626200 w 2625840"/>
              <a:gd name="textAreaTop" fmla="*/ 0 h 21960"/>
              <a:gd name="textAreaBottom" fmla="*/ 22320 h 21960"/>
            </a:gdLst>
            <a:ahLst/>
            <a:rect l="textAreaLeft" t="textAreaTop" r="textAreaRight" b="textAreaBottom"/>
            <a:pathLst>
              <a:path w="18217" h="92">
                <a:moveTo>
                  <a:pt x="18217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Freeform 48"/>
          <p:cNvSpPr/>
          <p:nvPr/>
        </p:nvSpPr>
        <p:spPr>
          <a:xfrm>
            <a:off x="3747960" y="1123920"/>
            <a:ext cx="108000" cy="436680"/>
          </a:xfrm>
          <a:custGeom>
            <a:avLst/>
            <a:gdLst>
              <a:gd name="textAreaLeft" fmla="*/ 0 w 108000"/>
              <a:gd name="textAreaRight" fmla="*/ 108360 w 108000"/>
              <a:gd name="textAreaTop" fmla="*/ 0 h 436680"/>
              <a:gd name="textAreaBottom" fmla="*/ 437040 h 436680"/>
            </a:gdLst>
            <a:ahLst/>
            <a:rect l="textAreaLeft" t="textAreaTop" r="textAreaRight" b="textAreaBottom"/>
            <a:pathLst>
              <a:path w="741" h="1788">
                <a:moveTo>
                  <a:pt x="741" y="1788"/>
                </a:moveTo>
                <a:lnTo>
                  <a:pt x="0" y="1788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Freeform 50"/>
          <p:cNvSpPr/>
          <p:nvPr/>
        </p:nvSpPr>
        <p:spPr>
          <a:xfrm>
            <a:off x="4173480" y="2944800"/>
            <a:ext cx="19080" cy="22320"/>
          </a:xfrm>
          <a:custGeom>
            <a:avLst/>
            <a:gdLst>
              <a:gd name="textAreaLeft" fmla="*/ 0 w 19080"/>
              <a:gd name="textAreaRight" fmla="*/ 19440 w 1908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139" h="91">
                <a:moveTo>
                  <a:pt x="139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Freeform 52"/>
          <p:cNvSpPr/>
          <p:nvPr/>
        </p:nvSpPr>
        <p:spPr>
          <a:xfrm>
            <a:off x="3984480" y="520560"/>
            <a:ext cx="433440" cy="165240"/>
          </a:xfrm>
          <a:custGeom>
            <a:avLst/>
            <a:gdLst>
              <a:gd name="textAreaLeft" fmla="*/ 0 w 433440"/>
              <a:gd name="textAreaRight" fmla="*/ 433800 w 433440"/>
              <a:gd name="textAreaTop" fmla="*/ 0 h 165240"/>
              <a:gd name="textAreaBottom" fmla="*/ 165600 h 165240"/>
            </a:gdLst>
            <a:ahLst/>
            <a:rect l="textAreaLeft" t="textAreaTop" r="textAreaRight" b="textAreaBottom"/>
            <a:pathLst>
              <a:path w="3003" h="675">
                <a:moveTo>
                  <a:pt x="3003" y="0"/>
                </a:moveTo>
                <a:lnTo>
                  <a:pt x="0" y="0"/>
                </a:lnTo>
                <a:lnTo>
                  <a:pt x="0" y="675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Freeform 53"/>
          <p:cNvSpPr/>
          <p:nvPr/>
        </p:nvSpPr>
        <p:spPr>
          <a:xfrm>
            <a:off x="4057560" y="2363760"/>
            <a:ext cx="39600" cy="103320"/>
          </a:xfrm>
          <a:custGeom>
            <a:avLst/>
            <a:gdLst>
              <a:gd name="textAreaLeft" fmla="*/ 0 w 39600"/>
              <a:gd name="textAreaRight" fmla="*/ 39960 w 39600"/>
              <a:gd name="textAreaTop" fmla="*/ 0 h 103320"/>
              <a:gd name="textAreaBottom" fmla="*/ 103680 h 103320"/>
            </a:gdLst>
            <a:ahLst/>
            <a:rect l="textAreaLeft" t="textAreaTop" r="textAreaRight" b="textAreaBottom"/>
            <a:pathLst>
              <a:path w="270" h="424">
                <a:moveTo>
                  <a:pt x="270" y="0"/>
                </a:moveTo>
                <a:lnTo>
                  <a:pt x="0" y="0"/>
                </a:lnTo>
                <a:lnTo>
                  <a:pt x="0" y="424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Freeform 54"/>
          <p:cNvSpPr/>
          <p:nvPr/>
        </p:nvSpPr>
        <p:spPr>
          <a:xfrm>
            <a:off x="4097160" y="2273400"/>
            <a:ext cx="158760" cy="90360"/>
          </a:xfrm>
          <a:custGeom>
            <a:avLst/>
            <a:gdLst>
              <a:gd name="textAreaLeft" fmla="*/ 0 w 158760"/>
              <a:gd name="textAreaRight" fmla="*/ 159120 w 158760"/>
              <a:gd name="textAreaTop" fmla="*/ 0 h 90360"/>
              <a:gd name="textAreaBottom" fmla="*/ 90720 h 90360"/>
            </a:gdLst>
            <a:ahLst/>
            <a:rect l="textAreaLeft" t="textAreaTop" r="textAreaRight" b="textAreaBottom"/>
            <a:pathLst>
              <a:path w="1114" h="366">
                <a:moveTo>
                  <a:pt x="1114" y="0"/>
                </a:moveTo>
                <a:lnTo>
                  <a:pt x="0" y="0"/>
                </a:lnTo>
                <a:lnTo>
                  <a:pt x="0" y="366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Freeform 55"/>
          <p:cNvSpPr/>
          <p:nvPr/>
        </p:nvSpPr>
        <p:spPr>
          <a:xfrm>
            <a:off x="4005360" y="2900520"/>
            <a:ext cx="487440" cy="58680"/>
          </a:xfrm>
          <a:custGeom>
            <a:avLst/>
            <a:gdLst>
              <a:gd name="textAreaLeft" fmla="*/ 0 w 487440"/>
              <a:gd name="textAreaRight" fmla="*/ 487800 w 487440"/>
              <a:gd name="textAreaTop" fmla="*/ 0 h 58680"/>
              <a:gd name="textAreaBottom" fmla="*/ 59040 h 58680"/>
            </a:gdLst>
            <a:ahLst/>
            <a:rect l="textAreaLeft" t="textAreaTop" r="textAreaRight" b="textAreaBottom"/>
            <a:pathLst>
              <a:path w="3387" h="240">
                <a:moveTo>
                  <a:pt x="3387" y="0"/>
                </a:moveTo>
                <a:lnTo>
                  <a:pt x="0" y="0"/>
                </a:lnTo>
                <a:lnTo>
                  <a:pt x="0" y="24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2240" bIns="1224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Freeform 57"/>
          <p:cNvSpPr/>
          <p:nvPr/>
        </p:nvSpPr>
        <p:spPr>
          <a:xfrm>
            <a:off x="4479840" y="828720"/>
            <a:ext cx="11160" cy="34920"/>
          </a:xfrm>
          <a:custGeom>
            <a:avLst/>
            <a:gdLst>
              <a:gd name="textAreaLeft" fmla="*/ 0 w 11160"/>
              <a:gd name="textAreaRight" fmla="*/ 11520 w 11160"/>
              <a:gd name="textAreaTop" fmla="*/ 0 h 34920"/>
              <a:gd name="textAreaBottom" fmla="*/ 35280 h 34920"/>
            </a:gdLst>
            <a:ahLst/>
            <a:rect l="textAreaLeft" t="textAreaTop" r="textAreaRight" b="textAreaBottom"/>
            <a:pathLst>
              <a:path w="70" h="138">
                <a:moveTo>
                  <a:pt x="70" y="138"/>
                </a:moveTo>
                <a:lnTo>
                  <a:pt x="0" y="138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1520" bIns="-115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Freeform 59"/>
          <p:cNvSpPr/>
          <p:nvPr/>
        </p:nvSpPr>
        <p:spPr>
          <a:xfrm>
            <a:off x="4300560" y="1928880"/>
            <a:ext cx="141120" cy="54000"/>
          </a:xfrm>
          <a:custGeom>
            <a:avLst/>
            <a:gdLst>
              <a:gd name="textAreaLeft" fmla="*/ 0 w 141120"/>
              <a:gd name="textAreaRight" fmla="*/ 141480 w 141120"/>
              <a:gd name="textAreaTop" fmla="*/ 0 h 54000"/>
              <a:gd name="textAreaBottom" fmla="*/ 54360 h 54000"/>
            </a:gdLst>
            <a:ahLst/>
            <a:rect l="textAreaLeft" t="textAreaTop" r="textAreaRight" b="textAreaBottom"/>
            <a:pathLst>
              <a:path w="982" h="217">
                <a:moveTo>
                  <a:pt x="982" y="217"/>
                </a:moveTo>
                <a:lnTo>
                  <a:pt x="0" y="217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560" bIns="75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Freeform 60"/>
          <p:cNvSpPr/>
          <p:nvPr/>
        </p:nvSpPr>
        <p:spPr>
          <a:xfrm>
            <a:off x="3981600" y="2787480"/>
            <a:ext cx="68040" cy="86040"/>
          </a:xfrm>
          <a:custGeom>
            <a:avLst/>
            <a:gdLst>
              <a:gd name="textAreaLeft" fmla="*/ 0 w 68040"/>
              <a:gd name="textAreaRight" fmla="*/ 68400 w 68040"/>
              <a:gd name="textAreaTop" fmla="*/ 0 h 86040"/>
              <a:gd name="textAreaBottom" fmla="*/ 86040 h 86040"/>
            </a:gdLst>
            <a:ahLst/>
            <a:rect l="textAreaLeft" t="textAreaTop" r="textAreaRight" b="textAreaBottom"/>
            <a:pathLst>
              <a:path w="480" h="349">
                <a:moveTo>
                  <a:pt x="480" y="0"/>
                </a:moveTo>
                <a:lnTo>
                  <a:pt x="0" y="0"/>
                </a:lnTo>
                <a:lnTo>
                  <a:pt x="0" y="349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9240" bIns="3924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Freeform 61"/>
          <p:cNvSpPr/>
          <p:nvPr/>
        </p:nvSpPr>
        <p:spPr>
          <a:xfrm>
            <a:off x="4513320" y="682560"/>
            <a:ext cx="36360" cy="33480"/>
          </a:xfrm>
          <a:custGeom>
            <a:avLst/>
            <a:gdLst>
              <a:gd name="textAreaLeft" fmla="*/ 0 w 36360"/>
              <a:gd name="textAreaRight" fmla="*/ 36720 w 36360"/>
              <a:gd name="textAreaTop" fmla="*/ 0 h 33480"/>
              <a:gd name="textAreaBottom" fmla="*/ 33840 h 33480"/>
            </a:gdLst>
            <a:ahLst/>
            <a:rect l="textAreaLeft" t="textAreaTop" r="textAreaRight" b="textAreaBottom"/>
            <a:pathLst>
              <a:path w="254" h="137">
                <a:moveTo>
                  <a:pt x="254" y="0"/>
                </a:moveTo>
                <a:lnTo>
                  <a:pt x="0" y="0"/>
                </a:lnTo>
                <a:lnTo>
                  <a:pt x="0" y="137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Freeform 63"/>
          <p:cNvSpPr/>
          <p:nvPr/>
        </p:nvSpPr>
        <p:spPr>
          <a:xfrm>
            <a:off x="4475160" y="3841920"/>
            <a:ext cx="162000" cy="21960"/>
          </a:xfrm>
          <a:custGeom>
            <a:avLst/>
            <a:gdLst>
              <a:gd name="textAreaLeft" fmla="*/ 0 w 162000"/>
              <a:gd name="textAreaRight" fmla="*/ 162360 w 162000"/>
              <a:gd name="textAreaTop" fmla="*/ 0 h 21960"/>
              <a:gd name="textAreaBottom" fmla="*/ 22320 h 21960"/>
            </a:gdLst>
            <a:ahLst/>
            <a:rect l="textAreaLeft" t="textAreaTop" r="textAreaRight" b="textAreaBottom"/>
            <a:pathLst>
              <a:path w="1131" h="91">
                <a:moveTo>
                  <a:pt x="1131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Freeform 65"/>
          <p:cNvSpPr/>
          <p:nvPr/>
        </p:nvSpPr>
        <p:spPr>
          <a:xfrm>
            <a:off x="4710240" y="2363760"/>
            <a:ext cx="29880" cy="22320"/>
          </a:xfrm>
          <a:custGeom>
            <a:avLst/>
            <a:gdLst>
              <a:gd name="textAreaLeft" fmla="*/ 0 w 29880"/>
              <a:gd name="textAreaRight" fmla="*/ 30240 w 2988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217" h="92">
                <a:moveTo>
                  <a:pt x="217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Freeform 66"/>
          <p:cNvSpPr/>
          <p:nvPr/>
        </p:nvSpPr>
        <p:spPr>
          <a:xfrm>
            <a:off x="4175280" y="1165320"/>
            <a:ext cx="42840" cy="48960"/>
          </a:xfrm>
          <a:custGeom>
            <a:avLst/>
            <a:gdLst>
              <a:gd name="textAreaLeft" fmla="*/ 0 w 42840"/>
              <a:gd name="textAreaRight" fmla="*/ 43200 w 42840"/>
              <a:gd name="textAreaTop" fmla="*/ 0 h 48960"/>
              <a:gd name="textAreaBottom" fmla="*/ 49320 h 48960"/>
            </a:gdLst>
            <a:ahLst/>
            <a:rect l="textAreaLeft" t="textAreaTop" r="textAreaRight" b="textAreaBottom"/>
            <a:pathLst>
              <a:path w="295" h="206">
                <a:moveTo>
                  <a:pt x="295" y="0"/>
                </a:moveTo>
                <a:lnTo>
                  <a:pt x="0" y="0"/>
                </a:lnTo>
                <a:lnTo>
                  <a:pt x="0" y="206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Freeform 74"/>
          <p:cNvSpPr/>
          <p:nvPr/>
        </p:nvSpPr>
        <p:spPr>
          <a:xfrm>
            <a:off x="4005360" y="2959200"/>
            <a:ext cx="115920" cy="58680"/>
          </a:xfrm>
          <a:custGeom>
            <a:avLst/>
            <a:gdLst>
              <a:gd name="textAreaLeft" fmla="*/ 0 w 115920"/>
              <a:gd name="textAreaRight" fmla="*/ 116280 w 115920"/>
              <a:gd name="textAreaTop" fmla="*/ 0 h 58680"/>
              <a:gd name="textAreaBottom" fmla="*/ 59040 h 58680"/>
            </a:gdLst>
            <a:ahLst/>
            <a:rect l="textAreaLeft" t="textAreaTop" r="textAreaRight" b="textAreaBottom"/>
            <a:pathLst>
              <a:path w="821" h="240">
                <a:moveTo>
                  <a:pt x="821" y="240"/>
                </a:moveTo>
                <a:lnTo>
                  <a:pt x="0" y="240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2240" bIns="1224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Freeform 75"/>
          <p:cNvSpPr/>
          <p:nvPr/>
        </p:nvSpPr>
        <p:spPr>
          <a:xfrm>
            <a:off x="4883040" y="2184480"/>
            <a:ext cx="55800" cy="22320"/>
          </a:xfrm>
          <a:custGeom>
            <a:avLst/>
            <a:gdLst>
              <a:gd name="textAreaLeft" fmla="*/ 0 w 55800"/>
              <a:gd name="textAreaRight" fmla="*/ 56160 w 5580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395" h="91">
                <a:moveTo>
                  <a:pt x="395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Freeform 76"/>
          <p:cNvSpPr/>
          <p:nvPr/>
        </p:nvSpPr>
        <p:spPr>
          <a:xfrm>
            <a:off x="4176720" y="3571920"/>
            <a:ext cx="65160" cy="22320"/>
          </a:xfrm>
          <a:custGeom>
            <a:avLst/>
            <a:gdLst>
              <a:gd name="textAreaLeft" fmla="*/ 0 w 65160"/>
              <a:gd name="textAreaRight" fmla="*/ 65520 w 6516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454" h="92">
                <a:moveTo>
                  <a:pt x="454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Freeform 77"/>
          <p:cNvSpPr/>
          <p:nvPr/>
        </p:nvSpPr>
        <p:spPr>
          <a:xfrm>
            <a:off x="3979800" y="3402000"/>
            <a:ext cx="220680" cy="103320"/>
          </a:xfrm>
          <a:custGeom>
            <a:avLst/>
            <a:gdLst>
              <a:gd name="textAreaLeft" fmla="*/ 0 w 220680"/>
              <a:gd name="textAreaRight" fmla="*/ 221040 w 220680"/>
              <a:gd name="textAreaTop" fmla="*/ 0 h 103320"/>
              <a:gd name="textAreaBottom" fmla="*/ 103680 h 103320"/>
            </a:gdLst>
            <a:ahLst/>
            <a:rect l="textAreaLeft" t="textAreaTop" r="textAreaRight" b="textAreaBottom"/>
            <a:pathLst>
              <a:path w="1527" h="424">
                <a:moveTo>
                  <a:pt x="1527" y="424"/>
                </a:moveTo>
                <a:lnTo>
                  <a:pt x="0" y="424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Freeform 83"/>
          <p:cNvSpPr/>
          <p:nvPr/>
        </p:nvSpPr>
        <p:spPr>
          <a:xfrm>
            <a:off x="3956040" y="1030320"/>
            <a:ext cx="69840" cy="183960"/>
          </a:xfrm>
          <a:custGeom>
            <a:avLst/>
            <a:gdLst>
              <a:gd name="textAreaLeft" fmla="*/ 0 w 69840"/>
              <a:gd name="textAreaRight" fmla="*/ 70200 w 69840"/>
              <a:gd name="textAreaTop" fmla="*/ 0 h 183960"/>
              <a:gd name="textAreaBottom" fmla="*/ 184320 h 183960"/>
            </a:gdLst>
            <a:ahLst/>
            <a:rect l="textAreaLeft" t="textAreaTop" r="textAreaRight" b="textAreaBottom"/>
            <a:pathLst>
              <a:path w="482" h="752">
                <a:moveTo>
                  <a:pt x="482" y="0"/>
                </a:moveTo>
                <a:lnTo>
                  <a:pt x="0" y="0"/>
                </a:lnTo>
                <a:lnTo>
                  <a:pt x="0" y="75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Freeform 84"/>
          <p:cNvSpPr/>
          <p:nvPr/>
        </p:nvSpPr>
        <p:spPr>
          <a:xfrm>
            <a:off x="4098960" y="1579680"/>
            <a:ext cx="108000" cy="21960"/>
          </a:xfrm>
          <a:custGeom>
            <a:avLst/>
            <a:gdLst>
              <a:gd name="textAreaLeft" fmla="*/ 0 w 108000"/>
              <a:gd name="textAreaRight" fmla="*/ 108360 w 108000"/>
              <a:gd name="textAreaTop" fmla="*/ 0 h 21960"/>
              <a:gd name="textAreaBottom" fmla="*/ 22320 h 21960"/>
            </a:gdLst>
            <a:ahLst/>
            <a:rect l="textAreaLeft" t="textAreaTop" r="textAreaRight" b="textAreaBottom"/>
            <a:pathLst>
              <a:path w="752" h="91">
                <a:moveTo>
                  <a:pt x="752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Freeform 85"/>
          <p:cNvSpPr/>
          <p:nvPr/>
        </p:nvSpPr>
        <p:spPr>
          <a:xfrm>
            <a:off x="4029120" y="1467000"/>
            <a:ext cx="287280" cy="39600"/>
          </a:xfrm>
          <a:custGeom>
            <a:avLst/>
            <a:gdLst>
              <a:gd name="textAreaLeft" fmla="*/ 0 w 287280"/>
              <a:gd name="textAreaRight" fmla="*/ 287640 w 287280"/>
              <a:gd name="textAreaTop" fmla="*/ 0 h 39600"/>
              <a:gd name="textAreaBottom" fmla="*/ 39960 h 39600"/>
            </a:gdLst>
            <a:ahLst/>
            <a:rect l="textAreaLeft" t="textAreaTop" r="textAreaRight" b="textAreaBottom"/>
            <a:pathLst>
              <a:path w="1997" h="160">
                <a:moveTo>
                  <a:pt x="1997" y="0"/>
                </a:moveTo>
                <a:lnTo>
                  <a:pt x="0" y="0"/>
                </a:lnTo>
                <a:lnTo>
                  <a:pt x="0" y="16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Freeform 86"/>
          <p:cNvSpPr/>
          <p:nvPr/>
        </p:nvSpPr>
        <p:spPr>
          <a:xfrm>
            <a:off x="4070520" y="1546200"/>
            <a:ext cx="28440" cy="33480"/>
          </a:xfrm>
          <a:custGeom>
            <a:avLst/>
            <a:gdLst>
              <a:gd name="textAreaLeft" fmla="*/ 0 w 28440"/>
              <a:gd name="textAreaRight" fmla="*/ 28800 w 28440"/>
              <a:gd name="textAreaTop" fmla="*/ 0 h 33480"/>
              <a:gd name="textAreaBottom" fmla="*/ 33840 h 33480"/>
            </a:gdLst>
            <a:ahLst/>
            <a:rect l="textAreaLeft" t="textAreaTop" r="textAreaRight" b="textAreaBottom"/>
            <a:pathLst>
              <a:path w="206" h="138">
                <a:moveTo>
                  <a:pt x="206" y="138"/>
                </a:moveTo>
                <a:lnTo>
                  <a:pt x="0" y="138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Freeform 88"/>
          <p:cNvSpPr/>
          <p:nvPr/>
        </p:nvSpPr>
        <p:spPr>
          <a:xfrm>
            <a:off x="3730680" y="3414600"/>
            <a:ext cx="288720" cy="403200"/>
          </a:xfrm>
          <a:custGeom>
            <a:avLst/>
            <a:gdLst>
              <a:gd name="textAreaLeft" fmla="*/ 0 w 288720"/>
              <a:gd name="textAreaRight" fmla="*/ 289080 w 288720"/>
              <a:gd name="textAreaTop" fmla="*/ 0 h 403200"/>
              <a:gd name="textAreaBottom" fmla="*/ 403560 h 403200"/>
            </a:gdLst>
            <a:ahLst/>
            <a:rect l="textAreaLeft" t="textAreaTop" r="textAreaRight" b="textAreaBottom"/>
            <a:pathLst>
              <a:path w="2008" h="1653">
                <a:moveTo>
                  <a:pt x="2008" y="1653"/>
                </a:moveTo>
                <a:lnTo>
                  <a:pt x="0" y="1653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Freeform 90"/>
          <p:cNvSpPr/>
          <p:nvPr/>
        </p:nvSpPr>
        <p:spPr>
          <a:xfrm>
            <a:off x="4019400" y="3705120"/>
            <a:ext cx="34920" cy="112680"/>
          </a:xfrm>
          <a:custGeom>
            <a:avLst/>
            <a:gdLst>
              <a:gd name="textAreaLeft" fmla="*/ 0 w 34920"/>
              <a:gd name="textAreaRight" fmla="*/ 35280 w 34920"/>
              <a:gd name="textAreaTop" fmla="*/ 0 h 112680"/>
              <a:gd name="textAreaBottom" fmla="*/ 113040 h 112680"/>
            </a:gdLst>
            <a:ahLst/>
            <a:rect l="textAreaLeft" t="textAreaTop" r="textAreaRight" b="textAreaBottom"/>
            <a:pathLst>
              <a:path w="238" h="461">
                <a:moveTo>
                  <a:pt x="238" y="0"/>
                </a:moveTo>
                <a:lnTo>
                  <a:pt x="0" y="0"/>
                </a:lnTo>
                <a:lnTo>
                  <a:pt x="0" y="46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Freeform 94"/>
          <p:cNvSpPr/>
          <p:nvPr/>
        </p:nvSpPr>
        <p:spPr>
          <a:xfrm>
            <a:off x="3500280" y="8589960"/>
            <a:ext cx="2292480" cy="22320"/>
          </a:xfrm>
          <a:custGeom>
            <a:avLst/>
            <a:gdLst>
              <a:gd name="textAreaLeft" fmla="*/ 0 w 2292480"/>
              <a:gd name="textAreaRight" fmla="*/ 2292840 w 229248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15901" h="92">
                <a:moveTo>
                  <a:pt x="15901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Freeform 97"/>
          <p:cNvSpPr/>
          <p:nvPr/>
        </p:nvSpPr>
        <p:spPr>
          <a:xfrm>
            <a:off x="4065480" y="1871640"/>
            <a:ext cx="163800" cy="135000"/>
          </a:xfrm>
          <a:custGeom>
            <a:avLst/>
            <a:gdLst>
              <a:gd name="textAreaLeft" fmla="*/ 0 w 163800"/>
              <a:gd name="textAreaRight" fmla="*/ 164160 w 163800"/>
              <a:gd name="textAreaTop" fmla="*/ 0 h 135000"/>
              <a:gd name="textAreaBottom" fmla="*/ 135360 h 135000"/>
            </a:gdLst>
            <a:ahLst/>
            <a:rect l="textAreaLeft" t="textAreaTop" r="textAreaRight" b="textAreaBottom"/>
            <a:pathLst>
              <a:path w="1133" h="553">
                <a:moveTo>
                  <a:pt x="1133" y="553"/>
                </a:moveTo>
                <a:lnTo>
                  <a:pt x="0" y="553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Freeform 98"/>
          <p:cNvSpPr/>
          <p:nvPr/>
        </p:nvSpPr>
        <p:spPr>
          <a:xfrm>
            <a:off x="3895560" y="1214280"/>
            <a:ext cx="60480" cy="216000"/>
          </a:xfrm>
          <a:custGeom>
            <a:avLst/>
            <a:gdLst>
              <a:gd name="textAreaLeft" fmla="*/ 0 w 60480"/>
              <a:gd name="textAreaRight" fmla="*/ 60840 w 60480"/>
              <a:gd name="textAreaTop" fmla="*/ 0 h 216000"/>
              <a:gd name="textAreaBottom" fmla="*/ 216360 h 216000"/>
            </a:gdLst>
            <a:ahLst/>
            <a:rect l="textAreaLeft" t="textAreaTop" r="textAreaRight" b="textAreaBottom"/>
            <a:pathLst>
              <a:path w="425" h="883">
                <a:moveTo>
                  <a:pt x="425" y="0"/>
                </a:moveTo>
                <a:lnTo>
                  <a:pt x="0" y="0"/>
                </a:lnTo>
                <a:lnTo>
                  <a:pt x="0" y="883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Freeform 99"/>
          <p:cNvSpPr/>
          <p:nvPr/>
        </p:nvSpPr>
        <p:spPr>
          <a:xfrm>
            <a:off x="4054320" y="3705120"/>
            <a:ext cx="95400" cy="42840"/>
          </a:xfrm>
          <a:custGeom>
            <a:avLst/>
            <a:gdLst>
              <a:gd name="textAreaLeft" fmla="*/ 0 w 95400"/>
              <a:gd name="textAreaRight" fmla="*/ 95760 w 95400"/>
              <a:gd name="textAreaTop" fmla="*/ 0 h 42840"/>
              <a:gd name="textAreaBottom" fmla="*/ 43200 h 42840"/>
            </a:gdLst>
            <a:ahLst/>
            <a:rect l="textAreaLeft" t="textAreaTop" r="textAreaRight" b="textAreaBottom"/>
            <a:pathLst>
              <a:path w="655" h="178">
                <a:moveTo>
                  <a:pt x="655" y="178"/>
                </a:moveTo>
                <a:lnTo>
                  <a:pt x="0" y="178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Freeform 100"/>
          <p:cNvSpPr/>
          <p:nvPr/>
        </p:nvSpPr>
        <p:spPr>
          <a:xfrm>
            <a:off x="4016520" y="3297240"/>
            <a:ext cx="42840" cy="74520"/>
          </a:xfrm>
          <a:custGeom>
            <a:avLst/>
            <a:gdLst>
              <a:gd name="textAreaLeft" fmla="*/ 0 w 42840"/>
              <a:gd name="textAreaRight" fmla="*/ 43200 w 42840"/>
              <a:gd name="textAreaTop" fmla="*/ 0 h 74520"/>
              <a:gd name="textAreaBottom" fmla="*/ 74880 h 74520"/>
            </a:gdLst>
            <a:ahLst/>
            <a:rect l="textAreaLeft" t="textAreaTop" r="textAreaRight" b="textAreaBottom"/>
            <a:pathLst>
              <a:path w="299" h="298">
                <a:moveTo>
                  <a:pt x="299" y="298"/>
                </a:moveTo>
                <a:lnTo>
                  <a:pt x="0" y="298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Freeform 102"/>
          <p:cNvSpPr/>
          <p:nvPr/>
        </p:nvSpPr>
        <p:spPr>
          <a:xfrm>
            <a:off x="4344840" y="1874880"/>
            <a:ext cx="142920" cy="39600"/>
          </a:xfrm>
          <a:custGeom>
            <a:avLst/>
            <a:gdLst>
              <a:gd name="textAreaLeft" fmla="*/ 0 w 142920"/>
              <a:gd name="textAreaRight" fmla="*/ 143280 w 142920"/>
              <a:gd name="textAreaTop" fmla="*/ 0 h 39600"/>
              <a:gd name="textAreaBottom" fmla="*/ 39960 h 39600"/>
            </a:gdLst>
            <a:ahLst/>
            <a:rect l="textAreaLeft" t="textAreaTop" r="textAreaRight" b="textAreaBottom"/>
            <a:pathLst>
              <a:path w="989" h="160">
                <a:moveTo>
                  <a:pt x="989" y="160"/>
                </a:moveTo>
                <a:lnTo>
                  <a:pt x="0" y="160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Freeform 105"/>
          <p:cNvSpPr/>
          <p:nvPr/>
        </p:nvSpPr>
        <p:spPr>
          <a:xfrm>
            <a:off x="4156200" y="2720880"/>
            <a:ext cx="480960" cy="22320"/>
          </a:xfrm>
          <a:custGeom>
            <a:avLst/>
            <a:gdLst>
              <a:gd name="textAreaLeft" fmla="*/ 0 w 480960"/>
              <a:gd name="textAreaRight" fmla="*/ 481320 w 48096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3337" h="91">
                <a:moveTo>
                  <a:pt x="3337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Freeform 108"/>
          <p:cNvSpPr/>
          <p:nvPr/>
        </p:nvSpPr>
        <p:spPr>
          <a:xfrm>
            <a:off x="4390920" y="2049480"/>
            <a:ext cx="216000" cy="33480"/>
          </a:xfrm>
          <a:custGeom>
            <a:avLst/>
            <a:gdLst>
              <a:gd name="textAreaLeft" fmla="*/ 0 w 216000"/>
              <a:gd name="textAreaRight" fmla="*/ 216360 w 216000"/>
              <a:gd name="textAreaTop" fmla="*/ 0 h 33480"/>
              <a:gd name="textAreaBottom" fmla="*/ 33840 h 33480"/>
            </a:gdLst>
            <a:ahLst/>
            <a:rect l="textAreaLeft" t="textAreaTop" r="textAreaRight" b="textAreaBottom"/>
            <a:pathLst>
              <a:path w="1491" h="137">
                <a:moveTo>
                  <a:pt x="1491" y="0"/>
                </a:moveTo>
                <a:lnTo>
                  <a:pt x="0" y="0"/>
                </a:lnTo>
                <a:lnTo>
                  <a:pt x="0" y="137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Freeform 110"/>
          <p:cNvSpPr/>
          <p:nvPr/>
        </p:nvSpPr>
        <p:spPr>
          <a:xfrm>
            <a:off x="4097160" y="3325680"/>
            <a:ext cx="108000" cy="22320"/>
          </a:xfrm>
          <a:custGeom>
            <a:avLst/>
            <a:gdLst>
              <a:gd name="textAreaLeft" fmla="*/ 0 w 108000"/>
              <a:gd name="textAreaRight" fmla="*/ 108360 w 10800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744" h="91">
                <a:moveTo>
                  <a:pt x="744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Freeform 112"/>
          <p:cNvSpPr/>
          <p:nvPr/>
        </p:nvSpPr>
        <p:spPr>
          <a:xfrm>
            <a:off x="4059360" y="3325680"/>
            <a:ext cx="37800" cy="46080"/>
          </a:xfrm>
          <a:custGeom>
            <a:avLst/>
            <a:gdLst>
              <a:gd name="textAreaLeft" fmla="*/ 0 w 37800"/>
              <a:gd name="textAreaRight" fmla="*/ 38160 w 37800"/>
              <a:gd name="textAreaTop" fmla="*/ 0 h 46080"/>
              <a:gd name="textAreaBottom" fmla="*/ 46440 h 46080"/>
            </a:gdLst>
            <a:ahLst/>
            <a:rect l="textAreaLeft" t="textAreaTop" r="textAreaRight" b="textAreaBottom"/>
            <a:pathLst>
              <a:path w="262" h="183">
                <a:moveTo>
                  <a:pt x="262" y="0"/>
                </a:moveTo>
                <a:lnTo>
                  <a:pt x="0" y="0"/>
                </a:lnTo>
                <a:lnTo>
                  <a:pt x="0" y="183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Freeform 114"/>
          <p:cNvSpPr/>
          <p:nvPr/>
        </p:nvSpPr>
        <p:spPr>
          <a:xfrm>
            <a:off x="4189320" y="3751200"/>
            <a:ext cx="55800" cy="39600"/>
          </a:xfrm>
          <a:custGeom>
            <a:avLst/>
            <a:gdLst>
              <a:gd name="textAreaLeft" fmla="*/ 0 w 55800"/>
              <a:gd name="textAreaRight" fmla="*/ 56160 w 55800"/>
              <a:gd name="textAreaTop" fmla="*/ 0 h 39600"/>
              <a:gd name="textAreaBottom" fmla="*/ 39960 h 39600"/>
            </a:gdLst>
            <a:ahLst/>
            <a:rect l="textAreaLeft" t="textAreaTop" r="textAreaRight" b="textAreaBottom"/>
            <a:pathLst>
              <a:path w="378" h="160">
                <a:moveTo>
                  <a:pt x="378" y="0"/>
                </a:moveTo>
                <a:lnTo>
                  <a:pt x="0" y="0"/>
                </a:lnTo>
                <a:lnTo>
                  <a:pt x="0" y="16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Freeform 115"/>
          <p:cNvSpPr/>
          <p:nvPr/>
        </p:nvSpPr>
        <p:spPr>
          <a:xfrm>
            <a:off x="4390920" y="3830760"/>
            <a:ext cx="84240" cy="33120"/>
          </a:xfrm>
          <a:custGeom>
            <a:avLst/>
            <a:gdLst>
              <a:gd name="textAreaLeft" fmla="*/ 0 w 84240"/>
              <a:gd name="textAreaRight" fmla="*/ 84600 w 84240"/>
              <a:gd name="textAreaTop" fmla="*/ 0 h 33120"/>
              <a:gd name="textAreaBottom" fmla="*/ 33480 h 33120"/>
            </a:gdLst>
            <a:ahLst/>
            <a:rect l="textAreaLeft" t="textAreaTop" r="textAreaRight" b="textAreaBottom"/>
            <a:pathLst>
              <a:path w="590" h="137">
                <a:moveTo>
                  <a:pt x="590" y="137"/>
                </a:moveTo>
                <a:lnTo>
                  <a:pt x="0" y="137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Freeform 118"/>
          <p:cNvSpPr/>
          <p:nvPr/>
        </p:nvSpPr>
        <p:spPr>
          <a:xfrm>
            <a:off x="5029200" y="2295360"/>
            <a:ext cx="100080" cy="22320"/>
          </a:xfrm>
          <a:custGeom>
            <a:avLst/>
            <a:gdLst>
              <a:gd name="textAreaLeft" fmla="*/ 0 w 100080"/>
              <a:gd name="textAreaRight" fmla="*/ 100440 w 10008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696" h="91">
                <a:moveTo>
                  <a:pt x="696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Freeform 120"/>
          <p:cNvSpPr/>
          <p:nvPr/>
        </p:nvSpPr>
        <p:spPr>
          <a:xfrm>
            <a:off x="4070520" y="1511280"/>
            <a:ext cx="133200" cy="34920"/>
          </a:xfrm>
          <a:custGeom>
            <a:avLst/>
            <a:gdLst>
              <a:gd name="textAreaLeft" fmla="*/ 0 w 133200"/>
              <a:gd name="textAreaRight" fmla="*/ 133560 w 133200"/>
              <a:gd name="textAreaTop" fmla="*/ 0 h 34920"/>
              <a:gd name="textAreaBottom" fmla="*/ 35280 h 34920"/>
            </a:gdLst>
            <a:ahLst/>
            <a:rect l="textAreaLeft" t="textAreaTop" r="textAreaRight" b="textAreaBottom"/>
            <a:pathLst>
              <a:path w="926" h="137">
                <a:moveTo>
                  <a:pt x="926" y="0"/>
                </a:moveTo>
                <a:lnTo>
                  <a:pt x="0" y="0"/>
                </a:lnTo>
                <a:lnTo>
                  <a:pt x="0" y="137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1520" bIns="-115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Freeform 123"/>
          <p:cNvSpPr/>
          <p:nvPr/>
        </p:nvSpPr>
        <p:spPr>
          <a:xfrm>
            <a:off x="4632480" y="1779480"/>
            <a:ext cx="496800" cy="23760"/>
          </a:xfrm>
          <a:custGeom>
            <a:avLst/>
            <a:gdLst>
              <a:gd name="textAreaLeft" fmla="*/ 0 w 496800"/>
              <a:gd name="textAreaRight" fmla="*/ 497160 w 496800"/>
              <a:gd name="textAreaTop" fmla="*/ 0 h 23760"/>
              <a:gd name="textAreaBottom" fmla="*/ 24120 h 23760"/>
            </a:gdLst>
            <a:ahLst/>
            <a:rect l="textAreaLeft" t="textAreaTop" r="textAreaRight" b="textAreaBottom"/>
            <a:pathLst>
              <a:path w="3444" h="92">
                <a:moveTo>
                  <a:pt x="3444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Freeform 124"/>
          <p:cNvSpPr/>
          <p:nvPr/>
        </p:nvSpPr>
        <p:spPr>
          <a:xfrm>
            <a:off x="4132440" y="1214280"/>
            <a:ext cx="42840" cy="76320"/>
          </a:xfrm>
          <a:custGeom>
            <a:avLst/>
            <a:gdLst>
              <a:gd name="textAreaLeft" fmla="*/ 0 w 42840"/>
              <a:gd name="textAreaRight" fmla="*/ 43200 w 42840"/>
              <a:gd name="textAreaTop" fmla="*/ 0 h 76320"/>
              <a:gd name="textAreaBottom" fmla="*/ 76680 h 76320"/>
            </a:gdLst>
            <a:ahLst/>
            <a:rect l="textAreaLeft" t="textAreaTop" r="textAreaRight" b="textAreaBottom"/>
            <a:pathLst>
              <a:path w="310" h="309">
                <a:moveTo>
                  <a:pt x="310" y="0"/>
                </a:moveTo>
                <a:lnTo>
                  <a:pt x="0" y="0"/>
                </a:lnTo>
                <a:lnTo>
                  <a:pt x="0" y="309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880" bIns="298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Freeform 126"/>
          <p:cNvSpPr/>
          <p:nvPr/>
        </p:nvSpPr>
        <p:spPr>
          <a:xfrm>
            <a:off x="4549680" y="660240"/>
            <a:ext cx="128520" cy="22320"/>
          </a:xfrm>
          <a:custGeom>
            <a:avLst/>
            <a:gdLst>
              <a:gd name="textAreaLeft" fmla="*/ 0 w 128520"/>
              <a:gd name="textAreaRight" fmla="*/ 128880 w 12852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895" h="92">
                <a:moveTo>
                  <a:pt x="895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Freeform 127"/>
          <p:cNvSpPr/>
          <p:nvPr/>
        </p:nvSpPr>
        <p:spPr>
          <a:xfrm>
            <a:off x="4175280" y="1214280"/>
            <a:ext cx="99720" cy="51120"/>
          </a:xfrm>
          <a:custGeom>
            <a:avLst/>
            <a:gdLst>
              <a:gd name="textAreaLeft" fmla="*/ 0 w 99720"/>
              <a:gd name="textAreaRight" fmla="*/ 100080 w 99720"/>
              <a:gd name="textAreaTop" fmla="*/ 0 h 51120"/>
              <a:gd name="textAreaBottom" fmla="*/ 51480 h 51120"/>
            </a:gdLst>
            <a:ahLst/>
            <a:rect l="textAreaLeft" t="textAreaTop" r="textAreaRight" b="textAreaBottom"/>
            <a:pathLst>
              <a:path w="682" h="206">
                <a:moveTo>
                  <a:pt x="682" y="206"/>
                </a:moveTo>
                <a:lnTo>
                  <a:pt x="0" y="206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" bIns="46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Freeform 128"/>
          <p:cNvSpPr/>
          <p:nvPr/>
        </p:nvSpPr>
        <p:spPr>
          <a:xfrm>
            <a:off x="3851280" y="3009960"/>
            <a:ext cx="92160" cy="488880"/>
          </a:xfrm>
          <a:custGeom>
            <a:avLst/>
            <a:gdLst>
              <a:gd name="textAreaLeft" fmla="*/ 0 w 92160"/>
              <a:gd name="textAreaRight" fmla="*/ 92520 w 92160"/>
              <a:gd name="textAreaTop" fmla="*/ 0 h 488880"/>
              <a:gd name="textAreaBottom" fmla="*/ 489240 h 488880"/>
            </a:gdLst>
            <a:ahLst/>
            <a:rect l="textAreaLeft" t="textAreaTop" r="textAreaRight" b="textAreaBottom"/>
            <a:pathLst>
              <a:path w="634" h="1998">
                <a:moveTo>
                  <a:pt x="634" y="1998"/>
                </a:moveTo>
                <a:lnTo>
                  <a:pt x="0" y="1998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Freeform 129"/>
          <p:cNvSpPr/>
          <p:nvPr/>
        </p:nvSpPr>
        <p:spPr>
          <a:xfrm>
            <a:off x="4029120" y="1506600"/>
            <a:ext cx="41400" cy="39600"/>
          </a:xfrm>
          <a:custGeom>
            <a:avLst/>
            <a:gdLst>
              <a:gd name="textAreaLeft" fmla="*/ 0 w 41400"/>
              <a:gd name="textAreaRight" fmla="*/ 41760 w 41400"/>
              <a:gd name="textAreaTop" fmla="*/ 0 h 39600"/>
              <a:gd name="textAreaBottom" fmla="*/ 39960 h 39600"/>
            </a:gdLst>
            <a:ahLst/>
            <a:rect l="textAreaLeft" t="textAreaTop" r="textAreaRight" b="textAreaBottom"/>
            <a:pathLst>
              <a:path w="280" h="160">
                <a:moveTo>
                  <a:pt x="280" y="160"/>
                </a:moveTo>
                <a:lnTo>
                  <a:pt x="0" y="160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Freeform 130"/>
          <p:cNvSpPr/>
          <p:nvPr/>
        </p:nvSpPr>
        <p:spPr>
          <a:xfrm>
            <a:off x="4491000" y="863640"/>
            <a:ext cx="42840" cy="20520"/>
          </a:xfrm>
          <a:custGeom>
            <a:avLst/>
            <a:gdLst>
              <a:gd name="textAreaLeft" fmla="*/ 0 w 42840"/>
              <a:gd name="textAreaRight" fmla="*/ 43200 w 42840"/>
              <a:gd name="textAreaTop" fmla="*/ 0 h 20520"/>
              <a:gd name="textAreaBottom" fmla="*/ 20520 h 20520"/>
            </a:gdLst>
            <a:ahLst/>
            <a:rect l="textAreaLeft" t="textAreaTop" r="textAreaRight" b="textAreaBottom"/>
            <a:pathLst>
              <a:path w="300" h="91">
                <a:moveTo>
                  <a:pt x="300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Freeform 136"/>
          <p:cNvSpPr/>
          <p:nvPr/>
        </p:nvSpPr>
        <p:spPr>
          <a:xfrm>
            <a:off x="4883040" y="2206800"/>
            <a:ext cx="115920" cy="21960"/>
          </a:xfrm>
          <a:custGeom>
            <a:avLst/>
            <a:gdLst>
              <a:gd name="textAreaLeft" fmla="*/ 0 w 115920"/>
              <a:gd name="textAreaRight" fmla="*/ 116280 w 115920"/>
              <a:gd name="textAreaTop" fmla="*/ 0 h 21960"/>
              <a:gd name="textAreaBottom" fmla="*/ 22320 h 21960"/>
            </a:gdLst>
            <a:ahLst/>
            <a:rect l="textAreaLeft" t="textAreaTop" r="textAreaRight" b="textAreaBottom"/>
            <a:pathLst>
              <a:path w="803" h="92">
                <a:moveTo>
                  <a:pt x="803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Freeform 137"/>
          <p:cNvSpPr/>
          <p:nvPr/>
        </p:nvSpPr>
        <p:spPr>
          <a:xfrm>
            <a:off x="4002120" y="1398600"/>
            <a:ext cx="27000" cy="108000"/>
          </a:xfrm>
          <a:custGeom>
            <a:avLst/>
            <a:gdLst>
              <a:gd name="textAreaLeft" fmla="*/ 0 w 27000"/>
              <a:gd name="textAreaRight" fmla="*/ 27360 w 27000"/>
              <a:gd name="textAreaTop" fmla="*/ 0 h 108000"/>
              <a:gd name="textAreaBottom" fmla="*/ 108360 h 108000"/>
            </a:gdLst>
            <a:ahLst/>
            <a:rect l="textAreaLeft" t="textAreaTop" r="textAreaRight" b="textAreaBottom"/>
            <a:pathLst>
              <a:path w="188" h="441">
                <a:moveTo>
                  <a:pt x="188" y="441"/>
                </a:moveTo>
                <a:lnTo>
                  <a:pt x="0" y="44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Freeform 143"/>
          <p:cNvSpPr/>
          <p:nvPr/>
        </p:nvSpPr>
        <p:spPr>
          <a:xfrm>
            <a:off x="5029200" y="2273400"/>
            <a:ext cx="112680" cy="21960"/>
          </a:xfrm>
          <a:custGeom>
            <a:avLst/>
            <a:gdLst>
              <a:gd name="textAreaLeft" fmla="*/ 0 w 112680"/>
              <a:gd name="textAreaRight" fmla="*/ 113040 w 112680"/>
              <a:gd name="textAreaTop" fmla="*/ 0 h 21960"/>
              <a:gd name="textAreaBottom" fmla="*/ 22320 h 21960"/>
            </a:gdLst>
            <a:ahLst/>
            <a:rect l="textAreaLeft" t="textAreaTop" r="textAreaRight" b="textAreaBottom"/>
            <a:pathLst>
              <a:path w="782" h="92">
                <a:moveTo>
                  <a:pt x="782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Freeform 146"/>
          <p:cNvSpPr/>
          <p:nvPr/>
        </p:nvSpPr>
        <p:spPr>
          <a:xfrm>
            <a:off x="3747960" y="685800"/>
            <a:ext cx="236520" cy="438120"/>
          </a:xfrm>
          <a:custGeom>
            <a:avLst/>
            <a:gdLst>
              <a:gd name="textAreaLeft" fmla="*/ 0 w 236520"/>
              <a:gd name="textAreaRight" fmla="*/ 236880 w 236520"/>
              <a:gd name="textAreaTop" fmla="*/ 0 h 438120"/>
              <a:gd name="textAreaBottom" fmla="*/ 438480 h 438120"/>
            </a:gdLst>
            <a:ahLst/>
            <a:rect l="textAreaLeft" t="textAreaTop" r="textAreaRight" b="textAreaBottom"/>
            <a:pathLst>
              <a:path w="1637" h="1789">
                <a:moveTo>
                  <a:pt x="1637" y="0"/>
                </a:moveTo>
                <a:lnTo>
                  <a:pt x="0" y="0"/>
                </a:lnTo>
                <a:lnTo>
                  <a:pt x="0" y="1789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Freeform 149"/>
          <p:cNvSpPr/>
          <p:nvPr/>
        </p:nvSpPr>
        <p:spPr>
          <a:xfrm>
            <a:off x="4626000" y="996840"/>
            <a:ext cx="280800" cy="22320"/>
          </a:xfrm>
          <a:custGeom>
            <a:avLst/>
            <a:gdLst>
              <a:gd name="textAreaLeft" fmla="*/ 0 w 280800"/>
              <a:gd name="textAreaRight" fmla="*/ 281160 w 28080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1943" h="92">
                <a:moveTo>
                  <a:pt x="1943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Freeform 150"/>
          <p:cNvSpPr/>
          <p:nvPr/>
        </p:nvSpPr>
        <p:spPr>
          <a:xfrm>
            <a:off x="4149720" y="3747960"/>
            <a:ext cx="39600" cy="42840"/>
          </a:xfrm>
          <a:custGeom>
            <a:avLst/>
            <a:gdLst>
              <a:gd name="textAreaLeft" fmla="*/ 0 w 39600"/>
              <a:gd name="textAreaRight" fmla="*/ 39960 w 39600"/>
              <a:gd name="textAreaTop" fmla="*/ 0 h 42840"/>
              <a:gd name="textAreaBottom" fmla="*/ 43200 h 42840"/>
            </a:gdLst>
            <a:ahLst/>
            <a:rect l="textAreaLeft" t="textAreaTop" r="textAreaRight" b="textAreaBottom"/>
            <a:pathLst>
              <a:path w="284" h="171">
                <a:moveTo>
                  <a:pt x="284" y="171"/>
                </a:moveTo>
                <a:lnTo>
                  <a:pt x="0" y="17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Freeform 152"/>
          <p:cNvSpPr/>
          <p:nvPr/>
        </p:nvSpPr>
        <p:spPr>
          <a:xfrm>
            <a:off x="4149720" y="3706920"/>
            <a:ext cx="114480" cy="41040"/>
          </a:xfrm>
          <a:custGeom>
            <a:avLst/>
            <a:gdLst>
              <a:gd name="textAreaLeft" fmla="*/ 0 w 114480"/>
              <a:gd name="textAreaRight" fmla="*/ 114840 w 114480"/>
              <a:gd name="textAreaTop" fmla="*/ 0 h 41040"/>
              <a:gd name="textAreaBottom" fmla="*/ 41400 h 41040"/>
            </a:gdLst>
            <a:ahLst/>
            <a:rect l="textAreaLeft" t="textAreaTop" r="textAreaRight" b="textAreaBottom"/>
            <a:pathLst>
              <a:path w="800" h="172">
                <a:moveTo>
                  <a:pt x="800" y="0"/>
                </a:moveTo>
                <a:lnTo>
                  <a:pt x="0" y="0"/>
                </a:lnTo>
                <a:lnTo>
                  <a:pt x="0" y="17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Freeform 153"/>
          <p:cNvSpPr/>
          <p:nvPr/>
        </p:nvSpPr>
        <p:spPr>
          <a:xfrm>
            <a:off x="4049640" y="2743200"/>
            <a:ext cx="106560" cy="44280"/>
          </a:xfrm>
          <a:custGeom>
            <a:avLst/>
            <a:gdLst>
              <a:gd name="textAreaLeft" fmla="*/ 0 w 106560"/>
              <a:gd name="textAreaRight" fmla="*/ 106920 w 106560"/>
              <a:gd name="textAreaTop" fmla="*/ 0 h 44280"/>
              <a:gd name="textAreaBottom" fmla="*/ 44640 h 44280"/>
            </a:gdLst>
            <a:ahLst/>
            <a:rect l="textAreaLeft" t="textAreaTop" r="textAreaRight" b="textAreaBottom"/>
            <a:pathLst>
              <a:path w="727" h="184">
                <a:moveTo>
                  <a:pt x="727" y="0"/>
                </a:moveTo>
                <a:lnTo>
                  <a:pt x="0" y="0"/>
                </a:lnTo>
                <a:lnTo>
                  <a:pt x="0" y="184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Freeform 155"/>
          <p:cNvSpPr/>
          <p:nvPr/>
        </p:nvSpPr>
        <p:spPr>
          <a:xfrm>
            <a:off x="4564080" y="2117880"/>
            <a:ext cx="108000" cy="20520"/>
          </a:xfrm>
          <a:custGeom>
            <a:avLst/>
            <a:gdLst>
              <a:gd name="textAreaLeft" fmla="*/ 0 w 108000"/>
              <a:gd name="textAreaRight" fmla="*/ 108360 w 108000"/>
              <a:gd name="textAreaTop" fmla="*/ 0 h 20520"/>
              <a:gd name="textAreaBottom" fmla="*/ 20520 h 20520"/>
            </a:gdLst>
            <a:ahLst/>
            <a:rect l="textAreaLeft" t="textAreaTop" r="textAreaRight" b="textAreaBottom"/>
            <a:pathLst>
              <a:path w="751" h="91">
                <a:moveTo>
                  <a:pt x="751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Freeform 157"/>
          <p:cNvSpPr/>
          <p:nvPr/>
        </p:nvSpPr>
        <p:spPr>
          <a:xfrm>
            <a:off x="4421160" y="771480"/>
            <a:ext cx="58680" cy="57240"/>
          </a:xfrm>
          <a:custGeom>
            <a:avLst/>
            <a:gdLst>
              <a:gd name="textAreaLeft" fmla="*/ 0 w 58680"/>
              <a:gd name="textAreaRight" fmla="*/ 59040 w 58680"/>
              <a:gd name="textAreaTop" fmla="*/ 0 h 57240"/>
              <a:gd name="textAreaBottom" fmla="*/ 57600 h 57240"/>
            </a:gdLst>
            <a:ahLst/>
            <a:rect l="textAreaLeft" t="textAreaTop" r="textAreaRight" b="textAreaBottom"/>
            <a:pathLst>
              <a:path w="403" h="229">
                <a:moveTo>
                  <a:pt x="403" y="229"/>
                </a:moveTo>
                <a:lnTo>
                  <a:pt x="0" y="229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0800" bIns="10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Freeform 158"/>
          <p:cNvSpPr/>
          <p:nvPr/>
        </p:nvSpPr>
        <p:spPr>
          <a:xfrm>
            <a:off x="4121280" y="3017880"/>
            <a:ext cx="31680" cy="50760"/>
          </a:xfrm>
          <a:custGeom>
            <a:avLst/>
            <a:gdLst>
              <a:gd name="textAreaLeft" fmla="*/ 0 w 31680"/>
              <a:gd name="textAreaRight" fmla="*/ 32040 w 31680"/>
              <a:gd name="textAreaTop" fmla="*/ 0 h 50760"/>
              <a:gd name="textAreaBottom" fmla="*/ 51120 h 50760"/>
            </a:gdLst>
            <a:ahLst/>
            <a:rect l="textAreaLeft" t="textAreaTop" r="textAreaRight" b="textAreaBottom"/>
            <a:pathLst>
              <a:path w="211" h="207">
                <a:moveTo>
                  <a:pt x="211" y="207"/>
                </a:moveTo>
                <a:lnTo>
                  <a:pt x="0" y="207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20" bIns="43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Freeform 160"/>
          <p:cNvSpPr/>
          <p:nvPr/>
        </p:nvSpPr>
        <p:spPr>
          <a:xfrm>
            <a:off x="4097160" y="2811600"/>
            <a:ext cx="520920" cy="21960"/>
          </a:xfrm>
          <a:custGeom>
            <a:avLst/>
            <a:gdLst>
              <a:gd name="textAreaLeft" fmla="*/ 0 w 520920"/>
              <a:gd name="textAreaRight" fmla="*/ 521280 w 520920"/>
              <a:gd name="textAreaTop" fmla="*/ 0 h 21960"/>
              <a:gd name="textAreaBottom" fmla="*/ 22320 h 21960"/>
            </a:gdLst>
            <a:ahLst/>
            <a:rect l="textAreaLeft" t="textAreaTop" r="textAreaRight" b="textAreaBottom"/>
            <a:pathLst>
              <a:path w="3614" h="92">
                <a:moveTo>
                  <a:pt x="3614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Line 164"/>
          <p:cNvSpPr/>
          <p:nvPr/>
        </p:nvSpPr>
        <p:spPr>
          <a:xfrm>
            <a:off x="291960" y="6724800"/>
            <a:ext cx="57240" cy="1440"/>
          </a:xfrm>
          <a:prstGeom prst="line">
            <a:avLst/>
          </a:prstGeom>
          <a:ln cap="rnd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Freeform 166"/>
          <p:cNvSpPr/>
          <p:nvPr/>
        </p:nvSpPr>
        <p:spPr>
          <a:xfrm>
            <a:off x="4513320" y="716040"/>
            <a:ext cx="47520" cy="34920"/>
          </a:xfrm>
          <a:custGeom>
            <a:avLst/>
            <a:gdLst>
              <a:gd name="textAreaLeft" fmla="*/ 0 w 47520"/>
              <a:gd name="textAreaRight" fmla="*/ 47880 w 47520"/>
              <a:gd name="textAreaTop" fmla="*/ 0 h 34920"/>
              <a:gd name="textAreaBottom" fmla="*/ 35280 h 34920"/>
            </a:gdLst>
            <a:ahLst/>
            <a:rect l="textAreaLeft" t="textAreaTop" r="textAreaRight" b="textAreaBottom"/>
            <a:pathLst>
              <a:path w="330" h="138">
                <a:moveTo>
                  <a:pt x="330" y="138"/>
                </a:moveTo>
                <a:lnTo>
                  <a:pt x="0" y="138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1520" bIns="-115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Freeform 170"/>
          <p:cNvSpPr/>
          <p:nvPr/>
        </p:nvSpPr>
        <p:spPr>
          <a:xfrm>
            <a:off x="349200" y="4838760"/>
            <a:ext cx="2932200" cy="1886040"/>
          </a:xfrm>
          <a:custGeom>
            <a:avLst/>
            <a:gdLst>
              <a:gd name="textAreaLeft" fmla="*/ 0 w 2932200"/>
              <a:gd name="textAreaRight" fmla="*/ 2932560 w 2932200"/>
              <a:gd name="textAreaTop" fmla="*/ 0 h 1886040"/>
              <a:gd name="textAreaBottom" fmla="*/ 1886400 h 1886040"/>
            </a:gdLst>
            <a:ahLst/>
            <a:rect l="textAreaLeft" t="textAreaTop" r="textAreaRight" b="textAreaBottom"/>
            <a:pathLst>
              <a:path w="20340" h="7714">
                <a:moveTo>
                  <a:pt x="20340" y="0"/>
                </a:moveTo>
                <a:lnTo>
                  <a:pt x="0" y="0"/>
                </a:lnTo>
                <a:lnTo>
                  <a:pt x="0" y="7714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Freeform 177"/>
          <p:cNvSpPr/>
          <p:nvPr/>
        </p:nvSpPr>
        <p:spPr>
          <a:xfrm>
            <a:off x="4549680" y="682560"/>
            <a:ext cx="63720" cy="22320"/>
          </a:xfrm>
          <a:custGeom>
            <a:avLst/>
            <a:gdLst>
              <a:gd name="textAreaLeft" fmla="*/ 0 w 63720"/>
              <a:gd name="textAreaRight" fmla="*/ 64080 w 6372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438" h="91">
                <a:moveTo>
                  <a:pt x="438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Freeform 180"/>
          <p:cNvSpPr/>
          <p:nvPr/>
        </p:nvSpPr>
        <p:spPr>
          <a:xfrm>
            <a:off x="4237200" y="2654280"/>
            <a:ext cx="114120" cy="22320"/>
          </a:xfrm>
          <a:custGeom>
            <a:avLst/>
            <a:gdLst>
              <a:gd name="textAreaLeft" fmla="*/ 0 w 114120"/>
              <a:gd name="textAreaRight" fmla="*/ 114480 w 11412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793" h="92">
                <a:moveTo>
                  <a:pt x="793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Freeform 181"/>
          <p:cNvSpPr/>
          <p:nvPr/>
        </p:nvSpPr>
        <p:spPr>
          <a:xfrm>
            <a:off x="4016520" y="3224160"/>
            <a:ext cx="54000" cy="73080"/>
          </a:xfrm>
          <a:custGeom>
            <a:avLst/>
            <a:gdLst>
              <a:gd name="textAreaLeft" fmla="*/ 0 w 54000"/>
              <a:gd name="textAreaRight" fmla="*/ 54360 w 54000"/>
              <a:gd name="textAreaTop" fmla="*/ 0 h 73080"/>
              <a:gd name="textAreaBottom" fmla="*/ 73440 h 73080"/>
            </a:gdLst>
            <a:ahLst/>
            <a:rect l="textAreaLeft" t="textAreaTop" r="textAreaRight" b="textAreaBottom"/>
            <a:pathLst>
              <a:path w="381" h="297">
                <a:moveTo>
                  <a:pt x="381" y="0"/>
                </a:moveTo>
                <a:lnTo>
                  <a:pt x="0" y="0"/>
                </a:lnTo>
                <a:lnTo>
                  <a:pt x="0" y="297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6640" bIns="2664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Freeform 183"/>
          <p:cNvSpPr/>
          <p:nvPr/>
        </p:nvSpPr>
        <p:spPr>
          <a:xfrm>
            <a:off x="4478400" y="560520"/>
            <a:ext cx="222120" cy="33120"/>
          </a:xfrm>
          <a:custGeom>
            <a:avLst/>
            <a:gdLst>
              <a:gd name="textAreaLeft" fmla="*/ 0 w 222120"/>
              <a:gd name="textAreaRight" fmla="*/ 222480 w 222120"/>
              <a:gd name="textAreaTop" fmla="*/ 0 h 33120"/>
              <a:gd name="textAreaBottom" fmla="*/ 33480 h 33120"/>
            </a:gdLst>
            <a:ahLst/>
            <a:rect l="textAreaLeft" t="textAreaTop" r="textAreaRight" b="textAreaBottom"/>
            <a:pathLst>
              <a:path w="1540" h="137">
                <a:moveTo>
                  <a:pt x="1540" y="137"/>
                </a:moveTo>
                <a:lnTo>
                  <a:pt x="0" y="137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Freeform 184"/>
          <p:cNvSpPr/>
          <p:nvPr/>
        </p:nvSpPr>
        <p:spPr>
          <a:xfrm>
            <a:off x="4192560" y="2620800"/>
            <a:ext cx="44640" cy="33480"/>
          </a:xfrm>
          <a:custGeom>
            <a:avLst/>
            <a:gdLst>
              <a:gd name="textAreaLeft" fmla="*/ 0 w 44640"/>
              <a:gd name="textAreaRight" fmla="*/ 44640 w 44640"/>
              <a:gd name="textAreaTop" fmla="*/ 0 h 33480"/>
              <a:gd name="textAreaBottom" fmla="*/ 33840 h 33480"/>
            </a:gdLst>
            <a:ahLst/>
            <a:rect l="textAreaLeft" t="textAreaTop" r="textAreaRight" b="textAreaBottom"/>
            <a:pathLst>
              <a:path w="310" h="137">
                <a:moveTo>
                  <a:pt x="310" y="137"/>
                </a:moveTo>
                <a:lnTo>
                  <a:pt x="0" y="137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Freeform 185"/>
          <p:cNvSpPr/>
          <p:nvPr/>
        </p:nvSpPr>
        <p:spPr>
          <a:xfrm>
            <a:off x="4121280" y="2967120"/>
            <a:ext cx="52200" cy="50760"/>
          </a:xfrm>
          <a:custGeom>
            <a:avLst/>
            <a:gdLst>
              <a:gd name="textAreaLeft" fmla="*/ 0 w 52200"/>
              <a:gd name="textAreaRight" fmla="*/ 52560 w 52200"/>
              <a:gd name="textAreaTop" fmla="*/ 0 h 50760"/>
              <a:gd name="textAreaBottom" fmla="*/ 51120 h 50760"/>
            </a:gdLst>
            <a:ahLst/>
            <a:rect l="textAreaLeft" t="textAreaTop" r="textAreaRight" b="textAreaBottom"/>
            <a:pathLst>
              <a:path w="342" h="206">
                <a:moveTo>
                  <a:pt x="342" y="0"/>
                </a:moveTo>
                <a:lnTo>
                  <a:pt x="0" y="0"/>
                </a:lnTo>
                <a:lnTo>
                  <a:pt x="0" y="206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20" bIns="43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Freeform 186"/>
          <p:cNvSpPr/>
          <p:nvPr/>
        </p:nvSpPr>
        <p:spPr>
          <a:xfrm>
            <a:off x="3281400" y="2268360"/>
            <a:ext cx="360360" cy="2570400"/>
          </a:xfrm>
          <a:custGeom>
            <a:avLst/>
            <a:gdLst>
              <a:gd name="textAreaLeft" fmla="*/ 0 w 360360"/>
              <a:gd name="textAreaRight" fmla="*/ 360720 w 360360"/>
              <a:gd name="textAreaTop" fmla="*/ 0 h 2570400"/>
              <a:gd name="textAreaBottom" fmla="*/ 2570760 h 2570400"/>
            </a:gdLst>
            <a:ahLst/>
            <a:rect l="textAreaLeft" t="textAreaTop" r="textAreaRight" b="textAreaBottom"/>
            <a:pathLst>
              <a:path w="2497" h="10511">
                <a:moveTo>
                  <a:pt x="2497" y="0"/>
                </a:moveTo>
                <a:lnTo>
                  <a:pt x="0" y="0"/>
                </a:lnTo>
                <a:lnTo>
                  <a:pt x="0" y="1051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Freeform 191"/>
          <p:cNvSpPr/>
          <p:nvPr/>
        </p:nvSpPr>
        <p:spPr>
          <a:xfrm>
            <a:off x="3851280" y="2521080"/>
            <a:ext cx="92160" cy="488880"/>
          </a:xfrm>
          <a:custGeom>
            <a:avLst/>
            <a:gdLst>
              <a:gd name="textAreaLeft" fmla="*/ 0 w 92160"/>
              <a:gd name="textAreaRight" fmla="*/ 92520 w 92160"/>
              <a:gd name="textAreaTop" fmla="*/ 0 h 488880"/>
              <a:gd name="textAreaBottom" fmla="*/ 489240 h 488880"/>
            </a:gdLst>
            <a:ahLst/>
            <a:rect l="textAreaLeft" t="textAreaTop" r="textAreaRight" b="textAreaBottom"/>
            <a:pathLst>
              <a:path w="631" h="1997">
                <a:moveTo>
                  <a:pt x="631" y="0"/>
                </a:moveTo>
                <a:lnTo>
                  <a:pt x="0" y="0"/>
                </a:lnTo>
                <a:lnTo>
                  <a:pt x="0" y="1997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Freeform 193"/>
          <p:cNvSpPr/>
          <p:nvPr/>
        </p:nvSpPr>
        <p:spPr>
          <a:xfrm>
            <a:off x="4275000" y="1265400"/>
            <a:ext cx="36720" cy="21960"/>
          </a:xfrm>
          <a:custGeom>
            <a:avLst/>
            <a:gdLst>
              <a:gd name="textAreaLeft" fmla="*/ 0 w 36720"/>
              <a:gd name="textAreaRight" fmla="*/ 37080 w 36720"/>
              <a:gd name="textAreaTop" fmla="*/ 0 h 21960"/>
              <a:gd name="textAreaBottom" fmla="*/ 22320 h 21960"/>
            </a:gdLst>
            <a:ahLst/>
            <a:rect l="textAreaLeft" t="textAreaTop" r="textAreaRight" b="textAreaBottom"/>
            <a:pathLst>
              <a:path w="259" h="92">
                <a:moveTo>
                  <a:pt x="259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Freeform 198"/>
          <p:cNvSpPr/>
          <p:nvPr/>
        </p:nvSpPr>
        <p:spPr>
          <a:xfrm>
            <a:off x="4156200" y="2743200"/>
            <a:ext cx="295200" cy="22320"/>
          </a:xfrm>
          <a:custGeom>
            <a:avLst/>
            <a:gdLst>
              <a:gd name="textAreaLeft" fmla="*/ 0 w 295200"/>
              <a:gd name="textAreaRight" fmla="*/ 295560 w 29520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2052" h="92">
                <a:moveTo>
                  <a:pt x="2052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Freeform 201"/>
          <p:cNvSpPr/>
          <p:nvPr/>
        </p:nvSpPr>
        <p:spPr>
          <a:xfrm>
            <a:off x="4098960" y="1557360"/>
            <a:ext cx="109440" cy="22320"/>
          </a:xfrm>
          <a:custGeom>
            <a:avLst/>
            <a:gdLst>
              <a:gd name="textAreaLeft" fmla="*/ 0 w 109440"/>
              <a:gd name="textAreaRight" fmla="*/ 109800 w 10944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760" h="92">
                <a:moveTo>
                  <a:pt x="760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Freeform 202"/>
          <p:cNvSpPr/>
          <p:nvPr/>
        </p:nvSpPr>
        <p:spPr>
          <a:xfrm>
            <a:off x="4049640" y="2787480"/>
            <a:ext cx="47520" cy="46080"/>
          </a:xfrm>
          <a:custGeom>
            <a:avLst/>
            <a:gdLst>
              <a:gd name="textAreaLeft" fmla="*/ 0 w 47520"/>
              <a:gd name="textAreaRight" fmla="*/ 47880 w 47520"/>
              <a:gd name="textAreaTop" fmla="*/ 0 h 46080"/>
              <a:gd name="textAreaBottom" fmla="*/ 46440 h 46080"/>
            </a:gdLst>
            <a:ahLst/>
            <a:rect l="textAreaLeft" t="textAreaTop" r="textAreaRight" b="textAreaBottom"/>
            <a:pathLst>
              <a:path w="325" h="183">
                <a:moveTo>
                  <a:pt x="325" y="183"/>
                </a:moveTo>
                <a:lnTo>
                  <a:pt x="0" y="183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Rectangle 410"/>
          <p:cNvSpPr/>
          <p:nvPr/>
        </p:nvSpPr>
        <p:spPr>
          <a:xfrm>
            <a:off x="4235760" y="3098880"/>
            <a:ext cx="142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NtrbohD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Rectangle 411"/>
          <p:cNvSpPr/>
          <p:nvPr/>
        </p:nvSpPr>
        <p:spPr>
          <a:xfrm>
            <a:off x="6138720" y="8609040"/>
            <a:ext cx="264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Cre03.g18830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Rectangle 412"/>
          <p:cNvSpPr/>
          <p:nvPr/>
        </p:nvSpPr>
        <p:spPr>
          <a:xfrm>
            <a:off x="4368600" y="1665360"/>
            <a:ext cx="2354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Mgu024518m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Rectangle 413"/>
          <p:cNvSpPr/>
          <p:nvPr/>
        </p:nvSpPr>
        <p:spPr>
          <a:xfrm>
            <a:off x="4203360" y="2919240"/>
            <a:ext cx="156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StRbohC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Rectangle 417"/>
          <p:cNvSpPr/>
          <p:nvPr/>
        </p:nvSpPr>
        <p:spPr>
          <a:xfrm>
            <a:off x="4581000" y="457200"/>
            <a:ext cx="1864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OsRBOHH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Rectangle 418"/>
          <p:cNvSpPr/>
          <p:nvPr/>
        </p:nvSpPr>
        <p:spPr>
          <a:xfrm>
            <a:off x="4505040" y="2874960"/>
            <a:ext cx="156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StRbohD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Rectangle 419"/>
          <p:cNvSpPr/>
          <p:nvPr/>
        </p:nvSpPr>
        <p:spPr>
          <a:xfrm>
            <a:off x="4238280" y="3054240"/>
            <a:ext cx="151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NbrbohB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Rectangle 423"/>
          <p:cNvSpPr/>
          <p:nvPr/>
        </p:nvSpPr>
        <p:spPr>
          <a:xfrm>
            <a:off x="4113360" y="3906720"/>
            <a:ext cx="1699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OsRBOHI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Rectangle 426"/>
          <p:cNvSpPr/>
          <p:nvPr/>
        </p:nvSpPr>
        <p:spPr>
          <a:xfrm>
            <a:off x="4651560" y="3817800"/>
            <a:ext cx="3985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ZmaGRMZM2G065144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Rectangle 428"/>
          <p:cNvSpPr/>
          <p:nvPr/>
        </p:nvSpPr>
        <p:spPr>
          <a:xfrm>
            <a:off x="4754520" y="2338560"/>
            <a:ext cx="156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AtRbohC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Rectangle 436"/>
          <p:cNvSpPr/>
          <p:nvPr/>
        </p:nvSpPr>
        <p:spPr>
          <a:xfrm>
            <a:off x="4952880" y="2158920"/>
            <a:ext cx="1548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AtRbohA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Rectangle 438"/>
          <p:cNvSpPr/>
          <p:nvPr/>
        </p:nvSpPr>
        <p:spPr>
          <a:xfrm>
            <a:off x="4253400" y="3546360"/>
            <a:ext cx="1864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CcoRbohA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Rectangle 443"/>
          <p:cNvSpPr/>
          <p:nvPr/>
        </p:nvSpPr>
        <p:spPr>
          <a:xfrm>
            <a:off x="4217400" y="3413160"/>
            <a:ext cx="2613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Ptr0003s158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Rectangle 450"/>
          <p:cNvSpPr/>
          <p:nvPr/>
        </p:nvSpPr>
        <p:spPr>
          <a:xfrm>
            <a:off x="4342680" y="1308240"/>
            <a:ext cx="1638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ff0000"/>
                </a:solidFill>
                <a:latin typeface="Arial"/>
              </a:rPr>
              <a:t>MtRbohG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Rectangle 451"/>
          <p:cNvSpPr/>
          <p:nvPr/>
        </p:nvSpPr>
        <p:spPr>
          <a:xfrm>
            <a:off x="4219920" y="1576440"/>
            <a:ext cx="1807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Mes22139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Rectangle 452"/>
          <p:cNvSpPr/>
          <p:nvPr/>
        </p:nvSpPr>
        <p:spPr>
          <a:xfrm>
            <a:off x="4328280" y="1442880"/>
            <a:ext cx="2491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Cucsa.18196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Rectangle 454"/>
          <p:cNvSpPr/>
          <p:nvPr/>
        </p:nvSpPr>
        <p:spPr>
          <a:xfrm>
            <a:off x="4458960" y="3144960"/>
            <a:ext cx="156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AtRbohD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Rectangle 455"/>
          <p:cNvSpPr/>
          <p:nvPr/>
        </p:nvSpPr>
        <p:spPr>
          <a:xfrm>
            <a:off x="4530240" y="905040"/>
            <a:ext cx="1850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OsRBOHB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Rectangle 456"/>
          <p:cNvSpPr/>
          <p:nvPr/>
        </p:nvSpPr>
        <p:spPr>
          <a:xfrm>
            <a:off x="4303080" y="1217520"/>
            <a:ext cx="2826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Glyma10g2928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Rectangle 458"/>
          <p:cNvSpPr/>
          <p:nvPr/>
        </p:nvSpPr>
        <p:spPr>
          <a:xfrm>
            <a:off x="4424040" y="3189240"/>
            <a:ext cx="1836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Aly917612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Rectangle 459"/>
          <p:cNvSpPr/>
          <p:nvPr/>
        </p:nvSpPr>
        <p:spPr>
          <a:xfrm>
            <a:off x="4543560" y="770040"/>
            <a:ext cx="3985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ZmaGRMZM2G022547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Rectangle 460"/>
          <p:cNvSpPr/>
          <p:nvPr/>
        </p:nvSpPr>
        <p:spPr>
          <a:xfrm>
            <a:off x="4226760" y="3637080"/>
            <a:ext cx="2401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Bradi4g1702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Rectangle 461"/>
          <p:cNvSpPr/>
          <p:nvPr/>
        </p:nvSpPr>
        <p:spPr>
          <a:xfrm>
            <a:off x="4259160" y="3457440"/>
            <a:ext cx="430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VviGSVIVT0000623300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Rectangle 464"/>
          <p:cNvSpPr/>
          <p:nvPr/>
        </p:nvSpPr>
        <p:spPr>
          <a:xfrm>
            <a:off x="5803560" y="8564400"/>
            <a:ext cx="264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Cre03.g18840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Rectangle 467"/>
          <p:cNvSpPr/>
          <p:nvPr/>
        </p:nvSpPr>
        <p:spPr>
          <a:xfrm>
            <a:off x="4303080" y="1397160"/>
            <a:ext cx="2826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Glyma03g396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Rectangle 471"/>
          <p:cNvSpPr/>
          <p:nvPr/>
        </p:nvSpPr>
        <p:spPr>
          <a:xfrm>
            <a:off x="4499280" y="1890720"/>
            <a:ext cx="1486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LjRbohA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Rectangle 473"/>
          <p:cNvSpPr/>
          <p:nvPr/>
        </p:nvSpPr>
        <p:spPr>
          <a:xfrm>
            <a:off x="4647960" y="2697120"/>
            <a:ext cx="2354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Mgu016531m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Rectangle 476"/>
          <p:cNvSpPr/>
          <p:nvPr/>
        </p:nvSpPr>
        <p:spPr>
          <a:xfrm>
            <a:off x="4619520" y="2023920"/>
            <a:ext cx="1609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ff0000"/>
                </a:solidFill>
                <a:latin typeface="Arial"/>
              </a:rPr>
              <a:t>MtRbohE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Rectangle 478"/>
          <p:cNvSpPr/>
          <p:nvPr/>
        </p:nvSpPr>
        <p:spPr>
          <a:xfrm>
            <a:off x="4381920" y="2606760"/>
            <a:ext cx="1807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Mes37279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Rectangle 479"/>
          <p:cNvSpPr/>
          <p:nvPr/>
        </p:nvSpPr>
        <p:spPr>
          <a:xfrm>
            <a:off x="4296960" y="2562120"/>
            <a:ext cx="3466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Rco30147.m014377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Rectangle 480"/>
          <p:cNvSpPr/>
          <p:nvPr/>
        </p:nvSpPr>
        <p:spPr>
          <a:xfrm>
            <a:off x="4305960" y="1352520"/>
            <a:ext cx="2826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Glyma19g4222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Rectangle 481"/>
          <p:cNvSpPr/>
          <p:nvPr/>
        </p:nvSpPr>
        <p:spPr>
          <a:xfrm>
            <a:off x="4241880" y="2830680"/>
            <a:ext cx="2354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Mgu001431m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Rectangle 482"/>
          <p:cNvSpPr/>
          <p:nvPr/>
        </p:nvSpPr>
        <p:spPr>
          <a:xfrm>
            <a:off x="4215600" y="3324240"/>
            <a:ext cx="1591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Mes7337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Rectangle 483"/>
          <p:cNvSpPr/>
          <p:nvPr/>
        </p:nvSpPr>
        <p:spPr>
          <a:xfrm>
            <a:off x="4257720" y="3728880"/>
            <a:ext cx="3985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ZmaGRMZM2G316585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Rectangle 485"/>
          <p:cNvSpPr/>
          <p:nvPr/>
        </p:nvSpPr>
        <p:spPr>
          <a:xfrm>
            <a:off x="4518720" y="1979640"/>
            <a:ext cx="2826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Glyma04g3804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Rectangle 486"/>
          <p:cNvSpPr/>
          <p:nvPr/>
        </p:nvSpPr>
        <p:spPr>
          <a:xfrm>
            <a:off x="5140080" y="2292480"/>
            <a:ext cx="1836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Aly492327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Rectangle 488"/>
          <p:cNvSpPr/>
          <p:nvPr/>
        </p:nvSpPr>
        <p:spPr>
          <a:xfrm>
            <a:off x="4212720" y="1486080"/>
            <a:ext cx="2613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Ptr0005s0263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Rectangle 490"/>
          <p:cNvSpPr/>
          <p:nvPr/>
        </p:nvSpPr>
        <p:spPr>
          <a:xfrm>
            <a:off x="5141880" y="1755720"/>
            <a:ext cx="1623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ff0000"/>
                </a:solidFill>
                <a:latin typeface="Arial"/>
              </a:rPr>
              <a:t>MtRbohD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Rectangle 492"/>
          <p:cNvSpPr/>
          <p:nvPr/>
        </p:nvSpPr>
        <p:spPr>
          <a:xfrm>
            <a:off x="4690080" y="636480"/>
            <a:ext cx="1864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HvRbohB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Rectangle 493"/>
          <p:cNvSpPr/>
          <p:nvPr/>
        </p:nvSpPr>
        <p:spPr>
          <a:xfrm>
            <a:off x="4856760" y="546120"/>
            <a:ext cx="2401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Sb08g01724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Rectangle 494"/>
          <p:cNvSpPr/>
          <p:nvPr/>
        </p:nvSpPr>
        <p:spPr>
          <a:xfrm>
            <a:off x="4573800" y="858960"/>
            <a:ext cx="3985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ZmaGRMZM2G034896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Rectangle 495"/>
          <p:cNvSpPr/>
          <p:nvPr/>
        </p:nvSpPr>
        <p:spPr>
          <a:xfrm>
            <a:off x="4287240" y="2517840"/>
            <a:ext cx="2613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Ptr0012s1134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Rectangle 497"/>
          <p:cNvSpPr/>
          <p:nvPr/>
        </p:nvSpPr>
        <p:spPr>
          <a:xfrm>
            <a:off x="4599720" y="2070000"/>
            <a:ext cx="2826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Glyma08g0088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Rectangle 502"/>
          <p:cNvSpPr/>
          <p:nvPr/>
        </p:nvSpPr>
        <p:spPr>
          <a:xfrm>
            <a:off x="5007960" y="2203560"/>
            <a:ext cx="1836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Aly325354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Rectangle 505"/>
          <p:cNvSpPr/>
          <p:nvPr/>
        </p:nvSpPr>
        <p:spPr>
          <a:xfrm>
            <a:off x="4250880" y="3278160"/>
            <a:ext cx="3466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Rco30128.m00859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Rectangle 508"/>
          <p:cNvSpPr/>
          <p:nvPr/>
        </p:nvSpPr>
        <p:spPr>
          <a:xfrm>
            <a:off x="4782240" y="501480"/>
            <a:ext cx="2401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Bradi4g0554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Rectangle 509"/>
          <p:cNvSpPr/>
          <p:nvPr/>
        </p:nvSpPr>
        <p:spPr>
          <a:xfrm>
            <a:off x="4128840" y="1620720"/>
            <a:ext cx="430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VviGSVIVT0002272800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Rectangle 510"/>
          <p:cNvSpPr/>
          <p:nvPr/>
        </p:nvSpPr>
        <p:spPr>
          <a:xfrm>
            <a:off x="5155200" y="2247840"/>
            <a:ext cx="1576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AtRbohG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Rectangle 511"/>
          <p:cNvSpPr/>
          <p:nvPr/>
        </p:nvSpPr>
        <p:spPr>
          <a:xfrm>
            <a:off x="4258440" y="3233880"/>
            <a:ext cx="1666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Cpa38.53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Rectangle 515"/>
          <p:cNvSpPr/>
          <p:nvPr/>
        </p:nvSpPr>
        <p:spPr>
          <a:xfrm>
            <a:off x="4917600" y="993600"/>
            <a:ext cx="1836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Aly47099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Rectangle 516"/>
          <p:cNvSpPr/>
          <p:nvPr/>
        </p:nvSpPr>
        <p:spPr>
          <a:xfrm>
            <a:off x="4757760" y="1711440"/>
            <a:ext cx="430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VviGSVIVT0002766500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Rectangle 517"/>
          <p:cNvSpPr/>
          <p:nvPr/>
        </p:nvSpPr>
        <p:spPr>
          <a:xfrm>
            <a:off x="4189680" y="3009960"/>
            <a:ext cx="2444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NaABW8787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Rectangle 518"/>
          <p:cNvSpPr/>
          <p:nvPr/>
        </p:nvSpPr>
        <p:spPr>
          <a:xfrm>
            <a:off x="4274280" y="3681360"/>
            <a:ext cx="2401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Sb05g02038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Rectangle 519"/>
          <p:cNvSpPr/>
          <p:nvPr/>
        </p:nvSpPr>
        <p:spPr>
          <a:xfrm>
            <a:off x="4682520" y="2112840"/>
            <a:ext cx="2826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Glyma05g3328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Rectangle 521"/>
          <p:cNvSpPr/>
          <p:nvPr/>
        </p:nvSpPr>
        <p:spPr>
          <a:xfrm>
            <a:off x="4518720" y="1935000"/>
            <a:ext cx="2826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Glyma06g1703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0" name="Rectangle 526"/>
          <p:cNvSpPr/>
          <p:nvPr/>
        </p:nvSpPr>
        <p:spPr>
          <a:xfrm>
            <a:off x="4630680" y="2786040"/>
            <a:ext cx="2354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Mgu008490m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1" name="Rectangle 527"/>
          <p:cNvSpPr/>
          <p:nvPr/>
        </p:nvSpPr>
        <p:spPr>
          <a:xfrm>
            <a:off x="4560840" y="1844640"/>
            <a:ext cx="1609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ff0000"/>
                </a:solidFill>
                <a:latin typeface="Arial"/>
              </a:rPr>
              <a:t>MtRbohB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Rectangle 528"/>
          <p:cNvSpPr/>
          <p:nvPr/>
        </p:nvSpPr>
        <p:spPr>
          <a:xfrm>
            <a:off x="4738680" y="3860640"/>
            <a:ext cx="3985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ZmaGRMZM2G358619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Rectangle 533"/>
          <p:cNvSpPr/>
          <p:nvPr/>
        </p:nvSpPr>
        <p:spPr>
          <a:xfrm>
            <a:off x="4571280" y="725400"/>
            <a:ext cx="2401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Bradi2g1279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Rectangle 535"/>
          <p:cNvSpPr/>
          <p:nvPr/>
        </p:nvSpPr>
        <p:spPr>
          <a:xfrm>
            <a:off x="4362480" y="3502080"/>
            <a:ext cx="430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VviGSVIVT0000623500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Rectangle 537"/>
          <p:cNvSpPr/>
          <p:nvPr/>
        </p:nvSpPr>
        <p:spPr>
          <a:xfrm>
            <a:off x="4822920" y="3772080"/>
            <a:ext cx="3985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ZmaGRMZM2G037993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Rectangle 538"/>
          <p:cNvSpPr/>
          <p:nvPr/>
        </p:nvSpPr>
        <p:spPr>
          <a:xfrm>
            <a:off x="4202280" y="2965320"/>
            <a:ext cx="2170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SlAAF73104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Rectangle 542"/>
          <p:cNvSpPr/>
          <p:nvPr/>
        </p:nvSpPr>
        <p:spPr>
          <a:xfrm>
            <a:off x="4381200" y="1173240"/>
            <a:ext cx="1609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ff0000"/>
                </a:solidFill>
                <a:latin typeface="Arial"/>
              </a:rPr>
              <a:t>MtRbohA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Rectangle 546"/>
          <p:cNvSpPr/>
          <p:nvPr/>
        </p:nvSpPr>
        <p:spPr>
          <a:xfrm>
            <a:off x="4807080" y="590400"/>
            <a:ext cx="3985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ZmaGRMZM2G300965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9" name="Rectangle 547"/>
          <p:cNvSpPr/>
          <p:nvPr/>
        </p:nvSpPr>
        <p:spPr>
          <a:xfrm>
            <a:off x="4623480" y="681120"/>
            <a:ext cx="1864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HvRbohB2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Rectangle 549"/>
          <p:cNvSpPr/>
          <p:nvPr/>
        </p:nvSpPr>
        <p:spPr>
          <a:xfrm>
            <a:off x="4229280" y="2427120"/>
            <a:ext cx="1882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Cpa13.202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Rectangle 551"/>
          <p:cNvSpPr/>
          <p:nvPr/>
        </p:nvSpPr>
        <p:spPr>
          <a:xfrm>
            <a:off x="4247640" y="3592440"/>
            <a:ext cx="2491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Cucsa.34076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2" name="Rectangle 552"/>
          <p:cNvSpPr/>
          <p:nvPr/>
        </p:nvSpPr>
        <p:spPr>
          <a:xfrm>
            <a:off x="4362840" y="2651040"/>
            <a:ext cx="1807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Mes17858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Rectangle 554"/>
          <p:cNvSpPr/>
          <p:nvPr/>
        </p:nvSpPr>
        <p:spPr>
          <a:xfrm>
            <a:off x="4085640" y="320040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Rectangle 557"/>
          <p:cNvSpPr/>
          <p:nvPr/>
        </p:nvSpPr>
        <p:spPr>
          <a:xfrm>
            <a:off x="4714200" y="56844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5" name="Rectangle 559"/>
          <p:cNvSpPr/>
          <p:nvPr/>
        </p:nvSpPr>
        <p:spPr>
          <a:xfrm>
            <a:off x="4233240" y="249408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Rectangle 561"/>
          <p:cNvSpPr/>
          <p:nvPr/>
        </p:nvSpPr>
        <p:spPr>
          <a:xfrm>
            <a:off x="4250880" y="262908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Rectangle 563"/>
          <p:cNvSpPr/>
          <p:nvPr/>
        </p:nvSpPr>
        <p:spPr>
          <a:xfrm>
            <a:off x="4185720" y="294336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Rectangle 564"/>
          <p:cNvSpPr/>
          <p:nvPr/>
        </p:nvSpPr>
        <p:spPr>
          <a:xfrm>
            <a:off x="3655080" y="224460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59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Rectangle 569"/>
          <p:cNvSpPr/>
          <p:nvPr/>
        </p:nvSpPr>
        <p:spPr>
          <a:xfrm>
            <a:off x="3955320" y="249876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Rectangle 577"/>
          <p:cNvSpPr/>
          <p:nvPr/>
        </p:nvSpPr>
        <p:spPr>
          <a:xfrm>
            <a:off x="3744000" y="338940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98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Rectangle 579"/>
          <p:cNvSpPr/>
          <p:nvPr/>
        </p:nvSpPr>
        <p:spPr>
          <a:xfrm>
            <a:off x="4110480" y="280836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96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2" name="Rectangle 580"/>
          <p:cNvSpPr/>
          <p:nvPr/>
        </p:nvSpPr>
        <p:spPr>
          <a:xfrm>
            <a:off x="3908880" y="140508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63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3" name="Rectangle 582"/>
          <p:cNvSpPr/>
          <p:nvPr/>
        </p:nvSpPr>
        <p:spPr>
          <a:xfrm>
            <a:off x="4016880" y="293544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94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4" name="Rectangle 585"/>
          <p:cNvSpPr/>
          <p:nvPr/>
        </p:nvSpPr>
        <p:spPr>
          <a:xfrm>
            <a:off x="3864960" y="298440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5" name="Rectangle 587"/>
          <p:cNvSpPr/>
          <p:nvPr/>
        </p:nvSpPr>
        <p:spPr>
          <a:xfrm>
            <a:off x="4895280" y="218268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Rectangle 589"/>
          <p:cNvSpPr/>
          <p:nvPr/>
        </p:nvSpPr>
        <p:spPr>
          <a:xfrm>
            <a:off x="4252320" y="1376280"/>
            <a:ext cx="540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9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7" name="Rectangle 591"/>
          <p:cNvSpPr/>
          <p:nvPr/>
        </p:nvSpPr>
        <p:spPr>
          <a:xfrm>
            <a:off x="3997080" y="214488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63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8" name="Rectangle 592"/>
          <p:cNvSpPr/>
          <p:nvPr/>
        </p:nvSpPr>
        <p:spPr>
          <a:xfrm>
            <a:off x="4030200" y="327492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" name="Rectangle 594"/>
          <p:cNvSpPr/>
          <p:nvPr/>
        </p:nvSpPr>
        <p:spPr>
          <a:xfrm>
            <a:off x="4160160" y="339084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" name="Rectangle 597"/>
          <p:cNvSpPr/>
          <p:nvPr/>
        </p:nvSpPr>
        <p:spPr>
          <a:xfrm>
            <a:off x="4358520" y="185112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Rectangle 599"/>
          <p:cNvSpPr/>
          <p:nvPr/>
        </p:nvSpPr>
        <p:spPr>
          <a:xfrm>
            <a:off x="4079160" y="184644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Rectangle 601"/>
          <p:cNvSpPr/>
          <p:nvPr/>
        </p:nvSpPr>
        <p:spPr>
          <a:xfrm>
            <a:off x="3869280" y="153504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63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3" name="Rectangle 602"/>
          <p:cNvSpPr/>
          <p:nvPr/>
        </p:nvSpPr>
        <p:spPr>
          <a:xfrm>
            <a:off x="4646160" y="177804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4" name="Rectangle 604"/>
          <p:cNvSpPr/>
          <p:nvPr/>
        </p:nvSpPr>
        <p:spPr>
          <a:xfrm>
            <a:off x="4430160" y="49536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5" name="Rectangle 605"/>
          <p:cNvSpPr/>
          <p:nvPr/>
        </p:nvSpPr>
        <p:spPr>
          <a:xfrm>
            <a:off x="4271400" y="224784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Rectangle 606"/>
          <p:cNvSpPr/>
          <p:nvPr/>
        </p:nvSpPr>
        <p:spPr>
          <a:xfrm>
            <a:off x="4110480" y="233856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92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7" name="Rectangle 609"/>
          <p:cNvSpPr/>
          <p:nvPr/>
        </p:nvSpPr>
        <p:spPr>
          <a:xfrm>
            <a:off x="4502520" y="83988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99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8" name="Rectangle 610"/>
          <p:cNvSpPr/>
          <p:nvPr/>
        </p:nvSpPr>
        <p:spPr>
          <a:xfrm>
            <a:off x="4453920" y="195732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9" name="Rectangle 611"/>
          <p:cNvSpPr/>
          <p:nvPr/>
        </p:nvSpPr>
        <p:spPr>
          <a:xfrm>
            <a:off x="5041440" y="227160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Rectangle 612"/>
          <p:cNvSpPr/>
          <p:nvPr/>
        </p:nvSpPr>
        <p:spPr>
          <a:xfrm>
            <a:off x="4065120" y="276372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1" name="Rectangle 613"/>
          <p:cNvSpPr/>
          <p:nvPr/>
        </p:nvSpPr>
        <p:spPr>
          <a:xfrm>
            <a:off x="4565160" y="65736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Rectangle 615"/>
          <p:cNvSpPr/>
          <p:nvPr/>
        </p:nvSpPr>
        <p:spPr>
          <a:xfrm>
            <a:off x="4491720" y="53496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98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Rectangle 616"/>
          <p:cNvSpPr/>
          <p:nvPr/>
        </p:nvSpPr>
        <p:spPr>
          <a:xfrm>
            <a:off x="4399920" y="82692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4" name="Rectangle 618"/>
          <p:cNvSpPr/>
          <p:nvPr/>
        </p:nvSpPr>
        <p:spPr>
          <a:xfrm>
            <a:off x="4230360" y="115236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7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5" name="Rectangle 619"/>
          <p:cNvSpPr/>
          <p:nvPr/>
        </p:nvSpPr>
        <p:spPr>
          <a:xfrm>
            <a:off x="4196160" y="133200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8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6" name="Rectangle 622"/>
          <p:cNvSpPr/>
          <p:nvPr/>
        </p:nvSpPr>
        <p:spPr>
          <a:xfrm>
            <a:off x="4136400" y="299412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7" name="Rectangle 624"/>
          <p:cNvSpPr/>
          <p:nvPr/>
        </p:nvSpPr>
        <p:spPr>
          <a:xfrm>
            <a:off x="4214160" y="347976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8" name="Rectangle 627"/>
          <p:cNvSpPr/>
          <p:nvPr/>
        </p:nvSpPr>
        <p:spPr>
          <a:xfrm>
            <a:off x="3761280" y="109872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62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9" name="Rectangle 629"/>
          <p:cNvSpPr/>
          <p:nvPr/>
        </p:nvSpPr>
        <p:spPr>
          <a:xfrm>
            <a:off x="4314240" y="190332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0" name="Rectangle 630"/>
          <p:cNvSpPr/>
          <p:nvPr/>
        </p:nvSpPr>
        <p:spPr>
          <a:xfrm>
            <a:off x="4406400" y="205740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1" name="Rectangle 632"/>
          <p:cNvSpPr/>
          <p:nvPr/>
        </p:nvSpPr>
        <p:spPr>
          <a:xfrm>
            <a:off x="4527000" y="69228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Rectangle 633"/>
          <p:cNvSpPr/>
          <p:nvPr/>
        </p:nvSpPr>
        <p:spPr>
          <a:xfrm>
            <a:off x="4039560" y="100656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Rectangle 634"/>
          <p:cNvSpPr/>
          <p:nvPr/>
        </p:nvSpPr>
        <p:spPr>
          <a:xfrm>
            <a:off x="4204800" y="259560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Rectangle 636"/>
          <p:cNvSpPr/>
          <p:nvPr/>
        </p:nvSpPr>
        <p:spPr>
          <a:xfrm>
            <a:off x="4114080" y="156060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Rectangle 637"/>
          <p:cNvSpPr/>
          <p:nvPr/>
        </p:nvSpPr>
        <p:spPr>
          <a:xfrm>
            <a:off x="4015440" y="137304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62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6" name="Rectangle 638"/>
          <p:cNvSpPr/>
          <p:nvPr/>
        </p:nvSpPr>
        <p:spPr>
          <a:xfrm>
            <a:off x="4033080" y="379260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Rectangle 640"/>
          <p:cNvSpPr/>
          <p:nvPr/>
        </p:nvSpPr>
        <p:spPr>
          <a:xfrm>
            <a:off x="4069440" y="368136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64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Rectangle 644"/>
          <p:cNvSpPr/>
          <p:nvPr/>
        </p:nvSpPr>
        <p:spPr>
          <a:xfrm>
            <a:off x="4723920" y="236052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Rectangle 646"/>
          <p:cNvSpPr/>
          <p:nvPr/>
        </p:nvSpPr>
        <p:spPr>
          <a:xfrm>
            <a:off x="3969360" y="118908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63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Rectangle 647"/>
          <p:cNvSpPr/>
          <p:nvPr/>
        </p:nvSpPr>
        <p:spPr>
          <a:xfrm>
            <a:off x="4242960" y="198108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1" name="Rectangle 648"/>
          <p:cNvSpPr/>
          <p:nvPr/>
        </p:nvSpPr>
        <p:spPr>
          <a:xfrm>
            <a:off x="3513600" y="858672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69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2" name="Rectangle 649"/>
          <p:cNvSpPr/>
          <p:nvPr/>
        </p:nvSpPr>
        <p:spPr>
          <a:xfrm>
            <a:off x="4172400" y="307800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75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3" name="Rectangle 650"/>
          <p:cNvSpPr/>
          <p:nvPr/>
        </p:nvSpPr>
        <p:spPr>
          <a:xfrm>
            <a:off x="4073040" y="334656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Rectangle 651"/>
          <p:cNvSpPr/>
          <p:nvPr/>
        </p:nvSpPr>
        <p:spPr>
          <a:xfrm>
            <a:off x="4161960" y="372420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5" name="Rectangle 652"/>
          <p:cNvSpPr/>
          <p:nvPr/>
        </p:nvSpPr>
        <p:spPr>
          <a:xfrm>
            <a:off x="4641120" y="97164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6" name="Rectangle 653"/>
          <p:cNvSpPr/>
          <p:nvPr/>
        </p:nvSpPr>
        <p:spPr>
          <a:xfrm>
            <a:off x="4434840" y="181116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7" name="Rectangle 657"/>
          <p:cNvSpPr/>
          <p:nvPr/>
        </p:nvSpPr>
        <p:spPr>
          <a:xfrm>
            <a:off x="3995280" y="337644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8" name="Rectangle 662"/>
          <p:cNvSpPr/>
          <p:nvPr/>
        </p:nvSpPr>
        <p:spPr>
          <a:xfrm>
            <a:off x="4111200" y="330048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9" name="Rectangle 665"/>
          <p:cNvSpPr/>
          <p:nvPr/>
        </p:nvSpPr>
        <p:spPr>
          <a:xfrm>
            <a:off x="4490280" y="383868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0" name="Rectangle 671"/>
          <p:cNvSpPr/>
          <p:nvPr/>
        </p:nvSpPr>
        <p:spPr>
          <a:xfrm>
            <a:off x="4188240" y="120492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69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Rectangle 677"/>
          <p:cNvSpPr/>
          <p:nvPr/>
        </p:nvSpPr>
        <p:spPr>
          <a:xfrm>
            <a:off x="4266360" y="1108080"/>
            <a:ext cx="540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7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Rectangle 678"/>
          <p:cNvSpPr/>
          <p:nvPr/>
        </p:nvSpPr>
        <p:spPr>
          <a:xfrm>
            <a:off x="4143960" y="126540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63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" name="Rectangle 680"/>
          <p:cNvSpPr/>
          <p:nvPr/>
        </p:nvSpPr>
        <p:spPr>
          <a:xfrm>
            <a:off x="4287240" y="123984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" name="Rectangle 683"/>
          <p:cNvSpPr/>
          <p:nvPr/>
        </p:nvSpPr>
        <p:spPr>
          <a:xfrm>
            <a:off x="4080960" y="151452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" name="Rectangle 684"/>
          <p:cNvSpPr/>
          <p:nvPr/>
        </p:nvSpPr>
        <p:spPr>
          <a:xfrm>
            <a:off x="3955320" y="347328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" name="Rectangle 688"/>
          <p:cNvSpPr/>
          <p:nvPr/>
        </p:nvSpPr>
        <p:spPr>
          <a:xfrm>
            <a:off x="4042440" y="146700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99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" name="Rectangle 697"/>
          <p:cNvSpPr/>
          <p:nvPr/>
        </p:nvSpPr>
        <p:spPr>
          <a:xfrm>
            <a:off x="3997440" y="66024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8" name="Rectangle 698"/>
          <p:cNvSpPr/>
          <p:nvPr/>
        </p:nvSpPr>
        <p:spPr>
          <a:xfrm>
            <a:off x="4141080" y="254628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9" name="Rectangle 701"/>
          <p:cNvSpPr/>
          <p:nvPr/>
        </p:nvSpPr>
        <p:spPr>
          <a:xfrm>
            <a:off x="3995280" y="284796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0" name="Rectangle 702"/>
          <p:cNvSpPr/>
          <p:nvPr/>
        </p:nvSpPr>
        <p:spPr>
          <a:xfrm>
            <a:off x="4204080" y="376560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97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1" name="Rectangle 704"/>
          <p:cNvSpPr/>
          <p:nvPr/>
        </p:nvSpPr>
        <p:spPr>
          <a:xfrm>
            <a:off x="4169880" y="271944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2" name="Rectangle 706"/>
          <p:cNvSpPr/>
          <p:nvPr/>
        </p:nvSpPr>
        <p:spPr>
          <a:xfrm>
            <a:off x="4404600" y="380520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Rectangle 707"/>
          <p:cNvSpPr/>
          <p:nvPr/>
        </p:nvSpPr>
        <p:spPr>
          <a:xfrm>
            <a:off x="4435920" y="74772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94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Rectangle 708"/>
          <p:cNvSpPr/>
          <p:nvPr/>
        </p:nvSpPr>
        <p:spPr>
          <a:xfrm>
            <a:off x="4493520" y="79524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5" name="Rectangle 709"/>
          <p:cNvSpPr/>
          <p:nvPr/>
        </p:nvSpPr>
        <p:spPr>
          <a:xfrm>
            <a:off x="4577760" y="209376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6" name="Rectangle 711"/>
          <p:cNvSpPr/>
          <p:nvPr/>
        </p:nvSpPr>
        <p:spPr>
          <a:xfrm>
            <a:off x="4166640" y="304308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Rectangle 717"/>
          <p:cNvSpPr/>
          <p:nvPr/>
        </p:nvSpPr>
        <p:spPr>
          <a:xfrm>
            <a:off x="4191840" y="357012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Rectangle 718"/>
          <p:cNvSpPr/>
          <p:nvPr/>
        </p:nvSpPr>
        <p:spPr>
          <a:xfrm>
            <a:off x="4538160" y="231624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Rectangle 720"/>
          <p:cNvSpPr/>
          <p:nvPr/>
        </p:nvSpPr>
        <p:spPr>
          <a:xfrm>
            <a:off x="4071240" y="244152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0" name="Rectangle 721"/>
          <p:cNvSpPr/>
          <p:nvPr/>
        </p:nvSpPr>
        <p:spPr>
          <a:xfrm>
            <a:off x="4407840" y="316692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1" name="Freeform 206"/>
          <p:cNvSpPr/>
          <p:nvPr/>
        </p:nvSpPr>
        <p:spPr>
          <a:xfrm>
            <a:off x="4219560" y="2496960"/>
            <a:ext cx="73080" cy="22320"/>
          </a:xfrm>
          <a:custGeom>
            <a:avLst/>
            <a:gdLst>
              <a:gd name="textAreaLeft" fmla="*/ 0 w 73080"/>
              <a:gd name="textAreaRight" fmla="*/ 73440 w 7308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503" h="92">
                <a:moveTo>
                  <a:pt x="503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2" name="Freeform 207"/>
          <p:cNvSpPr/>
          <p:nvPr/>
        </p:nvSpPr>
        <p:spPr>
          <a:xfrm>
            <a:off x="4632480" y="1803240"/>
            <a:ext cx="334800" cy="22320"/>
          </a:xfrm>
          <a:custGeom>
            <a:avLst/>
            <a:gdLst>
              <a:gd name="textAreaLeft" fmla="*/ 0 w 334800"/>
              <a:gd name="textAreaRight" fmla="*/ 335160 w 33480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2324" h="91">
                <a:moveTo>
                  <a:pt x="2324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3" name="Freeform 211"/>
          <p:cNvSpPr/>
          <p:nvPr/>
        </p:nvSpPr>
        <p:spPr>
          <a:xfrm>
            <a:off x="4145040" y="3392640"/>
            <a:ext cx="110880" cy="21960"/>
          </a:xfrm>
          <a:custGeom>
            <a:avLst/>
            <a:gdLst>
              <a:gd name="textAreaLeft" fmla="*/ 0 w 110880"/>
              <a:gd name="textAreaRight" fmla="*/ 111240 w 110880"/>
              <a:gd name="textAreaTop" fmla="*/ 0 h 21960"/>
              <a:gd name="textAreaBottom" fmla="*/ 22320 h 21960"/>
            </a:gdLst>
            <a:ahLst/>
            <a:rect l="textAreaLeft" t="textAreaTop" r="textAreaRight" b="textAreaBottom"/>
            <a:pathLst>
              <a:path w="760" h="91">
                <a:moveTo>
                  <a:pt x="760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4" name="Freeform 216"/>
          <p:cNvSpPr/>
          <p:nvPr/>
        </p:nvSpPr>
        <p:spPr>
          <a:xfrm>
            <a:off x="3943440" y="2168640"/>
            <a:ext cx="41040" cy="352440"/>
          </a:xfrm>
          <a:custGeom>
            <a:avLst/>
            <a:gdLst>
              <a:gd name="textAreaLeft" fmla="*/ 0 w 41040"/>
              <a:gd name="textAreaRight" fmla="*/ 41400 w 41040"/>
              <a:gd name="textAreaTop" fmla="*/ 0 h 352440"/>
              <a:gd name="textAreaBottom" fmla="*/ 352800 h 352440"/>
            </a:gdLst>
            <a:ahLst/>
            <a:rect l="textAreaLeft" t="textAreaTop" r="textAreaRight" b="textAreaBottom"/>
            <a:pathLst>
              <a:path w="291" h="1442">
                <a:moveTo>
                  <a:pt x="291" y="0"/>
                </a:moveTo>
                <a:lnTo>
                  <a:pt x="0" y="0"/>
                </a:lnTo>
                <a:lnTo>
                  <a:pt x="0" y="144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5" name="Freeform 219"/>
          <p:cNvSpPr/>
          <p:nvPr/>
        </p:nvSpPr>
        <p:spPr>
          <a:xfrm>
            <a:off x="3979800" y="3297240"/>
            <a:ext cx="36720" cy="104760"/>
          </a:xfrm>
          <a:custGeom>
            <a:avLst/>
            <a:gdLst>
              <a:gd name="textAreaLeft" fmla="*/ 0 w 36720"/>
              <a:gd name="textAreaRight" fmla="*/ 37080 w 36720"/>
              <a:gd name="textAreaTop" fmla="*/ 0 h 104760"/>
              <a:gd name="textAreaBottom" fmla="*/ 105120 h 104760"/>
            </a:gdLst>
            <a:ahLst/>
            <a:rect l="textAreaLeft" t="textAreaTop" r="textAreaRight" b="textAreaBottom"/>
            <a:pathLst>
              <a:path w="246" h="424">
                <a:moveTo>
                  <a:pt x="246" y="0"/>
                </a:moveTo>
                <a:lnTo>
                  <a:pt x="0" y="0"/>
                </a:lnTo>
                <a:lnTo>
                  <a:pt x="0" y="424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6" name="Freeform 223"/>
          <p:cNvSpPr/>
          <p:nvPr/>
        </p:nvSpPr>
        <p:spPr>
          <a:xfrm>
            <a:off x="4059360" y="3371760"/>
            <a:ext cx="85680" cy="42840"/>
          </a:xfrm>
          <a:custGeom>
            <a:avLst/>
            <a:gdLst>
              <a:gd name="textAreaLeft" fmla="*/ 0 w 85680"/>
              <a:gd name="textAreaRight" fmla="*/ 86040 w 85680"/>
              <a:gd name="textAreaTop" fmla="*/ 0 h 42840"/>
              <a:gd name="textAreaBottom" fmla="*/ 42840 h 42840"/>
            </a:gdLst>
            <a:ahLst/>
            <a:rect l="textAreaLeft" t="textAreaTop" r="textAreaRight" b="textAreaBottom"/>
            <a:pathLst>
              <a:path w="598" h="183">
                <a:moveTo>
                  <a:pt x="598" y="183"/>
                </a:moveTo>
                <a:lnTo>
                  <a:pt x="0" y="183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7" name="Freeform 225"/>
          <p:cNvSpPr/>
          <p:nvPr/>
        </p:nvSpPr>
        <p:spPr>
          <a:xfrm>
            <a:off x="4300560" y="1874880"/>
            <a:ext cx="44280" cy="54000"/>
          </a:xfrm>
          <a:custGeom>
            <a:avLst/>
            <a:gdLst>
              <a:gd name="textAreaLeft" fmla="*/ 0 w 44280"/>
              <a:gd name="textAreaRight" fmla="*/ 44640 w 44280"/>
              <a:gd name="textAreaTop" fmla="*/ 0 h 54000"/>
              <a:gd name="textAreaBottom" fmla="*/ 54360 h 54000"/>
            </a:gdLst>
            <a:ahLst/>
            <a:rect l="textAreaLeft" t="textAreaTop" r="textAreaRight" b="textAreaBottom"/>
            <a:pathLst>
              <a:path w="315" h="218">
                <a:moveTo>
                  <a:pt x="315" y="0"/>
                </a:moveTo>
                <a:lnTo>
                  <a:pt x="0" y="0"/>
                </a:lnTo>
                <a:lnTo>
                  <a:pt x="0" y="218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560" bIns="75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8" name="Freeform 229"/>
          <p:cNvSpPr/>
          <p:nvPr/>
        </p:nvSpPr>
        <p:spPr>
          <a:xfrm>
            <a:off x="4421160" y="1803240"/>
            <a:ext cx="211320" cy="33480"/>
          </a:xfrm>
          <a:custGeom>
            <a:avLst/>
            <a:gdLst>
              <a:gd name="textAreaLeft" fmla="*/ 0 w 211320"/>
              <a:gd name="textAreaRight" fmla="*/ 211680 w 211320"/>
              <a:gd name="textAreaTop" fmla="*/ 0 h 33480"/>
              <a:gd name="textAreaBottom" fmla="*/ 33840 h 33480"/>
            </a:gdLst>
            <a:ahLst/>
            <a:rect l="textAreaLeft" t="textAreaTop" r="textAreaRight" b="textAreaBottom"/>
            <a:pathLst>
              <a:path w="1464" h="137">
                <a:moveTo>
                  <a:pt x="1464" y="0"/>
                </a:moveTo>
                <a:lnTo>
                  <a:pt x="0" y="0"/>
                </a:lnTo>
                <a:lnTo>
                  <a:pt x="0" y="137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9" name="Freeform 231"/>
          <p:cNvSpPr/>
          <p:nvPr/>
        </p:nvSpPr>
        <p:spPr>
          <a:xfrm>
            <a:off x="3855960" y="1560600"/>
            <a:ext cx="501840" cy="129960"/>
          </a:xfrm>
          <a:custGeom>
            <a:avLst/>
            <a:gdLst>
              <a:gd name="textAreaLeft" fmla="*/ 0 w 501840"/>
              <a:gd name="textAreaRight" fmla="*/ 502200 w 501840"/>
              <a:gd name="textAreaTop" fmla="*/ 0 h 129960"/>
              <a:gd name="textAreaBottom" fmla="*/ 130320 h 129960"/>
            </a:gdLst>
            <a:ahLst/>
            <a:rect l="textAreaLeft" t="textAreaTop" r="textAreaRight" b="textAreaBottom"/>
            <a:pathLst>
              <a:path w="3480" h="534">
                <a:moveTo>
                  <a:pt x="3480" y="534"/>
                </a:moveTo>
                <a:lnTo>
                  <a:pt x="0" y="534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0" name="Freeform 233"/>
          <p:cNvSpPr/>
          <p:nvPr/>
        </p:nvSpPr>
        <p:spPr>
          <a:xfrm>
            <a:off x="4417920" y="482760"/>
            <a:ext cx="149400" cy="37800"/>
          </a:xfrm>
          <a:custGeom>
            <a:avLst/>
            <a:gdLst>
              <a:gd name="textAreaLeft" fmla="*/ 0 w 149400"/>
              <a:gd name="textAreaRight" fmla="*/ 149760 w 149400"/>
              <a:gd name="textAreaTop" fmla="*/ 0 h 37800"/>
              <a:gd name="textAreaBottom" fmla="*/ 38160 h 37800"/>
            </a:gdLst>
            <a:ahLst/>
            <a:rect l="textAreaLeft" t="textAreaTop" r="textAreaRight" b="textAreaBottom"/>
            <a:pathLst>
              <a:path w="1042" h="160">
                <a:moveTo>
                  <a:pt x="1042" y="0"/>
                </a:moveTo>
                <a:lnTo>
                  <a:pt x="0" y="0"/>
                </a:lnTo>
                <a:lnTo>
                  <a:pt x="0" y="16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Freeform 235"/>
          <p:cNvSpPr/>
          <p:nvPr/>
        </p:nvSpPr>
        <p:spPr>
          <a:xfrm>
            <a:off x="4157640" y="3079800"/>
            <a:ext cx="15840" cy="22320"/>
          </a:xfrm>
          <a:custGeom>
            <a:avLst/>
            <a:gdLst>
              <a:gd name="textAreaLeft" fmla="*/ 0 w 15840"/>
              <a:gd name="textAreaRight" fmla="*/ 16200 w 1584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100" h="92">
                <a:moveTo>
                  <a:pt x="100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2" name="Freeform 237"/>
          <p:cNvSpPr/>
          <p:nvPr/>
        </p:nvSpPr>
        <p:spPr>
          <a:xfrm>
            <a:off x="4524480" y="2295360"/>
            <a:ext cx="504720" cy="44640"/>
          </a:xfrm>
          <a:custGeom>
            <a:avLst/>
            <a:gdLst>
              <a:gd name="textAreaLeft" fmla="*/ 0 w 504720"/>
              <a:gd name="textAreaRight" fmla="*/ 505080 w 504720"/>
              <a:gd name="textAreaTop" fmla="*/ 0 h 44640"/>
              <a:gd name="textAreaBottom" fmla="*/ 45000 h 44640"/>
            </a:gdLst>
            <a:ahLst/>
            <a:rect l="textAreaLeft" t="textAreaTop" r="textAreaRight" b="textAreaBottom"/>
            <a:pathLst>
              <a:path w="3498" h="183">
                <a:moveTo>
                  <a:pt x="3498" y="0"/>
                </a:moveTo>
                <a:lnTo>
                  <a:pt x="0" y="0"/>
                </a:lnTo>
                <a:lnTo>
                  <a:pt x="0" y="183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" bIns="-1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3" name="Freeform 238"/>
          <p:cNvSpPr/>
          <p:nvPr/>
        </p:nvSpPr>
        <p:spPr>
          <a:xfrm>
            <a:off x="4019400" y="3817800"/>
            <a:ext cx="77760" cy="112680"/>
          </a:xfrm>
          <a:custGeom>
            <a:avLst/>
            <a:gdLst>
              <a:gd name="textAreaLeft" fmla="*/ 0 w 77760"/>
              <a:gd name="textAreaRight" fmla="*/ 78120 w 77760"/>
              <a:gd name="textAreaTop" fmla="*/ 0 h 112680"/>
              <a:gd name="textAreaBottom" fmla="*/ 113040 h 112680"/>
            </a:gdLst>
            <a:ahLst/>
            <a:rect l="textAreaLeft" t="textAreaTop" r="textAreaRight" b="textAreaBottom"/>
            <a:pathLst>
              <a:path w="540" h="461">
                <a:moveTo>
                  <a:pt x="540" y="461"/>
                </a:moveTo>
                <a:lnTo>
                  <a:pt x="0" y="46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4" name="Freeform 241"/>
          <p:cNvSpPr/>
          <p:nvPr/>
        </p:nvSpPr>
        <p:spPr>
          <a:xfrm>
            <a:off x="3984480" y="685800"/>
            <a:ext cx="403200" cy="165240"/>
          </a:xfrm>
          <a:custGeom>
            <a:avLst/>
            <a:gdLst>
              <a:gd name="textAreaLeft" fmla="*/ 0 w 403200"/>
              <a:gd name="textAreaRight" fmla="*/ 403560 w 403200"/>
              <a:gd name="textAreaTop" fmla="*/ 0 h 165240"/>
              <a:gd name="textAreaBottom" fmla="*/ 165600 h 165240"/>
            </a:gdLst>
            <a:ahLst/>
            <a:rect l="textAreaLeft" t="textAreaTop" r="textAreaRight" b="textAreaBottom"/>
            <a:pathLst>
              <a:path w="2793" h="676">
                <a:moveTo>
                  <a:pt x="2793" y="676"/>
                </a:moveTo>
                <a:lnTo>
                  <a:pt x="0" y="676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5" name="Freeform 242"/>
          <p:cNvSpPr/>
          <p:nvPr/>
        </p:nvSpPr>
        <p:spPr>
          <a:xfrm>
            <a:off x="4417920" y="520560"/>
            <a:ext cx="60480" cy="39960"/>
          </a:xfrm>
          <a:custGeom>
            <a:avLst/>
            <a:gdLst>
              <a:gd name="textAreaLeft" fmla="*/ 0 w 60480"/>
              <a:gd name="textAreaRight" fmla="*/ 60840 w 60480"/>
              <a:gd name="textAreaTop" fmla="*/ 0 h 39960"/>
              <a:gd name="textAreaBottom" fmla="*/ 40320 h 39960"/>
            </a:gdLst>
            <a:ahLst/>
            <a:rect l="textAreaLeft" t="textAreaTop" r="textAreaRight" b="textAreaBottom"/>
            <a:pathLst>
              <a:path w="424" h="160">
                <a:moveTo>
                  <a:pt x="424" y="160"/>
                </a:moveTo>
                <a:lnTo>
                  <a:pt x="0" y="160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6" name="Freeform 244"/>
          <p:cNvSpPr/>
          <p:nvPr/>
        </p:nvSpPr>
        <p:spPr>
          <a:xfrm>
            <a:off x="4132440" y="1290600"/>
            <a:ext cx="50760" cy="76320"/>
          </a:xfrm>
          <a:custGeom>
            <a:avLst/>
            <a:gdLst>
              <a:gd name="textAreaLeft" fmla="*/ 0 w 50760"/>
              <a:gd name="textAreaRight" fmla="*/ 51120 w 50760"/>
              <a:gd name="textAreaTop" fmla="*/ 0 h 76320"/>
              <a:gd name="textAreaBottom" fmla="*/ 76680 h 76320"/>
            </a:gdLst>
            <a:ahLst/>
            <a:rect l="textAreaLeft" t="textAreaTop" r="textAreaRight" b="textAreaBottom"/>
            <a:pathLst>
              <a:path w="359" h="309">
                <a:moveTo>
                  <a:pt x="359" y="309"/>
                </a:moveTo>
                <a:lnTo>
                  <a:pt x="0" y="309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880" bIns="298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7" name="Freeform 252"/>
          <p:cNvSpPr/>
          <p:nvPr/>
        </p:nvSpPr>
        <p:spPr>
          <a:xfrm>
            <a:off x="4145040" y="3414600"/>
            <a:ext cx="60120" cy="23760"/>
          </a:xfrm>
          <a:custGeom>
            <a:avLst/>
            <a:gdLst>
              <a:gd name="textAreaLeft" fmla="*/ 0 w 60120"/>
              <a:gd name="textAreaRight" fmla="*/ 60480 w 60120"/>
              <a:gd name="textAreaTop" fmla="*/ 0 h 23760"/>
              <a:gd name="textAreaBottom" fmla="*/ 24120 h 23760"/>
            </a:gdLst>
            <a:ahLst/>
            <a:rect l="textAreaLeft" t="textAreaTop" r="textAreaRight" b="textAreaBottom"/>
            <a:pathLst>
              <a:path w="420" h="92">
                <a:moveTo>
                  <a:pt x="420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Freeform 255"/>
          <p:cNvSpPr/>
          <p:nvPr/>
        </p:nvSpPr>
        <p:spPr>
          <a:xfrm>
            <a:off x="3641760" y="1123920"/>
            <a:ext cx="106200" cy="1144440"/>
          </a:xfrm>
          <a:custGeom>
            <a:avLst/>
            <a:gdLst>
              <a:gd name="textAreaLeft" fmla="*/ 0 w 106200"/>
              <a:gd name="textAreaRight" fmla="*/ 106560 w 106200"/>
              <a:gd name="textAreaTop" fmla="*/ 0 h 1144440"/>
              <a:gd name="textAreaBottom" fmla="*/ 1144800 h 1144440"/>
            </a:gdLst>
            <a:ahLst/>
            <a:rect l="textAreaLeft" t="textAreaTop" r="textAreaRight" b="textAreaBottom"/>
            <a:pathLst>
              <a:path w="745" h="4684">
                <a:moveTo>
                  <a:pt x="745" y="0"/>
                </a:moveTo>
                <a:lnTo>
                  <a:pt x="0" y="0"/>
                </a:lnTo>
                <a:lnTo>
                  <a:pt x="0" y="4684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9" name="Freeform 257"/>
          <p:cNvSpPr/>
          <p:nvPr/>
        </p:nvSpPr>
        <p:spPr>
          <a:xfrm>
            <a:off x="4229280" y="1928880"/>
            <a:ext cx="71280" cy="77760"/>
          </a:xfrm>
          <a:custGeom>
            <a:avLst/>
            <a:gdLst>
              <a:gd name="textAreaLeft" fmla="*/ 0 w 71280"/>
              <a:gd name="textAreaRight" fmla="*/ 71640 w 71280"/>
              <a:gd name="textAreaTop" fmla="*/ 0 h 77760"/>
              <a:gd name="textAreaBottom" fmla="*/ 78120 h 77760"/>
            </a:gdLst>
            <a:ahLst/>
            <a:rect l="textAreaLeft" t="textAreaTop" r="textAreaRight" b="textAreaBottom"/>
            <a:pathLst>
              <a:path w="495" h="315">
                <a:moveTo>
                  <a:pt x="495" y="0"/>
                </a:moveTo>
                <a:lnTo>
                  <a:pt x="0" y="0"/>
                </a:lnTo>
                <a:lnTo>
                  <a:pt x="0" y="315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1320" bIns="313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0" name="Freeform 260"/>
          <p:cNvSpPr/>
          <p:nvPr/>
        </p:nvSpPr>
        <p:spPr>
          <a:xfrm>
            <a:off x="4229280" y="2006640"/>
            <a:ext cx="161640" cy="76320"/>
          </a:xfrm>
          <a:custGeom>
            <a:avLst/>
            <a:gdLst>
              <a:gd name="textAreaLeft" fmla="*/ 0 w 161640"/>
              <a:gd name="textAreaRight" fmla="*/ 161640 w 161640"/>
              <a:gd name="textAreaTop" fmla="*/ 0 h 76320"/>
              <a:gd name="textAreaBottom" fmla="*/ 76680 h 76320"/>
            </a:gdLst>
            <a:ahLst/>
            <a:rect l="textAreaLeft" t="textAreaTop" r="textAreaRight" b="textAreaBottom"/>
            <a:pathLst>
              <a:path w="1137" h="314">
                <a:moveTo>
                  <a:pt x="1137" y="314"/>
                </a:moveTo>
                <a:lnTo>
                  <a:pt x="0" y="314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880" bIns="298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1" name="Freeform 261"/>
          <p:cNvSpPr/>
          <p:nvPr/>
        </p:nvSpPr>
        <p:spPr>
          <a:xfrm>
            <a:off x="4421160" y="716040"/>
            <a:ext cx="92160" cy="55440"/>
          </a:xfrm>
          <a:custGeom>
            <a:avLst/>
            <a:gdLst>
              <a:gd name="textAreaLeft" fmla="*/ 0 w 92160"/>
              <a:gd name="textAreaRight" fmla="*/ 92520 w 92160"/>
              <a:gd name="textAreaTop" fmla="*/ 0 h 55440"/>
              <a:gd name="textAreaBottom" fmla="*/ 55800 h 55440"/>
            </a:gdLst>
            <a:ahLst/>
            <a:rect l="textAreaLeft" t="textAreaTop" r="textAreaRight" b="textAreaBottom"/>
            <a:pathLst>
              <a:path w="631" h="229">
                <a:moveTo>
                  <a:pt x="631" y="0"/>
                </a:moveTo>
                <a:lnTo>
                  <a:pt x="0" y="0"/>
                </a:lnTo>
                <a:lnTo>
                  <a:pt x="0" y="229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2" name="Freeform 262"/>
          <p:cNvSpPr/>
          <p:nvPr/>
        </p:nvSpPr>
        <p:spPr>
          <a:xfrm>
            <a:off x="4127400" y="2570040"/>
            <a:ext cx="65160" cy="50760"/>
          </a:xfrm>
          <a:custGeom>
            <a:avLst/>
            <a:gdLst>
              <a:gd name="textAreaLeft" fmla="*/ 0 w 65160"/>
              <a:gd name="textAreaRight" fmla="*/ 65520 w 65160"/>
              <a:gd name="textAreaTop" fmla="*/ 0 h 50760"/>
              <a:gd name="textAreaBottom" fmla="*/ 51120 h 50760"/>
            </a:gdLst>
            <a:ahLst/>
            <a:rect l="textAreaLeft" t="textAreaTop" r="textAreaRight" b="textAreaBottom"/>
            <a:pathLst>
              <a:path w="447" h="206">
                <a:moveTo>
                  <a:pt x="447" y="206"/>
                </a:moveTo>
                <a:lnTo>
                  <a:pt x="0" y="206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20" bIns="43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3" name="Freeform 265"/>
          <p:cNvSpPr/>
          <p:nvPr/>
        </p:nvSpPr>
        <p:spPr>
          <a:xfrm>
            <a:off x="4183200" y="1332000"/>
            <a:ext cx="144360" cy="34920"/>
          </a:xfrm>
          <a:custGeom>
            <a:avLst/>
            <a:gdLst>
              <a:gd name="textAreaLeft" fmla="*/ 0 w 144360"/>
              <a:gd name="textAreaRight" fmla="*/ 144720 w 144360"/>
              <a:gd name="textAreaTop" fmla="*/ 0 h 34920"/>
              <a:gd name="textAreaBottom" fmla="*/ 35280 h 34920"/>
            </a:gdLst>
            <a:ahLst/>
            <a:rect l="textAreaLeft" t="textAreaTop" r="textAreaRight" b="textAreaBottom"/>
            <a:pathLst>
              <a:path w="1012" h="137">
                <a:moveTo>
                  <a:pt x="1012" y="0"/>
                </a:moveTo>
                <a:lnTo>
                  <a:pt x="0" y="0"/>
                </a:lnTo>
                <a:lnTo>
                  <a:pt x="0" y="137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1520" bIns="-115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4" name="Freeform 266"/>
          <p:cNvSpPr/>
          <p:nvPr/>
        </p:nvSpPr>
        <p:spPr>
          <a:xfrm>
            <a:off x="3956040" y="1214280"/>
            <a:ext cx="46080" cy="184320"/>
          </a:xfrm>
          <a:custGeom>
            <a:avLst/>
            <a:gdLst>
              <a:gd name="textAreaLeft" fmla="*/ 0 w 46080"/>
              <a:gd name="textAreaRight" fmla="*/ 46440 w 46080"/>
              <a:gd name="textAreaTop" fmla="*/ 0 h 184320"/>
              <a:gd name="textAreaBottom" fmla="*/ 184680 h 184320"/>
            </a:gdLst>
            <a:ahLst/>
            <a:rect l="textAreaLeft" t="textAreaTop" r="textAreaRight" b="textAreaBottom"/>
            <a:pathLst>
              <a:path w="312" h="753">
                <a:moveTo>
                  <a:pt x="312" y="753"/>
                </a:moveTo>
                <a:lnTo>
                  <a:pt x="0" y="753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5" name="Freeform 267"/>
          <p:cNvSpPr/>
          <p:nvPr/>
        </p:nvSpPr>
        <p:spPr>
          <a:xfrm>
            <a:off x="4394160" y="3168720"/>
            <a:ext cx="38160" cy="23760"/>
          </a:xfrm>
          <a:custGeom>
            <a:avLst/>
            <a:gdLst>
              <a:gd name="textAreaLeft" fmla="*/ 0 w 38160"/>
              <a:gd name="textAreaRight" fmla="*/ 38520 w 38160"/>
              <a:gd name="textAreaTop" fmla="*/ 0 h 23760"/>
              <a:gd name="textAreaBottom" fmla="*/ 24120 h 23760"/>
            </a:gdLst>
            <a:ahLst/>
            <a:rect l="textAreaLeft" t="textAreaTop" r="textAreaRight" b="textAreaBottom"/>
            <a:pathLst>
              <a:path w="268" h="91">
                <a:moveTo>
                  <a:pt x="268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6" name="Freeform 268"/>
          <p:cNvSpPr/>
          <p:nvPr/>
        </p:nvSpPr>
        <p:spPr>
          <a:xfrm>
            <a:off x="4275000" y="1243080"/>
            <a:ext cx="17640" cy="22320"/>
          </a:xfrm>
          <a:custGeom>
            <a:avLst/>
            <a:gdLst>
              <a:gd name="textAreaLeft" fmla="*/ 0 w 17640"/>
              <a:gd name="textAreaRight" fmla="*/ 18000 w 1764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129" h="91">
                <a:moveTo>
                  <a:pt x="129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7" name="Freeform 269"/>
          <p:cNvSpPr/>
          <p:nvPr/>
        </p:nvSpPr>
        <p:spPr>
          <a:xfrm>
            <a:off x="4387680" y="851040"/>
            <a:ext cx="127080" cy="79200"/>
          </a:xfrm>
          <a:custGeom>
            <a:avLst/>
            <a:gdLst>
              <a:gd name="textAreaLeft" fmla="*/ 0 w 127080"/>
              <a:gd name="textAreaRight" fmla="*/ 127440 w 127080"/>
              <a:gd name="textAreaTop" fmla="*/ 0 h 79200"/>
              <a:gd name="textAreaBottom" fmla="*/ 79560 h 79200"/>
            </a:gdLst>
            <a:ahLst/>
            <a:rect l="textAreaLeft" t="textAreaTop" r="textAreaRight" b="textAreaBottom"/>
            <a:pathLst>
              <a:path w="890" h="320">
                <a:moveTo>
                  <a:pt x="890" y="320"/>
                </a:moveTo>
                <a:lnTo>
                  <a:pt x="0" y="320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8" name="Freeform 270"/>
          <p:cNvSpPr/>
          <p:nvPr/>
        </p:nvSpPr>
        <p:spPr>
          <a:xfrm>
            <a:off x="4394160" y="3192480"/>
            <a:ext cx="4680" cy="20520"/>
          </a:xfrm>
          <a:custGeom>
            <a:avLst/>
            <a:gdLst>
              <a:gd name="textAreaLeft" fmla="*/ 0 w 4680"/>
              <a:gd name="textAreaRight" fmla="*/ 5040 w 4680"/>
              <a:gd name="textAreaTop" fmla="*/ 0 h 20520"/>
              <a:gd name="textAreaBottom" fmla="*/ 20880 h 20520"/>
            </a:gdLst>
            <a:ahLst/>
            <a:rect l="textAreaLeft" t="textAreaTop" r="textAreaRight" b="textAreaBottom"/>
            <a:pathLst>
              <a:path w="34" h="92">
                <a:moveTo>
                  <a:pt x="34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9" name="Freeform 271"/>
          <p:cNvSpPr/>
          <p:nvPr/>
        </p:nvSpPr>
        <p:spPr>
          <a:xfrm>
            <a:off x="4054320" y="3660840"/>
            <a:ext cx="160560" cy="44280"/>
          </a:xfrm>
          <a:custGeom>
            <a:avLst/>
            <a:gdLst>
              <a:gd name="textAreaLeft" fmla="*/ 0 w 160560"/>
              <a:gd name="textAreaRight" fmla="*/ 160920 w 160560"/>
              <a:gd name="textAreaTop" fmla="*/ 0 h 44280"/>
              <a:gd name="textAreaBottom" fmla="*/ 44640 h 44280"/>
            </a:gdLst>
            <a:ahLst/>
            <a:rect l="textAreaLeft" t="textAreaTop" r="textAreaRight" b="textAreaBottom"/>
            <a:pathLst>
              <a:path w="1117" h="177">
                <a:moveTo>
                  <a:pt x="1117" y="0"/>
                </a:moveTo>
                <a:lnTo>
                  <a:pt x="0" y="0"/>
                </a:lnTo>
                <a:lnTo>
                  <a:pt x="0" y="177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0" name="Freeform 272"/>
          <p:cNvSpPr/>
          <p:nvPr/>
        </p:nvSpPr>
        <p:spPr>
          <a:xfrm>
            <a:off x="4479840" y="795240"/>
            <a:ext cx="50760" cy="33480"/>
          </a:xfrm>
          <a:custGeom>
            <a:avLst/>
            <a:gdLst>
              <a:gd name="textAreaLeft" fmla="*/ 0 w 50760"/>
              <a:gd name="textAreaRight" fmla="*/ 51120 w 50760"/>
              <a:gd name="textAreaTop" fmla="*/ 0 h 33480"/>
              <a:gd name="textAreaBottom" fmla="*/ 33840 h 33480"/>
            </a:gdLst>
            <a:ahLst/>
            <a:rect l="textAreaLeft" t="textAreaTop" r="textAreaRight" b="textAreaBottom"/>
            <a:pathLst>
              <a:path w="347" h="137">
                <a:moveTo>
                  <a:pt x="347" y="0"/>
                </a:moveTo>
                <a:lnTo>
                  <a:pt x="0" y="0"/>
                </a:lnTo>
                <a:lnTo>
                  <a:pt x="0" y="137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1" name="Freeform 273"/>
          <p:cNvSpPr/>
          <p:nvPr/>
        </p:nvSpPr>
        <p:spPr>
          <a:xfrm>
            <a:off x="4200480" y="3483000"/>
            <a:ext cx="47520" cy="22320"/>
          </a:xfrm>
          <a:custGeom>
            <a:avLst/>
            <a:gdLst>
              <a:gd name="textAreaLeft" fmla="*/ 0 w 47520"/>
              <a:gd name="textAreaRight" fmla="*/ 47880 w 4752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334" h="92">
                <a:moveTo>
                  <a:pt x="334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2" name="Freeform 278"/>
          <p:cNvSpPr/>
          <p:nvPr/>
        </p:nvSpPr>
        <p:spPr>
          <a:xfrm>
            <a:off x="4238640" y="1400040"/>
            <a:ext cx="20520" cy="22320"/>
          </a:xfrm>
          <a:custGeom>
            <a:avLst/>
            <a:gdLst>
              <a:gd name="textAreaLeft" fmla="*/ 0 w 20520"/>
              <a:gd name="textAreaRight" fmla="*/ 20880 w 2052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141" h="91">
                <a:moveTo>
                  <a:pt x="141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3" name="Freeform 280"/>
          <p:cNvSpPr/>
          <p:nvPr/>
        </p:nvSpPr>
        <p:spPr>
          <a:xfrm>
            <a:off x="4524480" y="2340000"/>
            <a:ext cx="185760" cy="46080"/>
          </a:xfrm>
          <a:custGeom>
            <a:avLst/>
            <a:gdLst>
              <a:gd name="textAreaLeft" fmla="*/ 0 w 185760"/>
              <a:gd name="textAreaRight" fmla="*/ 186120 w 185760"/>
              <a:gd name="textAreaTop" fmla="*/ 0 h 46080"/>
              <a:gd name="textAreaBottom" fmla="*/ 46440 h 46080"/>
            </a:gdLst>
            <a:ahLst/>
            <a:rect l="textAreaLeft" t="textAreaTop" r="textAreaRight" b="textAreaBottom"/>
            <a:pathLst>
              <a:path w="1290" h="183">
                <a:moveTo>
                  <a:pt x="1290" y="183"/>
                </a:moveTo>
                <a:lnTo>
                  <a:pt x="0" y="183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4" name="Freeform 281"/>
          <p:cNvSpPr/>
          <p:nvPr/>
        </p:nvSpPr>
        <p:spPr>
          <a:xfrm>
            <a:off x="349200" y="6724800"/>
            <a:ext cx="3151080" cy="1887480"/>
          </a:xfrm>
          <a:custGeom>
            <a:avLst/>
            <a:gdLst>
              <a:gd name="textAreaLeft" fmla="*/ 0 w 3151080"/>
              <a:gd name="textAreaRight" fmla="*/ 3151440 w 3151080"/>
              <a:gd name="textAreaTop" fmla="*/ 0 h 1887480"/>
              <a:gd name="textAreaBottom" fmla="*/ 1887840 h 1887480"/>
            </a:gdLst>
            <a:ahLst/>
            <a:rect l="textAreaLeft" t="textAreaTop" r="textAreaRight" b="textAreaBottom"/>
            <a:pathLst>
              <a:path w="21863" h="7715">
                <a:moveTo>
                  <a:pt x="21863" y="7715"/>
                </a:moveTo>
                <a:lnTo>
                  <a:pt x="0" y="7715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5" name="Freeform 282"/>
          <p:cNvSpPr/>
          <p:nvPr/>
        </p:nvSpPr>
        <p:spPr>
          <a:xfrm>
            <a:off x="4152960" y="3068640"/>
            <a:ext cx="4680" cy="33480"/>
          </a:xfrm>
          <a:custGeom>
            <a:avLst/>
            <a:gdLst>
              <a:gd name="textAreaLeft" fmla="*/ 0 w 4680"/>
              <a:gd name="textAreaRight" fmla="*/ 5040 w 4680"/>
              <a:gd name="textAreaTop" fmla="*/ 0 h 33480"/>
              <a:gd name="textAreaBottom" fmla="*/ 33840 h 33480"/>
            </a:gdLst>
            <a:ahLst/>
            <a:rect l="textAreaLeft" t="textAreaTop" r="textAreaRight" b="textAreaBottom"/>
            <a:pathLst>
              <a:path w="34" h="137">
                <a:moveTo>
                  <a:pt x="34" y="137"/>
                </a:moveTo>
                <a:lnTo>
                  <a:pt x="0" y="137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6" name="Freeform 283"/>
          <p:cNvSpPr/>
          <p:nvPr/>
        </p:nvSpPr>
        <p:spPr>
          <a:xfrm>
            <a:off x="4344840" y="1836720"/>
            <a:ext cx="76320" cy="38160"/>
          </a:xfrm>
          <a:custGeom>
            <a:avLst/>
            <a:gdLst>
              <a:gd name="textAreaLeft" fmla="*/ 0 w 76320"/>
              <a:gd name="textAreaRight" fmla="*/ 76680 w 7632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530" h="160">
                <a:moveTo>
                  <a:pt x="530" y="0"/>
                </a:moveTo>
                <a:lnTo>
                  <a:pt x="0" y="0"/>
                </a:lnTo>
                <a:lnTo>
                  <a:pt x="0" y="16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8280" bIns="-82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7" name="Freeform 284"/>
          <p:cNvSpPr/>
          <p:nvPr/>
        </p:nvSpPr>
        <p:spPr>
          <a:xfrm>
            <a:off x="4025880" y="996840"/>
            <a:ext cx="600120" cy="33480"/>
          </a:xfrm>
          <a:custGeom>
            <a:avLst/>
            <a:gdLst>
              <a:gd name="textAreaLeft" fmla="*/ 0 w 600120"/>
              <a:gd name="textAreaRight" fmla="*/ 600480 w 600120"/>
              <a:gd name="textAreaTop" fmla="*/ 0 h 33480"/>
              <a:gd name="textAreaBottom" fmla="*/ 33840 h 33480"/>
            </a:gdLst>
            <a:ahLst/>
            <a:rect l="textAreaLeft" t="textAreaTop" r="textAreaRight" b="textAreaBottom"/>
            <a:pathLst>
              <a:path w="4162" h="138">
                <a:moveTo>
                  <a:pt x="4162" y="0"/>
                </a:moveTo>
                <a:lnTo>
                  <a:pt x="0" y="0"/>
                </a:lnTo>
                <a:lnTo>
                  <a:pt x="0" y="138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8" name="Freeform 290"/>
          <p:cNvSpPr/>
          <p:nvPr/>
        </p:nvSpPr>
        <p:spPr>
          <a:xfrm>
            <a:off x="3943440" y="3402000"/>
            <a:ext cx="36360" cy="96840"/>
          </a:xfrm>
          <a:custGeom>
            <a:avLst/>
            <a:gdLst>
              <a:gd name="textAreaLeft" fmla="*/ 0 w 36360"/>
              <a:gd name="textAreaRight" fmla="*/ 36720 w 36360"/>
              <a:gd name="textAreaTop" fmla="*/ 0 h 96840"/>
              <a:gd name="textAreaBottom" fmla="*/ 97200 h 96840"/>
            </a:gdLst>
            <a:ahLst/>
            <a:rect l="textAreaLeft" t="textAreaTop" r="textAreaRight" b="textAreaBottom"/>
            <a:pathLst>
              <a:path w="265" h="395">
                <a:moveTo>
                  <a:pt x="265" y="0"/>
                </a:moveTo>
                <a:lnTo>
                  <a:pt x="0" y="0"/>
                </a:lnTo>
                <a:lnTo>
                  <a:pt x="0" y="395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9" name="Freeform 293"/>
          <p:cNvSpPr/>
          <p:nvPr/>
        </p:nvSpPr>
        <p:spPr>
          <a:xfrm>
            <a:off x="4237200" y="2631960"/>
            <a:ext cx="133200" cy="22320"/>
          </a:xfrm>
          <a:custGeom>
            <a:avLst/>
            <a:gdLst>
              <a:gd name="textAreaLeft" fmla="*/ 0 w 133200"/>
              <a:gd name="textAreaRight" fmla="*/ 133560 w 13320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925" h="92">
                <a:moveTo>
                  <a:pt x="925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0" name="Freeform 294"/>
          <p:cNvSpPr/>
          <p:nvPr/>
        </p:nvSpPr>
        <p:spPr>
          <a:xfrm>
            <a:off x="4192560" y="2585880"/>
            <a:ext cx="95400" cy="34920"/>
          </a:xfrm>
          <a:custGeom>
            <a:avLst/>
            <a:gdLst>
              <a:gd name="textAreaLeft" fmla="*/ 0 w 95400"/>
              <a:gd name="textAreaRight" fmla="*/ 95760 w 95400"/>
              <a:gd name="textAreaTop" fmla="*/ 0 h 34920"/>
              <a:gd name="textAreaBottom" fmla="*/ 35280 h 34920"/>
            </a:gdLst>
            <a:ahLst/>
            <a:rect l="textAreaLeft" t="textAreaTop" r="textAreaRight" b="textAreaBottom"/>
            <a:pathLst>
              <a:path w="661" h="138">
                <a:moveTo>
                  <a:pt x="661" y="0"/>
                </a:moveTo>
                <a:lnTo>
                  <a:pt x="0" y="0"/>
                </a:lnTo>
                <a:lnTo>
                  <a:pt x="0" y="138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1520" bIns="-115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1" name="Freeform 295"/>
          <p:cNvSpPr/>
          <p:nvPr/>
        </p:nvSpPr>
        <p:spPr>
          <a:xfrm>
            <a:off x="4238640" y="1378080"/>
            <a:ext cx="25560" cy="21960"/>
          </a:xfrm>
          <a:custGeom>
            <a:avLst/>
            <a:gdLst>
              <a:gd name="textAreaLeft" fmla="*/ 0 w 25560"/>
              <a:gd name="textAreaRight" fmla="*/ 25920 w 25560"/>
              <a:gd name="textAreaTop" fmla="*/ 0 h 21960"/>
              <a:gd name="textAreaBottom" fmla="*/ 22320 h 21960"/>
            </a:gdLst>
            <a:ahLst/>
            <a:rect l="textAreaLeft" t="textAreaTop" r="textAreaRight" b="textAreaBottom"/>
            <a:pathLst>
              <a:path w="171" h="92">
                <a:moveTo>
                  <a:pt x="171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2" name="Freeform 296"/>
          <p:cNvSpPr/>
          <p:nvPr/>
        </p:nvSpPr>
        <p:spPr>
          <a:xfrm>
            <a:off x="4097160" y="2833560"/>
            <a:ext cx="132120" cy="22320"/>
          </a:xfrm>
          <a:custGeom>
            <a:avLst/>
            <a:gdLst>
              <a:gd name="textAreaLeft" fmla="*/ 0 w 132120"/>
              <a:gd name="textAreaRight" fmla="*/ 132480 w 13212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913" h="91">
                <a:moveTo>
                  <a:pt x="913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3" name="Freeform 300"/>
          <p:cNvSpPr/>
          <p:nvPr/>
        </p:nvSpPr>
        <p:spPr>
          <a:xfrm>
            <a:off x="4441680" y="1982880"/>
            <a:ext cx="65160" cy="21960"/>
          </a:xfrm>
          <a:custGeom>
            <a:avLst/>
            <a:gdLst>
              <a:gd name="textAreaLeft" fmla="*/ 0 w 65160"/>
              <a:gd name="textAreaRight" fmla="*/ 65520 w 65160"/>
              <a:gd name="textAreaTop" fmla="*/ 0 h 21960"/>
              <a:gd name="textAreaBottom" fmla="*/ 22320 h 21960"/>
            </a:gdLst>
            <a:ahLst/>
            <a:rect l="textAreaLeft" t="textAreaTop" r="textAreaRight" b="textAreaBottom"/>
            <a:pathLst>
              <a:path w="462" h="92">
                <a:moveTo>
                  <a:pt x="462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4" name="Freeform 307"/>
          <p:cNvSpPr/>
          <p:nvPr/>
        </p:nvSpPr>
        <p:spPr>
          <a:xfrm>
            <a:off x="4002120" y="1290600"/>
            <a:ext cx="130320" cy="108000"/>
          </a:xfrm>
          <a:custGeom>
            <a:avLst/>
            <a:gdLst>
              <a:gd name="textAreaLeft" fmla="*/ 0 w 130320"/>
              <a:gd name="textAreaRight" fmla="*/ 130680 w 130320"/>
              <a:gd name="textAreaTop" fmla="*/ 0 h 108000"/>
              <a:gd name="textAreaBottom" fmla="*/ 108360 h 108000"/>
            </a:gdLst>
            <a:ahLst/>
            <a:rect l="textAreaLeft" t="textAreaTop" r="textAreaRight" b="textAreaBottom"/>
            <a:pathLst>
              <a:path w="897" h="441">
                <a:moveTo>
                  <a:pt x="897" y="0"/>
                </a:moveTo>
                <a:lnTo>
                  <a:pt x="0" y="0"/>
                </a:lnTo>
                <a:lnTo>
                  <a:pt x="0" y="44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5" name="Freeform 308"/>
          <p:cNvSpPr/>
          <p:nvPr/>
        </p:nvSpPr>
        <p:spPr>
          <a:xfrm>
            <a:off x="4218120" y="1131840"/>
            <a:ext cx="34920" cy="33480"/>
          </a:xfrm>
          <a:custGeom>
            <a:avLst/>
            <a:gdLst>
              <a:gd name="textAreaLeft" fmla="*/ 0 w 34920"/>
              <a:gd name="textAreaRight" fmla="*/ 35280 w 34920"/>
              <a:gd name="textAreaTop" fmla="*/ 0 h 33480"/>
              <a:gd name="textAreaBottom" fmla="*/ 33840 h 33480"/>
            </a:gdLst>
            <a:ahLst/>
            <a:rect l="textAreaLeft" t="textAreaTop" r="textAreaRight" b="textAreaBottom"/>
            <a:pathLst>
              <a:path w="235" h="137">
                <a:moveTo>
                  <a:pt x="235" y="0"/>
                </a:moveTo>
                <a:lnTo>
                  <a:pt x="0" y="0"/>
                </a:lnTo>
                <a:lnTo>
                  <a:pt x="0" y="137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6" name="Freeform 311"/>
          <p:cNvSpPr/>
          <p:nvPr/>
        </p:nvSpPr>
        <p:spPr>
          <a:xfrm>
            <a:off x="4700520" y="571680"/>
            <a:ext cx="146160" cy="21960"/>
          </a:xfrm>
          <a:custGeom>
            <a:avLst/>
            <a:gdLst>
              <a:gd name="textAreaLeft" fmla="*/ 0 w 146160"/>
              <a:gd name="textAreaRight" fmla="*/ 146520 w 146160"/>
              <a:gd name="textAreaTop" fmla="*/ 0 h 21960"/>
              <a:gd name="textAreaBottom" fmla="*/ 22320 h 21960"/>
            </a:gdLst>
            <a:ahLst/>
            <a:rect l="textAreaLeft" t="textAreaTop" r="textAreaRight" b="textAreaBottom"/>
            <a:pathLst>
              <a:path w="1016" h="91">
                <a:moveTo>
                  <a:pt x="1016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7" name="Freeform 312"/>
          <p:cNvSpPr/>
          <p:nvPr/>
        </p:nvSpPr>
        <p:spPr>
          <a:xfrm>
            <a:off x="4219560" y="2519280"/>
            <a:ext cx="57240" cy="22320"/>
          </a:xfrm>
          <a:custGeom>
            <a:avLst/>
            <a:gdLst>
              <a:gd name="textAreaLeft" fmla="*/ 0 w 57240"/>
              <a:gd name="textAreaRight" fmla="*/ 57600 w 5724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396" h="91">
                <a:moveTo>
                  <a:pt x="396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8" name="Freeform 316"/>
          <p:cNvSpPr/>
          <p:nvPr/>
        </p:nvSpPr>
        <p:spPr>
          <a:xfrm>
            <a:off x="4564080" y="2093760"/>
            <a:ext cx="25560" cy="24120"/>
          </a:xfrm>
          <a:custGeom>
            <a:avLst/>
            <a:gdLst>
              <a:gd name="textAreaLeft" fmla="*/ 0 w 25560"/>
              <a:gd name="textAreaRight" fmla="*/ 25920 w 25560"/>
              <a:gd name="textAreaTop" fmla="*/ 0 h 24120"/>
              <a:gd name="textAreaBottom" fmla="*/ 24480 h 24120"/>
            </a:gdLst>
            <a:ahLst/>
            <a:rect l="textAreaLeft" t="textAreaTop" r="textAreaRight" b="textAreaBottom"/>
            <a:pathLst>
              <a:path w="179" h="92">
                <a:moveTo>
                  <a:pt x="179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2320" bIns="-223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9" name="Freeform 320"/>
          <p:cNvSpPr/>
          <p:nvPr/>
        </p:nvSpPr>
        <p:spPr>
          <a:xfrm>
            <a:off x="4097160" y="3303720"/>
            <a:ext cx="144720" cy="21960"/>
          </a:xfrm>
          <a:custGeom>
            <a:avLst/>
            <a:gdLst>
              <a:gd name="textAreaLeft" fmla="*/ 0 w 144720"/>
              <a:gd name="textAreaRight" fmla="*/ 145080 w 144720"/>
              <a:gd name="textAreaTop" fmla="*/ 0 h 21960"/>
              <a:gd name="textAreaBottom" fmla="*/ 22320 h 21960"/>
            </a:gdLst>
            <a:ahLst/>
            <a:rect l="textAreaLeft" t="textAreaTop" r="textAreaRight" b="textAreaBottom"/>
            <a:pathLst>
              <a:path w="1008" h="92">
                <a:moveTo>
                  <a:pt x="1008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0" name="Freeform 324"/>
          <p:cNvSpPr/>
          <p:nvPr/>
        </p:nvSpPr>
        <p:spPr>
          <a:xfrm>
            <a:off x="4478400" y="525600"/>
            <a:ext cx="293760" cy="34920"/>
          </a:xfrm>
          <a:custGeom>
            <a:avLst/>
            <a:gdLst>
              <a:gd name="textAreaLeft" fmla="*/ 0 w 293760"/>
              <a:gd name="textAreaRight" fmla="*/ 294120 w 293760"/>
              <a:gd name="textAreaTop" fmla="*/ 0 h 34920"/>
              <a:gd name="textAreaBottom" fmla="*/ 35280 h 34920"/>
            </a:gdLst>
            <a:ahLst/>
            <a:rect l="textAreaLeft" t="textAreaTop" r="textAreaRight" b="textAreaBottom"/>
            <a:pathLst>
              <a:path w="2034" h="137">
                <a:moveTo>
                  <a:pt x="2034" y="0"/>
                </a:moveTo>
                <a:lnTo>
                  <a:pt x="0" y="0"/>
                </a:lnTo>
                <a:lnTo>
                  <a:pt x="0" y="137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1520" bIns="-115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1" name="Freeform 326"/>
          <p:cNvSpPr/>
          <p:nvPr/>
        </p:nvSpPr>
        <p:spPr>
          <a:xfrm>
            <a:off x="3895560" y="1430280"/>
            <a:ext cx="222480" cy="216000"/>
          </a:xfrm>
          <a:custGeom>
            <a:avLst/>
            <a:gdLst>
              <a:gd name="textAreaLeft" fmla="*/ 0 w 222480"/>
              <a:gd name="textAreaRight" fmla="*/ 222840 w 222480"/>
              <a:gd name="textAreaTop" fmla="*/ 0 h 216000"/>
              <a:gd name="textAreaBottom" fmla="*/ 216360 h 216000"/>
            </a:gdLst>
            <a:ahLst/>
            <a:rect l="textAreaLeft" t="textAreaTop" r="textAreaRight" b="textAreaBottom"/>
            <a:pathLst>
              <a:path w="1546" h="883">
                <a:moveTo>
                  <a:pt x="1546" y="883"/>
                </a:moveTo>
                <a:lnTo>
                  <a:pt x="0" y="883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2" name="Freeform 327"/>
          <p:cNvSpPr/>
          <p:nvPr/>
        </p:nvSpPr>
        <p:spPr>
          <a:xfrm>
            <a:off x="4070520" y="3224160"/>
            <a:ext cx="174600" cy="34920"/>
          </a:xfrm>
          <a:custGeom>
            <a:avLst/>
            <a:gdLst>
              <a:gd name="textAreaLeft" fmla="*/ 0 w 174600"/>
              <a:gd name="textAreaRight" fmla="*/ 174960 w 174600"/>
              <a:gd name="textAreaTop" fmla="*/ 0 h 34920"/>
              <a:gd name="textAreaBottom" fmla="*/ 35280 h 34920"/>
            </a:gdLst>
            <a:ahLst/>
            <a:rect l="textAreaLeft" t="textAreaTop" r="textAreaRight" b="textAreaBottom"/>
            <a:pathLst>
              <a:path w="1212" h="137">
                <a:moveTo>
                  <a:pt x="1212" y="137"/>
                </a:moveTo>
                <a:lnTo>
                  <a:pt x="0" y="137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1520" bIns="-115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3" name="Freeform 329"/>
          <p:cNvSpPr/>
          <p:nvPr/>
        </p:nvSpPr>
        <p:spPr>
          <a:xfrm>
            <a:off x="4057560" y="2467080"/>
            <a:ext cx="69840" cy="102960"/>
          </a:xfrm>
          <a:custGeom>
            <a:avLst/>
            <a:gdLst>
              <a:gd name="textAreaLeft" fmla="*/ 0 w 69840"/>
              <a:gd name="textAreaRight" fmla="*/ 70200 w 69840"/>
              <a:gd name="textAreaTop" fmla="*/ 0 h 102960"/>
              <a:gd name="textAreaBottom" fmla="*/ 103320 h 102960"/>
            </a:gdLst>
            <a:ahLst/>
            <a:rect l="textAreaLeft" t="textAreaTop" r="textAreaRight" b="textAreaBottom"/>
            <a:pathLst>
              <a:path w="485" h="424">
                <a:moveTo>
                  <a:pt x="485" y="424"/>
                </a:moveTo>
                <a:lnTo>
                  <a:pt x="0" y="424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4" name="Freeform 330"/>
          <p:cNvSpPr/>
          <p:nvPr/>
        </p:nvSpPr>
        <p:spPr>
          <a:xfrm>
            <a:off x="3943440" y="2521080"/>
            <a:ext cx="38160" cy="352440"/>
          </a:xfrm>
          <a:custGeom>
            <a:avLst/>
            <a:gdLst>
              <a:gd name="textAreaLeft" fmla="*/ 0 w 38160"/>
              <a:gd name="textAreaRight" fmla="*/ 38520 w 38160"/>
              <a:gd name="textAreaTop" fmla="*/ 0 h 352440"/>
              <a:gd name="textAreaBottom" fmla="*/ 352800 h 352440"/>
            </a:gdLst>
            <a:ahLst/>
            <a:rect l="textAreaLeft" t="textAreaTop" r="textAreaRight" b="textAreaBottom"/>
            <a:pathLst>
              <a:path w="274" h="1442">
                <a:moveTo>
                  <a:pt x="274" y="1442"/>
                </a:moveTo>
                <a:lnTo>
                  <a:pt x="0" y="144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5" name="Freeform 332"/>
          <p:cNvSpPr/>
          <p:nvPr/>
        </p:nvSpPr>
        <p:spPr>
          <a:xfrm>
            <a:off x="4152960" y="3033720"/>
            <a:ext cx="27000" cy="34920"/>
          </a:xfrm>
          <a:custGeom>
            <a:avLst/>
            <a:gdLst>
              <a:gd name="textAreaLeft" fmla="*/ 0 w 27000"/>
              <a:gd name="textAreaRight" fmla="*/ 27360 w 27000"/>
              <a:gd name="textAreaTop" fmla="*/ 0 h 34920"/>
              <a:gd name="textAreaBottom" fmla="*/ 35280 h 34920"/>
            </a:gdLst>
            <a:ahLst/>
            <a:rect l="textAreaLeft" t="textAreaTop" r="textAreaRight" b="textAreaBottom"/>
            <a:pathLst>
              <a:path w="185" h="138">
                <a:moveTo>
                  <a:pt x="185" y="0"/>
                </a:moveTo>
                <a:lnTo>
                  <a:pt x="0" y="0"/>
                </a:lnTo>
                <a:lnTo>
                  <a:pt x="0" y="138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1520" bIns="-115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6" name="Freeform 333"/>
          <p:cNvSpPr/>
          <p:nvPr/>
        </p:nvSpPr>
        <p:spPr>
          <a:xfrm>
            <a:off x="4065480" y="1736640"/>
            <a:ext cx="682560" cy="135000"/>
          </a:xfrm>
          <a:custGeom>
            <a:avLst/>
            <a:gdLst>
              <a:gd name="textAreaLeft" fmla="*/ 0 w 682560"/>
              <a:gd name="textAreaRight" fmla="*/ 682920 w 682560"/>
              <a:gd name="textAreaTop" fmla="*/ 0 h 135000"/>
              <a:gd name="textAreaBottom" fmla="*/ 135360 h 135000"/>
            </a:gdLst>
            <a:ahLst/>
            <a:rect l="textAreaLeft" t="textAreaTop" r="textAreaRight" b="textAreaBottom"/>
            <a:pathLst>
              <a:path w="4738" h="552">
                <a:moveTo>
                  <a:pt x="4738" y="0"/>
                </a:moveTo>
                <a:lnTo>
                  <a:pt x="0" y="0"/>
                </a:lnTo>
                <a:lnTo>
                  <a:pt x="0" y="55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7" name="Freeform 334"/>
          <p:cNvSpPr/>
          <p:nvPr/>
        </p:nvSpPr>
        <p:spPr>
          <a:xfrm>
            <a:off x="4441680" y="1959120"/>
            <a:ext cx="68400" cy="23760"/>
          </a:xfrm>
          <a:custGeom>
            <a:avLst/>
            <a:gdLst>
              <a:gd name="textAreaLeft" fmla="*/ 0 w 68400"/>
              <a:gd name="textAreaRight" fmla="*/ 68760 w 68400"/>
              <a:gd name="textAreaTop" fmla="*/ 0 h 23760"/>
              <a:gd name="textAreaBottom" fmla="*/ 24120 h 23760"/>
            </a:gdLst>
            <a:ahLst/>
            <a:rect l="textAreaLeft" t="textAreaTop" r="textAreaRight" b="textAreaBottom"/>
            <a:pathLst>
              <a:path w="471" h="91">
                <a:moveTo>
                  <a:pt x="471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8" name="Freeform 335"/>
          <p:cNvSpPr/>
          <p:nvPr/>
        </p:nvSpPr>
        <p:spPr>
          <a:xfrm>
            <a:off x="4189320" y="3790800"/>
            <a:ext cx="201600" cy="39960"/>
          </a:xfrm>
          <a:custGeom>
            <a:avLst/>
            <a:gdLst>
              <a:gd name="textAreaLeft" fmla="*/ 0 w 201600"/>
              <a:gd name="textAreaRight" fmla="*/ 201960 w 201600"/>
              <a:gd name="textAreaTop" fmla="*/ 0 h 39960"/>
              <a:gd name="textAreaBottom" fmla="*/ 40320 h 39960"/>
            </a:gdLst>
            <a:ahLst/>
            <a:rect l="textAreaLeft" t="textAreaTop" r="textAreaRight" b="textAreaBottom"/>
            <a:pathLst>
              <a:path w="1391" h="161">
                <a:moveTo>
                  <a:pt x="1391" y="161"/>
                </a:moveTo>
                <a:lnTo>
                  <a:pt x="0" y="16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9" name="Freeform 336"/>
          <p:cNvSpPr/>
          <p:nvPr/>
        </p:nvSpPr>
        <p:spPr>
          <a:xfrm>
            <a:off x="4387680" y="771480"/>
            <a:ext cx="33480" cy="79560"/>
          </a:xfrm>
          <a:custGeom>
            <a:avLst/>
            <a:gdLst>
              <a:gd name="textAreaLeft" fmla="*/ 0 w 33480"/>
              <a:gd name="textAreaRight" fmla="*/ 33840 w 33480"/>
              <a:gd name="textAreaTop" fmla="*/ 0 h 79560"/>
              <a:gd name="textAreaBottom" fmla="*/ 79920 h 79560"/>
            </a:gdLst>
            <a:ahLst/>
            <a:rect l="textAreaLeft" t="textAreaTop" r="textAreaRight" b="textAreaBottom"/>
            <a:pathLst>
              <a:path w="243" h="321">
                <a:moveTo>
                  <a:pt x="243" y="0"/>
                </a:moveTo>
                <a:lnTo>
                  <a:pt x="0" y="0"/>
                </a:lnTo>
                <a:lnTo>
                  <a:pt x="0" y="32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3120" bIns="33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0" name="Freeform 339"/>
          <p:cNvSpPr/>
          <p:nvPr/>
        </p:nvSpPr>
        <p:spPr>
          <a:xfrm>
            <a:off x="4390920" y="2082960"/>
            <a:ext cx="173160" cy="34920"/>
          </a:xfrm>
          <a:custGeom>
            <a:avLst/>
            <a:gdLst>
              <a:gd name="textAreaLeft" fmla="*/ 0 w 173160"/>
              <a:gd name="textAreaRight" fmla="*/ 173520 w 173160"/>
              <a:gd name="textAreaTop" fmla="*/ 0 h 34920"/>
              <a:gd name="textAreaBottom" fmla="*/ 35280 h 34920"/>
            </a:gdLst>
            <a:ahLst/>
            <a:rect l="textAreaLeft" t="textAreaTop" r="textAreaRight" b="textAreaBottom"/>
            <a:pathLst>
              <a:path w="1186" h="138">
                <a:moveTo>
                  <a:pt x="1186" y="138"/>
                </a:moveTo>
                <a:lnTo>
                  <a:pt x="0" y="138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1520" bIns="-115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1" name="Freeform 343"/>
          <p:cNvSpPr/>
          <p:nvPr/>
        </p:nvSpPr>
        <p:spPr>
          <a:xfrm>
            <a:off x="4475160" y="3863880"/>
            <a:ext cx="252360" cy="22320"/>
          </a:xfrm>
          <a:custGeom>
            <a:avLst/>
            <a:gdLst>
              <a:gd name="textAreaLeft" fmla="*/ 0 w 252360"/>
              <a:gd name="textAreaRight" fmla="*/ 252720 w 25236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1745" h="92">
                <a:moveTo>
                  <a:pt x="1745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2" name="Freeform 344"/>
          <p:cNvSpPr/>
          <p:nvPr/>
        </p:nvSpPr>
        <p:spPr>
          <a:xfrm>
            <a:off x="4421160" y="1836720"/>
            <a:ext cx="127080" cy="33480"/>
          </a:xfrm>
          <a:custGeom>
            <a:avLst/>
            <a:gdLst>
              <a:gd name="textAreaLeft" fmla="*/ 0 w 127080"/>
              <a:gd name="textAreaRight" fmla="*/ 127440 w 127080"/>
              <a:gd name="textAreaTop" fmla="*/ 0 h 33480"/>
              <a:gd name="textAreaBottom" fmla="*/ 33840 h 33480"/>
            </a:gdLst>
            <a:ahLst/>
            <a:rect l="textAreaLeft" t="textAreaTop" r="textAreaRight" b="textAreaBottom"/>
            <a:pathLst>
              <a:path w="877" h="137">
                <a:moveTo>
                  <a:pt x="877" y="137"/>
                </a:moveTo>
                <a:lnTo>
                  <a:pt x="0" y="137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3" name="Freeform 348"/>
          <p:cNvSpPr/>
          <p:nvPr/>
        </p:nvSpPr>
        <p:spPr>
          <a:xfrm>
            <a:off x="4200480" y="3505320"/>
            <a:ext cx="150840" cy="21960"/>
          </a:xfrm>
          <a:custGeom>
            <a:avLst/>
            <a:gdLst>
              <a:gd name="textAreaLeft" fmla="*/ 0 w 150840"/>
              <a:gd name="textAreaRight" fmla="*/ 151200 w 150840"/>
              <a:gd name="textAreaTop" fmla="*/ 0 h 21960"/>
              <a:gd name="textAreaBottom" fmla="*/ 22320 h 21960"/>
            </a:gdLst>
            <a:ahLst/>
            <a:rect l="textAreaLeft" t="textAreaTop" r="textAreaRight" b="textAreaBottom"/>
            <a:pathLst>
              <a:path w="1047" h="91">
                <a:moveTo>
                  <a:pt x="1047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4" name="Freeform 349"/>
          <p:cNvSpPr/>
          <p:nvPr/>
        </p:nvSpPr>
        <p:spPr>
          <a:xfrm>
            <a:off x="4390920" y="3795840"/>
            <a:ext cx="420840" cy="34920"/>
          </a:xfrm>
          <a:custGeom>
            <a:avLst/>
            <a:gdLst>
              <a:gd name="textAreaLeft" fmla="*/ 0 w 420840"/>
              <a:gd name="textAreaRight" fmla="*/ 421200 w 420840"/>
              <a:gd name="textAreaTop" fmla="*/ 0 h 34920"/>
              <a:gd name="textAreaBottom" fmla="*/ 35280 h 34920"/>
            </a:gdLst>
            <a:ahLst/>
            <a:rect l="textAreaLeft" t="textAreaTop" r="textAreaRight" b="textAreaBottom"/>
            <a:pathLst>
              <a:path w="2917" h="138">
                <a:moveTo>
                  <a:pt x="2917" y="0"/>
                </a:moveTo>
                <a:lnTo>
                  <a:pt x="0" y="0"/>
                </a:lnTo>
                <a:lnTo>
                  <a:pt x="0" y="138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1520" bIns="-115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5" name="Freeform 351"/>
          <p:cNvSpPr/>
          <p:nvPr/>
        </p:nvSpPr>
        <p:spPr>
          <a:xfrm>
            <a:off x="3943440" y="3498840"/>
            <a:ext cx="233280" cy="95400"/>
          </a:xfrm>
          <a:custGeom>
            <a:avLst/>
            <a:gdLst>
              <a:gd name="textAreaLeft" fmla="*/ 0 w 233280"/>
              <a:gd name="textAreaRight" fmla="*/ 233640 w 233280"/>
              <a:gd name="textAreaTop" fmla="*/ 0 h 95400"/>
              <a:gd name="textAreaBottom" fmla="*/ 95760 h 95400"/>
            </a:gdLst>
            <a:ahLst/>
            <a:rect l="textAreaLeft" t="textAreaTop" r="textAreaRight" b="textAreaBottom"/>
            <a:pathLst>
              <a:path w="1626" h="395">
                <a:moveTo>
                  <a:pt x="1626" y="395"/>
                </a:moveTo>
                <a:lnTo>
                  <a:pt x="0" y="395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6" name="Freeform 352"/>
          <p:cNvSpPr/>
          <p:nvPr/>
        </p:nvSpPr>
        <p:spPr>
          <a:xfrm>
            <a:off x="4173480" y="2967120"/>
            <a:ext cx="15840" cy="23760"/>
          </a:xfrm>
          <a:custGeom>
            <a:avLst/>
            <a:gdLst>
              <a:gd name="textAreaLeft" fmla="*/ 0 w 15840"/>
              <a:gd name="textAreaRight" fmla="*/ 16200 w 15840"/>
              <a:gd name="textAreaTop" fmla="*/ 0 h 23760"/>
              <a:gd name="textAreaBottom" fmla="*/ 24120 h 23760"/>
            </a:gdLst>
            <a:ahLst/>
            <a:rect l="textAreaLeft" t="textAreaTop" r="textAreaRight" b="textAreaBottom"/>
            <a:pathLst>
              <a:path w="125" h="92">
                <a:moveTo>
                  <a:pt x="125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7" name="Freeform 354"/>
          <p:cNvSpPr/>
          <p:nvPr/>
        </p:nvSpPr>
        <p:spPr>
          <a:xfrm>
            <a:off x="4255920" y="2273400"/>
            <a:ext cx="268560" cy="66600"/>
          </a:xfrm>
          <a:custGeom>
            <a:avLst/>
            <a:gdLst>
              <a:gd name="textAreaLeft" fmla="*/ 0 w 268560"/>
              <a:gd name="textAreaRight" fmla="*/ 268920 w 268560"/>
              <a:gd name="textAreaTop" fmla="*/ 0 h 66600"/>
              <a:gd name="textAreaBottom" fmla="*/ 66960 h 66600"/>
            </a:gdLst>
            <a:ahLst/>
            <a:rect l="textAreaLeft" t="textAreaTop" r="textAreaRight" b="textAreaBottom"/>
            <a:pathLst>
              <a:path w="1853" h="275">
                <a:moveTo>
                  <a:pt x="1853" y="275"/>
                </a:moveTo>
                <a:lnTo>
                  <a:pt x="0" y="275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8" name="Freeform 355"/>
          <p:cNvSpPr/>
          <p:nvPr/>
        </p:nvSpPr>
        <p:spPr>
          <a:xfrm>
            <a:off x="3281400" y="4838760"/>
            <a:ext cx="165240" cy="2819520"/>
          </a:xfrm>
          <a:custGeom>
            <a:avLst/>
            <a:gdLst>
              <a:gd name="textAreaLeft" fmla="*/ 0 w 165240"/>
              <a:gd name="textAreaRight" fmla="*/ 165600 w 165240"/>
              <a:gd name="textAreaTop" fmla="*/ 0 h 2819520"/>
              <a:gd name="textAreaBottom" fmla="*/ 2819880 h 2819520"/>
            </a:gdLst>
            <a:ahLst/>
            <a:rect l="textAreaLeft" t="textAreaTop" r="textAreaRight" b="textAreaBottom"/>
            <a:pathLst>
              <a:path w="1148" h="9841">
                <a:moveTo>
                  <a:pt x="1148" y="9841"/>
                </a:moveTo>
                <a:lnTo>
                  <a:pt x="0" y="984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9" name="Freeform 356"/>
          <p:cNvSpPr/>
          <p:nvPr/>
        </p:nvSpPr>
        <p:spPr>
          <a:xfrm>
            <a:off x="4070520" y="3192480"/>
            <a:ext cx="323640" cy="31680"/>
          </a:xfrm>
          <a:custGeom>
            <a:avLst/>
            <a:gdLst>
              <a:gd name="textAreaLeft" fmla="*/ 0 w 323640"/>
              <a:gd name="textAreaRight" fmla="*/ 324000 w 323640"/>
              <a:gd name="textAreaTop" fmla="*/ 0 h 31680"/>
              <a:gd name="textAreaBottom" fmla="*/ 32040 h 31680"/>
            </a:gdLst>
            <a:ahLst/>
            <a:rect l="textAreaLeft" t="textAreaTop" r="textAreaRight" b="textAreaBottom"/>
            <a:pathLst>
              <a:path w="2239" h="138">
                <a:moveTo>
                  <a:pt x="2239" y="0"/>
                </a:moveTo>
                <a:lnTo>
                  <a:pt x="0" y="0"/>
                </a:lnTo>
                <a:lnTo>
                  <a:pt x="0" y="138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0" name="Freeform 357"/>
          <p:cNvSpPr/>
          <p:nvPr/>
        </p:nvSpPr>
        <p:spPr>
          <a:xfrm>
            <a:off x="3984480" y="2168640"/>
            <a:ext cx="73080" cy="298440"/>
          </a:xfrm>
          <a:custGeom>
            <a:avLst/>
            <a:gdLst>
              <a:gd name="textAreaLeft" fmla="*/ 0 w 73080"/>
              <a:gd name="textAreaRight" fmla="*/ 73440 w 73080"/>
              <a:gd name="textAreaTop" fmla="*/ 0 h 298440"/>
              <a:gd name="textAreaBottom" fmla="*/ 298440 h 298440"/>
            </a:gdLst>
            <a:ahLst/>
            <a:rect l="textAreaLeft" t="textAreaTop" r="textAreaRight" b="textAreaBottom"/>
            <a:pathLst>
              <a:path w="511" h="1218">
                <a:moveTo>
                  <a:pt x="511" y="1218"/>
                </a:moveTo>
                <a:lnTo>
                  <a:pt x="0" y="1218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1" name="Freeform 362"/>
          <p:cNvSpPr/>
          <p:nvPr/>
        </p:nvSpPr>
        <p:spPr>
          <a:xfrm>
            <a:off x="4218120" y="1165320"/>
            <a:ext cx="150840" cy="33120"/>
          </a:xfrm>
          <a:custGeom>
            <a:avLst/>
            <a:gdLst>
              <a:gd name="textAreaLeft" fmla="*/ 0 w 150840"/>
              <a:gd name="textAreaRight" fmla="*/ 151200 w 150840"/>
              <a:gd name="textAreaTop" fmla="*/ 0 h 33120"/>
              <a:gd name="textAreaBottom" fmla="*/ 33480 h 33120"/>
            </a:gdLst>
            <a:ahLst/>
            <a:rect l="textAreaLeft" t="textAreaTop" r="textAreaRight" b="textAreaBottom"/>
            <a:pathLst>
              <a:path w="1042" h="137">
                <a:moveTo>
                  <a:pt x="1042" y="137"/>
                </a:moveTo>
                <a:lnTo>
                  <a:pt x="0" y="137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2" name="Freeform 365"/>
          <p:cNvSpPr/>
          <p:nvPr/>
        </p:nvSpPr>
        <p:spPr>
          <a:xfrm>
            <a:off x="4700520" y="593640"/>
            <a:ext cx="93600" cy="22320"/>
          </a:xfrm>
          <a:custGeom>
            <a:avLst/>
            <a:gdLst>
              <a:gd name="textAreaLeft" fmla="*/ 0 w 93600"/>
              <a:gd name="textAreaRight" fmla="*/ 93960 w 9360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653" h="92">
                <a:moveTo>
                  <a:pt x="653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3" name="Freeform 367"/>
          <p:cNvSpPr/>
          <p:nvPr/>
        </p:nvSpPr>
        <p:spPr>
          <a:xfrm>
            <a:off x="4097160" y="2363760"/>
            <a:ext cx="120960" cy="88920"/>
          </a:xfrm>
          <a:custGeom>
            <a:avLst/>
            <a:gdLst>
              <a:gd name="textAreaLeft" fmla="*/ 0 w 120960"/>
              <a:gd name="textAreaRight" fmla="*/ 121320 w 120960"/>
              <a:gd name="textAreaTop" fmla="*/ 0 h 88920"/>
              <a:gd name="textAreaBottom" fmla="*/ 89280 h 88920"/>
            </a:gdLst>
            <a:ahLst/>
            <a:rect l="textAreaLeft" t="textAreaTop" r="textAreaRight" b="textAreaBottom"/>
            <a:pathLst>
              <a:path w="846" h="367">
                <a:moveTo>
                  <a:pt x="846" y="367"/>
                </a:moveTo>
                <a:lnTo>
                  <a:pt x="0" y="367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2480" bIns="424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4" name="Freeform 368"/>
          <p:cNvSpPr/>
          <p:nvPr/>
        </p:nvSpPr>
        <p:spPr>
          <a:xfrm>
            <a:off x="4176720" y="3594240"/>
            <a:ext cx="58680" cy="23760"/>
          </a:xfrm>
          <a:custGeom>
            <a:avLst/>
            <a:gdLst>
              <a:gd name="textAreaLeft" fmla="*/ 0 w 58680"/>
              <a:gd name="textAreaRight" fmla="*/ 59040 w 58680"/>
              <a:gd name="textAreaTop" fmla="*/ 0 h 23760"/>
              <a:gd name="textAreaBottom" fmla="*/ 24120 h 23760"/>
            </a:gdLst>
            <a:ahLst/>
            <a:rect l="textAreaLeft" t="textAreaTop" r="textAreaRight" b="textAreaBottom"/>
            <a:pathLst>
              <a:path w="411" h="92">
                <a:moveTo>
                  <a:pt x="411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5" name="Rectangle 370"/>
          <p:cNvSpPr/>
          <p:nvPr/>
        </p:nvSpPr>
        <p:spPr>
          <a:xfrm>
            <a:off x="4372200" y="1128600"/>
            <a:ext cx="1501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LjRbohC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6" name="Rectangle 374"/>
          <p:cNvSpPr/>
          <p:nvPr/>
        </p:nvSpPr>
        <p:spPr>
          <a:xfrm>
            <a:off x="4210920" y="1038240"/>
            <a:ext cx="1666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Cpa48.86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7" name="Rectangle 375"/>
          <p:cNvSpPr/>
          <p:nvPr/>
        </p:nvSpPr>
        <p:spPr>
          <a:xfrm>
            <a:off x="4321800" y="1263600"/>
            <a:ext cx="2826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Glyma20g3800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8" name="Rectangle 376"/>
          <p:cNvSpPr/>
          <p:nvPr/>
        </p:nvSpPr>
        <p:spPr>
          <a:xfrm>
            <a:off x="4563360" y="816120"/>
            <a:ext cx="2401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Sb03g01443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9" name="Rectangle 380"/>
          <p:cNvSpPr/>
          <p:nvPr/>
        </p:nvSpPr>
        <p:spPr>
          <a:xfrm>
            <a:off x="4760640" y="2382840"/>
            <a:ext cx="1836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Aly495172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0" name="Rectangle 381"/>
          <p:cNvSpPr/>
          <p:nvPr/>
        </p:nvSpPr>
        <p:spPr>
          <a:xfrm>
            <a:off x="4462560" y="2739960"/>
            <a:ext cx="2354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Mgu004629m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1" name="Rectangle 385"/>
          <p:cNvSpPr/>
          <p:nvPr/>
        </p:nvSpPr>
        <p:spPr>
          <a:xfrm>
            <a:off x="4219200" y="1531800"/>
            <a:ext cx="3466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Rco30128.m008818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2" name="Rectangle 389"/>
          <p:cNvSpPr/>
          <p:nvPr/>
        </p:nvSpPr>
        <p:spPr>
          <a:xfrm>
            <a:off x="4303440" y="2471760"/>
            <a:ext cx="2613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Ptr0015s1213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3" name="Rectangle 390"/>
          <p:cNvSpPr/>
          <p:nvPr/>
        </p:nvSpPr>
        <p:spPr>
          <a:xfrm>
            <a:off x="4981320" y="1800360"/>
            <a:ext cx="1623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ff0000"/>
                </a:solidFill>
                <a:latin typeface="Arial"/>
              </a:rPr>
              <a:t>MtRbohC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4" name="Rectangle 394"/>
          <p:cNvSpPr/>
          <p:nvPr/>
        </p:nvSpPr>
        <p:spPr>
          <a:xfrm>
            <a:off x="4719960" y="1084320"/>
            <a:ext cx="1486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LjRbohE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5" name="Rectangle 397"/>
          <p:cNvSpPr/>
          <p:nvPr/>
        </p:nvSpPr>
        <p:spPr>
          <a:xfrm>
            <a:off x="4265280" y="3367080"/>
            <a:ext cx="2613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Ptr0001s1265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6" name="Rectangle 399"/>
          <p:cNvSpPr/>
          <p:nvPr/>
        </p:nvSpPr>
        <p:spPr>
          <a:xfrm>
            <a:off x="4694040" y="949320"/>
            <a:ext cx="1548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AtRbohB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7" name="Freeform 17"/>
          <p:cNvSpPr/>
          <p:nvPr/>
        </p:nvSpPr>
        <p:spPr>
          <a:xfrm>
            <a:off x="3281400" y="5024520"/>
            <a:ext cx="139680" cy="164880"/>
          </a:xfrm>
          <a:custGeom>
            <a:avLst/>
            <a:gdLst>
              <a:gd name="textAreaLeft" fmla="*/ 0 w 139680"/>
              <a:gd name="textAreaRight" fmla="*/ 140040 w 139680"/>
              <a:gd name="textAreaTop" fmla="*/ 0 h 164880"/>
              <a:gd name="textAreaBottom" fmla="*/ 165240 h 164880"/>
            </a:gdLst>
            <a:ahLst/>
            <a:rect l="textAreaLeft" t="textAreaTop" r="textAreaRight" b="textAreaBottom"/>
            <a:pathLst>
              <a:path w="971" h="669">
                <a:moveTo>
                  <a:pt x="971" y="669"/>
                </a:moveTo>
                <a:lnTo>
                  <a:pt x="0" y="669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8" name="Rectangle 727"/>
          <p:cNvSpPr/>
          <p:nvPr/>
        </p:nvSpPr>
        <p:spPr>
          <a:xfrm>
            <a:off x="3294720" y="481320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69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9" name="Rectangle à coins arrondis 745"/>
          <p:cNvSpPr/>
          <p:nvPr/>
        </p:nvSpPr>
        <p:spPr>
          <a:xfrm>
            <a:off x="4025880" y="7340760"/>
            <a:ext cx="2108160" cy="1242720"/>
          </a:xfrm>
          <a:prstGeom prst="roundRect">
            <a:avLst>
              <a:gd name="adj" fmla="val 16667"/>
            </a:avLst>
          </a:prstGeom>
          <a:solidFill>
            <a:srgbClr val="0070c0">
              <a:alpha val="41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5160" rIns="65160" tIns="32760" bIns="327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0" name="Rectangle 407"/>
          <p:cNvSpPr/>
          <p:nvPr/>
        </p:nvSpPr>
        <p:spPr>
          <a:xfrm>
            <a:off x="5027400" y="8086680"/>
            <a:ext cx="2354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Mgu025613m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1" name="Rectangle 408"/>
          <p:cNvSpPr/>
          <p:nvPr/>
        </p:nvSpPr>
        <p:spPr>
          <a:xfrm>
            <a:off x="5352480" y="7729560"/>
            <a:ext cx="1836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Aly865878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2" name="Rectangle 420"/>
          <p:cNvSpPr/>
          <p:nvPr/>
        </p:nvSpPr>
        <p:spPr>
          <a:xfrm>
            <a:off x="4616280" y="7102440"/>
            <a:ext cx="2080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Smo235874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3" name="Rectangle 427"/>
          <p:cNvSpPr/>
          <p:nvPr/>
        </p:nvSpPr>
        <p:spPr>
          <a:xfrm>
            <a:off x="4788720" y="8400960"/>
            <a:ext cx="2401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Sb03g02207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4" name="Rectangle 429"/>
          <p:cNvSpPr/>
          <p:nvPr/>
        </p:nvSpPr>
        <p:spPr>
          <a:xfrm>
            <a:off x="4854600" y="7997760"/>
            <a:ext cx="430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VviGSVIVT0002443100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5" name="Rectangle 430"/>
          <p:cNvSpPr/>
          <p:nvPr/>
        </p:nvSpPr>
        <p:spPr>
          <a:xfrm>
            <a:off x="4758480" y="8312040"/>
            <a:ext cx="1591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HvRbohJ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6" name="Rectangle 431"/>
          <p:cNvSpPr/>
          <p:nvPr/>
        </p:nvSpPr>
        <p:spPr>
          <a:xfrm>
            <a:off x="4943520" y="6832440"/>
            <a:ext cx="1972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Ppa206166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7" name="Rectangle 433"/>
          <p:cNvSpPr/>
          <p:nvPr/>
        </p:nvSpPr>
        <p:spPr>
          <a:xfrm>
            <a:off x="6004800" y="6653160"/>
            <a:ext cx="2491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Cucsa.19823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8" name="Rectangle 435"/>
          <p:cNvSpPr/>
          <p:nvPr/>
        </p:nvSpPr>
        <p:spPr>
          <a:xfrm>
            <a:off x="5155920" y="7907400"/>
            <a:ext cx="3466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Rco30039.m00024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9" name="Rectangle 437"/>
          <p:cNvSpPr/>
          <p:nvPr/>
        </p:nvSpPr>
        <p:spPr>
          <a:xfrm>
            <a:off x="4965480" y="6880320"/>
            <a:ext cx="1972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Ppa14628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0" name="Rectangle 439"/>
          <p:cNvSpPr/>
          <p:nvPr/>
        </p:nvSpPr>
        <p:spPr>
          <a:xfrm>
            <a:off x="4375080" y="7148520"/>
            <a:ext cx="2080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Smo101139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1" name="Rectangle 440"/>
          <p:cNvSpPr/>
          <p:nvPr/>
        </p:nvSpPr>
        <p:spPr>
          <a:xfrm>
            <a:off x="4155120" y="7191360"/>
            <a:ext cx="1864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Smo97417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2" name="Rectangle 442"/>
          <p:cNvSpPr/>
          <p:nvPr/>
        </p:nvSpPr>
        <p:spPr>
          <a:xfrm>
            <a:off x="4554360" y="7237440"/>
            <a:ext cx="2080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Smo183259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3" name="Rectangle 447"/>
          <p:cNvSpPr/>
          <p:nvPr/>
        </p:nvSpPr>
        <p:spPr>
          <a:xfrm>
            <a:off x="5614200" y="7327800"/>
            <a:ext cx="2491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Cucsa.37967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4" name="Rectangle 457"/>
          <p:cNvSpPr/>
          <p:nvPr/>
        </p:nvSpPr>
        <p:spPr>
          <a:xfrm>
            <a:off x="5215680" y="7370640"/>
            <a:ext cx="2491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Cucsa.21356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5" name="Rectangle 474"/>
          <p:cNvSpPr/>
          <p:nvPr/>
        </p:nvSpPr>
        <p:spPr>
          <a:xfrm>
            <a:off x="5056920" y="7507440"/>
            <a:ext cx="1576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ff0000"/>
                </a:solidFill>
                <a:latin typeface="Arial"/>
              </a:rPr>
              <a:t>MtRbohF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6" name="Rectangle 477"/>
          <p:cNvSpPr/>
          <p:nvPr/>
        </p:nvSpPr>
        <p:spPr>
          <a:xfrm>
            <a:off x="4646160" y="8265960"/>
            <a:ext cx="1850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OsRBOHE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7" name="Rectangle 484"/>
          <p:cNvSpPr/>
          <p:nvPr/>
        </p:nvSpPr>
        <p:spPr>
          <a:xfrm>
            <a:off x="5344560" y="7639200"/>
            <a:ext cx="1836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Aly886234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8" name="Rectangle 489"/>
          <p:cNvSpPr/>
          <p:nvPr/>
        </p:nvSpPr>
        <p:spPr>
          <a:xfrm>
            <a:off x="5830200" y="6610320"/>
            <a:ext cx="2401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Sb01g02954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9" name="Rectangle 496"/>
          <p:cNvSpPr/>
          <p:nvPr/>
        </p:nvSpPr>
        <p:spPr>
          <a:xfrm>
            <a:off x="4522680" y="7012080"/>
            <a:ext cx="2080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Smo403353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0" name="Rectangle 498"/>
          <p:cNvSpPr/>
          <p:nvPr/>
        </p:nvSpPr>
        <p:spPr>
          <a:xfrm>
            <a:off x="5421240" y="8042400"/>
            <a:ext cx="2354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Mgu021568m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1" name="Rectangle 503"/>
          <p:cNvSpPr/>
          <p:nvPr/>
        </p:nvSpPr>
        <p:spPr>
          <a:xfrm>
            <a:off x="5133240" y="7416720"/>
            <a:ext cx="2826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Glyma18g3950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2" name="Rectangle 504"/>
          <p:cNvSpPr/>
          <p:nvPr/>
        </p:nvSpPr>
        <p:spPr>
          <a:xfrm>
            <a:off x="5064480" y="7550280"/>
            <a:ext cx="1486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LjRbohB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3" name="Rectangle 506"/>
          <p:cNvSpPr/>
          <p:nvPr/>
        </p:nvSpPr>
        <p:spPr>
          <a:xfrm>
            <a:off x="4693320" y="8177040"/>
            <a:ext cx="2401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Sb03g03905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4" name="Rectangle 512"/>
          <p:cNvSpPr/>
          <p:nvPr/>
        </p:nvSpPr>
        <p:spPr>
          <a:xfrm>
            <a:off x="5984640" y="6700680"/>
            <a:ext cx="3466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Rco29941.m00022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5" name="Rectangle 514"/>
          <p:cNvSpPr/>
          <p:nvPr/>
        </p:nvSpPr>
        <p:spPr>
          <a:xfrm>
            <a:off x="4940640" y="6969240"/>
            <a:ext cx="1760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Ppa66252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6" name="Rectangle 520"/>
          <p:cNvSpPr/>
          <p:nvPr/>
        </p:nvSpPr>
        <p:spPr>
          <a:xfrm>
            <a:off x="5272560" y="7953480"/>
            <a:ext cx="1807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Mes21138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7" name="Rectangle 523"/>
          <p:cNvSpPr/>
          <p:nvPr/>
        </p:nvSpPr>
        <p:spPr>
          <a:xfrm>
            <a:off x="4586760" y="7058160"/>
            <a:ext cx="1864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Smo81185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8" name="Rectangle 525"/>
          <p:cNvSpPr/>
          <p:nvPr/>
        </p:nvSpPr>
        <p:spPr>
          <a:xfrm>
            <a:off x="4095720" y="7280280"/>
            <a:ext cx="2080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Smo266977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9" name="Rectangle 534"/>
          <p:cNvSpPr/>
          <p:nvPr/>
        </p:nvSpPr>
        <p:spPr>
          <a:xfrm>
            <a:off x="5051880" y="8132760"/>
            <a:ext cx="151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SaNOX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0" name="Rectangle 541"/>
          <p:cNvSpPr/>
          <p:nvPr/>
        </p:nvSpPr>
        <p:spPr>
          <a:xfrm>
            <a:off x="5181120" y="7818480"/>
            <a:ext cx="2613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Ptr0016s1197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1" name="Rectangle 543"/>
          <p:cNvSpPr/>
          <p:nvPr/>
        </p:nvSpPr>
        <p:spPr>
          <a:xfrm>
            <a:off x="5144760" y="7864560"/>
            <a:ext cx="2613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Ptr0006s0985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2" name="Rectangle 550"/>
          <p:cNvSpPr/>
          <p:nvPr/>
        </p:nvSpPr>
        <p:spPr>
          <a:xfrm>
            <a:off x="4788000" y="8445600"/>
            <a:ext cx="3985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ZmaGRMZM2G32373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3" name="Rectangle 553"/>
          <p:cNvSpPr/>
          <p:nvPr/>
        </p:nvSpPr>
        <p:spPr>
          <a:xfrm>
            <a:off x="5366880" y="7684920"/>
            <a:ext cx="1486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AtRbohJ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4" name="Rectangle 560"/>
          <p:cNvSpPr/>
          <p:nvPr/>
        </p:nvSpPr>
        <p:spPr>
          <a:xfrm>
            <a:off x="4652280" y="694548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5" name="Rectangle 571"/>
          <p:cNvSpPr/>
          <p:nvPr/>
        </p:nvSpPr>
        <p:spPr>
          <a:xfrm>
            <a:off x="3468600" y="760572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97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6" name="Rectangle 573"/>
          <p:cNvSpPr/>
          <p:nvPr/>
        </p:nvSpPr>
        <p:spPr>
          <a:xfrm>
            <a:off x="4723920" y="771696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7" name="Rectangle 575"/>
          <p:cNvSpPr/>
          <p:nvPr/>
        </p:nvSpPr>
        <p:spPr>
          <a:xfrm>
            <a:off x="4755600" y="809784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8" name="Rectangle 576"/>
          <p:cNvSpPr/>
          <p:nvPr/>
        </p:nvSpPr>
        <p:spPr>
          <a:xfrm>
            <a:off x="5795280" y="676584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9" name="Rectangle 583"/>
          <p:cNvSpPr/>
          <p:nvPr/>
        </p:nvSpPr>
        <p:spPr>
          <a:xfrm>
            <a:off x="4698360" y="685656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0" name="Rectangle 584"/>
          <p:cNvSpPr/>
          <p:nvPr/>
        </p:nvSpPr>
        <p:spPr>
          <a:xfrm>
            <a:off x="4582440" y="734868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1" name="Rectangle 588"/>
          <p:cNvSpPr/>
          <p:nvPr/>
        </p:nvSpPr>
        <p:spPr>
          <a:xfrm>
            <a:off x="3696120" y="688500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78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2" name="Rectangle 590"/>
          <p:cNvSpPr/>
          <p:nvPr/>
        </p:nvSpPr>
        <p:spPr>
          <a:xfrm>
            <a:off x="4415400" y="805032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62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3" name="Rectangle 595"/>
          <p:cNvSpPr/>
          <p:nvPr/>
        </p:nvSpPr>
        <p:spPr>
          <a:xfrm>
            <a:off x="4077720" y="809460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4" name="Freeform 208"/>
          <p:cNvSpPr/>
          <p:nvPr/>
        </p:nvSpPr>
        <p:spPr>
          <a:xfrm>
            <a:off x="4500720" y="6880320"/>
            <a:ext cx="183960" cy="44280"/>
          </a:xfrm>
          <a:custGeom>
            <a:avLst/>
            <a:gdLst>
              <a:gd name="textAreaLeft" fmla="*/ 0 w 183960"/>
              <a:gd name="textAreaRight" fmla="*/ 184320 w 183960"/>
              <a:gd name="textAreaTop" fmla="*/ 0 h 44280"/>
              <a:gd name="textAreaBottom" fmla="*/ 44640 h 44280"/>
            </a:gdLst>
            <a:ahLst/>
            <a:rect l="textAreaLeft" t="textAreaTop" r="textAreaRight" b="textAreaBottom"/>
            <a:pathLst>
              <a:path w="1277" h="183">
                <a:moveTo>
                  <a:pt x="1277" y="0"/>
                </a:moveTo>
                <a:lnTo>
                  <a:pt x="0" y="0"/>
                </a:lnTo>
                <a:lnTo>
                  <a:pt x="0" y="183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5" name="Freeform 214"/>
          <p:cNvSpPr/>
          <p:nvPr/>
        </p:nvSpPr>
        <p:spPr>
          <a:xfrm>
            <a:off x="3619440" y="6910560"/>
            <a:ext cx="61920" cy="136440"/>
          </a:xfrm>
          <a:custGeom>
            <a:avLst/>
            <a:gdLst>
              <a:gd name="textAreaLeft" fmla="*/ 0 w 61920"/>
              <a:gd name="textAreaRight" fmla="*/ 62280 w 61920"/>
              <a:gd name="textAreaTop" fmla="*/ 0 h 136440"/>
              <a:gd name="textAreaBottom" fmla="*/ 136800 h 136440"/>
            </a:gdLst>
            <a:ahLst/>
            <a:rect l="textAreaLeft" t="textAreaTop" r="textAreaRight" b="textAreaBottom"/>
            <a:pathLst>
              <a:path w="432" h="558">
                <a:moveTo>
                  <a:pt x="432" y="0"/>
                </a:moveTo>
                <a:lnTo>
                  <a:pt x="0" y="0"/>
                </a:lnTo>
                <a:lnTo>
                  <a:pt x="0" y="558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6" name="Freeform 215"/>
          <p:cNvSpPr/>
          <p:nvPr/>
        </p:nvSpPr>
        <p:spPr>
          <a:xfrm>
            <a:off x="4356000" y="7856640"/>
            <a:ext cx="46080" cy="217440"/>
          </a:xfrm>
          <a:custGeom>
            <a:avLst/>
            <a:gdLst>
              <a:gd name="textAreaLeft" fmla="*/ 0 w 46080"/>
              <a:gd name="textAreaRight" fmla="*/ 46440 w 46080"/>
              <a:gd name="textAreaTop" fmla="*/ 0 h 217440"/>
              <a:gd name="textAreaBottom" fmla="*/ 217800 h 217440"/>
            </a:gdLst>
            <a:ahLst/>
            <a:rect l="textAreaLeft" t="textAreaTop" r="textAreaRight" b="textAreaBottom"/>
            <a:pathLst>
              <a:path w="324" h="885">
                <a:moveTo>
                  <a:pt x="324" y="885"/>
                </a:moveTo>
                <a:lnTo>
                  <a:pt x="0" y="885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7" name="Freeform 221"/>
          <p:cNvSpPr/>
          <p:nvPr/>
        </p:nvSpPr>
        <p:spPr>
          <a:xfrm>
            <a:off x="3456000" y="7526160"/>
            <a:ext cx="606240" cy="594000"/>
          </a:xfrm>
          <a:custGeom>
            <a:avLst/>
            <a:gdLst>
              <a:gd name="textAreaLeft" fmla="*/ 0 w 606240"/>
              <a:gd name="textAreaRight" fmla="*/ 606600 w 606240"/>
              <a:gd name="textAreaTop" fmla="*/ 0 h 594000"/>
              <a:gd name="textAreaBottom" fmla="*/ 594360 h 594000"/>
            </a:gdLst>
            <a:ahLst/>
            <a:rect l="textAreaLeft" t="textAreaTop" r="textAreaRight" b="textAreaBottom"/>
            <a:pathLst>
              <a:path w="4215" h="2428">
                <a:moveTo>
                  <a:pt x="4215" y="2428"/>
                </a:moveTo>
                <a:lnTo>
                  <a:pt x="0" y="2428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8" name="Freeform 222"/>
          <p:cNvSpPr/>
          <p:nvPr/>
        </p:nvSpPr>
        <p:spPr>
          <a:xfrm>
            <a:off x="4867200" y="8089920"/>
            <a:ext cx="147600" cy="22320"/>
          </a:xfrm>
          <a:custGeom>
            <a:avLst/>
            <a:gdLst>
              <a:gd name="textAreaLeft" fmla="*/ 0 w 147600"/>
              <a:gd name="textAreaRight" fmla="*/ 147960 w 14760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1036" h="92">
                <a:moveTo>
                  <a:pt x="1036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9" name="Freeform 224"/>
          <p:cNvSpPr/>
          <p:nvPr/>
        </p:nvSpPr>
        <p:spPr>
          <a:xfrm>
            <a:off x="5307120" y="7731000"/>
            <a:ext cx="34920" cy="22320"/>
          </a:xfrm>
          <a:custGeom>
            <a:avLst/>
            <a:gdLst>
              <a:gd name="textAreaLeft" fmla="*/ 0 w 34920"/>
              <a:gd name="textAreaRight" fmla="*/ 35280 w 3492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241" h="91">
                <a:moveTo>
                  <a:pt x="241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0" name="Freeform 234"/>
          <p:cNvSpPr/>
          <p:nvPr/>
        </p:nvSpPr>
        <p:spPr>
          <a:xfrm>
            <a:off x="3556080" y="7047000"/>
            <a:ext cx="63360" cy="106200"/>
          </a:xfrm>
          <a:custGeom>
            <a:avLst/>
            <a:gdLst>
              <a:gd name="textAreaLeft" fmla="*/ 0 w 63360"/>
              <a:gd name="textAreaRight" fmla="*/ 63720 w 63360"/>
              <a:gd name="textAreaTop" fmla="*/ 0 h 106200"/>
              <a:gd name="textAreaBottom" fmla="*/ 106560 h 106200"/>
            </a:gdLst>
            <a:ahLst/>
            <a:rect l="textAreaLeft" t="textAreaTop" r="textAreaRight" b="textAreaBottom"/>
            <a:pathLst>
              <a:path w="444" h="439">
                <a:moveTo>
                  <a:pt x="444" y="0"/>
                </a:moveTo>
                <a:lnTo>
                  <a:pt x="0" y="0"/>
                </a:lnTo>
                <a:lnTo>
                  <a:pt x="0" y="439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1" name="Freeform 243"/>
          <p:cNvSpPr/>
          <p:nvPr/>
        </p:nvSpPr>
        <p:spPr>
          <a:xfrm>
            <a:off x="4502160" y="8273880"/>
            <a:ext cx="38160" cy="51120"/>
          </a:xfrm>
          <a:custGeom>
            <a:avLst/>
            <a:gdLst>
              <a:gd name="textAreaLeft" fmla="*/ 0 w 38160"/>
              <a:gd name="textAreaRight" fmla="*/ 38520 w 38160"/>
              <a:gd name="textAreaTop" fmla="*/ 0 h 51120"/>
              <a:gd name="textAreaBottom" fmla="*/ 51480 h 51120"/>
            </a:gdLst>
            <a:ahLst/>
            <a:rect l="textAreaLeft" t="textAreaTop" r="textAreaRight" b="textAreaBottom"/>
            <a:pathLst>
              <a:path w="258" h="206">
                <a:moveTo>
                  <a:pt x="258" y="206"/>
                </a:moveTo>
                <a:lnTo>
                  <a:pt x="0" y="206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" bIns="46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2" name="Freeform 245"/>
          <p:cNvSpPr/>
          <p:nvPr/>
        </p:nvSpPr>
        <p:spPr>
          <a:xfrm>
            <a:off x="4608360" y="8335800"/>
            <a:ext cx="138240" cy="22320"/>
          </a:xfrm>
          <a:custGeom>
            <a:avLst/>
            <a:gdLst>
              <a:gd name="textAreaLeft" fmla="*/ 0 w 138240"/>
              <a:gd name="textAreaRight" fmla="*/ 138600 w 13824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955" h="91">
                <a:moveTo>
                  <a:pt x="955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3" name="Freeform 247"/>
          <p:cNvSpPr/>
          <p:nvPr/>
        </p:nvSpPr>
        <p:spPr>
          <a:xfrm>
            <a:off x="5133960" y="6678720"/>
            <a:ext cx="860400" cy="38160"/>
          </a:xfrm>
          <a:custGeom>
            <a:avLst/>
            <a:gdLst>
              <a:gd name="textAreaLeft" fmla="*/ 0 w 860400"/>
              <a:gd name="textAreaRight" fmla="*/ 860760 w 86040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5974" h="160">
                <a:moveTo>
                  <a:pt x="5974" y="0"/>
                </a:moveTo>
                <a:lnTo>
                  <a:pt x="0" y="0"/>
                </a:lnTo>
                <a:lnTo>
                  <a:pt x="0" y="16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8280" bIns="-82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4" name="Freeform 248"/>
          <p:cNvSpPr/>
          <p:nvPr/>
        </p:nvSpPr>
        <p:spPr>
          <a:xfrm>
            <a:off x="4684680" y="6880320"/>
            <a:ext cx="270000" cy="23760"/>
          </a:xfrm>
          <a:custGeom>
            <a:avLst/>
            <a:gdLst>
              <a:gd name="textAreaLeft" fmla="*/ 0 w 270000"/>
              <a:gd name="textAreaRight" fmla="*/ 270360 w 270000"/>
              <a:gd name="textAreaTop" fmla="*/ 0 h 23760"/>
              <a:gd name="textAreaBottom" fmla="*/ 24120 h 23760"/>
            </a:gdLst>
            <a:ahLst/>
            <a:rect l="textAreaLeft" t="textAreaTop" r="textAreaRight" b="textAreaBottom"/>
            <a:pathLst>
              <a:path w="1872" h="92">
                <a:moveTo>
                  <a:pt x="1872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5" name="Freeform 249"/>
          <p:cNvSpPr/>
          <p:nvPr/>
        </p:nvSpPr>
        <p:spPr>
          <a:xfrm>
            <a:off x="4336920" y="7149960"/>
            <a:ext cx="27000" cy="22320"/>
          </a:xfrm>
          <a:custGeom>
            <a:avLst/>
            <a:gdLst>
              <a:gd name="textAreaLeft" fmla="*/ 0 w 27000"/>
              <a:gd name="textAreaRight" fmla="*/ 27360 w 2700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183" h="92">
                <a:moveTo>
                  <a:pt x="183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6" name="Freeform 251"/>
          <p:cNvSpPr/>
          <p:nvPr/>
        </p:nvSpPr>
        <p:spPr>
          <a:xfrm>
            <a:off x="3708360" y="7182000"/>
            <a:ext cx="433440" cy="34920"/>
          </a:xfrm>
          <a:custGeom>
            <a:avLst/>
            <a:gdLst>
              <a:gd name="textAreaLeft" fmla="*/ 0 w 433440"/>
              <a:gd name="textAreaRight" fmla="*/ 433800 w 433440"/>
              <a:gd name="textAreaTop" fmla="*/ 0 h 34920"/>
              <a:gd name="textAreaBottom" fmla="*/ 35280 h 34920"/>
            </a:gdLst>
            <a:ahLst/>
            <a:rect l="textAreaLeft" t="textAreaTop" r="textAreaRight" b="textAreaBottom"/>
            <a:pathLst>
              <a:path w="3005" h="137">
                <a:moveTo>
                  <a:pt x="3005" y="137"/>
                </a:moveTo>
                <a:lnTo>
                  <a:pt x="0" y="137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1520" bIns="-115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7" name="Freeform 256"/>
          <p:cNvSpPr/>
          <p:nvPr/>
        </p:nvSpPr>
        <p:spPr>
          <a:xfrm>
            <a:off x="3681360" y="6910560"/>
            <a:ext cx="144360" cy="149040"/>
          </a:xfrm>
          <a:custGeom>
            <a:avLst/>
            <a:gdLst>
              <a:gd name="textAreaLeft" fmla="*/ 0 w 144360"/>
              <a:gd name="textAreaRight" fmla="*/ 144720 w 144360"/>
              <a:gd name="textAreaTop" fmla="*/ 0 h 149040"/>
              <a:gd name="textAreaBottom" fmla="*/ 149400 h 149040"/>
            </a:gdLst>
            <a:ahLst/>
            <a:rect l="textAreaLeft" t="textAreaTop" r="textAreaRight" b="textAreaBottom"/>
            <a:pathLst>
              <a:path w="997" h="612">
                <a:moveTo>
                  <a:pt x="997" y="612"/>
                </a:moveTo>
                <a:lnTo>
                  <a:pt x="0" y="61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8" name="Freeform 258"/>
          <p:cNvSpPr/>
          <p:nvPr/>
        </p:nvSpPr>
        <p:spPr>
          <a:xfrm>
            <a:off x="4570560" y="7351560"/>
            <a:ext cx="1033200" cy="20880"/>
          </a:xfrm>
          <a:custGeom>
            <a:avLst/>
            <a:gdLst>
              <a:gd name="textAreaLeft" fmla="*/ 0 w 1033200"/>
              <a:gd name="textAreaRight" fmla="*/ 1033560 w 1033200"/>
              <a:gd name="textAreaTop" fmla="*/ 0 h 20880"/>
              <a:gd name="textAreaBottom" fmla="*/ 21240 h 20880"/>
            </a:gdLst>
            <a:ahLst/>
            <a:rect l="textAreaLeft" t="textAreaTop" r="textAreaRight" b="textAreaBottom"/>
            <a:pathLst>
              <a:path w="7179" h="91">
                <a:moveTo>
                  <a:pt x="7179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5560" bIns="-255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9" name="Freeform 276"/>
          <p:cNvSpPr/>
          <p:nvPr/>
        </p:nvSpPr>
        <p:spPr>
          <a:xfrm>
            <a:off x="4200480" y="6499080"/>
            <a:ext cx="934920" cy="24120"/>
          </a:xfrm>
          <a:custGeom>
            <a:avLst/>
            <a:gdLst>
              <a:gd name="textAreaLeft" fmla="*/ 0 w 934920"/>
              <a:gd name="textAreaRight" fmla="*/ 935280 w 934920"/>
              <a:gd name="textAreaTop" fmla="*/ 0 h 24120"/>
              <a:gd name="textAreaBottom" fmla="*/ 24480 h 24120"/>
            </a:gdLst>
            <a:ahLst/>
            <a:rect l="textAreaLeft" t="textAreaTop" r="textAreaRight" b="textAreaBottom"/>
            <a:pathLst>
              <a:path w="6485" h="92">
                <a:moveTo>
                  <a:pt x="6485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2320" bIns="-223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0" name="Freeform 279"/>
          <p:cNvSpPr/>
          <p:nvPr/>
        </p:nvSpPr>
        <p:spPr>
          <a:xfrm>
            <a:off x="3841920" y="6595920"/>
            <a:ext cx="136440" cy="165240"/>
          </a:xfrm>
          <a:custGeom>
            <a:avLst/>
            <a:gdLst>
              <a:gd name="textAreaLeft" fmla="*/ 0 w 136440"/>
              <a:gd name="textAreaRight" fmla="*/ 136800 w 136440"/>
              <a:gd name="textAreaTop" fmla="*/ 0 h 165240"/>
              <a:gd name="textAreaBottom" fmla="*/ 165600 h 165240"/>
            </a:gdLst>
            <a:ahLst/>
            <a:rect l="textAreaLeft" t="textAreaTop" r="textAreaRight" b="textAreaBottom"/>
            <a:pathLst>
              <a:path w="940" h="674">
                <a:moveTo>
                  <a:pt x="940" y="0"/>
                </a:moveTo>
                <a:lnTo>
                  <a:pt x="0" y="0"/>
                </a:lnTo>
                <a:lnTo>
                  <a:pt x="0" y="674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1" name="Freeform 286"/>
          <p:cNvSpPr/>
          <p:nvPr/>
        </p:nvSpPr>
        <p:spPr>
          <a:xfrm>
            <a:off x="4740120" y="8089920"/>
            <a:ext cx="127080" cy="33480"/>
          </a:xfrm>
          <a:custGeom>
            <a:avLst/>
            <a:gdLst>
              <a:gd name="textAreaLeft" fmla="*/ 0 w 127080"/>
              <a:gd name="textAreaRight" fmla="*/ 127440 w 127080"/>
              <a:gd name="textAreaTop" fmla="*/ 0 h 33480"/>
              <a:gd name="textAreaBottom" fmla="*/ 33840 h 33480"/>
            </a:gdLst>
            <a:ahLst/>
            <a:rect l="textAreaLeft" t="textAreaTop" r="textAreaRight" b="textAreaBottom"/>
            <a:pathLst>
              <a:path w="869" h="138">
                <a:moveTo>
                  <a:pt x="869" y="0"/>
                </a:moveTo>
                <a:lnTo>
                  <a:pt x="0" y="0"/>
                </a:lnTo>
                <a:lnTo>
                  <a:pt x="0" y="138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2" name="Freeform 287"/>
          <p:cNvSpPr/>
          <p:nvPr/>
        </p:nvSpPr>
        <p:spPr>
          <a:xfrm>
            <a:off x="4792680" y="7462800"/>
            <a:ext cx="182520" cy="33480"/>
          </a:xfrm>
          <a:custGeom>
            <a:avLst/>
            <a:gdLst>
              <a:gd name="textAreaLeft" fmla="*/ 0 w 182520"/>
              <a:gd name="textAreaRight" fmla="*/ 182880 w 182520"/>
              <a:gd name="textAreaTop" fmla="*/ 0 h 33480"/>
              <a:gd name="textAreaBottom" fmla="*/ 33840 h 33480"/>
            </a:gdLst>
            <a:ahLst/>
            <a:rect l="textAreaLeft" t="textAreaTop" r="textAreaRight" b="textAreaBottom"/>
            <a:pathLst>
              <a:path w="1265" h="137">
                <a:moveTo>
                  <a:pt x="1265" y="0"/>
                </a:moveTo>
                <a:lnTo>
                  <a:pt x="0" y="0"/>
                </a:lnTo>
                <a:lnTo>
                  <a:pt x="0" y="137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3" name="Freeform 297"/>
          <p:cNvSpPr/>
          <p:nvPr/>
        </p:nvSpPr>
        <p:spPr>
          <a:xfrm>
            <a:off x="5087880" y="7686720"/>
            <a:ext cx="219240" cy="44280"/>
          </a:xfrm>
          <a:custGeom>
            <a:avLst/>
            <a:gdLst>
              <a:gd name="textAreaLeft" fmla="*/ 0 w 219240"/>
              <a:gd name="textAreaRight" fmla="*/ 219600 w 219240"/>
              <a:gd name="textAreaTop" fmla="*/ 0 h 44280"/>
              <a:gd name="textAreaBottom" fmla="*/ 44640 h 44280"/>
            </a:gdLst>
            <a:ahLst/>
            <a:rect l="textAreaLeft" t="textAreaTop" r="textAreaRight" b="textAreaBottom"/>
            <a:pathLst>
              <a:path w="1520" h="183">
                <a:moveTo>
                  <a:pt x="1520" y="183"/>
                </a:moveTo>
                <a:lnTo>
                  <a:pt x="0" y="183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4" name="Freeform 302"/>
          <p:cNvSpPr/>
          <p:nvPr/>
        </p:nvSpPr>
        <p:spPr>
          <a:xfrm>
            <a:off x="4684680" y="7910640"/>
            <a:ext cx="117360" cy="44280"/>
          </a:xfrm>
          <a:custGeom>
            <a:avLst/>
            <a:gdLst>
              <a:gd name="textAreaLeft" fmla="*/ 0 w 117360"/>
              <a:gd name="textAreaRight" fmla="*/ 117720 w 117360"/>
              <a:gd name="textAreaTop" fmla="*/ 0 h 44280"/>
              <a:gd name="textAreaBottom" fmla="*/ 44640 h 44280"/>
            </a:gdLst>
            <a:ahLst/>
            <a:rect l="textAreaLeft" t="textAreaTop" r="textAreaRight" b="textAreaBottom"/>
            <a:pathLst>
              <a:path w="807" h="184">
                <a:moveTo>
                  <a:pt x="807" y="184"/>
                </a:moveTo>
                <a:lnTo>
                  <a:pt x="0" y="184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5" name="Freeform 305"/>
          <p:cNvSpPr/>
          <p:nvPr/>
        </p:nvSpPr>
        <p:spPr>
          <a:xfrm>
            <a:off x="4502160" y="8224920"/>
            <a:ext cx="68400" cy="48960"/>
          </a:xfrm>
          <a:custGeom>
            <a:avLst/>
            <a:gdLst>
              <a:gd name="textAreaLeft" fmla="*/ 0 w 68400"/>
              <a:gd name="textAreaRight" fmla="*/ 68760 w 68400"/>
              <a:gd name="textAreaTop" fmla="*/ 0 h 48960"/>
              <a:gd name="textAreaBottom" fmla="*/ 49320 h 48960"/>
            </a:gdLst>
            <a:ahLst/>
            <a:rect l="textAreaLeft" t="textAreaTop" r="textAreaRight" b="textAreaBottom"/>
            <a:pathLst>
              <a:path w="469" h="206">
                <a:moveTo>
                  <a:pt x="469" y="0"/>
                </a:moveTo>
                <a:lnTo>
                  <a:pt x="0" y="0"/>
                </a:lnTo>
                <a:lnTo>
                  <a:pt x="0" y="206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6" name="Freeform 310"/>
          <p:cNvSpPr/>
          <p:nvPr/>
        </p:nvSpPr>
        <p:spPr>
          <a:xfrm>
            <a:off x="4062240" y="7856640"/>
            <a:ext cx="293760" cy="263520"/>
          </a:xfrm>
          <a:custGeom>
            <a:avLst/>
            <a:gdLst>
              <a:gd name="textAreaLeft" fmla="*/ 0 w 293760"/>
              <a:gd name="textAreaRight" fmla="*/ 294120 w 293760"/>
              <a:gd name="textAreaTop" fmla="*/ 0 h 263520"/>
              <a:gd name="textAreaBottom" fmla="*/ 263880 h 263520"/>
            </a:gdLst>
            <a:ahLst/>
            <a:rect l="textAreaLeft" t="textAreaTop" r="textAreaRight" b="textAreaBottom"/>
            <a:pathLst>
              <a:path w="2023" h="1078">
                <a:moveTo>
                  <a:pt x="2023" y="0"/>
                </a:moveTo>
                <a:lnTo>
                  <a:pt x="0" y="0"/>
                </a:lnTo>
                <a:lnTo>
                  <a:pt x="0" y="1078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7" name="Freeform 314"/>
          <p:cNvSpPr/>
          <p:nvPr/>
        </p:nvSpPr>
        <p:spPr>
          <a:xfrm>
            <a:off x="3825720" y="7037280"/>
            <a:ext cx="684360" cy="22320"/>
          </a:xfrm>
          <a:custGeom>
            <a:avLst/>
            <a:gdLst>
              <a:gd name="textAreaLeft" fmla="*/ 0 w 684360"/>
              <a:gd name="textAreaRight" fmla="*/ 684720 w 68436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4757" h="92">
                <a:moveTo>
                  <a:pt x="4757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8" name="Freeform 315"/>
          <p:cNvSpPr/>
          <p:nvPr/>
        </p:nvSpPr>
        <p:spPr>
          <a:xfrm>
            <a:off x="4867200" y="8067600"/>
            <a:ext cx="544680" cy="22320"/>
          </a:xfrm>
          <a:custGeom>
            <a:avLst/>
            <a:gdLst>
              <a:gd name="textAreaLeft" fmla="*/ 0 w 544680"/>
              <a:gd name="textAreaRight" fmla="*/ 545040 w 54468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3777" h="91">
                <a:moveTo>
                  <a:pt x="3777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9" name="Freeform 317"/>
          <p:cNvSpPr/>
          <p:nvPr/>
        </p:nvSpPr>
        <p:spPr>
          <a:xfrm>
            <a:off x="4975200" y="7440480"/>
            <a:ext cx="149400" cy="22320"/>
          </a:xfrm>
          <a:custGeom>
            <a:avLst/>
            <a:gdLst>
              <a:gd name="textAreaLeft" fmla="*/ 0 w 149400"/>
              <a:gd name="textAreaRight" fmla="*/ 149760 w 14940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1032" h="92">
                <a:moveTo>
                  <a:pt x="1032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0" name="Freeform 318"/>
          <p:cNvSpPr/>
          <p:nvPr/>
        </p:nvSpPr>
        <p:spPr>
          <a:xfrm>
            <a:off x="4746600" y="7534440"/>
            <a:ext cx="308160" cy="39600"/>
          </a:xfrm>
          <a:custGeom>
            <a:avLst/>
            <a:gdLst>
              <a:gd name="textAreaLeft" fmla="*/ 0 w 308160"/>
              <a:gd name="textAreaRight" fmla="*/ 308520 w 308160"/>
              <a:gd name="textAreaTop" fmla="*/ 0 h 39600"/>
              <a:gd name="textAreaBottom" fmla="*/ 39960 h 39600"/>
            </a:gdLst>
            <a:ahLst/>
            <a:rect l="textAreaLeft" t="textAreaTop" r="textAreaRight" b="textAreaBottom"/>
            <a:pathLst>
              <a:path w="2125" h="161">
                <a:moveTo>
                  <a:pt x="2125" y="161"/>
                </a:moveTo>
                <a:lnTo>
                  <a:pt x="0" y="16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1" name="Freeform 322"/>
          <p:cNvSpPr/>
          <p:nvPr/>
        </p:nvSpPr>
        <p:spPr>
          <a:xfrm>
            <a:off x="4570560" y="8201160"/>
            <a:ext cx="114120" cy="23760"/>
          </a:xfrm>
          <a:custGeom>
            <a:avLst/>
            <a:gdLst>
              <a:gd name="textAreaLeft" fmla="*/ 0 w 114120"/>
              <a:gd name="textAreaRight" fmla="*/ 114480 w 114120"/>
              <a:gd name="textAreaTop" fmla="*/ 0 h 23760"/>
              <a:gd name="textAreaBottom" fmla="*/ 24120 h 23760"/>
            </a:gdLst>
            <a:ahLst/>
            <a:rect l="textAreaLeft" t="textAreaTop" r="textAreaRight" b="textAreaBottom"/>
            <a:pathLst>
              <a:path w="788" h="92">
                <a:moveTo>
                  <a:pt x="788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2" name="Freeform 323"/>
          <p:cNvSpPr/>
          <p:nvPr/>
        </p:nvSpPr>
        <p:spPr>
          <a:xfrm>
            <a:off x="3619440" y="7047000"/>
            <a:ext cx="88920" cy="135000"/>
          </a:xfrm>
          <a:custGeom>
            <a:avLst/>
            <a:gdLst>
              <a:gd name="textAreaLeft" fmla="*/ 0 w 88920"/>
              <a:gd name="textAreaRight" fmla="*/ 89280 w 88920"/>
              <a:gd name="textAreaTop" fmla="*/ 0 h 135000"/>
              <a:gd name="textAreaBottom" fmla="*/ 135360 h 135000"/>
            </a:gdLst>
            <a:ahLst/>
            <a:rect l="textAreaLeft" t="textAreaTop" r="textAreaRight" b="textAreaBottom"/>
            <a:pathLst>
              <a:path w="619" h="558">
                <a:moveTo>
                  <a:pt x="619" y="558"/>
                </a:moveTo>
                <a:lnTo>
                  <a:pt x="0" y="558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3" name="Freeform 328"/>
          <p:cNvSpPr/>
          <p:nvPr/>
        </p:nvSpPr>
        <p:spPr>
          <a:xfrm>
            <a:off x="4637160" y="6970680"/>
            <a:ext cx="293760" cy="20520"/>
          </a:xfrm>
          <a:custGeom>
            <a:avLst/>
            <a:gdLst>
              <a:gd name="textAreaLeft" fmla="*/ 0 w 293760"/>
              <a:gd name="textAreaRight" fmla="*/ 294120 w 293760"/>
              <a:gd name="textAreaTop" fmla="*/ 0 h 20520"/>
              <a:gd name="textAreaBottom" fmla="*/ 20520 h 20520"/>
            </a:gdLst>
            <a:ahLst/>
            <a:rect l="textAreaLeft" t="textAreaTop" r="textAreaRight" b="textAreaBottom"/>
            <a:pathLst>
              <a:path w="2023" h="91">
                <a:moveTo>
                  <a:pt x="2023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4" name="Freeform 331"/>
          <p:cNvSpPr/>
          <p:nvPr/>
        </p:nvSpPr>
        <p:spPr>
          <a:xfrm>
            <a:off x="4573440" y="7826400"/>
            <a:ext cx="111240" cy="84240"/>
          </a:xfrm>
          <a:custGeom>
            <a:avLst/>
            <a:gdLst>
              <a:gd name="textAreaLeft" fmla="*/ 0 w 111240"/>
              <a:gd name="textAreaRight" fmla="*/ 111600 w 111240"/>
              <a:gd name="textAreaTop" fmla="*/ 0 h 84240"/>
              <a:gd name="textAreaBottom" fmla="*/ 84600 h 84240"/>
            </a:gdLst>
            <a:ahLst/>
            <a:rect l="textAreaLeft" t="textAreaTop" r="textAreaRight" b="textAreaBottom"/>
            <a:pathLst>
              <a:path w="783" h="343">
                <a:moveTo>
                  <a:pt x="783" y="343"/>
                </a:moveTo>
                <a:lnTo>
                  <a:pt x="0" y="343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5" name="Freeform 337"/>
          <p:cNvSpPr/>
          <p:nvPr/>
        </p:nvSpPr>
        <p:spPr>
          <a:xfrm>
            <a:off x="4684680" y="7866000"/>
            <a:ext cx="318960" cy="44640"/>
          </a:xfrm>
          <a:custGeom>
            <a:avLst/>
            <a:gdLst>
              <a:gd name="textAreaLeft" fmla="*/ 0 w 318960"/>
              <a:gd name="textAreaRight" fmla="*/ 319320 w 318960"/>
              <a:gd name="textAreaTop" fmla="*/ 0 h 44640"/>
              <a:gd name="textAreaBottom" fmla="*/ 45000 h 44640"/>
            </a:gdLst>
            <a:ahLst/>
            <a:rect l="textAreaLeft" t="textAreaTop" r="textAreaRight" b="textAreaBottom"/>
            <a:pathLst>
              <a:path w="2209" h="183">
                <a:moveTo>
                  <a:pt x="2209" y="0"/>
                </a:moveTo>
                <a:lnTo>
                  <a:pt x="0" y="0"/>
                </a:lnTo>
                <a:lnTo>
                  <a:pt x="0" y="183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" bIns="-1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6" name="Freeform 338"/>
          <p:cNvSpPr/>
          <p:nvPr/>
        </p:nvSpPr>
        <p:spPr>
          <a:xfrm>
            <a:off x="3825720" y="7059600"/>
            <a:ext cx="749520" cy="22320"/>
          </a:xfrm>
          <a:custGeom>
            <a:avLst/>
            <a:gdLst>
              <a:gd name="textAreaLeft" fmla="*/ 0 w 749520"/>
              <a:gd name="textAreaRight" fmla="*/ 749880 w 74952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5199" h="92">
                <a:moveTo>
                  <a:pt x="5199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7" name="Freeform 341"/>
          <p:cNvSpPr/>
          <p:nvPr/>
        </p:nvSpPr>
        <p:spPr>
          <a:xfrm>
            <a:off x="3456000" y="7305840"/>
            <a:ext cx="630360" cy="220320"/>
          </a:xfrm>
          <a:custGeom>
            <a:avLst/>
            <a:gdLst>
              <a:gd name="textAreaLeft" fmla="*/ 0 w 630360"/>
              <a:gd name="textAreaRight" fmla="*/ 630720 w 630360"/>
              <a:gd name="textAreaTop" fmla="*/ 0 h 220320"/>
              <a:gd name="textAreaBottom" fmla="*/ 220680 h 220320"/>
            </a:gdLst>
            <a:ahLst/>
            <a:rect l="textAreaLeft" t="textAreaTop" r="textAreaRight" b="textAreaBottom"/>
            <a:pathLst>
              <a:path w="4370" h="903">
                <a:moveTo>
                  <a:pt x="4370" y="0"/>
                </a:moveTo>
                <a:lnTo>
                  <a:pt x="0" y="0"/>
                </a:lnTo>
                <a:lnTo>
                  <a:pt x="0" y="903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8" name="Freeform 342"/>
          <p:cNvSpPr/>
          <p:nvPr/>
        </p:nvSpPr>
        <p:spPr>
          <a:xfrm>
            <a:off x="4390920" y="7454880"/>
            <a:ext cx="92160" cy="185760"/>
          </a:xfrm>
          <a:custGeom>
            <a:avLst/>
            <a:gdLst>
              <a:gd name="textAreaLeft" fmla="*/ 0 w 92160"/>
              <a:gd name="textAreaRight" fmla="*/ 92520 w 92160"/>
              <a:gd name="textAreaTop" fmla="*/ 0 h 185760"/>
              <a:gd name="textAreaBottom" fmla="*/ 186120 h 185760"/>
            </a:gdLst>
            <a:ahLst/>
            <a:rect l="textAreaLeft" t="textAreaTop" r="textAreaRight" b="textAreaBottom"/>
            <a:pathLst>
              <a:path w="635" h="762">
                <a:moveTo>
                  <a:pt x="635" y="0"/>
                </a:moveTo>
                <a:lnTo>
                  <a:pt x="0" y="0"/>
                </a:lnTo>
                <a:lnTo>
                  <a:pt x="0" y="76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9" name="Freeform 346"/>
          <p:cNvSpPr/>
          <p:nvPr/>
        </p:nvSpPr>
        <p:spPr>
          <a:xfrm>
            <a:off x="4832280" y="6675480"/>
            <a:ext cx="301680" cy="41400"/>
          </a:xfrm>
          <a:custGeom>
            <a:avLst/>
            <a:gdLst>
              <a:gd name="textAreaLeft" fmla="*/ 0 w 301680"/>
              <a:gd name="textAreaRight" fmla="*/ 302040 w 301680"/>
              <a:gd name="textAreaTop" fmla="*/ 0 h 41400"/>
              <a:gd name="textAreaBottom" fmla="*/ 41760 h 41400"/>
            </a:gdLst>
            <a:ahLst/>
            <a:rect l="textAreaLeft" t="textAreaTop" r="textAreaRight" b="textAreaBottom"/>
            <a:pathLst>
              <a:path w="2081" h="172">
                <a:moveTo>
                  <a:pt x="2081" y="172"/>
                </a:moveTo>
                <a:lnTo>
                  <a:pt x="0" y="17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5040" bIns="-504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0" name="Freeform 347"/>
          <p:cNvSpPr/>
          <p:nvPr/>
        </p:nvSpPr>
        <p:spPr>
          <a:xfrm>
            <a:off x="4740120" y="8123400"/>
            <a:ext cx="298440" cy="34920"/>
          </a:xfrm>
          <a:custGeom>
            <a:avLst/>
            <a:gdLst>
              <a:gd name="textAreaLeft" fmla="*/ 0 w 298440"/>
              <a:gd name="textAreaRight" fmla="*/ 298800 w 298440"/>
              <a:gd name="textAreaTop" fmla="*/ 0 h 34920"/>
              <a:gd name="textAreaBottom" fmla="*/ 35280 h 34920"/>
            </a:gdLst>
            <a:ahLst/>
            <a:rect l="textAreaLeft" t="textAreaTop" r="textAreaRight" b="textAreaBottom"/>
            <a:pathLst>
              <a:path w="2057" h="137">
                <a:moveTo>
                  <a:pt x="2057" y="137"/>
                </a:moveTo>
                <a:lnTo>
                  <a:pt x="0" y="137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1520" bIns="-115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1" name="Freeform 359"/>
          <p:cNvSpPr/>
          <p:nvPr/>
        </p:nvSpPr>
        <p:spPr>
          <a:xfrm>
            <a:off x="4390920" y="7640640"/>
            <a:ext cx="182520" cy="185760"/>
          </a:xfrm>
          <a:custGeom>
            <a:avLst/>
            <a:gdLst>
              <a:gd name="textAreaLeft" fmla="*/ 0 w 182520"/>
              <a:gd name="textAreaRight" fmla="*/ 182880 w 182520"/>
              <a:gd name="textAreaTop" fmla="*/ 0 h 185760"/>
              <a:gd name="textAreaBottom" fmla="*/ 186120 h 185760"/>
            </a:gdLst>
            <a:ahLst/>
            <a:rect l="textAreaLeft" t="textAreaTop" r="textAreaRight" b="textAreaBottom"/>
            <a:pathLst>
              <a:path w="1260" h="761">
                <a:moveTo>
                  <a:pt x="1260" y="761"/>
                </a:moveTo>
                <a:lnTo>
                  <a:pt x="0" y="76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2" name="Freeform 360"/>
          <p:cNvSpPr/>
          <p:nvPr/>
        </p:nvSpPr>
        <p:spPr>
          <a:xfrm>
            <a:off x="5087880" y="7642080"/>
            <a:ext cx="212760" cy="44640"/>
          </a:xfrm>
          <a:custGeom>
            <a:avLst/>
            <a:gdLst>
              <a:gd name="textAreaLeft" fmla="*/ 0 w 212760"/>
              <a:gd name="textAreaRight" fmla="*/ 213120 w 212760"/>
              <a:gd name="textAreaTop" fmla="*/ 0 h 44640"/>
              <a:gd name="textAreaBottom" fmla="*/ 45000 h 44640"/>
            </a:gdLst>
            <a:ahLst/>
            <a:rect l="textAreaLeft" t="textAreaTop" r="textAreaRight" b="textAreaBottom"/>
            <a:pathLst>
              <a:path w="1475" h="184">
                <a:moveTo>
                  <a:pt x="1475" y="0"/>
                </a:moveTo>
                <a:lnTo>
                  <a:pt x="0" y="0"/>
                </a:lnTo>
                <a:lnTo>
                  <a:pt x="0" y="184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" bIns="-1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3" name="Freeform 361"/>
          <p:cNvSpPr/>
          <p:nvPr/>
        </p:nvSpPr>
        <p:spPr>
          <a:xfrm>
            <a:off x="5133960" y="6716880"/>
            <a:ext cx="114480" cy="39600"/>
          </a:xfrm>
          <a:custGeom>
            <a:avLst/>
            <a:gdLst>
              <a:gd name="textAreaLeft" fmla="*/ 0 w 114480"/>
              <a:gd name="textAreaRight" fmla="*/ 114840 w 114480"/>
              <a:gd name="textAreaTop" fmla="*/ 0 h 39600"/>
              <a:gd name="textAreaBottom" fmla="*/ 39960 h 39600"/>
            </a:gdLst>
            <a:ahLst/>
            <a:rect l="textAreaLeft" t="textAreaTop" r="textAreaRight" b="textAreaBottom"/>
            <a:pathLst>
              <a:path w="802" h="160">
                <a:moveTo>
                  <a:pt x="802" y="160"/>
                </a:moveTo>
                <a:lnTo>
                  <a:pt x="0" y="160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4" name="Freeform 366"/>
          <p:cNvSpPr/>
          <p:nvPr/>
        </p:nvSpPr>
        <p:spPr>
          <a:xfrm>
            <a:off x="4713120" y="8447040"/>
            <a:ext cx="63720" cy="23760"/>
          </a:xfrm>
          <a:custGeom>
            <a:avLst/>
            <a:gdLst>
              <a:gd name="textAreaLeft" fmla="*/ 0 w 63720"/>
              <a:gd name="textAreaRight" fmla="*/ 64080 w 63720"/>
              <a:gd name="textAreaTop" fmla="*/ 0 h 23760"/>
              <a:gd name="textAreaBottom" fmla="*/ 24120 h 23760"/>
            </a:gdLst>
            <a:ahLst/>
            <a:rect l="textAreaLeft" t="textAreaTop" r="textAreaRight" b="textAreaBottom"/>
            <a:pathLst>
              <a:path w="431" h="91">
                <a:moveTo>
                  <a:pt x="431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5" name="Freeform 369"/>
          <p:cNvSpPr/>
          <p:nvPr/>
        </p:nvSpPr>
        <p:spPr>
          <a:xfrm>
            <a:off x="5307120" y="7709040"/>
            <a:ext cx="47520" cy="21960"/>
          </a:xfrm>
          <a:custGeom>
            <a:avLst/>
            <a:gdLst>
              <a:gd name="textAreaLeft" fmla="*/ 0 w 47520"/>
              <a:gd name="textAreaRight" fmla="*/ 47880 w 47520"/>
              <a:gd name="textAreaTop" fmla="*/ 0 h 21960"/>
              <a:gd name="textAreaBottom" fmla="*/ 22320 h 21960"/>
            </a:gdLst>
            <a:ahLst/>
            <a:rect l="textAreaLeft" t="textAreaTop" r="textAreaRight" b="textAreaBottom"/>
            <a:pathLst>
              <a:path w="331" h="92">
                <a:moveTo>
                  <a:pt x="331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6" name="Rectangle 377"/>
          <p:cNvSpPr/>
          <p:nvPr/>
        </p:nvSpPr>
        <p:spPr>
          <a:xfrm>
            <a:off x="5186880" y="7773840"/>
            <a:ext cx="1882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Cpa139.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7" name="Rectangle 386"/>
          <p:cNvSpPr/>
          <p:nvPr/>
        </p:nvSpPr>
        <p:spPr>
          <a:xfrm>
            <a:off x="5062320" y="6923160"/>
            <a:ext cx="1972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Ppa204103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8" name="Rectangle 387"/>
          <p:cNvSpPr/>
          <p:nvPr/>
        </p:nvSpPr>
        <p:spPr>
          <a:xfrm>
            <a:off x="5172840" y="7459560"/>
            <a:ext cx="2826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Glyma07g1569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9" name="Rectangle 388"/>
          <p:cNvSpPr/>
          <p:nvPr/>
        </p:nvSpPr>
        <p:spPr>
          <a:xfrm>
            <a:off x="4750560" y="8356680"/>
            <a:ext cx="2401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Bradi2g5424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0" name="Rectangle 392"/>
          <p:cNvSpPr/>
          <p:nvPr/>
        </p:nvSpPr>
        <p:spPr>
          <a:xfrm>
            <a:off x="4714920" y="8221680"/>
            <a:ext cx="3985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ZmaGRMZM2G426953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1" name="Rectangle 395"/>
          <p:cNvSpPr/>
          <p:nvPr/>
        </p:nvSpPr>
        <p:spPr>
          <a:xfrm>
            <a:off x="4599360" y="6564240"/>
            <a:ext cx="1864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Smo92554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2" name="Rectangle 396"/>
          <p:cNvSpPr/>
          <p:nvPr/>
        </p:nvSpPr>
        <p:spPr>
          <a:xfrm>
            <a:off x="5368680" y="7596360"/>
            <a:ext cx="156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AtRbohH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3" name="Rectangle 398"/>
          <p:cNvSpPr/>
          <p:nvPr/>
        </p:nvSpPr>
        <p:spPr>
          <a:xfrm>
            <a:off x="5957280" y="6743880"/>
            <a:ext cx="2826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Glyma17g086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4" name="Rectangle 403"/>
          <p:cNvSpPr/>
          <p:nvPr/>
        </p:nvSpPr>
        <p:spPr>
          <a:xfrm>
            <a:off x="6171480" y="6789600"/>
            <a:ext cx="2826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Glyma05g0042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5" name="Rectangle 422"/>
          <p:cNvSpPr/>
          <p:nvPr/>
        </p:nvSpPr>
        <p:spPr>
          <a:xfrm>
            <a:off x="4824360" y="6521400"/>
            <a:ext cx="2080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Smo11011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6" name="Rectangle 465"/>
          <p:cNvSpPr/>
          <p:nvPr/>
        </p:nvSpPr>
        <p:spPr>
          <a:xfrm>
            <a:off x="5147280" y="6475320"/>
            <a:ext cx="1864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Smo7426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7" name="Freeform 12"/>
          <p:cNvSpPr/>
          <p:nvPr/>
        </p:nvSpPr>
        <p:spPr>
          <a:xfrm>
            <a:off x="4500720" y="6924600"/>
            <a:ext cx="136440" cy="46080"/>
          </a:xfrm>
          <a:custGeom>
            <a:avLst/>
            <a:gdLst>
              <a:gd name="textAreaLeft" fmla="*/ 0 w 136440"/>
              <a:gd name="textAreaRight" fmla="*/ 136800 w 136440"/>
              <a:gd name="textAreaTop" fmla="*/ 0 h 46080"/>
              <a:gd name="textAreaBottom" fmla="*/ 46440 h 46080"/>
            </a:gdLst>
            <a:ahLst/>
            <a:rect l="textAreaLeft" t="textAreaTop" r="textAreaRight" b="textAreaBottom"/>
            <a:pathLst>
              <a:path w="952" h="184">
                <a:moveTo>
                  <a:pt x="952" y="184"/>
                </a:moveTo>
                <a:lnTo>
                  <a:pt x="0" y="184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8" name="Freeform 22"/>
          <p:cNvSpPr/>
          <p:nvPr/>
        </p:nvSpPr>
        <p:spPr>
          <a:xfrm>
            <a:off x="4710240" y="7742160"/>
            <a:ext cx="463320" cy="55800"/>
          </a:xfrm>
          <a:custGeom>
            <a:avLst/>
            <a:gdLst>
              <a:gd name="textAreaLeft" fmla="*/ 0 w 463320"/>
              <a:gd name="textAreaRight" fmla="*/ 463680 w 463320"/>
              <a:gd name="textAreaTop" fmla="*/ 0 h 55800"/>
              <a:gd name="textAreaBottom" fmla="*/ 56160 h 55800"/>
            </a:gdLst>
            <a:ahLst/>
            <a:rect l="textAreaLeft" t="textAreaTop" r="textAreaRight" b="textAreaBottom"/>
            <a:pathLst>
              <a:path w="3222" h="228">
                <a:moveTo>
                  <a:pt x="3222" y="228"/>
                </a:moveTo>
                <a:lnTo>
                  <a:pt x="0" y="228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9360" bIns="93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9" name="Freeform 23"/>
          <p:cNvSpPr/>
          <p:nvPr/>
        </p:nvSpPr>
        <p:spPr>
          <a:xfrm>
            <a:off x="4402080" y="8074080"/>
            <a:ext cx="338040" cy="49320"/>
          </a:xfrm>
          <a:custGeom>
            <a:avLst/>
            <a:gdLst>
              <a:gd name="textAreaLeft" fmla="*/ 0 w 338040"/>
              <a:gd name="textAreaRight" fmla="*/ 338400 w 338040"/>
              <a:gd name="textAreaTop" fmla="*/ 0 h 49320"/>
              <a:gd name="textAreaBottom" fmla="*/ 49680 h 49320"/>
            </a:gdLst>
            <a:ahLst/>
            <a:rect l="textAreaLeft" t="textAreaTop" r="textAreaRight" b="textAreaBottom"/>
            <a:pathLst>
              <a:path w="2359" h="206">
                <a:moveTo>
                  <a:pt x="2359" y="206"/>
                </a:moveTo>
                <a:lnTo>
                  <a:pt x="0" y="206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880" bIns="28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0" name="Freeform 27"/>
          <p:cNvSpPr/>
          <p:nvPr/>
        </p:nvSpPr>
        <p:spPr>
          <a:xfrm>
            <a:off x="4975200" y="7462800"/>
            <a:ext cx="187200" cy="22320"/>
          </a:xfrm>
          <a:custGeom>
            <a:avLst/>
            <a:gdLst>
              <a:gd name="textAreaLeft" fmla="*/ 0 w 187200"/>
              <a:gd name="textAreaRight" fmla="*/ 187560 w 18720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1302" h="91">
                <a:moveTo>
                  <a:pt x="1302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1" name="Freeform 28"/>
          <p:cNvSpPr/>
          <p:nvPr/>
        </p:nvSpPr>
        <p:spPr>
          <a:xfrm>
            <a:off x="4637160" y="6946920"/>
            <a:ext cx="412560" cy="23760"/>
          </a:xfrm>
          <a:custGeom>
            <a:avLst/>
            <a:gdLst>
              <a:gd name="textAreaLeft" fmla="*/ 0 w 412560"/>
              <a:gd name="textAreaRight" fmla="*/ 412920 w 412560"/>
              <a:gd name="textAreaTop" fmla="*/ 0 h 23760"/>
              <a:gd name="textAreaBottom" fmla="*/ 24120 h 23760"/>
            </a:gdLst>
            <a:ahLst/>
            <a:rect l="textAreaLeft" t="textAreaTop" r="textAreaRight" b="textAreaBottom"/>
            <a:pathLst>
              <a:path w="2862" h="92">
                <a:moveTo>
                  <a:pt x="2862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2" name="Freeform 32"/>
          <p:cNvSpPr/>
          <p:nvPr/>
        </p:nvSpPr>
        <p:spPr>
          <a:xfrm>
            <a:off x="4570560" y="8224920"/>
            <a:ext cx="133200" cy="22320"/>
          </a:xfrm>
          <a:custGeom>
            <a:avLst/>
            <a:gdLst>
              <a:gd name="textAreaLeft" fmla="*/ 0 w 133200"/>
              <a:gd name="textAreaRight" fmla="*/ 133560 w 13320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924" h="91">
                <a:moveTo>
                  <a:pt x="924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3" name="Freeform 33"/>
          <p:cNvSpPr/>
          <p:nvPr/>
        </p:nvSpPr>
        <p:spPr>
          <a:xfrm>
            <a:off x="4483080" y="7372440"/>
            <a:ext cx="87480" cy="82440"/>
          </a:xfrm>
          <a:custGeom>
            <a:avLst/>
            <a:gdLst>
              <a:gd name="textAreaLeft" fmla="*/ 0 w 87480"/>
              <a:gd name="textAreaRight" fmla="*/ 87840 w 87480"/>
              <a:gd name="textAreaTop" fmla="*/ 0 h 82440"/>
              <a:gd name="textAreaBottom" fmla="*/ 82440 h 82440"/>
            </a:gdLst>
            <a:ahLst/>
            <a:rect l="textAreaLeft" t="textAreaTop" r="textAreaRight" b="textAreaBottom"/>
            <a:pathLst>
              <a:path w="599" h="332">
                <a:moveTo>
                  <a:pt x="599" y="0"/>
                </a:moveTo>
                <a:lnTo>
                  <a:pt x="0" y="0"/>
                </a:lnTo>
                <a:lnTo>
                  <a:pt x="0" y="33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4" name="Freeform 35"/>
          <p:cNvSpPr/>
          <p:nvPr/>
        </p:nvSpPr>
        <p:spPr>
          <a:xfrm>
            <a:off x="3978360" y="6589800"/>
            <a:ext cx="609480" cy="6120"/>
          </a:xfrm>
          <a:custGeom>
            <a:avLst/>
            <a:gdLst>
              <a:gd name="textAreaLeft" fmla="*/ 0 w 609480"/>
              <a:gd name="textAreaRight" fmla="*/ 609840 w 609480"/>
              <a:gd name="textAreaTop" fmla="*/ 0 h 6120"/>
              <a:gd name="textAreaBottom" fmla="*/ 6480 h 6120"/>
            </a:gdLst>
            <a:ahLst/>
            <a:rect l="textAreaLeft" t="textAreaTop" r="textAreaRight" b="textAreaBottom"/>
            <a:pathLst>
              <a:path w="4234" h="27">
                <a:moveTo>
                  <a:pt x="4234" y="0"/>
                </a:moveTo>
                <a:lnTo>
                  <a:pt x="0" y="0"/>
                </a:lnTo>
                <a:lnTo>
                  <a:pt x="0" y="27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5" name="Freeform 37"/>
          <p:cNvSpPr/>
          <p:nvPr/>
        </p:nvSpPr>
        <p:spPr>
          <a:xfrm>
            <a:off x="5300640" y="7620120"/>
            <a:ext cx="55440" cy="21960"/>
          </a:xfrm>
          <a:custGeom>
            <a:avLst/>
            <a:gdLst>
              <a:gd name="textAreaLeft" fmla="*/ 0 w 55440"/>
              <a:gd name="textAreaRight" fmla="*/ 55800 w 55440"/>
              <a:gd name="textAreaTop" fmla="*/ 0 h 21960"/>
              <a:gd name="textAreaBottom" fmla="*/ 22320 h 21960"/>
            </a:gdLst>
            <a:ahLst/>
            <a:rect l="textAreaLeft" t="textAreaTop" r="textAreaRight" b="textAreaBottom"/>
            <a:pathLst>
              <a:path w="382" h="91">
                <a:moveTo>
                  <a:pt x="382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6" name="Freeform 39"/>
          <p:cNvSpPr/>
          <p:nvPr/>
        </p:nvSpPr>
        <p:spPr>
          <a:xfrm>
            <a:off x="5781600" y="6769080"/>
            <a:ext cx="165240" cy="22320"/>
          </a:xfrm>
          <a:custGeom>
            <a:avLst/>
            <a:gdLst>
              <a:gd name="textAreaLeft" fmla="*/ 0 w 165240"/>
              <a:gd name="textAreaRight" fmla="*/ 165600 w 16524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1144" h="92">
                <a:moveTo>
                  <a:pt x="1144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7" name="Freeform 43"/>
          <p:cNvSpPr/>
          <p:nvPr/>
        </p:nvSpPr>
        <p:spPr>
          <a:xfrm>
            <a:off x="5781600" y="6791400"/>
            <a:ext cx="379440" cy="20520"/>
          </a:xfrm>
          <a:custGeom>
            <a:avLst/>
            <a:gdLst>
              <a:gd name="textAreaLeft" fmla="*/ 0 w 379440"/>
              <a:gd name="textAreaRight" fmla="*/ 379800 w 379440"/>
              <a:gd name="textAreaTop" fmla="*/ 0 h 20520"/>
              <a:gd name="textAreaBottom" fmla="*/ 20520 h 20520"/>
            </a:gdLst>
            <a:ahLst/>
            <a:rect l="textAreaLeft" t="textAreaTop" r="textAreaRight" b="textAreaBottom"/>
            <a:pathLst>
              <a:path w="2629" h="91">
                <a:moveTo>
                  <a:pt x="2629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8" name="Freeform 56"/>
          <p:cNvSpPr/>
          <p:nvPr/>
        </p:nvSpPr>
        <p:spPr>
          <a:xfrm>
            <a:off x="4336920" y="7126200"/>
            <a:ext cx="266760" cy="23760"/>
          </a:xfrm>
          <a:custGeom>
            <a:avLst/>
            <a:gdLst>
              <a:gd name="textAreaLeft" fmla="*/ 0 w 266760"/>
              <a:gd name="textAreaRight" fmla="*/ 267120 w 266760"/>
              <a:gd name="textAreaTop" fmla="*/ 0 h 23760"/>
              <a:gd name="textAreaBottom" fmla="*/ 24120 h 23760"/>
            </a:gdLst>
            <a:ahLst/>
            <a:rect l="textAreaLeft" t="textAreaTop" r="textAreaRight" b="textAreaBottom"/>
            <a:pathLst>
              <a:path w="1855" h="91">
                <a:moveTo>
                  <a:pt x="1855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9" name="Freeform 58"/>
          <p:cNvSpPr/>
          <p:nvPr/>
        </p:nvSpPr>
        <p:spPr>
          <a:xfrm>
            <a:off x="4200480" y="6523200"/>
            <a:ext cx="612720" cy="20520"/>
          </a:xfrm>
          <a:custGeom>
            <a:avLst/>
            <a:gdLst>
              <a:gd name="textAreaLeft" fmla="*/ 0 w 612720"/>
              <a:gd name="textAreaRight" fmla="*/ 613080 w 612720"/>
              <a:gd name="textAreaTop" fmla="*/ 0 h 20520"/>
              <a:gd name="textAreaBottom" fmla="*/ 20520 h 20520"/>
            </a:gdLst>
            <a:ahLst/>
            <a:rect l="textAreaLeft" t="textAreaTop" r="textAreaRight" b="textAreaBottom"/>
            <a:pathLst>
              <a:path w="4254" h="91">
                <a:moveTo>
                  <a:pt x="4254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0" name="Freeform 64"/>
          <p:cNvSpPr/>
          <p:nvPr/>
        </p:nvSpPr>
        <p:spPr>
          <a:xfrm>
            <a:off x="4713120" y="8426520"/>
            <a:ext cx="63720" cy="20520"/>
          </a:xfrm>
          <a:custGeom>
            <a:avLst/>
            <a:gdLst>
              <a:gd name="textAreaLeft" fmla="*/ 0 w 63720"/>
              <a:gd name="textAreaRight" fmla="*/ 64080 w 63720"/>
              <a:gd name="textAreaTop" fmla="*/ 0 h 20520"/>
              <a:gd name="textAreaBottom" fmla="*/ 20880 h 20520"/>
            </a:gdLst>
            <a:ahLst/>
            <a:rect l="textAreaLeft" t="textAreaTop" r="textAreaRight" b="textAreaBottom"/>
            <a:pathLst>
              <a:path w="451" h="92">
                <a:moveTo>
                  <a:pt x="451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1" name="Freeform 69"/>
          <p:cNvSpPr/>
          <p:nvPr/>
        </p:nvSpPr>
        <p:spPr>
          <a:xfrm>
            <a:off x="4402080" y="8023320"/>
            <a:ext cx="441360" cy="50760"/>
          </a:xfrm>
          <a:custGeom>
            <a:avLst/>
            <a:gdLst>
              <a:gd name="textAreaLeft" fmla="*/ 0 w 441360"/>
              <a:gd name="textAreaRight" fmla="*/ 441720 w 441360"/>
              <a:gd name="textAreaTop" fmla="*/ 0 h 50760"/>
              <a:gd name="textAreaBottom" fmla="*/ 51120 h 50760"/>
            </a:gdLst>
            <a:ahLst/>
            <a:rect l="textAreaLeft" t="textAreaTop" r="textAreaRight" b="textAreaBottom"/>
            <a:pathLst>
              <a:path w="3070" h="207">
                <a:moveTo>
                  <a:pt x="3070" y="0"/>
                </a:moveTo>
                <a:lnTo>
                  <a:pt x="0" y="0"/>
                </a:lnTo>
                <a:lnTo>
                  <a:pt x="0" y="207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20" bIns="43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2" name="Freeform 70"/>
          <p:cNvSpPr/>
          <p:nvPr/>
        </p:nvSpPr>
        <p:spPr>
          <a:xfrm>
            <a:off x="4684680" y="6858000"/>
            <a:ext cx="247680" cy="22320"/>
          </a:xfrm>
          <a:custGeom>
            <a:avLst/>
            <a:gdLst>
              <a:gd name="textAreaLeft" fmla="*/ 0 w 247680"/>
              <a:gd name="textAreaRight" fmla="*/ 248040 w 24768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1724" h="91">
                <a:moveTo>
                  <a:pt x="1724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3" name="Freeform 72"/>
          <p:cNvSpPr/>
          <p:nvPr/>
        </p:nvSpPr>
        <p:spPr>
          <a:xfrm>
            <a:off x="4356000" y="7640640"/>
            <a:ext cx="34920" cy="216000"/>
          </a:xfrm>
          <a:custGeom>
            <a:avLst/>
            <a:gdLst>
              <a:gd name="textAreaLeft" fmla="*/ 0 w 34920"/>
              <a:gd name="textAreaRight" fmla="*/ 35280 w 34920"/>
              <a:gd name="textAreaTop" fmla="*/ 0 h 216000"/>
              <a:gd name="textAreaBottom" fmla="*/ 216360 h 216000"/>
            </a:gdLst>
            <a:ahLst/>
            <a:rect l="textAreaLeft" t="textAreaTop" r="textAreaRight" b="textAreaBottom"/>
            <a:pathLst>
              <a:path w="255" h="884">
                <a:moveTo>
                  <a:pt x="255" y="0"/>
                </a:moveTo>
                <a:lnTo>
                  <a:pt x="0" y="0"/>
                </a:lnTo>
                <a:lnTo>
                  <a:pt x="0" y="884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4" name="Freeform 73"/>
          <p:cNvSpPr/>
          <p:nvPr/>
        </p:nvSpPr>
        <p:spPr>
          <a:xfrm>
            <a:off x="4802040" y="7932600"/>
            <a:ext cx="344520" cy="22320"/>
          </a:xfrm>
          <a:custGeom>
            <a:avLst/>
            <a:gdLst>
              <a:gd name="textAreaLeft" fmla="*/ 0 w 344520"/>
              <a:gd name="textAreaRight" fmla="*/ 344880 w 34452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2390" h="92">
                <a:moveTo>
                  <a:pt x="2390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5" name="Freeform 78"/>
          <p:cNvSpPr/>
          <p:nvPr/>
        </p:nvSpPr>
        <p:spPr>
          <a:xfrm>
            <a:off x="3556080" y="7153200"/>
            <a:ext cx="985680" cy="108000"/>
          </a:xfrm>
          <a:custGeom>
            <a:avLst/>
            <a:gdLst>
              <a:gd name="textAreaLeft" fmla="*/ 0 w 985680"/>
              <a:gd name="textAreaRight" fmla="*/ 986040 w 985680"/>
              <a:gd name="textAreaTop" fmla="*/ 0 h 108000"/>
              <a:gd name="textAreaBottom" fmla="*/ 108360 h 108000"/>
            </a:gdLst>
            <a:ahLst/>
            <a:rect l="textAreaLeft" t="textAreaTop" r="textAreaRight" b="textAreaBottom"/>
            <a:pathLst>
              <a:path w="6848" h="439">
                <a:moveTo>
                  <a:pt x="6848" y="439"/>
                </a:moveTo>
                <a:lnTo>
                  <a:pt x="0" y="439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6" name="Freeform 80"/>
          <p:cNvSpPr/>
          <p:nvPr/>
        </p:nvSpPr>
        <p:spPr>
          <a:xfrm>
            <a:off x="4062240" y="8120160"/>
            <a:ext cx="344520" cy="263520"/>
          </a:xfrm>
          <a:custGeom>
            <a:avLst/>
            <a:gdLst>
              <a:gd name="textAreaLeft" fmla="*/ 0 w 344520"/>
              <a:gd name="textAreaRight" fmla="*/ 344880 w 344520"/>
              <a:gd name="textAreaTop" fmla="*/ 0 h 263520"/>
              <a:gd name="textAreaBottom" fmla="*/ 263880 h 263520"/>
            </a:gdLst>
            <a:ahLst/>
            <a:rect l="textAreaLeft" t="textAreaTop" r="textAreaRight" b="textAreaBottom"/>
            <a:pathLst>
              <a:path w="2388" h="1077">
                <a:moveTo>
                  <a:pt x="2388" y="1077"/>
                </a:moveTo>
                <a:lnTo>
                  <a:pt x="0" y="1077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7" name="Freeform 82"/>
          <p:cNvSpPr/>
          <p:nvPr/>
        </p:nvSpPr>
        <p:spPr>
          <a:xfrm>
            <a:off x="4483080" y="7454880"/>
            <a:ext cx="263520" cy="79560"/>
          </a:xfrm>
          <a:custGeom>
            <a:avLst/>
            <a:gdLst>
              <a:gd name="textAreaLeft" fmla="*/ 0 w 263520"/>
              <a:gd name="textAreaRight" fmla="*/ 263880 w 263520"/>
              <a:gd name="textAreaTop" fmla="*/ 0 h 79560"/>
              <a:gd name="textAreaBottom" fmla="*/ 79920 h 79560"/>
            </a:gdLst>
            <a:ahLst/>
            <a:rect l="textAreaLeft" t="textAreaTop" r="textAreaRight" b="textAreaBottom"/>
            <a:pathLst>
              <a:path w="1832" h="332">
                <a:moveTo>
                  <a:pt x="1832" y="332"/>
                </a:moveTo>
                <a:lnTo>
                  <a:pt x="0" y="33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3120" bIns="33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8" name="Freeform 89"/>
          <p:cNvSpPr/>
          <p:nvPr/>
        </p:nvSpPr>
        <p:spPr>
          <a:xfrm>
            <a:off x="3456000" y="7153200"/>
            <a:ext cx="100080" cy="372960"/>
          </a:xfrm>
          <a:custGeom>
            <a:avLst/>
            <a:gdLst>
              <a:gd name="textAreaLeft" fmla="*/ 0 w 100080"/>
              <a:gd name="textAreaRight" fmla="*/ 100440 w 100080"/>
              <a:gd name="textAreaTop" fmla="*/ 0 h 372960"/>
              <a:gd name="textAreaBottom" fmla="*/ 373320 h 372960"/>
            </a:gdLst>
            <a:ahLst/>
            <a:rect l="textAreaLeft" t="textAreaTop" r="textAreaRight" b="textAreaBottom"/>
            <a:pathLst>
              <a:path w="696" h="1525">
                <a:moveTo>
                  <a:pt x="696" y="0"/>
                </a:moveTo>
                <a:lnTo>
                  <a:pt x="0" y="0"/>
                </a:lnTo>
                <a:lnTo>
                  <a:pt x="0" y="1525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9" name="Freeform 91"/>
          <p:cNvSpPr/>
          <p:nvPr/>
        </p:nvSpPr>
        <p:spPr>
          <a:xfrm>
            <a:off x="4570560" y="7372440"/>
            <a:ext cx="634680" cy="23760"/>
          </a:xfrm>
          <a:custGeom>
            <a:avLst/>
            <a:gdLst>
              <a:gd name="textAreaLeft" fmla="*/ 0 w 634680"/>
              <a:gd name="textAreaRight" fmla="*/ 635040 w 634680"/>
              <a:gd name="textAreaTop" fmla="*/ 0 h 23760"/>
              <a:gd name="textAreaBottom" fmla="*/ 24120 h 23760"/>
            </a:gdLst>
            <a:ahLst/>
            <a:rect l="textAreaLeft" t="textAreaTop" r="textAreaRight" b="textAreaBottom"/>
            <a:pathLst>
              <a:path w="4415" h="92">
                <a:moveTo>
                  <a:pt x="4415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0" name="Freeform 92"/>
          <p:cNvSpPr/>
          <p:nvPr/>
        </p:nvSpPr>
        <p:spPr>
          <a:xfrm>
            <a:off x="4710240" y="7686720"/>
            <a:ext cx="377640" cy="55440"/>
          </a:xfrm>
          <a:custGeom>
            <a:avLst/>
            <a:gdLst>
              <a:gd name="textAreaLeft" fmla="*/ 0 w 377640"/>
              <a:gd name="textAreaRight" fmla="*/ 378000 w 377640"/>
              <a:gd name="textAreaTop" fmla="*/ 0 h 55440"/>
              <a:gd name="textAreaBottom" fmla="*/ 55800 h 55440"/>
            </a:gdLst>
            <a:ahLst/>
            <a:rect l="textAreaLeft" t="textAreaTop" r="textAreaRight" b="textAreaBottom"/>
            <a:pathLst>
              <a:path w="2623" h="229">
                <a:moveTo>
                  <a:pt x="2623" y="0"/>
                </a:moveTo>
                <a:lnTo>
                  <a:pt x="0" y="0"/>
                </a:lnTo>
                <a:lnTo>
                  <a:pt x="0" y="229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1" name="Freeform 103"/>
          <p:cNvSpPr/>
          <p:nvPr/>
        </p:nvSpPr>
        <p:spPr>
          <a:xfrm>
            <a:off x="4746600" y="7496280"/>
            <a:ext cx="46080" cy="38160"/>
          </a:xfrm>
          <a:custGeom>
            <a:avLst/>
            <a:gdLst>
              <a:gd name="textAreaLeft" fmla="*/ 0 w 46080"/>
              <a:gd name="textAreaRight" fmla="*/ 46440 w 4608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319" h="160">
                <a:moveTo>
                  <a:pt x="319" y="0"/>
                </a:moveTo>
                <a:lnTo>
                  <a:pt x="0" y="0"/>
                </a:lnTo>
                <a:lnTo>
                  <a:pt x="0" y="16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8280" bIns="-82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2" name="Freeform 104"/>
          <p:cNvSpPr/>
          <p:nvPr/>
        </p:nvSpPr>
        <p:spPr>
          <a:xfrm>
            <a:off x="4792680" y="7496280"/>
            <a:ext cx="250920" cy="33120"/>
          </a:xfrm>
          <a:custGeom>
            <a:avLst/>
            <a:gdLst>
              <a:gd name="textAreaLeft" fmla="*/ 0 w 250920"/>
              <a:gd name="textAreaRight" fmla="*/ 251280 w 250920"/>
              <a:gd name="textAreaTop" fmla="*/ 0 h 33120"/>
              <a:gd name="textAreaBottom" fmla="*/ 33480 h 33120"/>
            </a:gdLst>
            <a:ahLst/>
            <a:rect l="textAreaLeft" t="textAreaTop" r="textAreaRight" b="textAreaBottom"/>
            <a:pathLst>
              <a:path w="1736" h="137">
                <a:moveTo>
                  <a:pt x="1736" y="137"/>
                </a:moveTo>
                <a:lnTo>
                  <a:pt x="0" y="137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3" name="Freeform 107"/>
          <p:cNvSpPr/>
          <p:nvPr/>
        </p:nvSpPr>
        <p:spPr>
          <a:xfrm>
            <a:off x="4540320" y="8291520"/>
            <a:ext cx="93600" cy="33480"/>
          </a:xfrm>
          <a:custGeom>
            <a:avLst/>
            <a:gdLst>
              <a:gd name="textAreaLeft" fmla="*/ 0 w 93600"/>
              <a:gd name="textAreaRight" fmla="*/ 93960 w 93600"/>
              <a:gd name="textAreaTop" fmla="*/ 0 h 33480"/>
              <a:gd name="textAreaBottom" fmla="*/ 33840 h 33480"/>
            </a:gdLst>
            <a:ahLst/>
            <a:rect l="textAreaLeft" t="textAreaTop" r="textAreaRight" b="textAreaBottom"/>
            <a:pathLst>
              <a:path w="645" h="137">
                <a:moveTo>
                  <a:pt x="645" y="0"/>
                </a:moveTo>
                <a:lnTo>
                  <a:pt x="0" y="0"/>
                </a:lnTo>
                <a:lnTo>
                  <a:pt x="0" y="137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4" name="Freeform 111"/>
          <p:cNvSpPr/>
          <p:nvPr/>
        </p:nvSpPr>
        <p:spPr>
          <a:xfrm>
            <a:off x="3841920" y="6761160"/>
            <a:ext cx="658800" cy="163440"/>
          </a:xfrm>
          <a:custGeom>
            <a:avLst/>
            <a:gdLst>
              <a:gd name="textAreaLeft" fmla="*/ 0 w 658800"/>
              <a:gd name="textAreaRight" fmla="*/ 659160 w 658800"/>
              <a:gd name="textAreaTop" fmla="*/ 0 h 163440"/>
              <a:gd name="textAreaBottom" fmla="*/ 163800 h 163440"/>
            </a:gdLst>
            <a:ahLst/>
            <a:rect l="textAreaLeft" t="textAreaTop" r="textAreaRight" b="textAreaBottom"/>
            <a:pathLst>
              <a:path w="4570" h="673">
                <a:moveTo>
                  <a:pt x="4570" y="673"/>
                </a:moveTo>
                <a:lnTo>
                  <a:pt x="0" y="673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5" name="Freeform 113"/>
          <p:cNvSpPr/>
          <p:nvPr/>
        </p:nvSpPr>
        <p:spPr>
          <a:xfrm>
            <a:off x="4406760" y="8273880"/>
            <a:ext cx="95400" cy="109800"/>
          </a:xfrm>
          <a:custGeom>
            <a:avLst/>
            <a:gdLst>
              <a:gd name="textAreaLeft" fmla="*/ 0 w 95400"/>
              <a:gd name="textAreaRight" fmla="*/ 95760 w 95400"/>
              <a:gd name="textAreaTop" fmla="*/ 0 h 109800"/>
              <a:gd name="textAreaBottom" fmla="*/ 110160 h 109800"/>
            </a:gdLst>
            <a:ahLst/>
            <a:rect l="textAreaLeft" t="textAreaTop" r="textAreaRight" b="textAreaBottom"/>
            <a:pathLst>
              <a:path w="660" h="446">
                <a:moveTo>
                  <a:pt x="660" y="0"/>
                </a:moveTo>
                <a:lnTo>
                  <a:pt x="0" y="0"/>
                </a:lnTo>
                <a:lnTo>
                  <a:pt x="0" y="446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6" name="Freeform 116"/>
          <p:cNvSpPr/>
          <p:nvPr/>
        </p:nvSpPr>
        <p:spPr>
          <a:xfrm>
            <a:off x="5300640" y="7642080"/>
            <a:ext cx="31680" cy="22320"/>
          </a:xfrm>
          <a:custGeom>
            <a:avLst/>
            <a:gdLst>
              <a:gd name="textAreaLeft" fmla="*/ 0 w 31680"/>
              <a:gd name="textAreaRight" fmla="*/ 32040 w 3168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224" h="92">
                <a:moveTo>
                  <a:pt x="224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7" name="Freeform 119"/>
          <p:cNvSpPr/>
          <p:nvPr/>
        </p:nvSpPr>
        <p:spPr>
          <a:xfrm>
            <a:off x="4832280" y="6634080"/>
            <a:ext cx="987480" cy="41400"/>
          </a:xfrm>
          <a:custGeom>
            <a:avLst/>
            <a:gdLst>
              <a:gd name="textAreaLeft" fmla="*/ 0 w 987480"/>
              <a:gd name="textAreaRight" fmla="*/ 987840 w 987480"/>
              <a:gd name="textAreaTop" fmla="*/ 0 h 41400"/>
              <a:gd name="textAreaBottom" fmla="*/ 41760 h 41400"/>
            </a:gdLst>
            <a:ahLst/>
            <a:rect l="textAreaLeft" t="textAreaTop" r="textAreaRight" b="textAreaBottom"/>
            <a:pathLst>
              <a:path w="6844" h="171">
                <a:moveTo>
                  <a:pt x="6844" y="0"/>
                </a:moveTo>
                <a:lnTo>
                  <a:pt x="0" y="0"/>
                </a:lnTo>
                <a:lnTo>
                  <a:pt x="0" y="17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5040" bIns="-504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8" name="Freeform 122"/>
          <p:cNvSpPr/>
          <p:nvPr/>
        </p:nvSpPr>
        <p:spPr>
          <a:xfrm>
            <a:off x="4540320" y="8325000"/>
            <a:ext cx="68040" cy="33120"/>
          </a:xfrm>
          <a:custGeom>
            <a:avLst/>
            <a:gdLst>
              <a:gd name="textAreaLeft" fmla="*/ 0 w 68040"/>
              <a:gd name="textAreaRight" fmla="*/ 68400 w 68040"/>
              <a:gd name="textAreaTop" fmla="*/ 0 h 33120"/>
              <a:gd name="textAreaBottom" fmla="*/ 33480 h 33120"/>
            </a:gdLst>
            <a:ahLst/>
            <a:rect l="textAreaLeft" t="textAreaTop" r="textAreaRight" b="textAreaBottom"/>
            <a:pathLst>
              <a:path w="477" h="137">
                <a:moveTo>
                  <a:pt x="477" y="137"/>
                </a:moveTo>
                <a:lnTo>
                  <a:pt x="0" y="137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9" name="Freeform 135"/>
          <p:cNvSpPr/>
          <p:nvPr/>
        </p:nvSpPr>
        <p:spPr>
          <a:xfrm>
            <a:off x="3681360" y="6761160"/>
            <a:ext cx="160560" cy="149400"/>
          </a:xfrm>
          <a:custGeom>
            <a:avLst/>
            <a:gdLst>
              <a:gd name="textAreaLeft" fmla="*/ 0 w 160560"/>
              <a:gd name="textAreaRight" fmla="*/ 160920 w 160560"/>
              <a:gd name="textAreaTop" fmla="*/ 0 h 149400"/>
              <a:gd name="textAreaBottom" fmla="*/ 149760 h 149400"/>
            </a:gdLst>
            <a:ahLst/>
            <a:rect l="textAreaLeft" t="textAreaTop" r="textAreaRight" b="textAreaBottom"/>
            <a:pathLst>
              <a:path w="1109" h="611">
                <a:moveTo>
                  <a:pt x="1109" y="0"/>
                </a:moveTo>
                <a:lnTo>
                  <a:pt x="0" y="0"/>
                </a:lnTo>
                <a:lnTo>
                  <a:pt x="0" y="61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0" name="Freeform 142"/>
          <p:cNvSpPr/>
          <p:nvPr/>
        </p:nvSpPr>
        <p:spPr>
          <a:xfrm>
            <a:off x="3978360" y="6523200"/>
            <a:ext cx="222120" cy="72720"/>
          </a:xfrm>
          <a:custGeom>
            <a:avLst/>
            <a:gdLst>
              <a:gd name="textAreaLeft" fmla="*/ 0 w 222120"/>
              <a:gd name="textAreaRight" fmla="*/ 222480 w 222120"/>
              <a:gd name="textAreaTop" fmla="*/ 0 h 72720"/>
              <a:gd name="textAreaBottom" fmla="*/ 73080 h 72720"/>
            </a:gdLst>
            <a:ahLst/>
            <a:rect l="textAreaLeft" t="textAreaTop" r="textAreaRight" b="textAreaBottom"/>
            <a:pathLst>
              <a:path w="1547" h="301">
                <a:moveTo>
                  <a:pt x="1547" y="0"/>
                </a:moveTo>
                <a:lnTo>
                  <a:pt x="0" y="0"/>
                </a:lnTo>
                <a:lnTo>
                  <a:pt x="0" y="30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1" name="Freeform 144"/>
          <p:cNvSpPr/>
          <p:nvPr/>
        </p:nvSpPr>
        <p:spPr>
          <a:xfrm>
            <a:off x="5248440" y="6723000"/>
            <a:ext cx="726840" cy="33480"/>
          </a:xfrm>
          <a:custGeom>
            <a:avLst/>
            <a:gdLst>
              <a:gd name="textAreaLeft" fmla="*/ 0 w 726840"/>
              <a:gd name="textAreaRight" fmla="*/ 727200 w 726840"/>
              <a:gd name="textAreaTop" fmla="*/ 0 h 33480"/>
              <a:gd name="textAreaBottom" fmla="*/ 33840 h 33480"/>
            </a:gdLst>
            <a:ahLst/>
            <a:rect l="textAreaLeft" t="textAreaTop" r="textAreaRight" b="textAreaBottom"/>
            <a:pathLst>
              <a:path w="5040" h="137">
                <a:moveTo>
                  <a:pt x="5040" y="0"/>
                </a:moveTo>
                <a:lnTo>
                  <a:pt x="0" y="0"/>
                </a:lnTo>
                <a:lnTo>
                  <a:pt x="0" y="137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2" name="Freeform 148"/>
          <p:cNvSpPr/>
          <p:nvPr/>
        </p:nvSpPr>
        <p:spPr>
          <a:xfrm>
            <a:off x="3978360" y="6595920"/>
            <a:ext cx="853920" cy="79560"/>
          </a:xfrm>
          <a:custGeom>
            <a:avLst/>
            <a:gdLst>
              <a:gd name="textAreaLeft" fmla="*/ 0 w 853920"/>
              <a:gd name="textAreaRight" fmla="*/ 854280 w 853920"/>
              <a:gd name="textAreaTop" fmla="*/ 0 h 79560"/>
              <a:gd name="textAreaBottom" fmla="*/ 79920 h 79560"/>
            </a:gdLst>
            <a:ahLst/>
            <a:rect l="textAreaLeft" t="textAreaTop" r="textAreaRight" b="textAreaBottom"/>
            <a:pathLst>
              <a:path w="5936" h="328">
                <a:moveTo>
                  <a:pt x="5936" y="328"/>
                </a:moveTo>
                <a:lnTo>
                  <a:pt x="0" y="328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3120" bIns="33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3" name="Freeform 151"/>
          <p:cNvSpPr/>
          <p:nvPr/>
        </p:nvSpPr>
        <p:spPr>
          <a:xfrm>
            <a:off x="3708360" y="7149960"/>
            <a:ext cx="628560" cy="32040"/>
          </a:xfrm>
          <a:custGeom>
            <a:avLst/>
            <a:gdLst>
              <a:gd name="textAreaLeft" fmla="*/ 0 w 628560"/>
              <a:gd name="textAreaRight" fmla="*/ 628920 w 628560"/>
              <a:gd name="textAreaTop" fmla="*/ 0 h 32040"/>
              <a:gd name="textAreaBottom" fmla="*/ 32400 h 32040"/>
            </a:gdLst>
            <a:ahLst/>
            <a:rect l="textAreaLeft" t="textAreaTop" r="textAreaRight" b="textAreaBottom"/>
            <a:pathLst>
              <a:path w="4357" h="138">
                <a:moveTo>
                  <a:pt x="4357" y="0"/>
                </a:moveTo>
                <a:lnTo>
                  <a:pt x="0" y="0"/>
                </a:lnTo>
                <a:lnTo>
                  <a:pt x="0" y="138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4400" bIns="-144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4" name="Freeform 154"/>
          <p:cNvSpPr/>
          <p:nvPr/>
        </p:nvSpPr>
        <p:spPr>
          <a:xfrm>
            <a:off x="4802040" y="7954920"/>
            <a:ext cx="459000" cy="23760"/>
          </a:xfrm>
          <a:custGeom>
            <a:avLst/>
            <a:gdLst>
              <a:gd name="textAreaLeft" fmla="*/ 0 w 459000"/>
              <a:gd name="textAreaRight" fmla="*/ 459360 w 459000"/>
              <a:gd name="textAreaTop" fmla="*/ 0 h 23760"/>
              <a:gd name="textAreaBottom" fmla="*/ 24120 h 23760"/>
            </a:gdLst>
            <a:ahLst/>
            <a:rect l="textAreaLeft" t="textAreaTop" r="textAreaRight" b="textAreaBottom"/>
            <a:pathLst>
              <a:path w="3177" h="91">
                <a:moveTo>
                  <a:pt x="3177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5" name="Freeform 168"/>
          <p:cNvSpPr/>
          <p:nvPr/>
        </p:nvSpPr>
        <p:spPr>
          <a:xfrm>
            <a:off x="4406760" y="8383680"/>
            <a:ext cx="203400" cy="109440"/>
          </a:xfrm>
          <a:custGeom>
            <a:avLst/>
            <a:gdLst>
              <a:gd name="textAreaLeft" fmla="*/ 0 w 203400"/>
              <a:gd name="textAreaRight" fmla="*/ 203760 w 203400"/>
              <a:gd name="textAreaTop" fmla="*/ 0 h 109440"/>
              <a:gd name="textAreaBottom" fmla="*/ 109800 h 109440"/>
            </a:gdLst>
            <a:ahLst/>
            <a:rect l="textAreaLeft" t="textAreaTop" r="textAreaRight" b="textAreaBottom"/>
            <a:pathLst>
              <a:path w="1411" h="447">
                <a:moveTo>
                  <a:pt x="1411" y="447"/>
                </a:moveTo>
                <a:lnTo>
                  <a:pt x="0" y="447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6" name="Freeform 172"/>
          <p:cNvSpPr/>
          <p:nvPr/>
        </p:nvSpPr>
        <p:spPr>
          <a:xfrm>
            <a:off x="5003640" y="7843680"/>
            <a:ext cx="166680" cy="22320"/>
          </a:xfrm>
          <a:custGeom>
            <a:avLst/>
            <a:gdLst>
              <a:gd name="textAreaLeft" fmla="*/ 0 w 166680"/>
              <a:gd name="textAreaRight" fmla="*/ 167040 w 16668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1156" h="91">
                <a:moveTo>
                  <a:pt x="1156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7" name="Freeform 174"/>
          <p:cNvSpPr/>
          <p:nvPr/>
        </p:nvSpPr>
        <p:spPr>
          <a:xfrm>
            <a:off x="4610160" y="8447040"/>
            <a:ext cx="102960" cy="46080"/>
          </a:xfrm>
          <a:custGeom>
            <a:avLst/>
            <a:gdLst>
              <a:gd name="textAreaLeft" fmla="*/ 0 w 102960"/>
              <a:gd name="textAreaRight" fmla="*/ 103320 w 102960"/>
              <a:gd name="textAreaTop" fmla="*/ 0 h 46080"/>
              <a:gd name="textAreaBottom" fmla="*/ 46440 h 46080"/>
            </a:gdLst>
            <a:ahLst/>
            <a:rect l="textAreaLeft" t="textAreaTop" r="textAreaRight" b="textAreaBottom"/>
            <a:pathLst>
              <a:path w="711" h="183">
                <a:moveTo>
                  <a:pt x="711" y="0"/>
                </a:moveTo>
                <a:lnTo>
                  <a:pt x="0" y="0"/>
                </a:lnTo>
                <a:lnTo>
                  <a:pt x="0" y="183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8" name="Freeform 175"/>
          <p:cNvSpPr/>
          <p:nvPr/>
        </p:nvSpPr>
        <p:spPr>
          <a:xfrm>
            <a:off x="5003640" y="7866000"/>
            <a:ext cx="130320" cy="22320"/>
          </a:xfrm>
          <a:custGeom>
            <a:avLst/>
            <a:gdLst>
              <a:gd name="textAreaLeft" fmla="*/ 0 w 130320"/>
              <a:gd name="textAreaRight" fmla="*/ 130680 w 13032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900" h="92">
                <a:moveTo>
                  <a:pt x="900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9" name="Freeform 195"/>
          <p:cNvSpPr/>
          <p:nvPr/>
        </p:nvSpPr>
        <p:spPr>
          <a:xfrm>
            <a:off x="4573440" y="7742160"/>
            <a:ext cx="136800" cy="84240"/>
          </a:xfrm>
          <a:custGeom>
            <a:avLst/>
            <a:gdLst>
              <a:gd name="textAreaLeft" fmla="*/ 0 w 136800"/>
              <a:gd name="textAreaRight" fmla="*/ 137160 w 136800"/>
              <a:gd name="textAreaTop" fmla="*/ 0 h 84240"/>
              <a:gd name="textAreaBottom" fmla="*/ 84600 h 84240"/>
            </a:gdLst>
            <a:ahLst/>
            <a:rect l="textAreaLeft" t="textAreaTop" r="textAreaRight" b="textAreaBottom"/>
            <a:pathLst>
              <a:path w="951" h="343">
                <a:moveTo>
                  <a:pt x="951" y="0"/>
                </a:moveTo>
                <a:lnTo>
                  <a:pt x="0" y="0"/>
                </a:lnTo>
                <a:lnTo>
                  <a:pt x="0" y="343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7800" bIns="37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0" name="Freeform 197"/>
          <p:cNvSpPr/>
          <p:nvPr/>
        </p:nvSpPr>
        <p:spPr>
          <a:xfrm>
            <a:off x="5248440" y="6756480"/>
            <a:ext cx="533160" cy="34920"/>
          </a:xfrm>
          <a:custGeom>
            <a:avLst/>
            <a:gdLst>
              <a:gd name="textAreaLeft" fmla="*/ 0 w 533160"/>
              <a:gd name="textAreaRight" fmla="*/ 533520 w 533160"/>
              <a:gd name="textAreaTop" fmla="*/ 0 h 34920"/>
              <a:gd name="textAreaBottom" fmla="*/ 35280 h 34920"/>
            </a:gdLst>
            <a:ahLst/>
            <a:rect l="textAreaLeft" t="textAreaTop" r="textAreaRight" b="textAreaBottom"/>
            <a:pathLst>
              <a:path w="3700" h="138">
                <a:moveTo>
                  <a:pt x="3700" y="138"/>
                </a:moveTo>
                <a:lnTo>
                  <a:pt x="0" y="138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1520" bIns="-115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1" name="Freeform 203"/>
          <p:cNvSpPr/>
          <p:nvPr/>
        </p:nvSpPr>
        <p:spPr>
          <a:xfrm>
            <a:off x="4608360" y="8358120"/>
            <a:ext cx="130320" cy="22320"/>
          </a:xfrm>
          <a:custGeom>
            <a:avLst/>
            <a:gdLst>
              <a:gd name="textAreaLeft" fmla="*/ 0 w 130320"/>
              <a:gd name="textAreaRight" fmla="*/ 130680 w 13032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909" h="92">
                <a:moveTo>
                  <a:pt x="909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2" name="Rectangle 608"/>
          <p:cNvSpPr/>
          <p:nvPr/>
        </p:nvSpPr>
        <p:spPr>
          <a:xfrm>
            <a:off x="3623400" y="7021440"/>
            <a:ext cx="540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6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3" name="Rectangle 617"/>
          <p:cNvSpPr/>
          <p:nvPr/>
        </p:nvSpPr>
        <p:spPr>
          <a:xfrm>
            <a:off x="4553280" y="830088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79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4" name="Rectangle 623"/>
          <p:cNvSpPr/>
          <p:nvPr/>
        </p:nvSpPr>
        <p:spPr>
          <a:xfrm>
            <a:off x="4405680" y="761508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88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5" name="Rectangle 625"/>
          <p:cNvSpPr/>
          <p:nvPr/>
        </p:nvSpPr>
        <p:spPr>
          <a:xfrm>
            <a:off x="4422240" y="835992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6" name="Rectangle 628"/>
          <p:cNvSpPr/>
          <p:nvPr/>
        </p:nvSpPr>
        <p:spPr>
          <a:xfrm>
            <a:off x="3838320" y="703404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97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7" name="Rectangle 631"/>
          <p:cNvSpPr/>
          <p:nvPr/>
        </p:nvSpPr>
        <p:spPr>
          <a:xfrm>
            <a:off x="4760280" y="751212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8" name="Rectangle 639"/>
          <p:cNvSpPr/>
          <p:nvPr/>
        </p:nvSpPr>
        <p:spPr>
          <a:xfrm>
            <a:off x="3567600" y="712944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97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9" name="Rectangle 641"/>
          <p:cNvSpPr/>
          <p:nvPr/>
        </p:nvSpPr>
        <p:spPr>
          <a:xfrm>
            <a:off x="5101560" y="766116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0" name="Rectangle 645"/>
          <p:cNvSpPr/>
          <p:nvPr/>
        </p:nvSpPr>
        <p:spPr>
          <a:xfrm>
            <a:off x="3992040" y="657072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1" name="Rectangle 654"/>
          <p:cNvSpPr/>
          <p:nvPr/>
        </p:nvSpPr>
        <p:spPr>
          <a:xfrm>
            <a:off x="4879440" y="806436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2" name="Rectangle 655"/>
          <p:cNvSpPr/>
          <p:nvPr/>
        </p:nvSpPr>
        <p:spPr>
          <a:xfrm>
            <a:off x="4990320" y="743760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3" name="Rectangle 658"/>
          <p:cNvSpPr/>
          <p:nvPr/>
        </p:nvSpPr>
        <p:spPr>
          <a:xfrm>
            <a:off x="4806720" y="747072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66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4" name="Rectangle 663"/>
          <p:cNvSpPr/>
          <p:nvPr/>
        </p:nvSpPr>
        <p:spPr>
          <a:xfrm>
            <a:off x="4514400" y="689940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5" name="Rectangle 664"/>
          <p:cNvSpPr/>
          <p:nvPr/>
        </p:nvSpPr>
        <p:spPr>
          <a:xfrm>
            <a:off x="5322240" y="770580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6" name="Rectangle 666"/>
          <p:cNvSpPr/>
          <p:nvPr/>
        </p:nvSpPr>
        <p:spPr>
          <a:xfrm>
            <a:off x="4517280" y="824868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7" name="Rectangle 670"/>
          <p:cNvSpPr/>
          <p:nvPr/>
        </p:nvSpPr>
        <p:spPr>
          <a:xfrm>
            <a:off x="4815720" y="793116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8" name="Rectangle 672"/>
          <p:cNvSpPr/>
          <p:nvPr/>
        </p:nvSpPr>
        <p:spPr>
          <a:xfrm>
            <a:off x="4622040" y="833292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9" name="Rectangle 675"/>
          <p:cNvSpPr/>
          <p:nvPr/>
        </p:nvSpPr>
        <p:spPr>
          <a:xfrm>
            <a:off x="4584240" y="819936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0" name="Rectangle 682"/>
          <p:cNvSpPr/>
          <p:nvPr/>
        </p:nvSpPr>
        <p:spPr>
          <a:xfrm>
            <a:off x="4368240" y="783288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1" name="Rectangle 687"/>
          <p:cNvSpPr/>
          <p:nvPr/>
        </p:nvSpPr>
        <p:spPr>
          <a:xfrm>
            <a:off x="3855600" y="673560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2" name="Rectangle 692"/>
          <p:cNvSpPr/>
          <p:nvPr/>
        </p:nvSpPr>
        <p:spPr>
          <a:xfrm>
            <a:off x="4213800" y="649764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87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3" name="Rectangle 693"/>
          <p:cNvSpPr/>
          <p:nvPr/>
        </p:nvSpPr>
        <p:spPr>
          <a:xfrm>
            <a:off x="3723120" y="715788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94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4" name="Rectangle 699"/>
          <p:cNvSpPr/>
          <p:nvPr/>
        </p:nvSpPr>
        <p:spPr>
          <a:xfrm>
            <a:off x="4847760" y="665316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5" name="Rectangle 703"/>
          <p:cNvSpPr/>
          <p:nvPr/>
        </p:nvSpPr>
        <p:spPr>
          <a:xfrm>
            <a:off x="4700160" y="788508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6" name="Rectangle 705"/>
          <p:cNvSpPr/>
          <p:nvPr/>
        </p:nvSpPr>
        <p:spPr>
          <a:xfrm>
            <a:off x="4350600" y="712476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7" name="Rectangle 710"/>
          <p:cNvSpPr/>
          <p:nvPr/>
        </p:nvSpPr>
        <p:spPr>
          <a:xfrm>
            <a:off x="5017320" y="784080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8" name="Rectangle 713"/>
          <p:cNvSpPr/>
          <p:nvPr/>
        </p:nvSpPr>
        <p:spPr>
          <a:xfrm>
            <a:off x="4498200" y="742968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9" name="Rectangle 715"/>
          <p:cNvSpPr/>
          <p:nvPr/>
        </p:nvSpPr>
        <p:spPr>
          <a:xfrm>
            <a:off x="5146200" y="669456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0" name="Rectangle 723"/>
          <p:cNvSpPr/>
          <p:nvPr/>
        </p:nvSpPr>
        <p:spPr>
          <a:xfrm>
            <a:off x="4587120" y="780084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1" name="Rectangle 724"/>
          <p:cNvSpPr/>
          <p:nvPr/>
        </p:nvSpPr>
        <p:spPr>
          <a:xfrm>
            <a:off x="4625280" y="846756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2" name="Rectangle 725"/>
          <p:cNvSpPr/>
          <p:nvPr/>
        </p:nvSpPr>
        <p:spPr>
          <a:xfrm>
            <a:off x="5314320" y="761688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3" name="Rectangle 728"/>
          <p:cNvSpPr/>
          <p:nvPr/>
        </p:nvSpPr>
        <p:spPr>
          <a:xfrm>
            <a:off x="5261400" y="673272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87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4" name="Rectangle 730"/>
          <p:cNvSpPr/>
          <p:nvPr/>
        </p:nvSpPr>
        <p:spPr>
          <a:xfrm>
            <a:off x="4726800" y="842796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5" name="Freeform 232"/>
          <p:cNvSpPr/>
          <p:nvPr/>
        </p:nvSpPr>
        <p:spPr>
          <a:xfrm>
            <a:off x="4676760" y="8537400"/>
            <a:ext cx="171360" cy="22320"/>
          </a:xfrm>
          <a:custGeom>
            <a:avLst/>
            <a:gdLst>
              <a:gd name="textAreaLeft" fmla="*/ 0 w 171360"/>
              <a:gd name="textAreaRight" fmla="*/ 171720 w 17136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1186" h="92">
                <a:moveTo>
                  <a:pt x="1186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6" name="Rectangle 378"/>
          <p:cNvSpPr/>
          <p:nvPr/>
        </p:nvSpPr>
        <p:spPr>
          <a:xfrm>
            <a:off x="4953600" y="8491680"/>
            <a:ext cx="2401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Bradi2g2282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7" name="Freeform 133"/>
          <p:cNvSpPr/>
          <p:nvPr/>
        </p:nvSpPr>
        <p:spPr>
          <a:xfrm>
            <a:off x="4610160" y="8493120"/>
            <a:ext cx="66600" cy="44280"/>
          </a:xfrm>
          <a:custGeom>
            <a:avLst/>
            <a:gdLst>
              <a:gd name="textAreaLeft" fmla="*/ 0 w 66600"/>
              <a:gd name="textAreaRight" fmla="*/ 66960 w 66600"/>
              <a:gd name="textAreaTop" fmla="*/ 0 h 44280"/>
              <a:gd name="textAreaBottom" fmla="*/ 44640 h 44280"/>
            </a:gdLst>
            <a:ahLst/>
            <a:rect l="textAreaLeft" t="textAreaTop" r="textAreaRight" b="textAreaBottom"/>
            <a:pathLst>
              <a:path w="463" h="183">
                <a:moveTo>
                  <a:pt x="463" y="183"/>
                </a:moveTo>
                <a:lnTo>
                  <a:pt x="0" y="183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8" name="Freeform 194"/>
          <p:cNvSpPr/>
          <p:nvPr/>
        </p:nvSpPr>
        <p:spPr>
          <a:xfrm>
            <a:off x="4676760" y="8515440"/>
            <a:ext cx="264960" cy="21960"/>
          </a:xfrm>
          <a:custGeom>
            <a:avLst/>
            <a:gdLst>
              <a:gd name="textAreaLeft" fmla="*/ 0 w 264960"/>
              <a:gd name="textAreaRight" fmla="*/ 265320 w 264960"/>
              <a:gd name="textAreaTop" fmla="*/ 0 h 21960"/>
              <a:gd name="textAreaBottom" fmla="*/ 22320 h 21960"/>
            </a:gdLst>
            <a:ahLst/>
            <a:rect l="textAreaLeft" t="textAreaTop" r="textAreaRight" b="textAreaBottom"/>
            <a:pathLst>
              <a:path w="1840" h="92">
                <a:moveTo>
                  <a:pt x="1840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9" name="Rectangle 686"/>
          <p:cNvSpPr/>
          <p:nvPr/>
        </p:nvSpPr>
        <p:spPr>
          <a:xfrm>
            <a:off x="4691520" y="851220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72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0" name="Rectangle 415"/>
          <p:cNvSpPr/>
          <p:nvPr/>
        </p:nvSpPr>
        <p:spPr>
          <a:xfrm>
            <a:off x="4862160" y="8534520"/>
            <a:ext cx="1864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OsRBOHD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1" name="Rectangle à coins arrondis 1777"/>
          <p:cNvSpPr/>
          <p:nvPr/>
        </p:nvSpPr>
        <p:spPr>
          <a:xfrm>
            <a:off x="3632040" y="4857840"/>
            <a:ext cx="1422720" cy="1612800"/>
          </a:xfrm>
          <a:custGeom>
            <a:avLst/>
            <a:gdLst>
              <a:gd name="textAreaLeft" fmla="*/ 69120 w 1422720"/>
              <a:gd name="textAreaRight" fmla="*/ 1353600 w 1422720"/>
              <a:gd name="textAreaTop" fmla="*/ 69120 h 1612800"/>
              <a:gd name="textAreaBottom" fmla="*/ 1543680 h 1612800"/>
            </a:gdLst>
            <a:ahLst/>
            <a:rect l="textAreaLeft" t="textAreaTop" r="textAreaRight" b="textAreaBottom"/>
            <a:pathLst>
              <a:path w="21600" h="24485">
                <a:moveTo>
                  <a:pt x="3600" y="0"/>
                </a:moveTo>
                <a:arcTo wR="3600" hR="3600" stAng="16200000" swAng="-5400000"/>
                <a:lnTo>
                  <a:pt x="0" y="20885"/>
                </a:lnTo>
                <a:arcTo wR="3600" hR="3600" stAng="10800000" swAng="-5400000"/>
                <a:lnTo>
                  <a:pt x="18000" y="24485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solidFill>
            <a:srgbClr val="7030a0">
              <a:alpha val="41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5160" rIns="65160" tIns="32760" bIns="327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2" name="Rectangle à coins arrondis 986"/>
          <p:cNvSpPr/>
          <p:nvPr/>
        </p:nvSpPr>
        <p:spPr>
          <a:xfrm>
            <a:off x="3757680" y="3970440"/>
            <a:ext cx="1400040" cy="888840"/>
          </a:xfrm>
          <a:prstGeom prst="roundRect">
            <a:avLst>
              <a:gd name="adj" fmla="val 16667"/>
            </a:avLst>
          </a:prstGeom>
          <a:solidFill>
            <a:srgbClr val="ffc000">
              <a:alpha val="41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5160" rIns="65160" tIns="32760" bIns="327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3" name="Freeform 209"/>
          <p:cNvSpPr/>
          <p:nvPr/>
        </p:nvSpPr>
        <p:spPr>
          <a:xfrm>
            <a:off x="4278240" y="4797360"/>
            <a:ext cx="87480" cy="33480"/>
          </a:xfrm>
          <a:custGeom>
            <a:avLst/>
            <a:gdLst>
              <a:gd name="textAreaLeft" fmla="*/ 0 w 87480"/>
              <a:gd name="textAreaRight" fmla="*/ 87840 w 87480"/>
              <a:gd name="textAreaTop" fmla="*/ 0 h 33480"/>
              <a:gd name="textAreaBottom" fmla="*/ 33840 h 33480"/>
            </a:gdLst>
            <a:ahLst/>
            <a:rect l="textAreaLeft" t="textAreaTop" r="textAreaRight" b="textAreaBottom"/>
            <a:pathLst>
              <a:path w="613" h="137">
                <a:moveTo>
                  <a:pt x="613" y="137"/>
                </a:moveTo>
                <a:lnTo>
                  <a:pt x="0" y="137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4" name="Freeform 210"/>
          <p:cNvSpPr/>
          <p:nvPr/>
        </p:nvSpPr>
        <p:spPr>
          <a:xfrm>
            <a:off x="3897360" y="5865840"/>
            <a:ext cx="139680" cy="61920"/>
          </a:xfrm>
          <a:custGeom>
            <a:avLst/>
            <a:gdLst>
              <a:gd name="textAreaLeft" fmla="*/ 0 w 139680"/>
              <a:gd name="textAreaRight" fmla="*/ 140040 w 139680"/>
              <a:gd name="textAreaTop" fmla="*/ 0 h 61920"/>
              <a:gd name="textAreaBottom" fmla="*/ 62280 h 61920"/>
            </a:gdLst>
            <a:ahLst/>
            <a:rect l="textAreaLeft" t="textAreaTop" r="textAreaRight" b="textAreaBottom"/>
            <a:pathLst>
              <a:path w="962" h="251">
                <a:moveTo>
                  <a:pt x="962" y="251"/>
                </a:moveTo>
                <a:lnTo>
                  <a:pt x="0" y="25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5480" bIns="154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5" name="Freeform 212"/>
          <p:cNvSpPr/>
          <p:nvPr/>
        </p:nvSpPr>
        <p:spPr>
          <a:xfrm>
            <a:off x="4094280" y="4113360"/>
            <a:ext cx="195120" cy="34920"/>
          </a:xfrm>
          <a:custGeom>
            <a:avLst/>
            <a:gdLst>
              <a:gd name="textAreaLeft" fmla="*/ 0 w 195120"/>
              <a:gd name="textAreaRight" fmla="*/ 195480 w 195120"/>
              <a:gd name="textAreaTop" fmla="*/ 0 h 34920"/>
              <a:gd name="textAreaBottom" fmla="*/ 35280 h 34920"/>
            </a:gdLst>
            <a:ahLst/>
            <a:rect l="textAreaLeft" t="textAreaTop" r="textAreaRight" b="textAreaBottom"/>
            <a:pathLst>
              <a:path w="1352" h="138">
                <a:moveTo>
                  <a:pt x="1352" y="0"/>
                </a:moveTo>
                <a:lnTo>
                  <a:pt x="0" y="0"/>
                </a:lnTo>
                <a:lnTo>
                  <a:pt x="0" y="138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1520" bIns="-115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6" name="Freeform 213"/>
          <p:cNvSpPr/>
          <p:nvPr/>
        </p:nvSpPr>
        <p:spPr>
          <a:xfrm>
            <a:off x="4010040" y="6397560"/>
            <a:ext cx="88920" cy="22320"/>
          </a:xfrm>
          <a:custGeom>
            <a:avLst/>
            <a:gdLst>
              <a:gd name="textAreaLeft" fmla="*/ 0 w 88920"/>
              <a:gd name="textAreaRight" fmla="*/ 89280 w 8892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613" h="92">
                <a:moveTo>
                  <a:pt x="613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7" name="Freeform 217"/>
          <p:cNvSpPr/>
          <p:nvPr/>
        </p:nvSpPr>
        <p:spPr>
          <a:xfrm>
            <a:off x="4135320" y="4680000"/>
            <a:ext cx="57240" cy="66600"/>
          </a:xfrm>
          <a:custGeom>
            <a:avLst/>
            <a:gdLst>
              <a:gd name="textAreaLeft" fmla="*/ 0 w 57240"/>
              <a:gd name="textAreaRight" fmla="*/ 57600 w 57240"/>
              <a:gd name="textAreaTop" fmla="*/ 0 h 66600"/>
              <a:gd name="textAreaBottom" fmla="*/ 66960 h 66600"/>
            </a:gdLst>
            <a:ahLst/>
            <a:rect l="textAreaLeft" t="textAreaTop" r="textAreaRight" b="textAreaBottom"/>
            <a:pathLst>
              <a:path w="395" h="275">
                <a:moveTo>
                  <a:pt x="395" y="275"/>
                </a:moveTo>
                <a:lnTo>
                  <a:pt x="0" y="275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8" name="Freeform 218"/>
          <p:cNvSpPr/>
          <p:nvPr/>
        </p:nvSpPr>
        <p:spPr>
          <a:xfrm>
            <a:off x="4325760" y="4764240"/>
            <a:ext cx="73080" cy="21960"/>
          </a:xfrm>
          <a:custGeom>
            <a:avLst/>
            <a:gdLst>
              <a:gd name="textAreaLeft" fmla="*/ 0 w 73080"/>
              <a:gd name="textAreaRight" fmla="*/ 73440 w 73080"/>
              <a:gd name="textAreaTop" fmla="*/ 0 h 21960"/>
              <a:gd name="textAreaBottom" fmla="*/ 22320 h 21960"/>
            </a:gdLst>
            <a:ahLst/>
            <a:rect l="textAreaLeft" t="textAreaTop" r="textAreaRight" b="textAreaBottom"/>
            <a:pathLst>
              <a:path w="505" h="91">
                <a:moveTo>
                  <a:pt x="505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9" name="Freeform 220"/>
          <p:cNvSpPr/>
          <p:nvPr/>
        </p:nvSpPr>
        <p:spPr>
          <a:xfrm>
            <a:off x="4000680" y="5256360"/>
            <a:ext cx="114120" cy="44280"/>
          </a:xfrm>
          <a:custGeom>
            <a:avLst/>
            <a:gdLst>
              <a:gd name="textAreaLeft" fmla="*/ 0 w 114120"/>
              <a:gd name="textAreaRight" fmla="*/ 114480 w 114120"/>
              <a:gd name="textAreaTop" fmla="*/ 0 h 44280"/>
              <a:gd name="textAreaBottom" fmla="*/ 44640 h 44280"/>
            </a:gdLst>
            <a:ahLst/>
            <a:rect l="textAreaLeft" t="textAreaTop" r="textAreaRight" b="textAreaBottom"/>
            <a:pathLst>
              <a:path w="805" h="183">
                <a:moveTo>
                  <a:pt x="805" y="0"/>
                </a:moveTo>
                <a:lnTo>
                  <a:pt x="0" y="0"/>
                </a:lnTo>
                <a:lnTo>
                  <a:pt x="0" y="183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0" name="Freeform 226"/>
          <p:cNvSpPr/>
          <p:nvPr/>
        </p:nvSpPr>
        <p:spPr>
          <a:xfrm>
            <a:off x="4214880" y="4573440"/>
            <a:ext cx="117360" cy="39960"/>
          </a:xfrm>
          <a:custGeom>
            <a:avLst/>
            <a:gdLst>
              <a:gd name="textAreaLeft" fmla="*/ 0 w 117360"/>
              <a:gd name="textAreaRight" fmla="*/ 117720 w 117360"/>
              <a:gd name="textAreaTop" fmla="*/ 0 h 39960"/>
              <a:gd name="textAreaBottom" fmla="*/ 40320 h 39960"/>
            </a:gdLst>
            <a:ahLst/>
            <a:rect l="textAreaLeft" t="textAreaTop" r="textAreaRight" b="textAreaBottom"/>
            <a:pathLst>
              <a:path w="824" h="160">
                <a:moveTo>
                  <a:pt x="824" y="0"/>
                </a:moveTo>
                <a:lnTo>
                  <a:pt x="0" y="0"/>
                </a:lnTo>
                <a:lnTo>
                  <a:pt x="0" y="16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1" name="Freeform 227"/>
          <p:cNvSpPr/>
          <p:nvPr/>
        </p:nvSpPr>
        <p:spPr>
          <a:xfrm>
            <a:off x="4030560" y="6188040"/>
            <a:ext cx="63720" cy="74520"/>
          </a:xfrm>
          <a:custGeom>
            <a:avLst/>
            <a:gdLst>
              <a:gd name="textAreaLeft" fmla="*/ 0 w 63720"/>
              <a:gd name="textAreaRight" fmla="*/ 64080 w 63720"/>
              <a:gd name="textAreaTop" fmla="*/ 0 h 74520"/>
              <a:gd name="textAreaBottom" fmla="*/ 74880 h 74520"/>
            </a:gdLst>
            <a:ahLst/>
            <a:rect l="textAreaLeft" t="textAreaTop" r="textAreaRight" b="textAreaBottom"/>
            <a:pathLst>
              <a:path w="442" h="309">
                <a:moveTo>
                  <a:pt x="442" y="309"/>
                </a:moveTo>
                <a:lnTo>
                  <a:pt x="0" y="309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2" name="Freeform 228"/>
          <p:cNvSpPr/>
          <p:nvPr/>
        </p:nvSpPr>
        <p:spPr>
          <a:xfrm>
            <a:off x="4173480" y="4987800"/>
            <a:ext cx="7920" cy="33480"/>
          </a:xfrm>
          <a:custGeom>
            <a:avLst/>
            <a:gdLst>
              <a:gd name="textAreaLeft" fmla="*/ 0 w 7920"/>
              <a:gd name="textAreaRight" fmla="*/ 8280 w 7920"/>
              <a:gd name="textAreaTop" fmla="*/ 0 h 33480"/>
              <a:gd name="textAreaBottom" fmla="*/ 33840 h 33480"/>
            </a:gdLst>
            <a:ahLst/>
            <a:rect l="textAreaLeft" t="textAreaTop" r="textAreaRight" b="textAreaBottom"/>
            <a:pathLst>
              <a:path w="54" h="137">
                <a:moveTo>
                  <a:pt x="54" y="0"/>
                </a:moveTo>
                <a:lnTo>
                  <a:pt x="0" y="0"/>
                </a:lnTo>
                <a:lnTo>
                  <a:pt x="0" y="137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3" name="Freeform 230"/>
          <p:cNvSpPr/>
          <p:nvPr/>
        </p:nvSpPr>
        <p:spPr>
          <a:xfrm>
            <a:off x="4086360" y="6129360"/>
            <a:ext cx="58680" cy="31680"/>
          </a:xfrm>
          <a:custGeom>
            <a:avLst/>
            <a:gdLst>
              <a:gd name="textAreaLeft" fmla="*/ 0 w 58680"/>
              <a:gd name="textAreaRight" fmla="*/ 59040 w 58680"/>
              <a:gd name="textAreaTop" fmla="*/ 0 h 31680"/>
              <a:gd name="textAreaBottom" fmla="*/ 32040 h 31680"/>
            </a:gdLst>
            <a:ahLst/>
            <a:rect l="textAreaLeft" t="textAreaTop" r="textAreaRight" b="textAreaBottom"/>
            <a:pathLst>
              <a:path w="400" h="137">
                <a:moveTo>
                  <a:pt x="400" y="0"/>
                </a:moveTo>
                <a:lnTo>
                  <a:pt x="0" y="0"/>
                </a:lnTo>
                <a:lnTo>
                  <a:pt x="0" y="137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4" name="Freeform 236"/>
          <p:cNvSpPr/>
          <p:nvPr/>
        </p:nvSpPr>
        <p:spPr>
          <a:xfrm>
            <a:off x="4146480" y="5345280"/>
            <a:ext cx="19080" cy="21960"/>
          </a:xfrm>
          <a:custGeom>
            <a:avLst/>
            <a:gdLst>
              <a:gd name="textAreaLeft" fmla="*/ 0 w 19080"/>
              <a:gd name="textAreaRight" fmla="*/ 19440 w 19080"/>
              <a:gd name="textAreaTop" fmla="*/ 0 h 21960"/>
              <a:gd name="textAreaBottom" fmla="*/ 22320 h 21960"/>
            </a:gdLst>
            <a:ahLst/>
            <a:rect l="textAreaLeft" t="textAreaTop" r="textAreaRight" b="textAreaBottom"/>
            <a:pathLst>
              <a:path w="127" h="92">
                <a:moveTo>
                  <a:pt x="127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5" name="Freeform 239"/>
          <p:cNvSpPr/>
          <p:nvPr/>
        </p:nvSpPr>
        <p:spPr>
          <a:xfrm>
            <a:off x="4010040" y="5613480"/>
            <a:ext cx="47520" cy="22320"/>
          </a:xfrm>
          <a:custGeom>
            <a:avLst/>
            <a:gdLst>
              <a:gd name="textAreaLeft" fmla="*/ 0 w 47520"/>
              <a:gd name="textAreaRight" fmla="*/ 47880 w 4752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330" h="92">
                <a:moveTo>
                  <a:pt x="330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6" name="Freeform 240"/>
          <p:cNvSpPr/>
          <p:nvPr/>
        </p:nvSpPr>
        <p:spPr>
          <a:xfrm>
            <a:off x="4010040" y="5592600"/>
            <a:ext cx="50760" cy="20880"/>
          </a:xfrm>
          <a:custGeom>
            <a:avLst/>
            <a:gdLst>
              <a:gd name="textAreaLeft" fmla="*/ 0 w 50760"/>
              <a:gd name="textAreaRight" fmla="*/ 51120 w 50760"/>
              <a:gd name="textAreaTop" fmla="*/ 0 h 20880"/>
              <a:gd name="textAreaBottom" fmla="*/ 21240 h 20880"/>
            </a:gdLst>
            <a:ahLst/>
            <a:rect l="textAreaLeft" t="textAreaTop" r="textAreaRight" b="textAreaBottom"/>
            <a:pathLst>
              <a:path w="344" h="91">
                <a:moveTo>
                  <a:pt x="344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5560" bIns="-255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7" name="Freeform 246"/>
          <p:cNvSpPr/>
          <p:nvPr/>
        </p:nvSpPr>
        <p:spPr>
          <a:xfrm>
            <a:off x="4127400" y="6039000"/>
            <a:ext cx="19080" cy="23760"/>
          </a:xfrm>
          <a:custGeom>
            <a:avLst/>
            <a:gdLst>
              <a:gd name="textAreaLeft" fmla="*/ 0 w 19080"/>
              <a:gd name="textAreaRight" fmla="*/ 19440 w 19080"/>
              <a:gd name="textAreaTop" fmla="*/ 0 h 23760"/>
              <a:gd name="textAreaBottom" fmla="*/ 24120 h 23760"/>
            </a:gdLst>
            <a:ahLst/>
            <a:rect l="textAreaLeft" t="textAreaTop" r="textAreaRight" b="textAreaBottom"/>
            <a:pathLst>
              <a:path w="138" h="92">
                <a:moveTo>
                  <a:pt x="138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8" name="Freeform 250"/>
          <p:cNvSpPr/>
          <p:nvPr/>
        </p:nvSpPr>
        <p:spPr>
          <a:xfrm>
            <a:off x="4457880" y="4897440"/>
            <a:ext cx="183960" cy="22320"/>
          </a:xfrm>
          <a:custGeom>
            <a:avLst/>
            <a:gdLst>
              <a:gd name="textAreaLeft" fmla="*/ 0 w 183960"/>
              <a:gd name="textAreaRight" fmla="*/ 184320 w 18396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1286" h="92">
                <a:moveTo>
                  <a:pt x="1286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9" name="Freeform 253"/>
          <p:cNvSpPr/>
          <p:nvPr/>
        </p:nvSpPr>
        <p:spPr>
          <a:xfrm>
            <a:off x="4332240" y="4573440"/>
            <a:ext cx="176400" cy="33480"/>
          </a:xfrm>
          <a:custGeom>
            <a:avLst/>
            <a:gdLst>
              <a:gd name="textAreaLeft" fmla="*/ 0 w 176400"/>
              <a:gd name="textAreaRight" fmla="*/ 176760 w 176400"/>
              <a:gd name="textAreaTop" fmla="*/ 0 h 33480"/>
              <a:gd name="textAreaBottom" fmla="*/ 33840 h 33480"/>
            </a:gdLst>
            <a:ahLst/>
            <a:rect l="textAreaLeft" t="textAreaTop" r="textAreaRight" b="textAreaBottom"/>
            <a:pathLst>
              <a:path w="1222" h="137">
                <a:moveTo>
                  <a:pt x="1222" y="137"/>
                </a:moveTo>
                <a:lnTo>
                  <a:pt x="0" y="137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0" name="Freeform 254"/>
          <p:cNvSpPr/>
          <p:nvPr/>
        </p:nvSpPr>
        <p:spPr>
          <a:xfrm>
            <a:off x="4325760" y="4740120"/>
            <a:ext cx="117720" cy="24120"/>
          </a:xfrm>
          <a:custGeom>
            <a:avLst/>
            <a:gdLst>
              <a:gd name="textAreaLeft" fmla="*/ 0 w 117720"/>
              <a:gd name="textAreaRight" fmla="*/ 118080 w 117720"/>
              <a:gd name="textAreaTop" fmla="*/ 0 h 24120"/>
              <a:gd name="textAreaBottom" fmla="*/ 24480 h 24120"/>
            </a:gdLst>
            <a:ahLst/>
            <a:rect l="textAreaLeft" t="textAreaTop" r="textAreaRight" b="textAreaBottom"/>
            <a:pathLst>
              <a:path w="820" h="92">
                <a:moveTo>
                  <a:pt x="820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2320" bIns="-223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1" name="Freeform 259"/>
          <p:cNvSpPr/>
          <p:nvPr/>
        </p:nvSpPr>
        <p:spPr>
          <a:xfrm>
            <a:off x="4192560" y="4697280"/>
            <a:ext cx="168480" cy="49320"/>
          </a:xfrm>
          <a:custGeom>
            <a:avLst/>
            <a:gdLst>
              <a:gd name="textAreaLeft" fmla="*/ 0 w 168480"/>
              <a:gd name="textAreaRight" fmla="*/ 168840 w 168480"/>
              <a:gd name="textAreaTop" fmla="*/ 0 h 49320"/>
              <a:gd name="textAreaBottom" fmla="*/ 49680 h 49320"/>
            </a:gdLst>
            <a:ahLst/>
            <a:rect l="textAreaLeft" t="textAreaTop" r="textAreaRight" b="textAreaBottom"/>
            <a:pathLst>
              <a:path w="1163" h="206">
                <a:moveTo>
                  <a:pt x="1163" y="0"/>
                </a:moveTo>
                <a:lnTo>
                  <a:pt x="0" y="0"/>
                </a:lnTo>
                <a:lnTo>
                  <a:pt x="0" y="206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880" bIns="28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2" name="Freeform 263"/>
          <p:cNvSpPr/>
          <p:nvPr/>
        </p:nvSpPr>
        <p:spPr>
          <a:xfrm>
            <a:off x="4260960" y="4292640"/>
            <a:ext cx="164880" cy="34920"/>
          </a:xfrm>
          <a:custGeom>
            <a:avLst/>
            <a:gdLst>
              <a:gd name="textAreaLeft" fmla="*/ 0 w 164880"/>
              <a:gd name="textAreaRight" fmla="*/ 164880 w 164880"/>
              <a:gd name="textAreaTop" fmla="*/ 0 h 34920"/>
              <a:gd name="textAreaBottom" fmla="*/ 35280 h 34920"/>
            </a:gdLst>
            <a:ahLst/>
            <a:rect l="textAreaLeft" t="textAreaTop" r="textAreaRight" b="textAreaBottom"/>
            <a:pathLst>
              <a:path w="1144" h="138">
                <a:moveTo>
                  <a:pt x="1144" y="0"/>
                </a:moveTo>
                <a:lnTo>
                  <a:pt x="0" y="0"/>
                </a:lnTo>
                <a:lnTo>
                  <a:pt x="0" y="138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1520" bIns="-115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3" name="Freeform 264"/>
          <p:cNvSpPr/>
          <p:nvPr/>
        </p:nvSpPr>
        <p:spPr>
          <a:xfrm>
            <a:off x="3921120" y="5300640"/>
            <a:ext cx="79560" cy="55440"/>
          </a:xfrm>
          <a:custGeom>
            <a:avLst/>
            <a:gdLst>
              <a:gd name="textAreaLeft" fmla="*/ 0 w 79560"/>
              <a:gd name="textAreaRight" fmla="*/ 79920 w 79560"/>
              <a:gd name="textAreaTop" fmla="*/ 0 h 55440"/>
              <a:gd name="textAreaBottom" fmla="*/ 55800 h 55440"/>
            </a:gdLst>
            <a:ahLst/>
            <a:rect l="textAreaLeft" t="textAreaTop" r="textAreaRight" b="textAreaBottom"/>
            <a:pathLst>
              <a:path w="543" h="229">
                <a:moveTo>
                  <a:pt x="543" y="0"/>
                </a:moveTo>
                <a:lnTo>
                  <a:pt x="0" y="0"/>
                </a:lnTo>
                <a:lnTo>
                  <a:pt x="0" y="229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4" name="Freeform 274"/>
          <p:cNvSpPr/>
          <p:nvPr/>
        </p:nvSpPr>
        <p:spPr>
          <a:xfrm>
            <a:off x="4040280" y="6308640"/>
            <a:ext cx="88920" cy="22320"/>
          </a:xfrm>
          <a:custGeom>
            <a:avLst/>
            <a:gdLst>
              <a:gd name="textAreaLeft" fmla="*/ 0 w 88920"/>
              <a:gd name="textAreaRight" fmla="*/ 89280 w 8892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616" h="91">
                <a:moveTo>
                  <a:pt x="616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5" name="Freeform 275"/>
          <p:cNvSpPr/>
          <p:nvPr/>
        </p:nvSpPr>
        <p:spPr>
          <a:xfrm>
            <a:off x="4114800" y="5256360"/>
            <a:ext cx="22320" cy="21960"/>
          </a:xfrm>
          <a:custGeom>
            <a:avLst/>
            <a:gdLst>
              <a:gd name="textAreaLeft" fmla="*/ 0 w 22320"/>
              <a:gd name="textAreaRight" fmla="*/ 22680 w 22320"/>
              <a:gd name="textAreaTop" fmla="*/ 0 h 21960"/>
              <a:gd name="textAreaBottom" fmla="*/ 22320 h 21960"/>
            </a:gdLst>
            <a:ahLst/>
            <a:rect l="textAreaLeft" t="textAreaTop" r="textAreaRight" b="textAreaBottom"/>
            <a:pathLst>
              <a:path w="145" h="91">
                <a:moveTo>
                  <a:pt x="145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6" name="Freeform 277"/>
          <p:cNvSpPr/>
          <p:nvPr/>
        </p:nvSpPr>
        <p:spPr>
          <a:xfrm>
            <a:off x="4038480" y="4248000"/>
            <a:ext cx="563760" cy="39960"/>
          </a:xfrm>
          <a:custGeom>
            <a:avLst/>
            <a:gdLst>
              <a:gd name="textAreaLeft" fmla="*/ 0 w 563760"/>
              <a:gd name="textAreaRight" fmla="*/ 564120 w 563760"/>
              <a:gd name="textAreaTop" fmla="*/ 0 h 39960"/>
              <a:gd name="textAreaBottom" fmla="*/ 40320 h 39960"/>
            </a:gdLst>
            <a:ahLst/>
            <a:rect l="textAreaLeft" t="textAreaTop" r="textAreaRight" b="textAreaBottom"/>
            <a:pathLst>
              <a:path w="3914" h="160">
                <a:moveTo>
                  <a:pt x="3914" y="0"/>
                </a:moveTo>
                <a:lnTo>
                  <a:pt x="0" y="0"/>
                </a:lnTo>
                <a:lnTo>
                  <a:pt x="0" y="16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7" name="Freeform 285"/>
          <p:cNvSpPr/>
          <p:nvPr/>
        </p:nvSpPr>
        <p:spPr>
          <a:xfrm>
            <a:off x="3921120" y="5356080"/>
            <a:ext cx="173160" cy="57240"/>
          </a:xfrm>
          <a:custGeom>
            <a:avLst/>
            <a:gdLst>
              <a:gd name="textAreaLeft" fmla="*/ 0 w 173160"/>
              <a:gd name="textAreaRight" fmla="*/ 173520 w 173160"/>
              <a:gd name="textAreaTop" fmla="*/ 0 h 57240"/>
              <a:gd name="textAreaBottom" fmla="*/ 57600 h 57240"/>
            </a:gdLst>
            <a:ahLst/>
            <a:rect l="textAreaLeft" t="textAreaTop" r="textAreaRight" b="textAreaBottom"/>
            <a:pathLst>
              <a:path w="1200" h="229">
                <a:moveTo>
                  <a:pt x="1200" y="229"/>
                </a:moveTo>
                <a:lnTo>
                  <a:pt x="0" y="229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0800" bIns="10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8" name="Freeform 288"/>
          <p:cNvSpPr/>
          <p:nvPr/>
        </p:nvSpPr>
        <p:spPr>
          <a:xfrm>
            <a:off x="4192560" y="6173640"/>
            <a:ext cx="360" cy="22320"/>
          </a:xfrm>
          <a:custGeom>
            <a:avLst/>
            <a:gdLst>
              <a:gd name="textAreaLeft" fmla="*/ 0 w 360"/>
              <a:gd name="textAreaRight" fmla="*/ 720 w 36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6" h="92">
                <a:moveTo>
                  <a:pt x="6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9" name="Freeform 289"/>
          <p:cNvSpPr/>
          <p:nvPr/>
        </p:nvSpPr>
        <p:spPr>
          <a:xfrm>
            <a:off x="4068720" y="5748480"/>
            <a:ext cx="30240" cy="44280"/>
          </a:xfrm>
          <a:custGeom>
            <a:avLst/>
            <a:gdLst>
              <a:gd name="textAreaLeft" fmla="*/ 0 w 30240"/>
              <a:gd name="textAreaRight" fmla="*/ 30600 w 30240"/>
              <a:gd name="textAreaTop" fmla="*/ 0 h 44280"/>
              <a:gd name="textAreaBottom" fmla="*/ 44640 h 44280"/>
            </a:gdLst>
            <a:ahLst/>
            <a:rect l="textAreaLeft" t="textAreaTop" r="textAreaRight" b="textAreaBottom"/>
            <a:pathLst>
              <a:path w="210" h="183">
                <a:moveTo>
                  <a:pt x="210" y="183"/>
                </a:moveTo>
                <a:lnTo>
                  <a:pt x="0" y="183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0" name="Freeform 291"/>
          <p:cNvSpPr/>
          <p:nvPr/>
        </p:nvSpPr>
        <p:spPr>
          <a:xfrm>
            <a:off x="3978360" y="5514840"/>
            <a:ext cx="101520" cy="32040"/>
          </a:xfrm>
          <a:custGeom>
            <a:avLst/>
            <a:gdLst>
              <a:gd name="textAreaLeft" fmla="*/ 0 w 101520"/>
              <a:gd name="textAreaRight" fmla="*/ 101880 w 101520"/>
              <a:gd name="textAreaTop" fmla="*/ 0 h 32040"/>
              <a:gd name="textAreaBottom" fmla="*/ 32400 h 32040"/>
            </a:gdLst>
            <a:ahLst/>
            <a:rect l="textAreaLeft" t="textAreaTop" r="textAreaRight" b="textAreaBottom"/>
            <a:pathLst>
              <a:path w="700" h="137">
                <a:moveTo>
                  <a:pt x="700" y="137"/>
                </a:moveTo>
                <a:lnTo>
                  <a:pt x="0" y="137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4400" bIns="-144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1" name="Freeform 292"/>
          <p:cNvSpPr/>
          <p:nvPr/>
        </p:nvSpPr>
        <p:spPr>
          <a:xfrm>
            <a:off x="3968640" y="4319640"/>
            <a:ext cx="34920" cy="129960"/>
          </a:xfrm>
          <a:custGeom>
            <a:avLst/>
            <a:gdLst>
              <a:gd name="textAreaLeft" fmla="*/ 0 w 34920"/>
              <a:gd name="textAreaRight" fmla="*/ 35280 w 34920"/>
              <a:gd name="textAreaTop" fmla="*/ 0 h 129960"/>
              <a:gd name="textAreaBottom" fmla="*/ 130320 h 129960"/>
            </a:gdLst>
            <a:ahLst/>
            <a:rect l="textAreaLeft" t="textAreaTop" r="textAreaRight" b="textAreaBottom"/>
            <a:pathLst>
              <a:path w="247" h="532">
                <a:moveTo>
                  <a:pt x="247" y="532"/>
                </a:moveTo>
                <a:lnTo>
                  <a:pt x="0" y="53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2" name="Freeform 298"/>
          <p:cNvSpPr/>
          <p:nvPr/>
        </p:nvSpPr>
        <p:spPr>
          <a:xfrm>
            <a:off x="3665520" y="5295960"/>
            <a:ext cx="79560" cy="492120"/>
          </a:xfrm>
          <a:custGeom>
            <a:avLst/>
            <a:gdLst>
              <a:gd name="textAreaLeft" fmla="*/ 0 w 79560"/>
              <a:gd name="textAreaRight" fmla="*/ 79920 w 79560"/>
              <a:gd name="textAreaTop" fmla="*/ 0 h 492120"/>
              <a:gd name="textAreaBottom" fmla="*/ 492480 h 492120"/>
            </a:gdLst>
            <a:ahLst/>
            <a:rect l="textAreaLeft" t="textAreaTop" r="textAreaRight" b="textAreaBottom"/>
            <a:pathLst>
              <a:path w="558" h="2019">
                <a:moveTo>
                  <a:pt x="558" y="0"/>
                </a:moveTo>
                <a:lnTo>
                  <a:pt x="0" y="0"/>
                </a:lnTo>
                <a:lnTo>
                  <a:pt x="0" y="2019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3" name="Freeform 299"/>
          <p:cNvSpPr/>
          <p:nvPr/>
        </p:nvSpPr>
        <p:spPr>
          <a:xfrm>
            <a:off x="3875040" y="5460840"/>
            <a:ext cx="17640" cy="201600"/>
          </a:xfrm>
          <a:custGeom>
            <a:avLst/>
            <a:gdLst>
              <a:gd name="textAreaLeft" fmla="*/ 0 w 17640"/>
              <a:gd name="textAreaRight" fmla="*/ 18000 w 17640"/>
              <a:gd name="textAreaTop" fmla="*/ 0 h 201600"/>
              <a:gd name="textAreaBottom" fmla="*/ 201960 h 201600"/>
            </a:gdLst>
            <a:ahLst/>
            <a:rect l="textAreaLeft" t="textAreaTop" r="textAreaRight" b="textAreaBottom"/>
            <a:pathLst>
              <a:path w="120" h="831">
                <a:moveTo>
                  <a:pt x="120" y="0"/>
                </a:moveTo>
                <a:lnTo>
                  <a:pt x="0" y="0"/>
                </a:lnTo>
                <a:lnTo>
                  <a:pt x="0" y="83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4" name="Freeform 301"/>
          <p:cNvSpPr/>
          <p:nvPr/>
        </p:nvSpPr>
        <p:spPr>
          <a:xfrm>
            <a:off x="4464000" y="4538520"/>
            <a:ext cx="100080" cy="24120"/>
          </a:xfrm>
          <a:custGeom>
            <a:avLst/>
            <a:gdLst>
              <a:gd name="textAreaLeft" fmla="*/ 0 w 100080"/>
              <a:gd name="textAreaRight" fmla="*/ 100440 w 100080"/>
              <a:gd name="textAreaTop" fmla="*/ 0 h 24120"/>
              <a:gd name="textAreaBottom" fmla="*/ 24480 h 24120"/>
            </a:gdLst>
            <a:ahLst/>
            <a:rect l="textAreaLeft" t="textAreaTop" r="textAreaRight" b="textAreaBottom"/>
            <a:pathLst>
              <a:path w="689" h="91">
                <a:moveTo>
                  <a:pt x="689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2320" bIns="-223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5" name="Freeform 303"/>
          <p:cNvSpPr/>
          <p:nvPr/>
        </p:nvSpPr>
        <p:spPr>
          <a:xfrm>
            <a:off x="3963960" y="6188040"/>
            <a:ext cx="66600" cy="92160"/>
          </a:xfrm>
          <a:custGeom>
            <a:avLst/>
            <a:gdLst>
              <a:gd name="textAreaLeft" fmla="*/ 0 w 66600"/>
              <a:gd name="textAreaRight" fmla="*/ 66960 w 66600"/>
              <a:gd name="textAreaTop" fmla="*/ 0 h 92160"/>
              <a:gd name="textAreaBottom" fmla="*/ 92520 h 92160"/>
            </a:gdLst>
            <a:ahLst/>
            <a:rect l="textAreaLeft" t="textAreaTop" r="textAreaRight" b="textAreaBottom"/>
            <a:pathLst>
              <a:path w="461" h="384">
                <a:moveTo>
                  <a:pt x="461" y="0"/>
                </a:moveTo>
                <a:lnTo>
                  <a:pt x="0" y="0"/>
                </a:lnTo>
                <a:lnTo>
                  <a:pt x="0" y="384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6" name="Freeform 304"/>
          <p:cNvSpPr/>
          <p:nvPr/>
        </p:nvSpPr>
        <p:spPr>
          <a:xfrm>
            <a:off x="3914640" y="5803920"/>
            <a:ext cx="152640" cy="55440"/>
          </a:xfrm>
          <a:custGeom>
            <a:avLst/>
            <a:gdLst>
              <a:gd name="textAreaLeft" fmla="*/ 0 w 152640"/>
              <a:gd name="textAreaRight" fmla="*/ 153000 w 152640"/>
              <a:gd name="textAreaTop" fmla="*/ 0 h 55440"/>
              <a:gd name="textAreaBottom" fmla="*/ 55800 h 55440"/>
            </a:gdLst>
            <a:ahLst/>
            <a:rect l="textAreaLeft" t="textAreaTop" r="textAreaRight" b="textAreaBottom"/>
            <a:pathLst>
              <a:path w="1067" h="229">
                <a:moveTo>
                  <a:pt x="1067" y="229"/>
                </a:moveTo>
                <a:lnTo>
                  <a:pt x="0" y="229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7" name="Freeform 306"/>
          <p:cNvSpPr/>
          <p:nvPr/>
        </p:nvSpPr>
        <p:spPr>
          <a:xfrm>
            <a:off x="4000680" y="5300640"/>
            <a:ext cx="145800" cy="44640"/>
          </a:xfrm>
          <a:custGeom>
            <a:avLst/>
            <a:gdLst>
              <a:gd name="textAreaLeft" fmla="*/ 0 w 145800"/>
              <a:gd name="textAreaRight" fmla="*/ 146160 w 145800"/>
              <a:gd name="textAreaTop" fmla="*/ 0 h 44640"/>
              <a:gd name="textAreaBottom" fmla="*/ 45000 h 44640"/>
            </a:gdLst>
            <a:ahLst/>
            <a:rect l="textAreaLeft" t="textAreaTop" r="textAreaRight" b="textAreaBottom"/>
            <a:pathLst>
              <a:path w="1023" h="183">
                <a:moveTo>
                  <a:pt x="1023" y="183"/>
                </a:moveTo>
                <a:lnTo>
                  <a:pt x="0" y="183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" bIns="-1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8" name="Freeform 309"/>
          <p:cNvSpPr/>
          <p:nvPr/>
        </p:nvSpPr>
        <p:spPr>
          <a:xfrm>
            <a:off x="3978360" y="5479920"/>
            <a:ext cx="20520" cy="34920"/>
          </a:xfrm>
          <a:custGeom>
            <a:avLst/>
            <a:gdLst>
              <a:gd name="textAreaLeft" fmla="*/ 0 w 20520"/>
              <a:gd name="textAreaRight" fmla="*/ 20880 w 20520"/>
              <a:gd name="textAreaTop" fmla="*/ 0 h 34920"/>
              <a:gd name="textAreaBottom" fmla="*/ 35280 h 34920"/>
            </a:gdLst>
            <a:ahLst/>
            <a:rect l="textAreaLeft" t="textAreaTop" r="textAreaRight" b="textAreaBottom"/>
            <a:pathLst>
              <a:path w="137" h="137">
                <a:moveTo>
                  <a:pt x="137" y="0"/>
                </a:moveTo>
                <a:lnTo>
                  <a:pt x="0" y="0"/>
                </a:lnTo>
                <a:lnTo>
                  <a:pt x="0" y="137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1520" bIns="-115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9" name="Freeform 313"/>
          <p:cNvSpPr/>
          <p:nvPr/>
        </p:nvSpPr>
        <p:spPr>
          <a:xfrm>
            <a:off x="3745080" y="4897440"/>
            <a:ext cx="712800" cy="398520"/>
          </a:xfrm>
          <a:custGeom>
            <a:avLst/>
            <a:gdLst>
              <a:gd name="textAreaLeft" fmla="*/ 0 w 712800"/>
              <a:gd name="textAreaRight" fmla="*/ 713160 w 712800"/>
              <a:gd name="textAreaTop" fmla="*/ 0 h 398520"/>
              <a:gd name="textAreaBottom" fmla="*/ 398880 h 398520"/>
            </a:gdLst>
            <a:ahLst/>
            <a:rect l="textAreaLeft" t="textAreaTop" r="textAreaRight" b="textAreaBottom"/>
            <a:pathLst>
              <a:path w="4943" h="1624">
                <a:moveTo>
                  <a:pt x="4943" y="0"/>
                </a:moveTo>
                <a:lnTo>
                  <a:pt x="0" y="0"/>
                </a:lnTo>
                <a:lnTo>
                  <a:pt x="0" y="1624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0" name="Freeform 319"/>
          <p:cNvSpPr/>
          <p:nvPr/>
        </p:nvSpPr>
        <p:spPr>
          <a:xfrm>
            <a:off x="4013280" y="4189320"/>
            <a:ext cx="25200" cy="98640"/>
          </a:xfrm>
          <a:custGeom>
            <a:avLst/>
            <a:gdLst>
              <a:gd name="textAreaLeft" fmla="*/ 0 w 25200"/>
              <a:gd name="textAreaRight" fmla="*/ 25560 w 25200"/>
              <a:gd name="textAreaTop" fmla="*/ 0 h 98640"/>
              <a:gd name="textAreaBottom" fmla="*/ 99000 h 98640"/>
            </a:gdLst>
            <a:ahLst/>
            <a:rect l="textAreaLeft" t="textAreaTop" r="textAreaRight" b="textAreaBottom"/>
            <a:pathLst>
              <a:path w="170" h="400">
                <a:moveTo>
                  <a:pt x="170" y="400"/>
                </a:moveTo>
                <a:lnTo>
                  <a:pt x="0" y="400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1" name="Freeform 321"/>
          <p:cNvSpPr/>
          <p:nvPr/>
        </p:nvSpPr>
        <p:spPr>
          <a:xfrm>
            <a:off x="4146480" y="5324400"/>
            <a:ext cx="23760" cy="20880"/>
          </a:xfrm>
          <a:custGeom>
            <a:avLst/>
            <a:gdLst>
              <a:gd name="textAreaLeft" fmla="*/ 0 w 23760"/>
              <a:gd name="textAreaRight" fmla="*/ 24120 w 23760"/>
              <a:gd name="textAreaTop" fmla="*/ 0 h 20880"/>
              <a:gd name="textAreaBottom" fmla="*/ 21240 h 20880"/>
            </a:gdLst>
            <a:ahLst/>
            <a:rect l="textAreaLeft" t="textAreaTop" r="textAreaRight" b="textAreaBottom"/>
            <a:pathLst>
              <a:path w="165" h="92">
                <a:moveTo>
                  <a:pt x="165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5560" bIns="-255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2" name="Freeform 325"/>
          <p:cNvSpPr/>
          <p:nvPr/>
        </p:nvSpPr>
        <p:spPr>
          <a:xfrm>
            <a:off x="3665520" y="5788080"/>
            <a:ext cx="298440" cy="492120"/>
          </a:xfrm>
          <a:custGeom>
            <a:avLst/>
            <a:gdLst>
              <a:gd name="textAreaLeft" fmla="*/ 0 w 298440"/>
              <a:gd name="textAreaRight" fmla="*/ 298800 w 298440"/>
              <a:gd name="textAreaTop" fmla="*/ 0 h 492120"/>
              <a:gd name="textAreaBottom" fmla="*/ 492480 h 492120"/>
            </a:gdLst>
            <a:ahLst/>
            <a:rect l="textAreaLeft" t="textAreaTop" r="textAreaRight" b="textAreaBottom"/>
            <a:pathLst>
              <a:path w="2081" h="2019">
                <a:moveTo>
                  <a:pt x="2081" y="2019"/>
                </a:moveTo>
                <a:lnTo>
                  <a:pt x="0" y="2019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3" name="Freeform 340"/>
          <p:cNvSpPr/>
          <p:nvPr/>
        </p:nvSpPr>
        <p:spPr>
          <a:xfrm>
            <a:off x="4118040" y="5703840"/>
            <a:ext cx="98280" cy="20520"/>
          </a:xfrm>
          <a:custGeom>
            <a:avLst/>
            <a:gdLst>
              <a:gd name="textAreaLeft" fmla="*/ 0 w 98280"/>
              <a:gd name="textAreaRight" fmla="*/ 98640 w 98280"/>
              <a:gd name="textAreaTop" fmla="*/ 0 h 20520"/>
              <a:gd name="textAreaBottom" fmla="*/ 20520 h 20520"/>
            </a:gdLst>
            <a:ahLst/>
            <a:rect l="textAreaLeft" t="textAreaTop" r="textAreaRight" b="textAreaBottom"/>
            <a:pathLst>
              <a:path w="687" h="91">
                <a:moveTo>
                  <a:pt x="687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4" name="Freeform 345"/>
          <p:cNvSpPr/>
          <p:nvPr/>
        </p:nvSpPr>
        <p:spPr>
          <a:xfrm>
            <a:off x="3808440" y="5691240"/>
            <a:ext cx="277920" cy="303120"/>
          </a:xfrm>
          <a:custGeom>
            <a:avLst/>
            <a:gdLst>
              <a:gd name="textAreaLeft" fmla="*/ 0 w 277920"/>
              <a:gd name="textAreaRight" fmla="*/ 278280 w 277920"/>
              <a:gd name="textAreaTop" fmla="*/ 0 h 303120"/>
              <a:gd name="textAreaBottom" fmla="*/ 303480 h 303120"/>
            </a:gdLst>
            <a:ahLst/>
            <a:rect l="textAreaLeft" t="textAreaTop" r="textAreaRight" b="textAreaBottom"/>
            <a:pathLst>
              <a:path w="1925" h="1241">
                <a:moveTo>
                  <a:pt x="1925" y="1241"/>
                </a:moveTo>
                <a:lnTo>
                  <a:pt x="0" y="124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5" name="Freeform 350"/>
          <p:cNvSpPr/>
          <p:nvPr/>
        </p:nvSpPr>
        <p:spPr>
          <a:xfrm>
            <a:off x="3745080" y="5295960"/>
            <a:ext cx="63360" cy="395280"/>
          </a:xfrm>
          <a:custGeom>
            <a:avLst/>
            <a:gdLst>
              <a:gd name="textAreaLeft" fmla="*/ 0 w 63360"/>
              <a:gd name="textAreaRight" fmla="*/ 63720 w 63360"/>
              <a:gd name="textAreaTop" fmla="*/ 0 h 395280"/>
              <a:gd name="textAreaBottom" fmla="*/ 395640 h 395280"/>
            </a:gdLst>
            <a:ahLst/>
            <a:rect l="textAreaLeft" t="textAreaTop" r="textAreaRight" b="textAreaBottom"/>
            <a:pathLst>
              <a:path w="438" h="1623">
                <a:moveTo>
                  <a:pt x="438" y="1623"/>
                </a:moveTo>
                <a:lnTo>
                  <a:pt x="0" y="1623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6" name="Freeform 353"/>
          <p:cNvSpPr/>
          <p:nvPr/>
        </p:nvSpPr>
        <p:spPr>
          <a:xfrm>
            <a:off x="4013280" y="4091040"/>
            <a:ext cx="17280" cy="98280"/>
          </a:xfrm>
          <a:custGeom>
            <a:avLst/>
            <a:gdLst>
              <a:gd name="textAreaLeft" fmla="*/ 0 w 17280"/>
              <a:gd name="textAreaRight" fmla="*/ 17640 w 17280"/>
              <a:gd name="textAreaTop" fmla="*/ 0 h 98280"/>
              <a:gd name="textAreaBottom" fmla="*/ 98640 h 98280"/>
            </a:gdLst>
            <a:ahLst/>
            <a:rect l="textAreaLeft" t="textAreaTop" r="textAreaRight" b="textAreaBottom"/>
            <a:pathLst>
              <a:path w="123" h="401">
                <a:moveTo>
                  <a:pt x="123" y="0"/>
                </a:moveTo>
                <a:lnTo>
                  <a:pt x="0" y="0"/>
                </a:lnTo>
                <a:lnTo>
                  <a:pt x="0" y="40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7" name="Freeform 358"/>
          <p:cNvSpPr/>
          <p:nvPr/>
        </p:nvSpPr>
        <p:spPr>
          <a:xfrm>
            <a:off x="4181400" y="4965840"/>
            <a:ext cx="82800" cy="21960"/>
          </a:xfrm>
          <a:custGeom>
            <a:avLst/>
            <a:gdLst>
              <a:gd name="textAreaLeft" fmla="*/ 0 w 82800"/>
              <a:gd name="textAreaRight" fmla="*/ 82800 w 82800"/>
              <a:gd name="textAreaTop" fmla="*/ 0 h 21960"/>
              <a:gd name="textAreaBottom" fmla="*/ 22320 h 21960"/>
            </a:gdLst>
            <a:ahLst/>
            <a:rect l="textAreaLeft" t="textAreaTop" r="textAreaRight" b="textAreaBottom"/>
            <a:pathLst>
              <a:path w="579" h="92">
                <a:moveTo>
                  <a:pt x="579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8" name="Freeform 363"/>
          <p:cNvSpPr/>
          <p:nvPr/>
        </p:nvSpPr>
        <p:spPr>
          <a:xfrm>
            <a:off x="4173480" y="5021280"/>
            <a:ext cx="3240" cy="33480"/>
          </a:xfrm>
          <a:custGeom>
            <a:avLst/>
            <a:gdLst>
              <a:gd name="textAreaLeft" fmla="*/ 0 w 3240"/>
              <a:gd name="textAreaRight" fmla="*/ 3600 w 3240"/>
              <a:gd name="textAreaTop" fmla="*/ 0 h 33480"/>
              <a:gd name="textAreaBottom" fmla="*/ 33840 h 33480"/>
            </a:gdLst>
            <a:ahLst/>
            <a:rect l="textAreaLeft" t="textAreaTop" r="textAreaRight" b="textAreaBottom"/>
            <a:pathLst>
              <a:path w="20" h="137">
                <a:moveTo>
                  <a:pt x="20" y="137"/>
                </a:moveTo>
                <a:lnTo>
                  <a:pt x="0" y="137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9" name="Freeform 364"/>
          <p:cNvSpPr/>
          <p:nvPr/>
        </p:nvSpPr>
        <p:spPr>
          <a:xfrm>
            <a:off x="4003560" y="4427640"/>
            <a:ext cx="451080" cy="21960"/>
          </a:xfrm>
          <a:custGeom>
            <a:avLst/>
            <a:gdLst>
              <a:gd name="textAreaLeft" fmla="*/ 0 w 451080"/>
              <a:gd name="textAreaRight" fmla="*/ 451440 w 451080"/>
              <a:gd name="textAreaTop" fmla="*/ 0 h 21960"/>
              <a:gd name="textAreaBottom" fmla="*/ 22320 h 21960"/>
            </a:gdLst>
            <a:ahLst/>
            <a:rect l="textAreaLeft" t="textAreaTop" r="textAreaRight" b="textAreaBottom"/>
            <a:pathLst>
              <a:path w="3135" h="91">
                <a:moveTo>
                  <a:pt x="3135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0" name="Rectangle 371"/>
          <p:cNvSpPr/>
          <p:nvPr/>
        </p:nvSpPr>
        <p:spPr>
          <a:xfrm>
            <a:off x="4506120" y="4357800"/>
            <a:ext cx="2826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Glyma15g2012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1" name="Rectangle 372"/>
          <p:cNvSpPr/>
          <p:nvPr/>
        </p:nvSpPr>
        <p:spPr>
          <a:xfrm>
            <a:off x="4383360" y="5119560"/>
            <a:ext cx="1882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Cpa2279.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2" name="Rectangle 373"/>
          <p:cNvSpPr/>
          <p:nvPr/>
        </p:nvSpPr>
        <p:spPr>
          <a:xfrm>
            <a:off x="4137480" y="5478480"/>
            <a:ext cx="1807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Mes39277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3" name="Rectangle 379"/>
          <p:cNvSpPr/>
          <p:nvPr/>
        </p:nvSpPr>
        <p:spPr>
          <a:xfrm>
            <a:off x="4205520" y="4984920"/>
            <a:ext cx="2232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StBAC06825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4" name="Rectangle 382"/>
          <p:cNvSpPr/>
          <p:nvPr/>
        </p:nvSpPr>
        <p:spPr>
          <a:xfrm>
            <a:off x="4770360" y="3954600"/>
            <a:ext cx="1548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AtRbohE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5" name="Rectangle 383"/>
          <p:cNvSpPr/>
          <p:nvPr/>
        </p:nvSpPr>
        <p:spPr>
          <a:xfrm>
            <a:off x="4271760" y="5924520"/>
            <a:ext cx="2354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Mgu001280m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6" name="Rectangle 391"/>
          <p:cNvSpPr/>
          <p:nvPr/>
        </p:nvSpPr>
        <p:spPr>
          <a:xfrm>
            <a:off x="4331520" y="4044960"/>
            <a:ext cx="1666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Cpa82.74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7" name="Rectangle 393"/>
          <p:cNvSpPr/>
          <p:nvPr/>
        </p:nvSpPr>
        <p:spPr>
          <a:xfrm>
            <a:off x="4377600" y="4805280"/>
            <a:ext cx="2401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Sb02g02566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8" name="Rectangle 400"/>
          <p:cNvSpPr/>
          <p:nvPr/>
        </p:nvSpPr>
        <p:spPr>
          <a:xfrm>
            <a:off x="4300200" y="4089240"/>
            <a:ext cx="2613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Ptr0006s1395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9" name="Rectangle 401"/>
          <p:cNvSpPr/>
          <p:nvPr/>
        </p:nvSpPr>
        <p:spPr>
          <a:xfrm>
            <a:off x="4577400" y="4492800"/>
            <a:ext cx="2401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Sb07g02225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0" name="Rectangle 402"/>
          <p:cNvSpPr/>
          <p:nvPr/>
        </p:nvSpPr>
        <p:spPr>
          <a:xfrm>
            <a:off x="4109040" y="6372360"/>
            <a:ext cx="2401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Sb03g03380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1" name="Rectangle 404"/>
          <p:cNvSpPr/>
          <p:nvPr/>
        </p:nvSpPr>
        <p:spPr>
          <a:xfrm>
            <a:off x="4407480" y="4761000"/>
            <a:ext cx="2401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Bradi4g3113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2" name="Rectangle 405"/>
          <p:cNvSpPr/>
          <p:nvPr/>
        </p:nvSpPr>
        <p:spPr>
          <a:xfrm>
            <a:off x="4106160" y="6327720"/>
            <a:ext cx="2401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Bradi2g4904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3" name="Freeform 7"/>
          <p:cNvSpPr/>
          <p:nvPr/>
        </p:nvSpPr>
        <p:spPr>
          <a:xfrm>
            <a:off x="3944880" y="5564160"/>
            <a:ext cx="65160" cy="49320"/>
          </a:xfrm>
          <a:custGeom>
            <a:avLst/>
            <a:gdLst>
              <a:gd name="textAreaLeft" fmla="*/ 0 w 65160"/>
              <a:gd name="textAreaRight" fmla="*/ 65520 w 65160"/>
              <a:gd name="textAreaTop" fmla="*/ 0 h 49320"/>
              <a:gd name="textAreaBottom" fmla="*/ 49680 h 49320"/>
            </a:gdLst>
            <a:ahLst/>
            <a:rect l="textAreaLeft" t="textAreaTop" r="textAreaRight" b="textAreaBottom"/>
            <a:pathLst>
              <a:path w="455" h="206">
                <a:moveTo>
                  <a:pt x="455" y="206"/>
                </a:moveTo>
                <a:lnTo>
                  <a:pt x="0" y="206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880" bIns="28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4" name="Freeform 9"/>
          <p:cNvSpPr/>
          <p:nvPr/>
        </p:nvSpPr>
        <p:spPr>
          <a:xfrm>
            <a:off x="4038480" y="4287960"/>
            <a:ext cx="222480" cy="39600"/>
          </a:xfrm>
          <a:custGeom>
            <a:avLst/>
            <a:gdLst>
              <a:gd name="textAreaLeft" fmla="*/ 0 w 222480"/>
              <a:gd name="textAreaRight" fmla="*/ 222840 w 222480"/>
              <a:gd name="textAreaTop" fmla="*/ 0 h 39600"/>
              <a:gd name="textAreaBottom" fmla="*/ 39960 h 39600"/>
            </a:gdLst>
            <a:ahLst/>
            <a:rect l="textAreaLeft" t="textAreaTop" r="textAreaRight" b="textAreaBottom"/>
            <a:pathLst>
              <a:path w="1546" h="161">
                <a:moveTo>
                  <a:pt x="1546" y="161"/>
                </a:moveTo>
                <a:lnTo>
                  <a:pt x="0" y="16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5" name="Freeform 10"/>
          <p:cNvSpPr/>
          <p:nvPr/>
        </p:nvSpPr>
        <p:spPr>
          <a:xfrm>
            <a:off x="4006800" y="5145120"/>
            <a:ext cx="365040" cy="20520"/>
          </a:xfrm>
          <a:custGeom>
            <a:avLst/>
            <a:gdLst>
              <a:gd name="textAreaLeft" fmla="*/ 0 w 365040"/>
              <a:gd name="textAreaRight" fmla="*/ 365400 w 365040"/>
              <a:gd name="textAreaTop" fmla="*/ 0 h 20520"/>
              <a:gd name="textAreaBottom" fmla="*/ 20520 h 20520"/>
            </a:gdLst>
            <a:ahLst/>
            <a:rect l="textAreaLeft" t="textAreaTop" r="textAreaRight" b="textAreaBottom"/>
            <a:pathLst>
              <a:path w="2524" h="91">
                <a:moveTo>
                  <a:pt x="2524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6" name="Freeform 11"/>
          <p:cNvSpPr/>
          <p:nvPr/>
        </p:nvSpPr>
        <p:spPr>
          <a:xfrm>
            <a:off x="4422600" y="4359240"/>
            <a:ext cx="71640" cy="23760"/>
          </a:xfrm>
          <a:custGeom>
            <a:avLst/>
            <a:gdLst>
              <a:gd name="textAreaLeft" fmla="*/ 0 w 71640"/>
              <a:gd name="textAreaRight" fmla="*/ 72000 w 71640"/>
              <a:gd name="textAreaTop" fmla="*/ 0 h 23760"/>
              <a:gd name="textAreaBottom" fmla="*/ 24120 h 23760"/>
            </a:gdLst>
            <a:ahLst/>
            <a:rect l="textAreaLeft" t="textAreaTop" r="textAreaRight" b="textAreaBottom"/>
            <a:pathLst>
              <a:path w="498" h="92">
                <a:moveTo>
                  <a:pt x="498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7" name="Freeform 14"/>
          <p:cNvSpPr/>
          <p:nvPr/>
        </p:nvSpPr>
        <p:spPr>
          <a:xfrm>
            <a:off x="3429000" y="4498920"/>
            <a:ext cx="355680" cy="646200"/>
          </a:xfrm>
          <a:custGeom>
            <a:avLst/>
            <a:gdLst>
              <a:gd name="textAreaLeft" fmla="*/ 0 w 355680"/>
              <a:gd name="textAreaRight" fmla="*/ 356040 w 355680"/>
              <a:gd name="textAreaTop" fmla="*/ 0 h 646200"/>
              <a:gd name="textAreaBottom" fmla="*/ 646560 h 646200"/>
            </a:gdLst>
            <a:ahLst/>
            <a:rect l="textAreaLeft" t="textAreaTop" r="textAreaRight" b="textAreaBottom"/>
            <a:pathLst>
              <a:path w="2470" h="2635">
                <a:moveTo>
                  <a:pt x="2470" y="0"/>
                </a:moveTo>
                <a:lnTo>
                  <a:pt x="0" y="0"/>
                </a:lnTo>
                <a:lnTo>
                  <a:pt x="0" y="2635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8" name="Freeform 15"/>
          <p:cNvSpPr/>
          <p:nvPr/>
        </p:nvSpPr>
        <p:spPr>
          <a:xfrm>
            <a:off x="3998880" y="5479920"/>
            <a:ext cx="127080" cy="22320"/>
          </a:xfrm>
          <a:custGeom>
            <a:avLst/>
            <a:gdLst>
              <a:gd name="textAreaLeft" fmla="*/ 0 w 127080"/>
              <a:gd name="textAreaRight" fmla="*/ 127440 w 12708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881" h="91">
                <a:moveTo>
                  <a:pt x="881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9" name="Freeform 16"/>
          <p:cNvSpPr/>
          <p:nvPr/>
        </p:nvSpPr>
        <p:spPr>
          <a:xfrm>
            <a:off x="4030560" y="6111720"/>
            <a:ext cx="23760" cy="76320"/>
          </a:xfrm>
          <a:custGeom>
            <a:avLst/>
            <a:gdLst>
              <a:gd name="textAreaLeft" fmla="*/ 0 w 23760"/>
              <a:gd name="textAreaRight" fmla="*/ 24120 w 23760"/>
              <a:gd name="textAreaTop" fmla="*/ 0 h 76320"/>
              <a:gd name="textAreaBottom" fmla="*/ 76680 h 76320"/>
            </a:gdLst>
            <a:ahLst/>
            <a:rect l="textAreaLeft" t="textAreaTop" r="textAreaRight" b="textAreaBottom"/>
            <a:pathLst>
              <a:path w="157" h="309">
                <a:moveTo>
                  <a:pt x="157" y="0"/>
                </a:moveTo>
                <a:lnTo>
                  <a:pt x="0" y="0"/>
                </a:lnTo>
                <a:lnTo>
                  <a:pt x="0" y="309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880" bIns="298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0" name="Freeform 20"/>
          <p:cNvSpPr/>
          <p:nvPr/>
        </p:nvSpPr>
        <p:spPr>
          <a:xfrm>
            <a:off x="3857760" y="5388120"/>
            <a:ext cx="17280" cy="274320"/>
          </a:xfrm>
          <a:custGeom>
            <a:avLst/>
            <a:gdLst>
              <a:gd name="textAreaLeft" fmla="*/ 0 w 17280"/>
              <a:gd name="textAreaRight" fmla="*/ 17640 w 17280"/>
              <a:gd name="textAreaTop" fmla="*/ 0 h 274320"/>
              <a:gd name="textAreaBottom" fmla="*/ 274320 h 274320"/>
            </a:gdLst>
            <a:ahLst/>
            <a:rect l="textAreaLeft" t="textAreaTop" r="textAreaRight" b="textAreaBottom"/>
            <a:pathLst>
              <a:path w="117" h="1125">
                <a:moveTo>
                  <a:pt x="117" y="1125"/>
                </a:moveTo>
                <a:lnTo>
                  <a:pt x="0" y="1125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1" name="Freeform 21"/>
          <p:cNvSpPr/>
          <p:nvPr/>
        </p:nvSpPr>
        <p:spPr>
          <a:xfrm>
            <a:off x="4181400" y="4987800"/>
            <a:ext cx="12600" cy="22320"/>
          </a:xfrm>
          <a:custGeom>
            <a:avLst/>
            <a:gdLst>
              <a:gd name="textAreaLeft" fmla="*/ 0 w 12600"/>
              <a:gd name="textAreaRight" fmla="*/ 12960 w 1260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85" h="91">
                <a:moveTo>
                  <a:pt x="85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2" name="Freeform 25"/>
          <p:cNvSpPr/>
          <p:nvPr/>
        </p:nvSpPr>
        <p:spPr>
          <a:xfrm>
            <a:off x="4135320" y="4613400"/>
            <a:ext cx="79560" cy="66600"/>
          </a:xfrm>
          <a:custGeom>
            <a:avLst/>
            <a:gdLst>
              <a:gd name="textAreaLeft" fmla="*/ 0 w 79560"/>
              <a:gd name="textAreaRight" fmla="*/ 79920 w 79560"/>
              <a:gd name="textAreaTop" fmla="*/ 0 h 66600"/>
              <a:gd name="textAreaBottom" fmla="*/ 66960 h 66600"/>
            </a:gdLst>
            <a:ahLst/>
            <a:rect l="textAreaLeft" t="textAreaTop" r="textAreaRight" b="textAreaBottom"/>
            <a:pathLst>
              <a:path w="545" h="275">
                <a:moveTo>
                  <a:pt x="545" y="0"/>
                </a:moveTo>
                <a:lnTo>
                  <a:pt x="0" y="0"/>
                </a:lnTo>
                <a:lnTo>
                  <a:pt x="0" y="275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3" name="Freeform 30"/>
          <p:cNvSpPr/>
          <p:nvPr/>
        </p:nvSpPr>
        <p:spPr>
          <a:xfrm>
            <a:off x="4094280" y="4035600"/>
            <a:ext cx="225360" cy="34920"/>
          </a:xfrm>
          <a:custGeom>
            <a:avLst/>
            <a:gdLst>
              <a:gd name="textAreaLeft" fmla="*/ 0 w 225360"/>
              <a:gd name="textAreaRight" fmla="*/ 225720 w 225360"/>
              <a:gd name="textAreaTop" fmla="*/ 0 h 34920"/>
              <a:gd name="textAreaBottom" fmla="*/ 35280 h 34920"/>
            </a:gdLst>
            <a:ahLst/>
            <a:rect l="textAreaLeft" t="textAreaTop" r="textAreaRight" b="textAreaBottom"/>
            <a:pathLst>
              <a:path w="1565" h="137">
                <a:moveTo>
                  <a:pt x="1565" y="137"/>
                </a:moveTo>
                <a:lnTo>
                  <a:pt x="0" y="137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1520" bIns="-115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4" name="Freeform 40"/>
          <p:cNvSpPr/>
          <p:nvPr/>
        </p:nvSpPr>
        <p:spPr>
          <a:xfrm>
            <a:off x="4464000" y="4518000"/>
            <a:ext cx="101520" cy="20520"/>
          </a:xfrm>
          <a:custGeom>
            <a:avLst/>
            <a:gdLst>
              <a:gd name="textAreaLeft" fmla="*/ 0 w 101520"/>
              <a:gd name="textAreaRight" fmla="*/ 101880 w 101520"/>
              <a:gd name="textAreaTop" fmla="*/ 0 h 20520"/>
              <a:gd name="textAreaBottom" fmla="*/ 20880 h 20520"/>
            </a:gdLst>
            <a:ahLst/>
            <a:rect l="textAreaLeft" t="textAreaTop" r="textAreaRight" b="textAreaBottom"/>
            <a:pathLst>
              <a:path w="713" h="92">
                <a:moveTo>
                  <a:pt x="713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5" name="Freeform 44"/>
          <p:cNvSpPr/>
          <p:nvPr/>
        </p:nvSpPr>
        <p:spPr>
          <a:xfrm>
            <a:off x="4040280" y="6330960"/>
            <a:ext cx="55440" cy="20520"/>
          </a:xfrm>
          <a:custGeom>
            <a:avLst/>
            <a:gdLst>
              <a:gd name="textAreaLeft" fmla="*/ 0 w 55440"/>
              <a:gd name="textAreaRight" fmla="*/ 55800 w 55440"/>
              <a:gd name="textAreaTop" fmla="*/ 0 h 20520"/>
              <a:gd name="textAreaBottom" fmla="*/ 20880 h 20520"/>
            </a:gdLst>
            <a:ahLst/>
            <a:rect l="textAreaLeft" t="textAreaTop" r="textAreaRight" b="textAreaBottom"/>
            <a:pathLst>
              <a:path w="392" h="92">
                <a:moveTo>
                  <a:pt x="392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6" name="Freeform 49"/>
          <p:cNvSpPr/>
          <p:nvPr/>
        </p:nvSpPr>
        <p:spPr>
          <a:xfrm>
            <a:off x="3990960" y="6330960"/>
            <a:ext cx="49320" cy="44280"/>
          </a:xfrm>
          <a:custGeom>
            <a:avLst/>
            <a:gdLst>
              <a:gd name="textAreaLeft" fmla="*/ 0 w 49320"/>
              <a:gd name="textAreaRight" fmla="*/ 49680 w 49320"/>
              <a:gd name="textAreaTop" fmla="*/ 0 h 44280"/>
              <a:gd name="textAreaBottom" fmla="*/ 44640 h 44280"/>
            </a:gdLst>
            <a:ahLst/>
            <a:rect l="textAreaLeft" t="textAreaTop" r="textAreaRight" b="textAreaBottom"/>
            <a:pathLst>
              <a:path w="342" h="183">
                <a:moveTo>
                  <a:pt x="342" y="0"/>
                </a:moveTo>
                <a:lnTo>
                  <a:pt x="0" y="0"/>
                </a:lnTo>
                <a:lnTo>
                  <a:pt x="0" y="183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7" name="Freeform 51"/>
          <p:cNvSpPr/>
          <p:nvPr/>
        </p:nvSpPr>
        <p:spPr>
          <a:xfrm>
            <a:off x="4003560" y="4449600"/>
            <a:ext cx="265320" cy="22320"/>
          </a:xfrm>
          <a:custGeom>
            <a:avLst/>
            <a:gdLst>
              <a:gd name="textAreaLeft" fmla="*/ 0 w 265320"/>
              <a:gd name="textAreaRight" fmla="*/ 265680 w 26532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1831" h="92">
                <a:moveTo>
                  <a:pt x="1831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8" name="Freeform 62"/>
          <p:cNvSpPr/>
          <p:nvPr/>
        </p:nvSpPr>
        <p:spPr>
          <a:xfrm>
            <a:off x="3897360" y="5803920"/>
            <a:ext cx="17280" cy="61920"/>
          </a:xfrm>
          <a:custGeom>
            <a:avLst/>
            <a:gdLst>
              <a:gd name="textAreaLeft" fmla="*/ 0 w 17280"/>
              <a:gd name="textAreaRight" fmla="*/ 17640 w 17280"/>
              <a:gd name="textAreaTop" fmla="*/ 0 h 61920"/>
              <a:gd name="textAreaBottom" fmla="*/ 62280 h 61920"/>
            </a:gdLst>
            <a:ahLst/>
            <a:rect l="textAreaLeft" t="textAreaTop" r="textAreaRight" b="textAreaBottom"/>
            <a:pathLst>
              <a:path w="109" h="252">
                <a:moveTo>
                  <a:pt x="109" y="0"/>
                </a:moveTo>
                <a:lnTo>
                  <a:pt x="0" y="0"/>
                </a:lnTo>
                <a:lnTo>
                  <a:pt x="0" y="25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5480" bIns="154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9" name="Freeform 67"/>
          <p:cNvSpPr/>
          <p:nvPr/>
        </p:nvSpPr>
        <p:spPr>
          <a:xfrm>
            <a:off x="3429000" y="5145120"/>
            <a:ext cx="236520" cy="642960"/>
          </a:xfrm>
          <a:custGeom>
            <a:avLst/>
            <a:gdLst>
              <a:gd name="textAreaLeft" fmla="*/ 0 w 236520"/>
              <a:gd name="textAreaRight" fmla="*/ 236880 w 236520"/>
              <a:gd name="textAreaTop" fmla="*/ 0 h 642960"/>
              <a:gd name="textAreaBottom" fmla="*/ 643320 h 642960"/>
            </a:gdLst>
            <a:ahLst/>
            <a:rect l="textAreaLeft" t="textAreaTop" r="textAreaRight" b="textAreaBottom"/>
            <a:pathLst>
              <a:path w="1638" h="2636">
                <a:moveTo>
                  <a:pt x="1638" y="2636"/>
                </a:moveTo>
                <a:lnTo>
                  <a:pt x="0" y="2636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0" name="Freeform 68"/>
          <p:cNvSpPr/>
          <p:nvPr/>
        </p:nvSpPr>
        <p:spPr>
          <a:xfrm>
            <a:off x="3897360" y="5113440"/>
            <a:ext cx="109440" cy="52200"/>
          </a:xfrm>
          <a:custGeom>
            <a:avLst/>
            <a:gdLst>
              <a:gd name="textAreaLeft" fmla="*/ 0 w 109440"/>
              <a:gd name="textAreaRight" fmla="*/ 109800 w 109440"/>
              <a:gd name="textAreaTop" fmla="*/ 0 h 52200"/>
              <a:gd name="textAreaBottom" fmla="*/ 52560 h 52200"/>
            </a:gdLst>
            <a:ahLst/>
            <a:rect l="textAreaLeft" t="textAreaTop" r="textAreaRight" b="textAreaBottom"/>
            <a:pathLst>
              <a:path w="769" h="217">
                <a:moveTo>
                  <a:pt x="769" y="217"/>
                </a:moveTo>
                <a:lnTo>
                  <a:pt x="0" y="217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5760" bIns="57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1" name="Freeform 71"/>
          <p:cNvSpPr/>
          <p:nvPr/>
        </p:nvSpPr>
        <p:spPr>
          <a:xfrm>
            <a:off x="4118040" y="5681520"/>
            <a:ext cx="7920" cy="22320"/>
          </a:xfrm>
          <a:custGeom>
            <a:avLst/>
            <a:gdLst>
              <a:gd name="textAreaLeft" fmla="*/ 0 w 7920"/>
              <a:gd name="textAreaRight" fmla="*/ 8280 w 792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51" h="92">
                <a:moveTo>
                  <a:pt x="51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2" name="Freeform 79"/>
          <p:cNvSpPr/>
          <p:nvPr/>
        </p:nvSpPr>
        <p:spPr>
          <a:xfrm>
            <a:off x="4068720" y="5703840"/>
            <a:ext cx="49320" cy="44640"/>
          </a:xfrm>
          <a:custGeom>
            <a:avLst/>
            <a:gdLst>
              <a:gd name="textAreaLeft" fmla="*/ 0 w 49320"/>
              <a:gd name="textAreaRight" fmla="*/ 49680 w 49320"/>
              <a:gd name="textAreaTop" fmla="*/ 0 h 44640"/>
              <a:gd name="textAreaBottom" fmla="*/ 45000 h 44640"/>
            </a:gdLst>
            <a:ahLst/>
            <a:rect l="textAreaLeft" t="textAreaTop" r="textAreaRight" b="textAreaBottom"/>
            <a:pathLst>
              <a:path w="346" h="183">
                <a:moveTo>
                  <a:pt x="346" y="0"/>
                </a:moveTo>
                <a:lnTo>
                  <a:pt x="0" y="0"/>
                </a:lnTo>
                <a:lnTo>
                  <a:pt x="0" y="183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" bIns="-1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3" name="Freeform 81"/>
          <p:cNvSpPr/>
          <p:nvPr/>
        </p:nvSpPr>
        <p:spPr>
          <a:xfrm>
            <a:off x="4098960" y="5770440"/>
            <a:ext cx="14400" cy="22320"/>
          </a:xfrm>
          <a:custGeom>
            <a:avLst/>
            <a:gdLst>
              <a:gd name="textAreaLeft" fmla="*/ 0 w 14400"/>
              <a:gd name="textAreaRight" fmla="*/ 14760 w 1440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104" h="92">
                <a:moveTo>
                  <a:pt x="104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4" name="Freeform 87"/>
          <p:cNvSpPr/>
          <p:nvPr/>
        </p:nvSpPr>
        <p:spPr>
          <a:xfrm>
            <a:off x="4705200" y="4002120"/>
            <a:ext cx="16200" cy="22320"/>
          </a:xfrm>
          <a:custGeom>
            <a:avLst/>
            <a:gdLst>
              <a:gd name="textAreaLeft" fmla="*/ 0 w 16200"/>
              <a:gd name="textAreaRight" fmla="*/ 16560 w 1620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125" h="92">
                <a:moveTo>
                  <a:pt x="125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5" name="Freeform 93"/>
          <p:cNvSpPr/>
          <p:nvPr/>
        </p:nvSpPr>
        <p:spPr>
          <a:xfrm>
            <a:off x="4030560" y="4091040"/>
            <a:ext cx="63720" cy="57240"/>
          </a:xfrm>
          <a:custGeom>
            <a:avLst/>
            <a:gdLst>
              <a:gd name="textAreaLeft" fmla="*/ 0 w 63720"/>
              <a:gd name="textAreaRight" fmla="*/ 64080 w 63720"/>
              <a:gd name="textAreaTop" fmla="*/ 0 h 57240"/>
              <a:gd name="textAreaBottom" fmla="*/ 57600 h 57240"/>
            </a:gdLst>
            <a:ahLst/>
            <a:rect l="textAreaLeft" t="textAreaTop" r="textAreaRight" b="textAreaBottom"/>
            <a:pathLst>
              <a:path w="444" h="229">
                <a:moveTo>
                  <a:pt x="444" y="229"/>
                </a:moveTo>
                <a:lnTo>
                  <a:pt x="0" y="229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0800" bIns="10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6" name="Freeform 95"/>
          <p:cNvSpPr/>
          <p:nvPr/>
        </p:nvSpPr>
        <p:spPr>
          <a:xfrm>
            <a:off x="4098960" y="5792760"/>
            <a:ext cx="22320" cy="22320"/>
          </a:xfrm>
          <a:custGeom>
            <a:avLst/>
            <a:gdLst>
              <a:gd name="textAreaLeft" fmla="*/ 0 w 22320"/>
              <a:gd name="textAreaRight" fmla="*/ 22680 w 2232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149" h="92">
                <a:moveTo>
                  <a:pt x="149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7" name="Freeform 96"/>
          <p:cNvSpPr/>
          <p:nvPr/>
        </p:nvSpPr>
        <p:spPr>
          <a:xfrm>
            <a:off x="4278240" y="4764240"/>
            <a:ext cx="47520" cy="33120"/>
          </a:xfrm>
          <a:custGeom>
            <a:avLst/>
            <a:gdLst>
              <a:gd name="textAreaLeft" fmla="*/ 0 w 47520"/>
              <a:gd name="textAreaRight" fmla="*/ 47880 w 47520"/>
              <a:gd name="textAreaTop" fmla="*/ 0 h 33120"/>
              <a:gd name="textAreaBottom" fmla="*/ 33480 h 33120"/>
            </a:gdLst>
            <a:ahLst/>
            <a:rect l="textAreaLeft" t="textAreaTop" r="textAreaRight" b="textAreaBottom"/>
            <a:pathLst>
              <a:path w="331" h="137">
                <a:moveTo>
                  <a:pt x="331" y="0"/>
                </a:moveTo>
                <a:lnTo>
                  <a:pt x="0" y="0"/>
                </a:lnTo>
                <a:lnTo>
                  <a:pt x="0" y="137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8" name="Freeform 101"/>
          <p:cNvSpPr/>
          <p:nvPr/>
        </p:nvSpPr>
        <p:spPr>
          <a:xfrm>
            <a:off x="4192560" y="6195960"/>
            <a:ext cx="4680" cy="22320"/>
          </a:xfrm>
          <a:custGeom>
            <a:avLst/>
            <a:gdLst>
              <a:gd name="textAreaLeft" fmla="*/ 0 w 4680"/>
              <a:gd name="textAreaRight" fmla="*/ 5040 w 468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46" h="91">
                <a:moveTo>
                  <a:pt x="46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9" name="Freeform 106"/>
          <p:cNvSpPr/>
          <p:nvPr/>
        </p:nvSpPr>
        <p:spPr>
          <a:xfrm>
            <a:off x="3968640" y="4189320"/>
            <a:ext cx="44640" cy="130320"/>
          </a:xfrm>
          <a:custGeom>
            <a:avLst/>
            <a:gdLst>
              <a:gd name="textAreaLeft" fmla="*/ 0 w 44640"/>
              <a:gd name="textAreaRight" fmla="*/ 45000 w 44640"/>
              <a:gd name="textAreaTop" fmla="*/ 0 h 130320"/>
              <a:gd name="textAreaBottom" fmla="*/ 130680 h 130320"/>
            </a:gdLst>
            <a:ahLst/>
            <a:rect l="textAreaLeft" t="textAreaTop" r="textAreaRight" b="textAreaBottom"/>
            <a:pathLst>
              <a:path w="315" h="532">
                <a:moveTo>
                  <a:pt x="315" y="0"/>
                </a:moveTo>
                <a:lnTo>
                  <a:pt x="0" y="0"/>
                </a:lnTo>
                <a:lnTo>
                  <a:pt x="0" y="53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0" name="Freeform 109"/>
          <p:cNvSpPr/>
          <p:nvPr/>
        </p:nvSpPr>
        <p:spPr>
          <a:xfrm>
            <a:off x="3990960" y="6375240"/>
            <a:ext cx="19080" cy="44640"/>
          </a:xfrm>
          <a:custGeom>
            <a:avLst/>
            <a:gdLst>
              <a:gd name="textAreaLeft" fmla="*/ 0 w 19080"/>
              <a:gd name="textAreaRight" fmla="*/ 19440 w 19080"/>
              <a:gd name="textAreaTop" fmla="*/ 0 h 44640"/>
              <a:gd name="textAreaBottom" fmla="*/ 45000 h 44640"/>
            </a:gdLst>
            <a:ahLst/>
            <a:rect l="textAreaLeft" t="textAreaTop" r="textAreaRight" b="textAreaBottom"/>
            <a:pathLst>
              <a:path w="143" h="184">
                <a:moveTo>
                  <a:pt x="143" y="184"/>
                </a:moveTo>
                <a:lnTo>
                  <a:pt x="0" y="184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" bIns="-1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1" name="Freeform 117"/>
          <p:cNvSpPr/>
          <p:nvPr/>
        </p:nvSpPr>
        <p:spPr>
          <a:xfrm>
            <a:off x="3875040" y="5662440"/>
            <a:ext cx="22320" cy="203400"/>
          </a:xfrm>
          <a:custGeom>
            <a:avLst/>
            <a:gdLst>
              <a:gd name="textAreaLeft" fmla="*/ 0 w 22320"/>
              <a:gd name="textAreaRight" fmla="*/ 22680 w 22320"/>
              <a:gd name="textAreaTop" fmla="*/ 0 h 203400"/>
              <a:gd name="textAreaBottom" fmla="*/ 203760 h 203400"/>
            </a:gdLst>
            <a:ahLst/>
            <a:rect l="textAreaLeft" t="textAreaTop" r="textAreaRight" b="textAreaBottom"/>
            <a:pathLst>
              <a:path w="161" h="830">
                <a:moveTo>
                  <a:pt x="161" y="830"/>
                </a:moveTo>
                <a:lnTo>
                  <a:pt x="0" y="830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2" name="Freeform 121"/>
          <p:cNvSpPr/>
          <p:nvPr/>
        </p:nvSpPr>
        <p:spPr>
          <a:xfrm>
            <a:off x="4054320" y="6062760"/>
            <a:ext cx="73080" cy="48960"/>
          </a:xfrm>
          <a:custGeom>
            <a:avLst/>
            <a:gdLst>
              <a:gd name="textAreaLeft" fmla="*/ 0 w 73080"/>
              <a:gd name="textAreaRight" fmla="*/ 73440 w 73080"/>
              <a:gd name="textAreaTop" fmla="*/ 0 h 48960"/>
              <a:gd name="textAreaBottom" fmla="*/ 49320 h 48960"/>
            </a:gdLst>
            <a:ahLst/>
            <a:rect l="textAreaLeft" t="textAreaTop" r="textAreaRight" b="textAreaBottom"/>
            <a:pathLst>
              <a:path w="510" h="206">
                <a:moveTo>
                  <a:pt x="510" y="0"/>
                </a:moveTo>
                <a:lnTo>
                  <a:pt x="0" y="0"/>
                </a:lnTo>
                <a:lnTo>
                  <a:pt x="0" y="206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3" name="Freeform 125"/>
          <p:cNvSpPr/>
          <p:nvPr/>
        </p:nvSpPr>
        <p:spPr>
          <a:xfrm>
            <a:off x="3784680" y="4319640"/>
            <a:ext cx="183960" cy="179280"/>
          </a:xfrm>
          <a:custGeom>
            <a:avLst/>
            <a:gdLst>
              <a:gd name="textAreaLeft" fmla="*/ 0 w 183960"/>
              <a:gd name="textAreaRight" fmla="*/ 184320 w 183960"/>
              <a:gd name="textAreaTop" fmla="*/ 0 h 179280"/>
              <a:gd name="textAreaBottom" fmla="*/ 179640 h 179280"/>
            </a:gdLst>
            <a:ahLst/>
            <a:rect l="textAreaLeft" t="textAreaTop" r="textAreaRight" b="textAreaBottom"/>
            <a:pathLst>
              <a:path w="1273" h="736">
                <a:moveTo>
                  <a:pt x="1273" y="0"/>
                </a:moveTo>
                <a:lnTo>
                  <a:pt x="0" y="0"/>
                </a:lnTo>
                <a:lnTo>
                  <a:pt x="0" y="736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4" name="Freeform 131"/>
          <p:cNvSpPr/>
          <p:nvPr/>
        </p:nvSpPr>
        <p:spPr>
          <a:xfrm>
            <a:off x="4006800" y="5165640"/>
            <a:ext cx="44640" cy="23760"/>
          </a:xfrm>
          <a:custGeom>
            <a:avLst/>
            <a:gdLst>
              <a:gd name="textAreaLeft" fmla="*/ 0 w 44640"/>
              <a:gd name="textAreaRight" fmla="*/ 45000 w 44640"/>
              <a:gd name="textAreaTop" fmla="*/ 0 h 23760"/>
              <a:gd name="textAreaBottom" fmla="*/ 24120 h 23760"/>
            </a:gdLst>
            <a:ahLst/>
            <a:rect l="textAreaLeft" t="textAreaTop" r="textAreaRight" b="textAreaBottom"/>
            <a:pathLst>
              <a:path w="299" h="92">
                <a:moveTo>
                  <a:pt x="299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5" name="Freeform 132"/>
          <p:cNvSpPr/>
          <p:nvPr/>
        </p:nvSpPr>
        <p:spPr>
          <a:xfrm>
            <a:off x="4214880" y="4613400"/>
            <a:ext cx="158760" cy="37800"/>
          </a:xfrm>
          <a:custGeom>
            <a:avLst/>
            <a:gdLst>
              <a:gd name="textAreaLeft" fmla="*/ 0 w 158760"/>
              <a:gd name="textAreaRight" fmla="*/ 159120 w 158760"/>
              <a:gd name="textAreaTop" fmla="*/ 0 h 37800"/>
              <a:gd name="textAreaBottom" fmla="*/ 38160 h 37800"/>
            </a:gdLst>
            <a:ahLst/>
            <a:rect l="textAreaLeft" t="textAreaTop" r="textAreaRight" b="textAreaBottom"/>
            <a:pathLst>
              <a:path w="1105" h="161">
                <a:moveTo>
                  <a:pt x="1105" y="161"/>
                </a:moveTo>
                <a:lnTo>
                  <a:pt x="0" y="16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6" name="Freeform 134"/>
          <p:cNvSpPr/>
          <p:nvPr/>
        </p:nvSpPr>
        <p:spPr>
          <a:xfrm>
            <a:off x="4037040" y="5904000"/>
            <a:ext cx="87120" cy="23760"/>
          </a:xfrm>
          <a:custGeom>
            <a:avLst/>
            <a:gdLst>
              <a:gd name="textAreaLeft" fmla="*/ 0 w 87120"/>
              <a:gd name="textAreaRight" fmla="*/ 87480 w 87120"/>
              <a:gd name="textAreaTop" fmla="*/ 0 h 23760"/>
              <a:gd name="textAreaBottom" fmla="*/ 24120 h 23760"/>
            </a:gdLst>
            <a:ahLst/>
            <a:rect l="textAreaLeft" t="textAreaTop" r="textAreaRight" b="textAreaBottom"/>
            <a:pathLst>
              <a:path w="607" h="91">
                <a:moveTo>
                  <a:pt x="607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7" name="Freeform 138"/>
          <p:cNvSpPr/>
          <p:nvPr/>
        </p:nvSpPr>
        <p:spPr>
          <a:xfrm>
            <a:off x="4094280" y="4148280"/>
            <a:ext cx="52200" cy="33120"/>
          </a:xfrm>
          <a:custGeom>
            <a:avLst/>
            <a:gdLst>
              <a:gd name="textAreaLeft" fmla="*/ 0 w 52200"/>
              <a:gd name="textAreaRight" fmla="*/ 52560 w 52200"/>
              <a:gd name="textAreaTop" fmla="*/ 0 h 33120"/>
              <a:gd name="textAreaBottom" fmla="*/ 33480 h 33120"/>
            </a:gdLst>
            <a:ahLst/>
            <a:rect l="textAreaLeft" t="textAreaTop" r="textAreaRight" b="textAreaBottom"/>
            <a:pathLst>
              <a:path w="361" h="137">
                <a:moveTo>
                  <a:pt x="361" y="137"/>
                </a:moveTo>
                <a:lnTo>
                  <a:pt x="0" y="137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8" name="Freeform 139"/>
          <p:cNvSpPr/>
          <p:nvPr/>
        </p:nvSpPr>
        <p:spPr>
          <a:xfrm>
            <a:off x="4094280" y="4002120"/>
            <a:ext cx="610920" cy="33480"/>
          </a:xfrm>
          <a:custGeom>
            <a:avLst/>
            <a:gdLst>
              <a:gd name="textAreaLeft" fmla="*/ 0 w 610920"/>
              <a:gd name="textAreaRight" fmla="*/ 611280 w 610920"/>
              <a:gd name="textAreaTop" fmla="*/ 0 h 33480"/>
              <a:gd name="textAreaBottom" fmla="*/ 33840 h 33480"/>
            </a:gdLst>
            <a:ahLst/>
            <a:rect l="textAreaLeft" t="textAreaTop" r="textAreaRight" b="textAreaBottom"/>
            <a:pathLst>
              <a:path w="4236" h="138">
                <a:moveTo>
                  <a:pt x="4236" y="0"/>
                </a:moveTo>
                <a:lnTo>
                  <a:pt x="0" y="0"/>
                </a:lnTo>
                <a:lnTo>
                  <a:pt x="0" y="138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2960" bIns="-129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9" name="Freeform 140"/>
          <p:cNvSpPr/>
          <p:nvPr/>
        </p:nvSpPr>
        <p:spPr>
          <a:xfrm>
            <a:off x="3963960" y="6280200"/>
            <a:ext cx="27000" cy="95040"/>
          </a:xfrm>
          <a:custGeom>
            <a:avLst/>
            <a:gdLst>
              <a:gd name="textAreaLeft" fmla="*/ 0 w 27000"/>
              <a:gd name="textAreaRight" fmla="*/ 27360 w 27000"/>
              <a:gd name="textAreaTop" fmla="*/ 0 h 95040"/>
              <a:gd name="textAreaBottom" fmla="*/ 95400 h 95040"/>
            </a:gdLst>
            <a:ahLst/>
            <a:rect l="textAreaLeft" t="textAreaTop" r="textAreaRight" b="textAreaBottom"/>
            <a:pathLst>
              <a:path w="179" h="383">
                <a:moveTo>
                  <a:pt x="179" y="383"/>
                </a:moveTo>
                <a:lnTo>
                  <a:pt x="0" y="383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0" name="Freeform 141"/>
          <p:cNvSpPr/>
          <p:nvPr/>
        </p:nvSpPr>
        <p:spPr>
          <a:xfrm>
            <a:off x="3944880" y="5514840"/>
            <a:ext cx="33480" cy="49320"/>
          </a:xfrm>
          <a:custGeom>
            <a:avLst/>
            <a:gdLst>
              <a:gd name="textAreaLeft" fmla="*/ 0 w 33480"/>
              <a:gd name="textAreaRight" fmla="*/ 33840 w 33480"/>
              <a:gd name="textAreaTop" fmla="*/ 0 h 49320"/>
              <a:gd name="textAreaBottom" fmla="*/ 49680 h 49320"/>
            </a:gdLst>
            <a:ahLst/>
            <a:rect l="textAreaLeft" t="textAreaTop" r="textAreaRight" b="textAreaBottom"/>
            <a:pathLst>
              <a:path w="233" h="206">
                <a:moveTo>
                  <a:pt x="233" y="0"/>
                </a:moveTo>
                <a:lnTo>
                  <a:pt x="0" y="0"/>
                </a:lnTo>
                <a:lnTo>
                  <a:pt x="0" y="206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880" bIns="28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1" name="Freeform 145"/>
          <p:cNvSpPr/>
          <p:nvPr/>
        </p:nvSpPr>
        <p:spPr>
          <a:xfrm>
            <a:off x="4127400" y="6062760"/>
            <a:ext cx="20880" cy="20520"/>
          </a:xfrm>
          <a:custGeom>
            <a:avLst/>
            <a:gdLst>
              <a:gd name="textAreaLeft" fmla="*/ 0 w 20880"/>
              <a:gd name="textAreaRight" fmla="*/ 21240 w 20880"/>
              <a:gd name="textAreaTop" fmla="*/ 0 h 20520"/>
              <a:gd name="textAreaBottom" fmla="*/ 20880 h 20520"/>
            </a:gdLst>
            <a:ahLst/>
            <a:rect l="textAreaLeft" t="textAreaTop" r="textAreaRight" b="textAreaBottom"/>
            <a:pathLst>
              <a:path w="145" h="92">
                <a:moveTo>
                  <a:pt x="145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2" name="Freeform 147"/>
          <p:cNvSpPr/>
          <p:nvPr/>
        </p:nvSpPr>
        <p:spPr>
          <a:xfrm>
            <a:off x="3897360" y="5060880"/>
            <a:ext cx="263520" cy="52560"/>
          </a:xfrm>
          <a:custGeom>
            <a:avLst/>
            <a:gdLst>
              <a:gd name="textAreaLeft" fmla="*/ 0 w 263520"/>
              <a:gd name="textAreaRight" fmla="*/ 263880 w 263520"/>
              <a:gd name="textAreaTop" fmla="*/ 0 h 52560"/>
              <a:gd name="textAreaBottom" fmla="*/ 52920 h 52560"/>
            </a:gdLst>
            <a:ahLst/>
            <a:rect l="textAreaLeft" t="textAreaTop" r="textAreaRight" b="textAreaBottom"/>
            <a:pathLst>
              <a:path w="1836" h="218">
                <a:moveTo>
                  <a:pt x="1836" y="0"/>
                </a:moveTo>
                <a:lnTo>
                  <a:pt x="0" y="0"/>
                </a:lnTo>
                <a:lnTo>
                  <a:pt x="0" y="218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6120" bIns="6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3" name="Freeform 156"/>
          <p:cNvSpPr/>
          <p:nvPr/>
        </p:nvSpPr>
        <p:spPr>
          <a:xfrm>
            <a:off x="4160880" y="5060880"/>
            <a:ext cx="9360" cy="38160"/>
          </a:xfrm>
          <a:custGeom>
            <a:avLst/>
            <a:gdLst>
              <a:gd name="textAreaLeft" fmla="*/ 0 w 9360"/>
              <a:gd name="textAreaRight" fmla="*/ 9720 w 936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63" h="161">
                <a:moveTo>
                  <a:pt x="63" y="161"/>
                </a:moveTo>
                <a:lnTo>
                  <a:pt x="0" y="16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8280" bIns="-82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4" name="Freeform 159"/>
          <p:cNvSpPr/>
          <p:nvPr/>
        </p:nvSpPr>
        <p:spPr>
          <a:xfrm>
            <a:off x="3914640" y="5748480"/>
            <a:ext cx="154080" cy="55440"/>
          </a:xfrm>
          <a:custGeom>
            <a:avLst/>
            <a:gdLst>
              <a:gd name="textAreaLeft" fmla="*/ 0 w 154080"/>
              <a:gd name="textAreaRight" fmla="*/ 154440 w 154080"/>
              <a:gd name="textAreaTop" fmla="*/ 0 h 55440"/>
              <a:gd name="textAreaBottom" fmla="*/ 55800 h 55440"/>
            </a:gdLst>
            <a:ahLst/>
            <a:rect l="textAreaLeft" t="textAreaTop" r="textAreaRight" b="textAreaBottom"/>
            <a:pathLst>
              <a:path w="1073" h="229">
                <a:moveTo>
                  <a:pt x="1073" y="0"/>
                </a:moveTo>
                <a:lnTo>
                  <a:pt x="0" y="0"/>
                </a:lnTo>
                <a:lnTo>
                  <a:pt x="0" y="229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5" name="Freeform 161"/>
          <p:cNvSpPr/>
          <p:nvPr/>
        </p:nvSpPr>
        <p:spPr>
          <a:xfrm>
            <a:off x="4146480" y="4159080"/>
            <a:ext cx="146160" cy="22320"/>
          </a:xfrm>
          <a:custGeom>
            <a:avLst/>
            <a:gdLst>
              <a:gd name="textAreaLeft" fmla="*/ 0 w 146160"/>
              <a:gd name="textAreaRight" fmla="*/ 146520 w 14616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1015" h="91">
                <a:moveTo>
                  <a:pt x="1015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6" name="Freeform 162"/>
          <p:cNvSpPr/>
          <p:nvPr/>
        </p:nvSpPr>
        <p:spPr>
          <a:xfrm>
            <a:off x="4457880" y="4875120"/>
            <a:ext cx="203040" cy="22320"/>
          </a:xfrm>
          <a:custGeom>
            <a:avLst/>
            <a:gdLst>
              <a:gd name="textAreaLeft" fmla="*/ 0 w 203040"/>
              <a:gd name="textAreaRight" fmla="*/ 203400 w 20304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1409" h="91">
                <a:moveTo>
                  <a:pt x="1409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7" name="Freeform 163"/>
          <p:cNvSpPr/>
          <p:nvPr/>
        </p:nvSpPr>
        <p:spPr>
          <a:xfrm>
            <a:off x="4192560" y="4746600"/>
            <a:ext cx="85680" cy="50760"/>
          </a:xfrm>
          <a:custGeom>
            <a:avLst/>
            <a:gdLst>
              <a:gd name="textAreaLeft" fmla="*/ 0 w 85680"/>
              <a:gd name="textAreaRight" fmla="*/ 86040 w 85680"/>
              <a:gd name="textAreaTop" fmla="*/ 0 h 50760"/>
              <a:gd name="textAreaBottom" fmla="*/ 51120 h 50760"/>
            </a:gdLst>
            <a:ahLst/>
            <a:rect l="textAreaLeft" t="textAreaTop" r="textAreaRight" b="textAreaBottom"/>
            <a:pathLst>
              <a:path w="590" h="206">
                <a:moveTo>
                  <a:pt x="590" y="206"/>
                </a:moveTo>
                <a:lnTo>
                  <a:pt x="0" y="206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20" bIns="43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8" name="Freeform 165"/>
          <p:cNvSpPr/>
          <p:nvPr/>
        </p:nvSpPr>
        <p:spPr>
          <a:xfrm>
            <a:off x="3998880" y="5457960"/>
            <a:ext cx="138240" cy="21960"/>
          </a:xfrm>
          <a:custGeom>
            <a:avLst/>
            <a:gdLst>
              <a:gd name="textAreaLeft" fmla="*/ 0 w 138240"/>
              <a:gd name="textAreaRight" fmla="*/ 138600 w 138240"/>
              <a:gd name="textAreaTop" fmla="*/ 0 h 21960"/>
              <a:gd name="textAreaBottom" fmla="*/ 22320 h 21960"/>
            </a:gdLst>
            <a:ahLst/>
            <a:rect l="textAreaLeft" t="textAreaTop" r="textAreaRight" b="textAreaBottom"/>
            <a:pathLst>
              <a:path w="956" h="92">
                <a:moveTo>
                  <a:pt x="956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9" name="Freeform 167"/>
          <p:cNvSpPr/>
          <p:nvPr/>
        </p:nvSpPr>
        <p:spPr>
          <a:xfrm>
            <a:off x="4114800" y="5234040"/>
            <a:ext cx="19080" cy="22320"/>
          </a:xfrm>
          <a:custGeom>
            <a:avLst/>
            <a:gdLst>
              <a:gd name="textAreaLeft" fmla="*/ 0 w 19080"/>
              <a:gd name="textAreaRight" fmla="*/ 19440 w 1908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137" h="92">
                <a:moveTo>
                  <a:pt x="137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0" name="Freeform 169"/>
          <p:cNvSpPr/>
          <p:nvPr/>
        </p:nvSpPr>
        <p:spPr>
          <a:xfrm>
            <a:off x="4146480" y="4181400"/>
            <a:ext cx="138240" cy="22320"/>
          </a:xfrm>
          <a:custGeom>
            <a:avLst/>
            <a:gdLst>
              <a:gd name="textAreaLeft" fmla="*/ 0 w 138240"/>
              <a:gd name="textAreaRight" fmla="*/ 138600 w 13824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948" h="92">
                <a:moveTo>
                  <a:pt x="948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1" name="Freeform 171"/>
          <p:cNvSpPr/>
          <p:nvPr/>
        </p:nvSpPr>
        <p:spPr>
          <a:xfrm>
            <a:off x="3808440" y="5388120"/>
            <a:ext cx="49320" cy="303120"/>
          </a:xfrm>
          <a:custGeom>
            <a:avLst/>
            <a:gdLst>
              <a:gd name="textAreaLeft" fmla="*/ 0 w 49320"/>
              <a:gd name="textAreaRight" fmla="*/ 49680 w 49320"/>
              <a:gd name="textAreaTop" fmla="*/ 0 h 303120"/>
              <a:gd name="textAreaBottom" fmla="*/ 303480 h 303120"/>
            </a:gdLst>
            <a:ahLst/>
            <a:rect l="textAreaLeft" t="textAreaTop" r="textAreaRight" b="textAreaBottom"/>
            <a:pathLst>
              <a:path w="346" h="1240">
                <a:moveTo>
                  <a:pt x="346" y="0"/>
                </a:moveTo>
                <a:lnTo>
                  <a:pt x="0" y="0"/>
                </a:lnTo>
                <a:lnTo>
                  <a:pt x="0" y="124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2" name="Freeform 173"/>
          <p:cNvSpPr/>
          <p:nvPr/>
        </p:nvSpPr>
        <p:spPr>
          <a:xfrm>
            <a:off x="4086360" y="6161040"/>
            <a:ext cx="106200" cy="34920"/>
          </a:xfrm>
          <a:custGeom>
            <a:avLst/>
            <a:gdLst>
              <a:gd name="textAreaLeft" fmla="*/ 0 w 106200"/>
              <a:gd name="textAreaRight" fmla="*/ 106560 w 106200"/>
              <a:gd name="textAreaTop" fmla="*/ 0 h 34920"/>
              <a:gd name="textAreaBottom" fmla="*/ 35280 h 34920"/>
            </a:gdLst>
            <a:ahLst/>
            <a:rect l="textAreaLeft" t="textAreaTop" r="textAreaRight" b="textAreaBottom"/>
            <a:pathLst>
              <a:path w="730" h="138">
                <a:moveTo>
                  <a:pt x="730" y="138"/>
                </a:moveTo>
                <a:lnTo>
                  <a:pt x="0" y="138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1520" bIns="-115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3" name="Freeform 176"/>
          <p:cNvSpPr/>
          <p:nvPr/>
        </p:nvSpPr>
        <p:spPr>
          <a:xfrm>
            <a:off x="3892680" y="5356080"/>
            <a:ext cx="28440" cy="104760"/>
          </a:xfrm>
          <a:custGeom>
            <a:avLst/>
            <a:gdLst>
              <a:gd name="textAreaLeft" fmla="*/ 0 w 28440"/>
              <a:gd name="textAreaRight" fmla="*/ 28800 w 28440"/>
              <a:gd name="textAreaTop" fmla="*/ 0 h 104760"/>
              <a:gd name="textAreaBottom" fmla="*/ 105120 h 104760"/>
            </a:gdLst>
            <a:ahLst/>
            <a:rect l="textAreaLeft" t="textAreaTop" r="textAreaRight" b="textAreaBottom"/>
            <a:pathLst>
              <a:path w="201" h="423">
                <a:moveTo>
                  <a:pt x="201" y="0"/>
                </a:moveTo>
                <a:lnTo>
                  <a:pt x="0" y="0"/>
                </a:lnTo>
                <a:lnTo>
                  <a:pt x="0" y="423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4" name="Freeform 178"/>
          <p:cNvSpPr/>
          <p:nvPr/>
        </p:nvSpPr>
        <p:spPr>
          <a:xfrm>
            <a:off x="4422600" y="4338720"/>
            <a:ext cx="52560" cy="20520"/>
          </a:xfrm>
          <a:custGeom>
            <a:avLst/>
            <a:gdLst>
              <a:gd name="textAreaLeft" fmla="*/ 0 w 52560"/>
              <a:gd name="textAreaRight" fmla="*/ 52920 w 52560"/>
              <a:gd name="textAreaTop" fmla="*/ 0 h 20520"/>
              <a:gd name="textAreaBottom" fmla="*/ 20880 h 20520"/>
            </a:gdLst>
            <a:ahLst/>
            <a:rect l="textAreaLeft" t="textAreaTop" r="textAreaRight" b="textAreaBottom"/>
            <a:pathLst>
              <a:path w="352" h="92">
                <a:moveTo>
                  <a:pt x="352" y="0"/>
                </a:moveTo>
                <a:lnTo>
                  <a:pt x="0" y="0"/>
                </a:lnTo>
                <a:lnTo>
                  <a:pt x="0" y="92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5" name="Freeform 179"/>
          <p:cNvSpPr/>
          <p:nvPr/>
        </p:nvSpPr>
        <p:spPr>
          <a:xfrm>
            <a:off x="4160880" y="5021280"/>
            <a:ext cx="12600" cy="39600"/>
          </a:xfrm>
          <a:custGeom>
            <a:avLst/>
            <a:gdLst>
              <a:gd name="textAreaLeft" fmla="*/ 0 w 12600"/>
              <a:gd name="textAreaRight" fmla="*/ 12960 w 12600"/>
              <a:gd name="textAreaTop" fmla="*/ 0 h 39600"/>
              <a:gd name="textAreaBottom" fmla="*/ 39960 h 39600"/>
            </a:gdLst>
            <a:ahLst/>
            <a:rect l="textAreaLeft" t="textAreaTop" r="textAreaRight" b="textAreaBottom"/>
            <a:pathLst>
              <a:path w="86" h="160">
                <a:moveTo>
                  <a:pt x="86" y="0"/>
                </a:moveTo>
                <a:lnTo>
                  <a:pt x="0" y="0"/>
                </a:lnTo>
                <a:lnTo>
                  <a:pt x="0" y="16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6" name="Freeform 182"/>
          <p:cNvSpPr/>
          <p:nvPr/>
        </p:nvSpPr>
        <p:spPr>
          <a:xfrm>
            <a:off x="4332240" y="4538520"/>
            <a:ext cx="131760" cy="34920"/>
          </a:xfrm>
          <a:custGeom>
            <a:avLst/>
            <a:gdLst>
              <a:gd name="textAreaLeft" fmla="*/ 0 w 131760"/>
              <a:gd name="textAreaRight" fmla="*/ 132120 w 131760"/>
              <a:gd name="textAreaTop" fmla="*/ 0 h 34920"/>
              <a:gd name="textAreaBottom" fmla="*/ 35280 h 34920"/>
            </a:gdLst>
            <a:ahLst/>
            <a:rect l="textAreaLeft" t="textAreaTop" r="textAreaRight" b="textAreaBottom"/>
            <a:pathLst>
              <a:path w="913" h="137">
                <a:moveTo>
                  <a:pt x="913" y="0"/>
                </a:moveTo>
                <a:lnTo>
                  <a:pt x="0" y="0"/>
                </a:lnTo>
                <a:lnTo>
                  <a:pt x="0" y="137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1520" bIns="-115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7" name="Freeform 187"/>
          <p:cNvSpPr/>
          <p:nvPr/>
        </p:nvSpPr>
        <p:spPr>
          <a:xfrm>
            <a:off x="3784680" y="4498920"/>
            <a:ext cx="350640" cy="181080"/>
          </a:xfrm>
          <a:custGeom>
            <a:avLst/>
            <a:gdLst>
              <a:gd name="textAreaLeft" fmla="*/ 0 w 350640"/>
              <a:gd name="textAreaRight" fmla="*/ 351000 w 350640"/>
              <a:gd name="textAreaTop" fmla="*/ 0 h 181080"/>
              <a:gd name="textAreaBottom" fmla="*/ 181440 h 181080"/>
            </a:gdLst>
            <a:ahLst/>
            <a:rect l="textAreaLeft" t="textAreaTop" r="textAreaRight" b="textAreaBottom"/>
            <a:pathLst>
              <a:path w="2436" h="735">
                <a:moveTo>
                  <a:pt x="2436" y="735"/>
                </a:moveTo>
                <a:lnTo>
                  <a:pt x="0" y="735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8" name="Freeform 188"/>
          <p:cNvSpPr/>
          <p:nvPr/>
        </p:nvSpPr>
        <p:spPr>
          <a:xfrm>
            <a:off x="4030560" y="4035600"/>
            <a:ext cx="63720" cy="55440"/>
          </a:xfrm>
          <a:custGeom>
            <a:avLst/>
            <a:gdLst>
              <a:gd name="textAreaLeft" fmla="*/ 0 w 63720"/>
              <a:gd name="textAreaRight" fmla="*/ 64080 w 63720"/>
              <a:gd name="textAreaTop" fmla="*/ 0 h 55440"/>
              <a:gd name="textAreaBottom" fmla="*/ 55800 h 55440"/>
            </a:gdLst>
            <a:ahLst/>
            <a:rect l="textAreaLeft" t="textAreaTop" r="textAreaRight" b="textAreaBottom"/>
            <a:pathLst>
              <a:path w="434" h="229">
                <a:moveTo>
                  <a:pt x="434" y="0"/>
                </a:moveTo>
                <a:lnTo>
                  <a:pt x="0" y="0"/>
                </a:lnTo>
                <a:lnTo>
                  <a:pt x="0" y="229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9" name="Freeform 189"/>
          <p:cNvSpPr/>
          <p:nvPr/>
        </p:nvSpPr>
        <p:spPr>
          <a:xfrm>
            <a:off x="4260960" y="4327560"/>
            <a:ext cx="161640" cy="31680"/>
          </a:xfrm>
          <a:custGeom>
            <a:avLst/>
            <a:gdLst>
              <a:gd name="textAreaLeft" fmla="*/ 0 w 161640"/>
              <a:gd name="textAreaRight" fmla="*/ 162000 w 161640"/>
              <a:gd name="textAreaTop" fmla="*/ 0 h 31680"/>
              <a:gd name="textAreaBottom" fmla="*/ 32040 h 31680"/>
            </a:gdLst>
            <a:ahLst/>
            <a:rect l="textAreaLeft" t="textAreaTop" r="textAreaRight" b="textAreaBottom"/>
            <a:pathLst>
              <a:path w="1127" h="137">
                <a:moveTo>
                  <a:pt x="1127" y="137"/>
                </a:moveTo>
                <a:lnTo>
                  <a:pt x="0" y="137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0" name="Freeform 190"/>
          <p:cNvSpPr/>
          <p:nvPr/>
        </p:nvSpPr>
        <p:spPr>
          <a:xfrm>
            <a:off x="4054320" y="6111720"/>
            <a:ext cx="32040" cy="49320"/>
          </a:xfrm>
          <a:custGeom>
            <a:avLst/>
            <a:gdLst>
              <a:gd name="textAreaLeft" fmla="*/ 0 w 32040"/>
              <a:gd name="textAreaRight" fmla="*/ 32400 w 32040"/>
              <a:gd name="textAreaTop" fmla="*/ 0 h 49320"/>
              <a:gd name="textAreaBottom" fmla="*/ 49680 h 49320"/>
            </a:gdLst>
            <a:ahLst/>
            <a:rect l="textAreaLeft" t="textAreaTop" r="textAreaRight" b="textAreaBottom"/>
            <a:pathLst>
              <a:path w="229" h="206">
                <a:moveTo>
                  <a:pt x="229" y="206"/>
                </a:moveTo>
                <a:lnTo>
                  <a:pt x="0" y="206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880" bIns="288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1" name="Freeform 192"/>
          <p:cNvSpPr/>
          <p:nvPr/>
        </p:nvSpPr>
        <p:spPr>
          <a:xfrm>
            <a:off x="3892680" y="5460840"/>
            <a:ext cx="52200" cy="103320"/>
          </a:xfrm>
          <a:custGeom>
            <a:avLst/>
            <a:gdLst>
              <a:gd name="textAreaLeft" fmla="*/ 0 w 52200"/>
              <a:gd name="textAreaRight" fmla="*/ 52560 w 52200"/>
              <a:gd name="textAreaTop" fmla="*/ 0 h 103320"/>
              <a:gd name="textAreaBottom" fmla="*/ 103680 h 103320"/>
            </a:gdLst>
            <a:ahLst/>
            <a:rect l="textAreaLeft" t="textAreaTop" r="textAreaRight" b="textAreaBottom"/>
            <a:pathLst>
              <a:path w="368" h="424">
                <a:moveTo>
                  <a:pt x="368" y="424"/>
                </a:moveTo>
                <a:lnTo>
                  <a:pt x="0" y="424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2" name="Freeform 196"/>
          <p:cNvSpPr/>
          <p:nvPr/>
        </p:nvSpPr>
        <p:spPr>
          <a:xfrm>
            <a:off x="4705200" y="3979800"/>
            <a:ext cx="52560" cy="22320"/>
          </a:xfrm>
          <a:custGeom>
            <a:avLst/>
            <a:gdLst>
              <a:gd name="textAreaLeft" fmla="*/ 0 w 52560"/>
              <a:gd name="textAreaRight" fmla="*/ 52920 w 5256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375" h="91">
                <a:moveTo>
                  <a:pt x="375" y="0"/>
                </a:moveTo>
                <a:lnTo>
                  <a:pt x="0" y="0"/>
                </a:lnTo>
                <a:lnTo>
                  <a:pt x="0" y="91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3" name="Freeform 199"/>
          <p:cNvSpPr/>
          <p:nvPr/>
        </p:nvSpPr>
        <p:spPr>
          <a:xfrm>
            <a:off x="4010040" y="6419880"/>
            <a:ext cx="66600" cy="22320"/>
          </a:xfrm>
          <a:custGeom>
            <a:avLst/>
            <a:gdLst>
              <a:gd name="textAreaLeft" fmla="*/ 0 w 66600"/>
              <a:gd name="textAreaRight" fmla="*/ 66960 w 6660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453" h="91">
                <a:moveTo>
                  <a:pt x="453" y="91"/>
                </a:moveTo>
                <a:lnTo>
                  <a:pt x="0" y="91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4" name="Freeform 200"/>
          <p:cNvSpPr/>
          <p:nvPr/>
        </p:nvSpPr>
        <p:spPr>
          <a:xfrm>
            <a:off x="4037040" y="5927760"/>
            <a:ext cx="222120" cy="22320"/>
          </a:xfrm>
          <a:custGeom>
            <a:avLst/>
            <a:gdLst>
              <a:gd name="textAreaLeft" fmla="*/ 0 w 222120"/>
              <a:gd name="textAreaRight" fmla="*/ 222480 w 22212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1548" h="92">
                <a:moveTo>
                  <a:pt x="1548" y="92"/>
                </a:moveTo>
                <a:lnTo>
                  <a:pt x="0" y="92"/>
                </a:lnTo>
                <a:lnTo>
                  <a:pt x="0" y="0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5" name="Freeform 204"/>
          <p:cNvSpPr/>
          <p:nvPr/>
        </p:nvSpPr>
        <p:spPr>
          <a:xfrm>
            <a:off x="3857760" y="5113440"/>
            <a:ext cx="39600" cy="274680"/>
          </a:xfrm>
          <a:custGeom>
            <a:avLst/>
            <a:gdLst>
              <a:gd name="textAreaLeft" fmla="*/ 0 w 39600"/>
              <a:gd name="textAreaRight" fmla="*/ 39960 w 39600"/>
              <a:gd name="textAreaTop" fmla="*/ 0 h 274680"/>
              <a:gd name="textAreaBottom" fmla="*/ 275040 h 274680"/>
            </a:gdLst>
            <a:ahLst/>
            <a:rect l="textAreaLeft" t="textAreaTop" r="textAreaRight" b="textAreaBottom"/>
            <a:pathLst>
              <a:path w="268" h="1125">
                <a:moveTo>
                  <a:pt x="268" y="0"/>
                </a:moveTo>
                <a:lnTo>
                  <a:pt x="0" y="0"/>
                </a:lnTo>
                <a:lnTo>
                  <a:pt x="0" y="1125"/>
                </a:lnTo>
              </a:path>
            </a:pathLst>
          </a:custGeom>
          <a:noFill/>
          <a:ln cap="rnd"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6" name="Rectangle 409"/>
          <p:cNvSpPr/>
          <p:nvPr/>
        </p:nvSpPr>
        <p:spPr>
          <a:xfrm>
            <a:off x="4109760" y="6237360"/>
            <a:ext cx="1864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OsRBOHC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7" name="Rectangle 414"/>
          <p:cNvSpPr/>
          <p:nvPr/>
        </p:nvSpPr>
        <p:spPr>
          <a:xfrm>
            <a:off x="4155120" y="6103800"/>
            <a:ext cx="2401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Bradi2g1909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8" name="Rectangle 416"/>
          <p:cNvSpPr/>
          <p:nvPr/>
        </p:nvSpPr>
        <p:spPr>
          <a:xfrm>
            <a:off x="4276800" y="4446720"/>
            <a:ext cx="430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VviGSVIVT0001638600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9" name="Rectangle 421"/>
          <p:cNvSpPr/>
          <p:nvPr/>
        </p:nvSpPr>
        <p:spPr>
          <a:xfrm>
            <a:off x="4176000" y="5343480"/>
            <a:ext cx="2826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Glyma01g4319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0" name="Rectangle 424"/>
          <p:cNvSpPr/>
          <p:nvPr/>
        </p:nvSpPr>
        <p:spPr>
          <a:xfrm>
            <a:off x="4069800" y="5567400"/>
            <a:ext cx="2613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Ptr0001s0997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1" name="Rectangle 425"/>
          <p:cNvSpPr/>
          <p:nvPr/>
        </p:nvSpPr>
        <p:spPr>
          <a:xfrm>
            <a:off x="4069800" y="5611680"/>
            <a:ext cx="2613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Ptr0003s133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2" name="Rectangle 432"/>
          <p:cNvSpPr/>
          <p:nvPr/>
        </p:nvSpPr>
        <p:spPr>
          <a:xfrm>
            <a:off x="4156920" y="6014880"/>
            <a:ext cx="2401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Sb09g02632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3" name="Rectangle 434"/>
          <p:cNvSpPr/>
          <p:nvPr/>
        </p:nvSpPr>
        <p:spPr>
          <a:xfrm>
            <a:off x="4147920" y="5656320"/>
            <a:ext cx="1548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StRbohA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4" name="Rectangle 441"/>
          <p:cNvSpPr/>
          <p:nvPr/>
        </p:nvSpPr>
        <p:spPr>
          <a:xfrm>
            <a:off x="4654080" y="4896000"/>
            <a:ext cx="1836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Aly489958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5" name="Rectangle 444"/>
          <p:cNvSpPr/>
          <p:nvPr/>
        </p:nvSpPr>
        <p:spPr>
          <a:xfrm>
            <a:off x="4520520" y="4581360"/>
            <a:ext cx="2401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Bradi3g3753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6" name="Rectangle 445"/>
          <p:cNvSpPr/>
          <p:nvPr/>
        </p:nvSpPr>
        <p:spPr>
          <a:xfrm>
            <a:off x="4455360" y="4716360"/>
            <a:ext cx="16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HvRbohE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7" name="Rectangle 446"/>
          <p:cNvSpPr/>
          <p:nvPr/>
        </p:nvSpPr>
        <p:spPr>
          <a:xfrm>
            <a:off x="4127400" y="5745240"/>
            <a:ext cx="151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NbrbohA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8" name="Rectangle 448"/>
          <p:cNvSpPr/>
          <p:nvPr/>
        </p:nvSpPr>
        <p:spPr>
          <a:xfrm>
            <a:off x="4375440" y="4672080"/>
            <a:ext cx="1882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OsRBOHG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9" name="Rectangle 449"/>
          <p:cNvSpPr/>
          <p:nvPr/>
        </p:nvSpPr>
        <p:spPr>
          <a:xfrm>
            <a:off x="4437360" y="4268880"/>
            <a:ext cx="1501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LjRbohD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0" name="Rectangle 453"/>
          <p:cNvSpPr/>
          <p:nvPr/>
        </p:nvSpPr>
        <p:spPr>
          <a:xfrm>
            <a:off x="4733640" y="3998880"/>
            <a:ext cx="1836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Aly31286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1" name="Rectangle 462"/>
          <p:cNvSpPr/>
          <p:nvPr/>
        </p:nvSpPr>
        <p:spPr>
          <a:xfrm>
            <a:off x="4141440" y="6283440"/>
            <a:ext cx="1836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HvRbohF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2" name="Rectangle 463"/>
          <p:cNvSpPr/>
          <p:nvPr/>
        </p:nvSpPr>
        <p:spPr>
          <a:xfrm>
            <a:off x="4132800" y="5789520"/>
            <a:ext cx="1530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NtRbohF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3" name="Rectangle 466"/>
          <p:cNvSpPr/>
          <p:nvPr/>
        </p:nvSpPr>
        <p:spPr>
          <a:xfrm>
            <a:off x="4147200" y="5253120"/>
            <a:ext cx="2826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Glyma05g3733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4" name="Rectangle 468"/>
          <p:cNvSpPr/>
          <p:nvPr/>
        </p:nvSpPr>
        <p:spPr>
          <a:xfrm>
            <a:off x="4614120" y="4224240"/>
            <a:ext cx="2491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Cucsa.01169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5" name="Rectangle 469"/>
          <p:cNvSpPr/>
          <p:nvPr/>
        </p:nvSpPr>
        <p:spPr>
          <a:xfrm>
            <a:off x="4210920" y="6192720"/>
            <a:ext cx="16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HvRbohA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6" name="Rectangle 470"/>
          <p:cNvSpPr/>
          <p:nvPr/>
        </p:nvSpPr>
        <p:spPr>
          <a:xfrm>
            <a:off x="4104720" y="5388120"/>
            <a:ext cx="2491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Cucsa.30357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7" name="Rectangle 472"/>
          <p:cNvSpPr/>
          <p:nvPr/>
        </p:nvSpPr>
        <p:spPr>
          <a:xfrm>
            <a:off x="4204800" y="6148440"/>
            <a:ext cx="1836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HvRbohF2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8" name="Rectangle 475"/>
          <p:cNvSpPr/>
          <p:nvPr/>
        </p:nvSpPr>
        <p:spPr>
          <a:xfrm>
            <a:off x="4089240" y="5522760"/>
            <a:ext cx="3466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Rco30190.m011285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9" name="Rectangle 487"/>
          <p:cNvSpPr/>
          <p:nvPr/>
        </p:nvSpPr>
        <p:spPr>
          <a:xfrm>
            <a:off x="4577040" y="4537080"/>
            <a:ext cx="3985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ZmaGRMZM2G448185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0" name="Rectangle 491"/>
          <p:cNvSpPr/>
          <p:nvPr/>
        </p:nvSpPr>
        <p:spPr>
          <a:xfrm>
            <a:off x="4076640" y="5835600"/>
            <a:ext cx="430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VviGSVIVT0000252500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1" name="Rectangle 499"/>
          <p:cNvSpPr/>
          <p:nvPr/>
        </p:nvSpPr>
        <p:spPr>
          <a:xfrm>
            <a:off x="4388040" y="4626000"/>
            <a:ext cx="1821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OsRBOHF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2" name="Rectangle 500"/>
          <p:cNvSpPr/>
          <p:nvPr/>
        </p:nvSpPr>
        <p:spPr>
          <a:xfrm>
            <a:off x="4063320" y="5164200"/>
            <a:ext cx="1666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Cpa201.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3" name="Rectangle 501"/>
          <p:cNvSpPr/>
          <p:nvPr/>
        </p:nvSpPr>
        <p:spPr>
          <a:xfrm>
            <a:off x="4137480" y="5880240"/>
            <a:ext cx="151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SaNOX2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4" name="Rectangle 507"/>
          <p:cNvSpPr/>
          <p:nvPr/>
        </p:nvSpPr>
        <p:spPr>
          <a:xfrm>
            <a:off x="4180680" y="5299200"/>
            <a:ext cx="2826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Glyma11g023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5" name="Rectangle 513"/>
          <p:cNvSpPr/>
          <p:nvPr/>
        </p:nvSpPr>
        <p:spPr>
          <a:xfrm>
            <a:off x="4160880" y="6058080"/>
            <a:ext cx="3985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ZmaGRMZM2G043435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6" name="Rectangle 522"/>
          <p:cNvSpPr/>
          <p:nvPr/>
        </p:nvSpPr>
        <p:spPr>
          <a:xfrm>
            <a:off x="4190400" y="5073480"/>
            <a:ext cx="1836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Aly474949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7" name="Rectangle 524"/>
          <p:cNvSpPr/>
          <p:nvPr/>
        </p:nvSpPr>
        <p:spPr>
          <a:xfrm>
            <a:off x="4228560" y="5700600"/>
            <a:ext cx="2217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SlAAD2530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8" name="Rectangle 529"/>
          <p:cNvSpPr/>
          <p:nvPr/>
        </p:nvSpPr>
        <p:spPr>
          <a:xfrm>
            <a:off x="4303440" y="4133880"/>
            <a:ext cx="34668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Rco29739.m003705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9" name="Rectangle 530"/>
          <p:cNvSpPr/>
          <p:nvPr/>
        </p:nvSpPr>
        <p:spPr>
          <a:xfrm>
            <a:off x="4096800" y="5969160"/>
            <a:ext cx="2491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Cucsa.1070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0" name="Rectangle 531"/>
          <p:cNvSpPr/>
          <p:nvPr/>
        </p:nvSpPr>
        <p:spPr>
          <a:xfrm>
            <a:off x="4673880" y="4851360"/>
            <a:ext cx="1393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AtRbohI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1" name="Rectangle 532"/>
          <p:cNvSpPr/>
          <p:nvPr/>
        </p:nvSpPr>
        <p:spPr>
          <a:xfrm>
            <a:off x="4148280" y="5432400"/>
            <a:ext cx="1807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Mes13052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2" name="Rectangle 536"/>
          <p:cNvSpPr/>
          <p:nvPr/>
        </p:nvSpPr>
        <p:spPr>
          <a:xfrm>
            <a:off x="4145760" y="5208480"/>
            <a:ext cx="2826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Glyma08g0221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3" name="Rectangle 539"/>
          <p:cNvSpPr/>
          <p:nvPr/>
        </p:nvSpPr>
        <p:spPr>
          <a:xfrm>
            <a:off x="4278960" y="4940280"/>
            <a:ext cx="151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StRbohF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4" name="Rectangle 540"/>
          <p:cNvSpPr/>
          <p:nvPr/>
        </p:nvSpPr>
        <p:spPr>
          <a:xfrm>
            <a:off x="4296240" y="4178160"/>
            <a:ext cx="18072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Mes10513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5" name="Rectangle 544"/>
          <p:cNvSpPr/>
          <p:nvPr/>
        </p:nvSpPr>
        <p:spPr>
          <a:xfrm>
            <a:off x="4467240" y="4403880"/>
            <a:ext cx="2354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Mgu003890m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6" name="Rectangle 545"/>
          <p:cNvSpPr/>
          <p:nvPr/>
        </p:nvSpPr>
        <p:spPr>
          <a:xfrm>
            <a:off x="4199400" y="5030640"/>
            <a:ext cx="1515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AtRbohF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7" name="Rectangle 548"/>
          <p:cNvSpPr/>
          <p:nvPr/>
        </p:nvSpPr>
        <p:spPr>
          <a:xfrm>
            <a:off x="4483800" y="4313160"/>
            <a:ext cx="28260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Glyma09g08470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8" name="Rectangle 555"/>
          <p:cNvSpPr/>
          <p:nvPr/>
        </p:nvSpPr>
        <p:spPr>
          <a:xfrm>
            <a:off x="4477680" y="451476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9" name="Rectangle 556"/>
          <p:cNvSpPr/>
          <p:nvPr/>
        </p:nvSpPr>
        <p:spPr>
          <a:xfrm>
            <a:off x="4025160" y="559116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0" name="Rectangle 558"/>
          <p:cNvSpPr/>
          <p:nvPr/>
        </p:nvSpPr>
        <p:spPr>
          <a:xfrm>
            <a:off x="4274640" y="430200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1" name="Rectangle 562"/>
          <p:cNvSpPr/>
          <p:nvPr/>
        </p:nvSpPr>
        <p:spPr>
          <a:xfrm>
            <a:off x="3797640" y="447516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97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2" name="Rectangle 565"/>
          <p:cNvSpPr/>
          <p:nvPr/>
        </p:nvSpPr>
        <p:spPr>
          <a:xfrm>
            <a:off x="4106520" y="401004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85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3" name="Rectangle 566"/>
          <p:cNvSpPr/>
          <p:nvPr/>
        </p:nvSpPr>
        <p:spPr>
          <a:xfrm>
            <a:off x="4149000" y="465444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4" name="Rectangle 567"/>
          <p:cNvSpPr/>
          <p:nvPr/>
        </p:nvSpPr>
        <p:spPr>
          <a:xfrm>
            <a:off x="4438080" y="433548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5" name="Rectangle 568"/>
          <p:cNvSpPr/>
          <p:nvPr/>
        </p:nvSpPr>
        <p:spPr>
          <a:xfrm>
            <a:off x="4101480" y="613872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6" name="Rectangle 570"/>
          <p:cNvSpPr/>
          <p:nvPr/>
        </p:nvSpPr>
        <p:spPr>
          <a:xfrm>
            <a:off x="4068000" y="608652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7" name="Rectangle 572"/>
          <p:cNvSpPr/>
          <p:nvPr/>
        </p:nvSpPr>
        <p:spPr>
          <a:xfrm>
            <a:off x="3958560" y="553896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8" name="Rectangle 574"/>
          <p:cNvSpPr/>
          <p:nvPr/>
        </p:nvSpPr>
        <p:spPr>
          <a:xfrm>
            <a:off x="3887640" y="563724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66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9" name="Rectangle 578"/>
          <p:cNvSpPr/>
          <p:nvPr/>
        </p:nvSpPr>
        <p:spPr>
          <a:xfrm>
            <a:off x="4228560" y="458784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0" name="Rectangle 581"/>
          <p:cNvSpPr/>
          <p:nvPr/>
        </p:nvSpPr>
        <p:spPr>
          <a:xfrm>
            <a:off x="3910680" y="508968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62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1" name="Rectangle 586"/>
          <p:cNvSpPr/>
          <p:nvPr/>
        </p:nvSpPr>
        <p:spPr>
          <a:xfrm>
            <a:off x="4050720" y="590220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2" name="Rectangle 593"/>
          <p:cNvSpPr/>
          <p:nvPr/>
        </p:nvSpPr>
        <p:spPr>
          <a:xfrm>
            <a:off x="4206240" y="472140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3" name="Rectangle 596"/>
          <p:cNvSpPr/>
          <p:nvPr/>
        </p:nvSpPr>
        <p:spPr>
          <a:xfrm>
            <a:off x="4128480" y="523224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4" name="Rectangle 598"/>
          <p:cNvSpPr/>
          <p:nvPr/>
        </p:nvSpPr>
        <p:spPr>
          <a:xfrm>
            <a:off x="4347720" y="454824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5" name="Rectangle 600"/>
          <p:cNvSpPr/>
          <p:nvPr/>
        </p:nvSpPr>
        <p:spPr>
          <a:xfrm>
            <a:off x="4195080" y="496404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6" name="Rectangle 603"/>
          <p:cNvSpPr/>
          <p:nvPr/>
        </p:nvSpPr>
        <p:spPr>
          <a:xfrm>
            <a:off x="4053960" y="630540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7" name="Rectangle 614"/>
          <p:cNvSpPr/>
          <p:nvPr/>
        </p:nvSpPr>
        <p:spPr>
          <a:xfrm>
            <a:off x="3926520" y="577836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86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8" name="Rectangle 620"/>
          <p:cNvSpPr/>
          <p:nvPr/>
        </p:nvSpPr>
        <p:spPr>
          <a:xfrm>
            <a:off x="4022280" y="514368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9" name="Rectangle 621"/>
          <p:cNvSpPr/>
          <p:nvPr/>
        </p:nvSpPr>
        <p:spPr>
          <a:xfrm>
            <a:off x="3679200" y="576252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0" name="Rectangle 626"/>
          <p:cNvSpPr/>
          <p:nvPr/>
        </p:nvSpPr>
        <p:spPr>
          <a:xfrm>
            <a:off x="4133160" y="568008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1" name="Rectangle 635"/>
          <p:cNvSpPr/>
          <p:nvPr/>
        </p:nvSpPr>
        <p:spPr>
          <a:xfrm>
            <a:off x="4014360" y="527688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2" name="Rectangle 642"/>
          <p:cNvSpPr/>
          <p:nvPr/>
        </p:nvSpPr>
        <p:spPr>
          <a:xfrm>
            <a:off x="4109400" y="412272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3" name="Rectangle 643"/>
          <p:cNvSpPr/>
          <p:nvPr/>
        </p:nvSpPr>
        <p:spPr>
          <a:xfrm>
            <a:off x="4339800" y="473868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4" name="Rectangle 656"/>
          <p:cNvSpPr/>
          <p:nvPr/>
        </p:nvSpPr>
        <p:spPr>
          <a:xfrm>
            <a:off x="4112640" y="576900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5" name="Rectangle 659"/>
          <p:cNvSpPr/>
          <p:nvPr/>
        </p:nvSpPr>
        <p:spPr>
          <a:xfrm>
            <a:off x="4026240" y="416556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86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6" name="Rectangle 660"/>
          <p:cNvSpPr/>
          <p:nvPr/>
        </p:nvSpPr>
        <p:spPr>
          <a:xfrm>
            <a:off x="4016880" y="442908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83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7" name="Rectangle 661"/>
          <p:cNvSpPr/>
          <p:nvPr/>
        </p:nvSpPr>
        <p:spPr>
          <a:xfrm>
            <a:off x="4024800" y="639612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59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8" name="Rectangle 667"/>
          <p:cNvSpPr/>
          <p:nvPr/>
        </p:nvSpPr>
        <p:spPr>
          <a:xfrm>
            <a:off x="3905640" y="543564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66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9" name="Rectangle 668"/>
          <p:cNvSpPr/>
          <p:nvPr/>
        </p:nvSpPr>
        <p:spPr>
          <a:xfrm>
            <a:off x="3759840" y="527040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99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0" name="Rectangle 669"/>
          <p:cNvSpPr/>
          <p:nvPr/>
        </p:nvSpPr>
        <p:spPr>
          <a:xfrm>
            <a:off x="3910680" y="586116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92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1" name="Rectangle 673"/>
          <p:cNvSpPr/>
          <p:nvPr/>
        </p:nvSpPr>
        <p:spPr>
          <a:xfrm>
            <a:off x="4141080" y="603900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2" name="Rectangle 674"/>
          <p:cNvSpPr/>
          <p:nvPr/>
        </p:nvSpPr>
        <p:spPr>
          <a:xfrm>
            <a:off x="4046040" y="616284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3" name="Rectangle 676"/>
          <p:cNvSpPr/>
          <p:nvPr/>
        </p:nvSpPr>
        <p:spPr>
          <a:xfrm>
            <a:off x="3982320" y="429588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4" name="Rectangle 679"/>
          <p:cNvSpPr/>
          <p:nvPr/>
        </p:nvSpPr>
        <p:spPr>
          <a:xfrm>
            <a:off x="4160160" y="532296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5" name="Rectangle 681"/>
          <p:cNvSpPr/>
          <p:nvPr/>
        </p:nvSpPr>
        <p:spPr>
          <a:xfrm>
            <a:off x="4011480" y="545472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97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6" name="Rectangle 685"/>
          <p:cNvSpPr/>
          <p:nvPr/>
        </p:nvSpPr>
        <p:spPr>
          <a:xfrm>
            <a:off x="4471560" y="487512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7" name="Rectangle 689"/>
          <p:cNvSpPr/>
          <p:nvPr/>
        </p:nvSpPr>
        <p:spPr>
          <a:xfrm>
            <a:off x="4050360" y="426240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68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8" name="Rectangle 690"/>
          <p:cNvSpPr/>
          <p:nvPr/>
        </p:nvSpPr>
        <p:spPr>
          <a:xfrm>
            <a:off x="4718880" y="397656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9" name="Rectangle 691"/>
          <p:cNvSpPr/>
          <p:nvPr/>
        </p:nvSpPr>
        <p:spPr>
          <a:xfrm>
            <a:off x="4160160" y="415620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0" name="Rectangle 694"/>
          <p:cNvSpPr/>
          <p:nvPr/>
        </p:nvSpPr>
        <p:spPr>
          <a:xfrm>
            <a:off x="3993480" y="550224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1" name="Rectangle 695"/>
          <p:cNvSpPr/>
          <p:nvPr/>
        </p:nvSpPr>
        <p:spPr>
          <a:xfrm>
            <a:off x="4004280" y="635004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67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2" name="Rectangle 696"/>
          <p:cNvSpPr/>
          <p:nvPr/>
        </p:nvSpPr>
        <p:spPr>
          <a:xfrm>
            <a:off x="3979440" y="625644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3" name="Rectangle 700"/>
          <p:cNvSpPr/>
          <p:nvPr/>
        </p:nvSpPr>
        <p:spPr>
          <a:xfrm>
            <a:off x="4174560" y="503568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4" name="Rectangle 712"/>
          <p:cNvSpPr/>
          <p:nvPr/>
        </p:nvSpPr>
        <p:spPr>
          <a:xfrm>
            <a:off x="4082400" y="572292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5" name="Rectangle 714"/>
          <p:cNvSpPr/>
          <p:nvPr/>
        </p:nvSpPr>
        <p:spPr>
          <a:xfrm>
            <a:off x="4291200" y="477216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6" name="Rectangle 716"/>
          <p:cNvSpPr/>
          <p:nvPr/>
        </p:nvSpPr>
        <p:spPr>
          <a:xfrm>
            <a:off x="3823200" y="566568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6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7" name="Rectangle 719"/>
          <p:cNvSpPr/>
          <p:nvPr/>
        </p:nvSpPr>
        <p:spPr>
          <a:xfrm>
            <a:off x="4042440" y="407052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58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8" name="Rectangle 722"/>
          <p:cNvSpPr/>
          <p:nvPr/>
        </p:nvSpPr>
        <p:spPr>
          <a:xfrm>
            <a:off x="3442320" y="511956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53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9" name="Rectangle 726"/>
          <p:cNvSpPr/>
          <p:nvPr/>
        </p:nvSpPr>
        <p:spPr>
          <a:xfrm>
            <a:off x="3870720" y="536400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62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0" name="Rectangle 729"/>
          <p:cNvSpPr/>
          <p:nvPr/>
        </p:nvSpPr>
        <p:spPr>
          <a:xfrm>
            <a:off x="4206240" y="617076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1" name="Rectangle 731"/>
          <p:cNvSpPr/>
          <p:nvPr/>
        </p:nvSpPr>
        <p:spPr>
          <a:xfrm>
            <a:off x="3926520" y="5324400"/>
            <a:ext cx="752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0,88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2" name="Rectangle 732"/>
          <p:cNvSpPr/>
          <p:nvPr/>
        </p:nvSpPr>
        <p:spPr>
          <a:xfrm>
            <a:off x="4191840" y="4995720"/>
            <a:ext cx="2196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73" name=""/>
          <p:cNvGrpSpPr/>
          <p:nvPr/>
        </p:nvGrpSpPr>
        <p:grpSpPr>
          <a:xfrm>
            <a:off x="5075280" y="1332000"/>
            <a:ext cx="1387440" cy="7077600"/>
            <a:chOff x="5075280" y="1332000"/>
            <a:chExt cx="1387440" cy="7077600"/>
          </a:xfrm>
        </p:grpSpPr>
        <p:sp>
          <p:nvSpPr>
            <p:cNvPr id="774" name="ZoneTexte 736"/>
            <p:cNvSpPr/>
            <p:nvPr/>
          </p:nvSpPr>
          <p:spPr>
            <a:xfrm>
              <a:off x="5434560" y="1332000"/>
              <a:ext cx="309240" cy="34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5160" rIns="65160" tIns="32760" bIns="3276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1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5" name="ZoneTexte 738"/>
            <p:cNvSpPr/>
            <p:nvPr/>
          </p:nvSpPr>
          <p:spPr>
            <a:xfrm>
              <a:off x="5690520" y="3388680"/>
              <a:ext cx="309240" cy="34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5160" rIns="65160" tIns="32760" bIns="3276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2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6" name="ZoneTexte 746"/>
            <p:cNvSpPr/>
            <p:nvPr/>
          </p:nvSpPr>
          <p:spPr>
            <a:xfrm>
              <a:off x="6154560" y="8069400"/>
              <a:ext cx="308160" cy="34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5160" rIns="65160" tIns="32760" bIns="3276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5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7" name="ZoneTexte 984"/>
            <p:cNvSpPr/>
            <p:nvPr/>
          </p:nvSpPr>
          <p:spPr>
            <a:xfrm>
              <a:off x="5177160" y="4403520"/>
              <a:ext cx="307080" cy="34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5160" rIns="65160" tIns="32760" bIns="3276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8" name="ZoneTexte 985"/>
            <p:cNvSpPr/>
            <p:nvPr/>
          </p:nvSpPr>
          <p:spPr>
            <a:xfrm>
              <a:off x="5075280" y="5961600"/>
              <a:ext cx="308160" cy="34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5160" rIns="65160" tIns="32760" bIns="3276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4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79" name="Rectangle 384"/>
          <p:cNvSpPr/>
          <p:nvPr/>
        </p:nvSpPr>
        <p:spPr>
          <a:xfrm>
            <a:off x="4120920" y="6415200"/>
            <a:ext cx="185040" cy="4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300" spc="-1" strike="noStrike">
                <a:solidFill>
                  <a:srgbClr val="000000"/>
                </a:solidFill>
                <a:latin typeface="Arial"/>
              </a:rPr>
              <a:t>OsRBOHA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0" name="Rectangle 301"/>
          <p:cNvSpPr/>
          <p:nvPr/>
        </p:nvSpPr>
        <p:spPr>
          <a:xfrm>
            <a:off x="6203880" y="8969400"/>
            <a:ext cx="642960" cy="172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1" lang="en-GB" sz="700" spc="-1" strike="noStrike">
                <a:solidFill>
                  <a:srgbClr val="000000"/>
                </a:solidFill>
                <a:latin typeface="Arial"/>
              </a:rPr>
              <a:t>Marino</a:t>
            </a:r>
            <a:r>
              <a:rPr b="1" i="1" lang="en-GB" sz="700" spc="-1" strike="noStrike">
                <a:solidFill>
                  <a:srgbClr val="000000"/>
                </a:solidFill>
                <a:latin typeface="Arial"/>
              </a:rPr>
              <a:t> et al.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1" name="Rectangle 302"/>
          <p:cNvSpPr/>
          <p:nvPr/>
        </p:nvSpPr>
        <p:spPr>
          <a:xfrm>
            <a:off x="-7200" y="8895240"/>
            <a:ext cx="5268960" cy="24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Figure S2. </a:t>
            </a:r>
            <a:r>
              <a:rPr b="1" i="1" lang="en-GB" sz="1200" spc="-1" strike="noStrike">
                <a:solidFill>
                  <a:srgbClr val="000000"/>
                </a:solidFill>
                <a:latin typeface="Arial"/>
              </a:rPr>
              <a:t>MtRboh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 gene expression analysis in different plant tissues.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782" name=""/>
          <p:cNvGraphicFramePr/>
          <p:nvPr/>
        </p:nvGraphicFramePr>
        <p:xfrm>
          <a:off x="7920" y="1263600"/>
          <a:ext cx="6850080" cy="289404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783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920" y="1263600"/>
                    <a:ext cx="6850080" cy="2894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84" name="Zone de texte 4"/>
          <p:cNvSpPr/>
          <p:nvPr/>
        </p:nvSpPr>
        <p:spPr>
          <a:xfrm>
            <a:off x="0" y="0"/>
            <a:ext cx="1413000" cy="27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5160" rIns="65160" tIns="32760" bIns="3276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Figure S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85" name="Groupe 8"/>
          <p:cNvGrpSpPr/>
          <p:nvPr/>
        </p:nvGrpSpPr>
        <p:grpSpPr>
          <a:xfrm>
            <a:off x="1728360" y="2276640"/>
            <a:ext cx="2057400" cy="2595240"/>
            <a:chOff x="1728360" y="2276640"/>
            <a:chExt cx="2057400" cy="2595240"/>
          </a:xfrm>
        </p:grpSpPr>
        <p:pic>
          <p:nvPicPr>
            <p:cNvPr id="786" name="Image 9" descr="AxioCamHR53"/>
            <p:cNvPicPr/>
            <p:nvPr/>
          </p:nvPicPr>
          <p:blipFill>
            <a:blip r:embed="rId1"/>
            <a:stretch/>
          </p:blipFill>
          <p:spPr>
            <a:xfrm rot="5400000">
              <a:off x="1459080" y="2545560"/>
              <a:ext cx="2595240" cy="2057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87" name="Trait 10"/>
            <p:cNvSpPr/>
            <p:nvPr/>
          </p:nvSpPr>
          <p:spPr>
            <a:xfrm>
              <a:off x="3425760" y="4791960"/>
              <a:ext cx="296640" cy="0"/>
            </a:xfrm>
            <a:prstGeom prst="line">
              <a:avLst/>
            </a:prstGeom>
            <a:ln w="316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88" name="Rectangle 12"/>
          <p:cNvSpPr/>
          <p:nvPr/>
        </p:nvSpPr>
        <p:spPr>
          <a:xfrm>
            <a:off x="0" y="8712720"/>
            <a:ext cx="6858000" cy="430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5160" rIns="65160" tIns="32760" bIns="3276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Figure S3.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Simultaneous </a:t>
            </a:r>
            <a:r>
              <a:rPr b="1" i="1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MtRbohA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expression and </a:t>
            </a:r>
            <a:r>
              <a:rPr b="1" i="1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S. meliloti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localization in </a:t>
            </a:r>
            <a:r>
              <a:rPr b="1" i="1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M. truncatula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nodules</a:t>
            </a: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.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9" name="Rectangle 13"/>
          <p:cNvSpPr/>
          <p:nvPr/>
        </p:nvSpPr>
        <p:spPr>
          <a:xfrm>
            <a:off x="6213240" y="8969400"/>
            <a:ext cx="642960" cy="172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1" lang="en-GB" sz="700" spc="-1" strike="noStrike">
                <a:solidFill>
                  <a:srgbClr val="000000"/>
                </a:solidFill>
                <a:latin typeface="Arial"/>
              </a:rPr>
              <a:t>Marino</a:t>
            </a:r>
            <a:r>
              <a:rPr b="1" i="1" lang="en-GB" sz="700" spc="-1" strike="noStrike">
                <a:solidFill>
                  <a:srgbClr val="000000"/>
                </a:solidFill>
                <a:latin typeface="Arial"/>
              </a:rPr>
              <a:t> et al.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0" name="Zone de texte 4"/>
          <p:cNvSpPr/>
          <p:nvPr/>
        </p:nvSpPr>
        <p:spPr>
          <a:xfrm>
            <a:off x="0" y="0"/>
            <a:ext cx="1413000" cy="27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5160" rIns="65160" tIns="32760" bIns="3276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Figure S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1" name="Rectangle 12"/>
          <p:cNvSpPr/>
          <p:nvPr/>
        </p:nvSpPr>
        <p:spPr>
          <a:xfrm>
            <a:off x="0" y="8919000"/>
            <a:ext cx="6122880" cy="24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5160" rIns="65160" tIns="32760" bIns="3276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Figure S4..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Morphological analysis of control and </a:t>
            </a:r>
            <a:r>
              <a:rPr b="1" i="1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MtRbohA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::RNAi nodules</a:t>
            </a: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.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2" name="Rectangle 13"/>
          <p:cNvSpPr/>
          <p:nvPr/>
        </p:nvSpPr>
        <p:spPr>
          <a:xfrm>
            <a:off x="6213240" y="8969400"/>
            <a:ext cx="642960" cy="172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1" lang="en-GB" sz="700" spc="-1" strike="noStrike">
                <a:solidFill>
                  <a:srgbClr val="000000"/>
                </a:solidFill>
                <a:latin typeface="Arial"/>
              </a:rPr>
              <a:t>Marino</a:t>
            </a:r>
            <a:r>
              <a:rPr b="1" i="1" lang="en-GB" sz="700" spc="-1" strike="noStrike">
                <a:solidFill>
                  <a:srgbClr val="000000"/>
                </a:solidFill>
                <a:latin typeface="Arial"/>
              </a:rPr>
              <a:t> et al.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3" name=""/>
          <p:cNvSpPr/>
          <p:nvPr/>
        </p:nvSpPr>
        <p:spPr>
          <a:xfrm>
            <a:off x="1891440" y="5570640"/>
            <a:ext cx="865440" cy="34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4" name=""/>
          <p:cNvSpPr/>
          <p:nvPr/>
        </p:nvSpPr>
        <p:spPr>
          <a:xfrm>
            <a:off x="4097520" y="5570640"/>
            <a:ext cx="662760" cy="34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RNAi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95" name=""/>
          <p:cNvGrpSpPr/>
          <p:nvPr/>
        </p:nvGrpSpPr>
        <p:grpSpPr>
          <a:xfrm>
            <a:off x="3017880" y="1765440"/>
            <a:ext cx="2761920" cy="3675600"/>
            <a:chOff x="3017880" y="1765440"/>
            <a:chExt cx="2761920" cy="3675600"/>
          </a:xfrm>
        </p:grpSpPr>
        <p:pic>
          <p:nvPicPr>
            <p:cNvPr id="796" name="" descr=""/>
            <p:cNvPicPr/>
            <p:nvPr/>
          </p:nvPicPr>
          <p:blipFill>
            <a:blip r:embed="rId1"/>
            <a:stretch/>
          </p:blipFill>
          <p:spPr>
            <a:xfrm rot="7741200">
              <a:off x="3288240" y="2299320"/>
              <a:ext cx="2208960" cy="1749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97" name="" descr=""/>
            <p:cNvPicPr/>
            <p:nvPr/>
          </p:nvPicPr>
          <p:blipFill>
            <a:blip r:embed="rId2"/>
            <a:stretch/>
          </p:blipFill>
          <p:spPr>
            <a:xfrm rot="7741200">
              <a:off x="3300120" y="3157560"/>
              <a:ext cx="2208960" cy="174924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798" name=""/>
          <p:cNvGrpSpPr/>
          <p:nvPr/>
        </p:nvGrpSpPr>
        <p:grpSpPr>
          <a:xfrm>
            <a:off x="770040" y="1800360"/>
            <a:ext cx="2611440" cy="3484080"/>
            <a:chOff x="770040" y="1800360"/>
            <a:chExt cx="2611440" cy="3484080"/>
          </a:xfrm>
        </p:grpSpPr>
        <p:pic>
          <p:nvPicPr>
            <p:cNvPr id="799" name="" descr=""/>
            <p:cNvPicPr/>
            <p:nvPr/>
          </p:nvPicPr>
          <p:blipFill>
            <a:blip r:embed="rId3"/>
            <a:stretch/>
          </p:blipFill>
          <p:spPr>
            <a:xfrm rot="2912400">
              <a:off x="1458000" y="2211120"/>
              <a:ext cx="1705680" cy="135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00" name="" descr=""/>
            <p:cNvPicPr/>
            <p:nvPr/>
          </p:nvPicPr>
          <p:blipFill>
            <a:blip r:embed="rId4"/>
            <a:stretch/>
          </p:blipFill>
          <p:spPr>
            <a:xfrm rot="2912400">
              <a:off x="987480" y="3522960"/>
              <a:ext cx="1705680" cy="13500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801" name=""/>
          <p:cNvSpPr/>
          <p:nvPr/>
        </p:nvSpPr>
        <p:spPr>
          <a:xfrm>
            <a:off x="1062000" y="1641600"/>
            <a:ext cx="4734000" cy="3805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2" name=""/>
          <p:cNvSpPr/>
          <p:nvPr/>
        </p:nvSpPr>
        <p:spPr>
          <a:xfrm>
            <a:off x="3429000" y="1641600"/>
            <a:ext cx="0" cy="3805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3" name=""/>
          <p:cNvSpPr/>
          <p:nvPr/>
        </p:nvSpPr>
        <p:spPr>
          <a:xfrm>
            <a:off x="3017880" y="5292720"/>
            <a:ext cx="2206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4" name=""/>
          <p:cNvSpPr/>
          <p:nvPr/>
        </p:nvSpPr>
        <p:spPr>
          <a:xfrm>
            <a:off x="5383080" y="5292720"/>
            <a:ext cx="2224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5" name="Zone de texte 4"/>
          <p:cNvSpPr/>
          <p:nvPr/>
        </p:nvSpPr>
        <p:spPr>
          <a:xfrm>
            <a:off x="0" y="0"/>
            <a:ext cx="1413000" cy="27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5160" rIns="65160" tIns="32760" bIns="3276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Figure S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6" name="Rectangle 12"/>
          <p:cNvSpPr/>
          <p:nvPr/>
        </p:nvSpPr>
        <p:spPr>
          <a:xfrm>
            <a:off x="0" y="8895240"/>
            <a:ext cx="6122880" cy="24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5160" rIns="65160" tIns="32760" bIns="3276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Figure S5. Nitrogen fixation activity in 3SS::</a:t>
            </a:r>
            <a:r>
              <a:rPr b="1" i="1" lang="en-GB" sz="1200" spc="-1" strike="noStrike">
                <a:solidFill>
                  <a:srgbClr val="000000"/>
                </a:solidFill>
                <a:latin typeface="Arial"/>
              </a:rPr>
              <a:t>MtRbohA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 RNAi nodules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7" name="Rectangle 13"/>
          <p:cNvSpPr/>
          <p:nvPr/>
        </p:nvSpPr>
        <p:spPr>
          <a:xfrm>
            <a:off x="6213240" y="8969400"/>
            <a:ext cx="642960" cy="172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5160" rIns="65160" tIns="32760" bIns="3276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1" lang="en-GB" sz="700" spc="-1" strike="noStrike">
                <a:solidFill>
                  <a:srgbClr val="000000"/>
                </a:solidFill>
                <a:latin typeface="Arial"/>
              </a:rPr>
              <a:t>Marino</a:t>
            </a:r>
            <a:r>
              <a:rPr b="1" i="1" lang="en-GB" sz="700" spc="-1" strike="noStrike">
                <a:solidFill>
                  <a:srgbClr val="000000"/>
                </a:solidFill>
                <a:latin typeface="Arial"/>
              </a:rPr>
              <a:t> et al.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808" name=""/>
          <p:cNvGraphicFramePr/>
          <p:nvPr/>
        </p:nvGraphicFramePr>
        <p:xfrm>
          <a:off x="549360" y="2257560"/>
          <a:ext cx="5759280" cy="279720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809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549360" y="2257560"/>
                    <a:ext cx="5759280" cy="2797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10" name="Zone de texte 4"/>
          <p:cNvSpPr/>
          <p:nvPr/>
        </p:nvSpPr>
        <p:spPr>
          <a:xfrm>
            <a:off x="0" y="0"/>
            <a:ext cx="1413000" cy="27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5160" rIns="65160" tIns="32760" bIns="3276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652320"/>
                <a:tab algn="l" pos="1305000"/>
                <a:tab algn="l" pos="1957320"/>
                <a:tab algn="l" pos="2610000"/>
                <a:tab algn="l" pos="3262320"/>
                <a:tab algn="l" pos="3914640"/>
                <a:tab algn="l" pos="4567320"/>
                <a:tab algn="l" pos="5219640"/>
                <a:tab algn="l" pos="5872320"/>
                <a:tab algn="l" pos="6524640"/>
                <a:tab algn="l" pos="7176960"/>
                <a:tab algn="l" pos="7829640"/>
                <a:tab algn="l" pos="8481960"/>
                <a:tab algn="l" pos="9134640"/>
                <a:tab algn="l" pos="9786960"/>
                <a:tab algn="l" pos="1043928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Figure S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1" name=""/>
          <p:cNvSpPr/>
          <p:nvPr/>
        </p:nvSpPr>
        <p:spPr>
          <a:xfrm>
            <a:off x="4871880" y="2828880"/>
            <a:ext cx="275040" cy="64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279440"/>
                <a:tab algn="l" pos="2558880"/>
                <a:tab algn="l" pos="3838680"/>
                <a:tab algn="l" pos="5118120"/>
                <a:tab algn="l" pos="6397560"/>
                <a:tab algn="l" pos="7677000"/>
                <a:tab algn="l" pos="8956800"/>
                <a:tab algn="l" pos="10236240"/>
              </a:tabLst>
            </a:pPr>
            <a:r>
              <a:rPr b="0" lang="en-US" sz="3200" spc="-1" strike="noStrike" baseline="-25000">
                <a:solidFill>
                  <a:srgbClr val="000000"/>
                </a:solidFill>
                <a:latin typeface="Arial"/>
              </a:rPr>
              <a:t>*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6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7-05T12:21:09Z</dcterms:created>
  <dc:creator>Etienne Danchin</dc:creator>
  <dc:description/>
  <dc:language>en-US</dc:language>
  <cp:lastModifiedBy>Nicolas Pauly</cp:lastModifiedBy>
  <dcterms:modified xsi:type="dcterms:W3CDTF">2010-09-02T12:11:12Z</dcterms:modified>
  <cp:revision>30</cp:revision>
  <dc:subject/>
  <dc:title>Diapositive 1</dc:title>
</cp:coreProperties>
</file>